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7772400" cy="100584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showPr showNarration="1">
    <p:present/>
    <p:sldAll/>
    <p:penClr>
      <a:srgbClr val="FF0000"/>
    </p:penClr>
    <p:extLst>
      <p:ext uri="{EC167BDD-8182-4AB7-AECC-EB403E3ABB37}">
        <p14:laserClr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>
          <a:srgbClr val="FF0000"/>
        </p14:laserClr>
      </p:ext>
      <p:ext uri="{2FDB2607-1784-4EEB-B798-7EB5836EED8A}">
        <p14:showMediaCtrls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1"/>
      </p:ext>
    </p:extLst>
  </p:showPr>
  <p:clrMru>
    <a:srgbClr val="3366FF"/>
    <a:srgbClr val="0000CC"/>
    <a:srgbClr val="CC0000"/>
    <a:srgbClr val="CCECFF"/>
    <a:srgbClr val="6699FF"/>
    <a:srgbClr val="3333FF"/>
    <a:srgbClr val="000066"/>
    <a:srgbClr val="FF7C80"/>
    <a:srgbClr val="FFCCCC"/>
  </p:clrMru>
  <p:extLst>
    <p:ext uri="{E76CE94A-603C-4142-B9EB-6D1370010A27}">
      <p14:discardImageEditData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0"/>
    </p:ext>
    <p:ext uri="{D31A062A-798A-4329-ABDD-BBA856620510}">
      <p14:defaultImageDpi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848" y="1888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FEACC1D-76C9-442D-8C54-DE29623170D1}" type="datetime1">
              <a:rPr lang="en-US"/>
              <a:pPr/>
              <a:t>5/27/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cs typeface="ＭＳ Ｐゴシック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AF08235-94A3-4A46-80A9-1D028A1A724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2629472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613" y="3124200"/>
            <a:ext cx="6607175" cy="2155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225" y="5699125"/>
            <a:ext cx="5441950" cy="257175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FDBA242-A094-4E06-BF00-92ED338731B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833496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8E27AEF-3926-4842-99FE-A7D4E06B66A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2232256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5625" y="403225"/>
            <a:ext cx="1747838" cy="85820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938" y="403225"/>
            <a:ext cx="5094287" cy="85820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414E90B-CD63-4D9F-82AC-888D798D192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4058533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152D545-F2A8-4B0E-97A9-8C8F00896A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93001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363" y="6462713"/>
            <a:ext cx="6605587" cy="19986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363" y="4262438"/>
            <a:ext cx="6605587" cy="22002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BCE77E-29DB-43E9-A361-49B8D025D62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314340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938" y="2346325"/>
            <a:ext cx="3421062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2400" y="2346325"/>
            <a:ext cx="3421063" cy="6638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C8B34F7-FA52-480C-8CDA-0AF86F4C768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4103999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938" y="2251075"/>
            <a:ext cx="3433762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938" y="3189288"/>
            <a:ext cx="3433762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113" y="2251075"/>
            <a:ext cx="3435350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113" y="3189288"/>
            <a:ext cx="3435350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E037020-BFFB-4440-9F67-5C69D27589E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987624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1BA5E6-AA2A-4299-B7C0-DBCA71081EF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54453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69B11BF-7CEB-4DE7-8295-0034C910076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133388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2557462" cy="17049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475" y="400050"/>
            <a:ext cx="4344988" cy="8585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938" y="2105025"/>
            <a:ext cx="2557462" cy="68802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1EE3372-7797-47F0-87CB-A16DFEE5436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341273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0" y="7040563"/>
            <a:ext cx="4662488" cy="8318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0" y="898525"/>
            <a:ext cx="4662488" cy="6035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4000" y="7872413"/>
            <a:ext cx="4662488" cy="11795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3EB43FB-78B8-475A-9598-D9B248B8CDE0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p14="http://schemas.microsoft.com/office/powerpoint/2010/main" xmlns="" val="975988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88938" y="403225"/>
            <a:ext cx="6994525" cy="167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88938" y="2346325"/>
            <a:ext cx="6994525" cy="663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889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655888" y="9159875"/>
            <a:ext cx="24606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ctr">
              <a:defRPr sz="1600" b="0"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570538" y="9159875"/>
            <a:ext cx="1812925" cy="69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01882" tIns="50941" rIns="101882" bIns="50941" numCol="1" anchor="t" anchorCtr="0" compatLnSpc="1">
            <a:prstTxWarp prst="textNoShape">
              <a:avLst/>
            </a:prstTxWarp>
          </a:bodyPr>
          <a:lstStyle>
            <a:lvl1pPr algn="r">
              <a:defRPr sz="1600" b="0"/>
            </a:lvl1pPr>
          </a:lstStyle>
          <a:p>
            <a:fld id="{EF862D10-19BD-4301-AC82-5860AEA6F385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defTabSz="1019175" rtl="0" eaLnBrk="0" fontAlgn="base" hangingPunct="0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6pPr>
      <a:lvl7pPr marL="9144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7pPr>
      <a:lvl8pPr marL="13716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8pPr>
      <a:lvl9pPr marL="1828800" algn="ctr" defTabSz="1019175" rtl="0" fontAlgn="base">
        <a:spcBef>
          <a:spcPct val="0"/>
        </a:spcBef>
        <a:spcAft>
          <a:spcPct val="0"/>
        </a:spcAft>
        <a:defRPr sz="4900">
          <a:solidFill>
            <a:schemeClr val="tx2"/>
          </a:solidFill>
          <a:latin typeface="Arial" charset="0"/>
        </a:defRPr>
      </a:lvl9pPr>
    </p:titleStyle>
    <p:bodyStyle>
      <a:lvl1pPr marL="382588" indent="-382588" algn="l" defTabSz="1019175" rtl="0" eaLnBrk="0" fontAlgn="base" hangingPunct="0">
        <a:spcBef>
          <a:spcPct val="20000"/>
        </a:spcBef>
        <a:spcAft>
          <a:spcPct val="0"/>
        </a:spcAft>
        <a:buChar char="•"/>
        <a:defRPr sz="36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827088" indent="-3175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3100">
          <a:solidFill>
            <a:schemeClr val="tx1"/>
          </a:solidFill>
          <a:latin typeface="+mn-lt"/>
          <a:ea typeface="ＭＳ Ｐゴシック" charset="-128"/>
        </a:defRPr>
      </a:lvl2pPr>
      <a:lvl3pPr marL="1273175" indent="-254000" algn="l" defTabSz="1019175" rtl="0" eaLnBrk="0" fontAlgn="base" hangingPunct="0">
        <a:spcBef>
          <a:spcPct val="20000"/>
        </a:spcBef>
        <a:spcAft>
          <a:spcPct val="0"/>
        </a:spcAft>
        <a:buChar char="•"/>
        <a:defRPr sz="2700">
          <a:solidFill>
            <a:schemeClr val="tx1"/>
          </a:solidFill>
          <a:latin typeface="+mn-lt"/>
          <a:ea typeface="ＭＳ Ｐゴシック" charset="-128"/>
        </a:defRPr>
      </a:lvl3pPr>
      <a:lvl4pPr marL="1782763" indent="-254000" algn="l" defTabSz="1019175" rtl="0" eaLnBrk="0" fontAlgn="base" hangingPunct="0">
        <a:spcBef>
          <a:spcPct val="20000"/>
        </a:spcBef>
        <a:spcAft>
          <a:spcPct val="0"/>
        </a:spcAft>
        <a:buChar char="–"/>
        <a:defRPr sz="2200">
          <a:solidFill>
            <a:schemeClr val="tx1"/>
          </a:solidFill>
          <a:latin typeface="+mn-lt"/>
          <a:ea typeface="ＭＳ Ｐゴシック" charset="-128"/>
        </a:defRPr>
      </a:lvl4pPr>
      <a:lvl5pPr marL="2292350" indent="-254000" algn="l" defTabSz="1019175" rtl="0" eaLnBrk="0" fontAlgn="base" hangingPunct="0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5pPr>
      <a:lvl6pPr marL="27495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6pPr>
      <a:lvl7pPr marL="32067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7pPr>
      <a:lvl8pPr marL="36639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8pPr>
      <a:lvl9pPr marL="4121150" indent="-254000" algn="l" defTabSz="1019175" rtl="0" fontAlgn="base">
        <a:spcBef>
          <a:spcPct val="20000"/>
        </a:spcBef>
        <a:spcAft>
          <a:spcPct val="0"/>
        </a:spcAft>
        <a:buChar char="»"/>
        <a:defRPr sz="2200">
          <a:solidFill>
            <a:schemeClr val="tx1"/>
          </a:solidFill>
          <a:latin typeface="+mn-lt"/>
          <a:ea typeface="ＭＳ Ｐゴシック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3" name="Text Box 5"/>
          <p:cNvSpPr txBox="1">
            <a:spLocks noChangeArrowheads="1"/>
          </p:cNvSpPr>
          <p:nvPr/>
        </p:nvSpPr>
        <p:spPr bwMode="auto">
          <a:xfrm>
            <a:off x="814388" y="720725"/>
            <a:ext cx="88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dirty="0"/>
              <a:t>Figure </a:t>
            </a:r>
            <a:r>
              <a:rPr lang="en-US" sz="1200" dirty="0" smtClean="0"/>
              <a:t>S4</a:t>
            </a:r>
            <a:endParaRPr lang="en-US" sz="1200" dirty="0"/>
          </a:p>
        </p:txBody>
      </p:sp>
      <p:sp>
        <p:nvSpPr>
          <p:cNvPr id="25604" name="Text Box 5"/>
          <p:cNvSpPr txBox="1">
            <a:spLocks noChangeArrowheads="1"/>
          </p:cNvSpPr>
          <p:nvPr/>
        </p:nvSpPr>
        <p:spPr bwMode="auto">
          <a:xfrm>
            <a:off x="814388" y="10668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/>
              <a:t>A</a:t>
            </a:r>
          </a:p>
        </p:txBody>
      </p:sp>
      <p:sp>
        <p:nvSpPr>
          <p:cNvPr id="25605" name="Text Box 5"/>
          <p:cNvSpPr txBox="1">
            <a:spLocks noChangeArrowheads="1"/>
          </p:cNvSpPr>
          <p:nvPr/>
        </p:nvSpPr>
        <p:spPr bwMode="auto">
          <a:xfrm>
            <a:off x="3778250" y="10668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/>
              <a:t>B</a:t>
            </a:r>
          </a:p>
        </p:txBody>
      </p:sp>
      <p:grpSp>
        <p:nvGrpSpPr>
          <p:cNvPr id="25606" name="Group 1"/>
          <p:cNvGrpSpPr>
            <a:grpSpLocks/>
          </p:cNvGrpSpPr>
          <p:nvPr/>
        </p:nvGrpSpPr>
        <p:grpSpPr bwMode="auto">
          <a:xfrm>
            <a:off x="890590" y="1506538"/>
            <a:ext cx="2884485" cy="2225430"/>
            <a:chOff x="891243" y="1183588"/>
            <a:chExt cx="2884451" cy="2226727"/>
          </a:xfrm>
        </p:grpSpPr>
        <p:sp>
          <p:nvSpPr>
            <p:cNvPr id="25820" name="Rectangle 208"/>
            <p:cNvSpPr>
              <a:spLocks noChangeArrowheads="1"/>
            </p:cNvSpPr>
            <p:nvPr/>
          </p:nvSpPr>
          <p:spPr bwMode="auto">
            <a:xfrm>
              <a:off x="1162156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1" name="Rectangle 210"/>
            <p:cNvSpPr>
              <a:spLocks noChangeArrowheads="1"/>
            </p:cNvSpPr>
            <p:nvPr/>
          </p:nvSpPr>
          <p:spPr bwMode="auto">
            <a:xfrm>
              <a:off x="1425407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2" name="Rectangle 212"/>
            <p:cNvSpPr>
              <a:spLocks noChangeArrowheads="1"/>
            </p:cNvSpPr>
            <p:nvPr/>
          </p:nvSpPr>
          <p:spPr bwMode="auto">
            <a:xfrm>
              <a:off x="1690765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3" name="Rectangle 214"/>
            <p:cNvSpPr>
              <a:spLocks noChangeArrowheads="1"/>
            </p:cNvSpPr>
            <p:nvPr/>
          </p:nvSpPr>
          <p:spPr bwMode="auto">
            <a:xfrm>
              <a:off x="1956123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8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4" name="Rectangle 216"/>
            <p:cNvSpPr>
              <a:spLocks noChangeArrowheads="1"/>
            </p:cNvSpPr>
            <p:nvPr/>
          </p:nvSpPr>
          <p:spPr bwMode="auto">
            <a:xfrm>
              <a:off x="2221480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5" name="Rectangle 218"/>
            <p:cNvSpPr>
              <a:spLocks noChangeArrowheads="1"/>
            </p:cNvSpPr>
            <p:nvPr/>
          </p:nvSpPr>
          <p:spPr bwMode="auto">
            <a:xfrm>
              <a:off x="2486838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6" name="Rectangle 220"/>
            <p:cNvSpPr>
              <a:spLocks noChangeArrowheads="1"/>
            </p:cNvSpPr>
            <p:nvPr/>
          </p:nvSpPr>
          <p:spPr bwMode="auto">
            <a:xfrm>
              <a:off x="2752196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1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7" name="Rectangle 222"/>
            <p:cNvSpPr>
              <a:spLocks noChangeArrowheads="1"/>
            </p:cNvSpPr>
            <p:nvPr/>
          </p:nvSpPr>
          <p:spPr bwMode="auto">
            <a:xfrm>
              <a:off x="3015447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8" name="Rectangle 224"/>
            <p:cNvSpPr>
              <a:spLocks noChangeArrowheads="1"/>
            </p:cNvSpPr>
            <p:nvPr/>
          </p:nvSpPr>
          <p:spPr bwMode="auto">
            <a:xfrm>
              <a:off x="3280805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29" name="Rectangle 226"/>
            <p:cNvSpPr>
              <a:spLocks noChangeArrowheads="1"/>
            </p:cNvSpPr>
            <p:nvPr/>
          </p:nvSpPr>
          <p:spPr bwMode="auto">
            <a:xfrm>
              <a:off x="3546163" y="3224477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0" name="Rectangle 227"/>
            <p:cNvSpPr>
              <a:spLocks noChangeArrowheads="1"/>
            </p:cNvSpPr>
            <p:nvPr/>
          </p:nvSpPr>
          <p:spPr bwMode="auto">
            <a:xfrm>
              <a:off x="2432058" y="3287132"/>
              <a:ext cx="171018" cy="1231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err="1">
                  <a:solidFill>
                    <a:srgbClr val="000000"/>
                  </a:solidFill>
                  <a:cs typeface="Arial" charset="0"/>
                </a:rPr>
                <a:t>m/z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25831" name="Rectangle 310"/>
            <p:cNvSpPr>
              <a:spLocks noChangeArrowheads="1"/>
            </p:cNvSpPr>
            <p:nvPr/>
          </p:nvSpPr>
          <p:spPr bwMode="auto">
            <a:xfrm>
              <a:off x="1127868" y="3174338"/>
              <a:ext cx="16481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2" name="Rectangle 318"/>
            <p:cNvSpPr>
              <a:spLocks noChangeArrowheads="1"/>
            </p:cNvSpPr>
            <p:nvPr/>
          </p:nvSpPr>
          <p:spPr bwMode="auto">
            <a:xfrm>
              <a:off x="1111388" y="2853171"/>
              <a:ext cx="32962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3" name="Rectangle 326"/>
            <p:cNvSpPr>
              <a:spLocks noChangeArrowheads="1"/>
            </p:cNvSpPr>
            <p:nvPr/>
          </p:nvSpPr>
          <p:spPr bwMode="auto">
            <a:xfrm>
              <a:off x="1111388" y="2529371"/>
              <a:ext cx="32962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4" name="Rectangle 334"/>
            <p:cNvSpPr>
              <a:spLocks noChangeArrowheads="1"/>
            </p:cNvSpPr>
            <p:nvPr/>
          </p:nvSpPr>
          <p:spPr bwMode="auto">
            <a:xfrm>
              <a:off x="1111388" y="2205571"/>
              <a:ext cx="32962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5" name="Rectangle 342"/>
            <p:cNvSpPr>
              <a:spLocks noChangeArrowheads="1"/>
            </p:cNvSpPr>
            <p:nvPr/>
          </p:nvSpPr>
          <p:spPr bwMode="auto">
            <a:xfrm>
              <a:off x="1111388" y="1881771"/>
              <a:ext cx="32962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6" name="Rectangle 350"/>
            <p:cNvSpPr>
              <a:spLocks noChangeArrowheads="1"/>
            </p:cNvSpPr>
            <p:nvPr/>
          </p:nvSpPr>
          <p:spPr bwMode="auto">
            <a:xfrm>
              <a:off x="1094906" y="1557971"/>
              <a:ext cx="49443" cy="357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10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37" name="Rectangle 351"/>
            <p:cNvSpPr>
              <a:spLocks noChangeArrowheads="1"/>
            </p:cNvSpPr>
            <p:nvPr/>
          </p:nvSpPr>
          <p:spPr bwMode="auto">
            <a:xfrm rot="16200000">
              <a:off x="458785" y="2320779"/>
              <a:ext cx="988025" cy="123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Relative Abundance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25838" name="Rectangle 353"/>
            <p:cNvSpPr>
              <a:spLocks noChangeArrowheads="1"/>
            </p:cNvSpPr>
            <p:nvPr/>
          </p:nvSpPr>
          <p:spPr bwMode="auto">
            <a:xfrm rot="-5400000">
              <a:off x="2320598" y="1316477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cs typeface="Arial" charset="0"/>
                </a:rPr>
                <a:t>909.9847</a:t>
              </a:r>
              <a:endParaRPr lang="en-US" sz="700">
                <a:cs typeface="Arial" charset="0"/>
              </a:endParaRPr>
            </a:p>
          </p:txBody>
        </p:sp>
        <p:sp>
          <p:nvSpPr>
            <p:cNvPr id="25839" name="Rectangle 355"/>
            <p:cNvSpPr>
              <a:spLocks noChangeArrowheads="1"/>
            </p:cNvSpPr>
            <p:nvPr/>
          </p:nvSpPr>
          <p:spPr bwMode="auto">
            <a:xfrm rot="-5400000">
              <a:off x="2453277" y="1432308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0.485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0" name="Rectangle 357"/>
            <p:cNvSpPr>
              <a:spLocks noChangeArrowheads="1"/>
            </p:cNvSpPr>
            <p:nvPr/>
          </p:nvSpPr>
          <p:spPr bwMode="auto">
            <a:xfrm rot="-5400000">
              <a:off x="2585956" y="2248914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0.987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1" name="Rectangle 359"/>
            <p:cNvSpPr>
              <a:spLocks noChangeArrowheads="1"/>
            </p:cNvSpPr>
            <p:nvPr/>
          </p:nvSpPr>
          <p:spPr bwMode="auto">
            <a:xfrm rot="-5400000">
              <a:off x="1391320" y="2364745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cs typeface="Arial" charset="0"/>
                </a:rPr>
                <a:t>906.4762</a:t>
              </a:r>
              <a:endParaRPr lang="en-US" sz="700">
                <a:cs typeface="Arial" charset="0"/>
              </a:endParaRPr>
            </a:p>
          </p:txBody>
        </p:sp>
        <p:sp>
          <p:nvSpPr>
            <p:cNvPr id="25842" name="Rectangle 361"/>
            <p:cNvSpPr>
              <a:spLocks noChangeArrowheads="1"/>
            </p:cNvSpPr>
            <p:nvPr/>
          </p:nvSpPr>
          <p:spPr bwMode="auto">
            <a:xfrm rot="-5400000">
              <a:off x="1656677" y="2662746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7.478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3" name="Rectangle 363"/>
            <p:cNvSpPr>
              <a:spLocks noChangeArrowheads="1"/>
            </p:cNvSpPr>
            <p:nvPr/>
          </p:nvSpPr>
          <p:spPr bwMode="auto">
            <a:xfrm rot="-5400000">
              <a:off x="2718634" y="270434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1.488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4" name="Rectangle 365"/>
            <p:cNvSpPr>
              <a:spLocks noChangeArrowheads="1"/>
            </p:cNvSpPr>
            <p:nvPr/>
          </p:nvSpPr>
          <p:spPr bwMode="auto">
            <a:xfrm rot="-5400000">
              <a:off x="1789356" y="285492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7.979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5" name="Rectangle 367"/>
            <p:cNvSpPr>
              <a:spLocks noChangeArrowheads="1"/>
            </p:cNvSpPr>
            <p:nvPr/>
          </p:nvSpPr>
          <p:spPr bwMode="auto">
            <a:xfrm rot="-5400000">
              <a:off x="2187919" y="288493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9.484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6" name="Rectangle 369"/>
            <p:cNvSpPr>
              <a:spLocks noChangeArrowheads="1"/>
            </p:cNvSpPr>
            <p:nvPr/>
          </p:nvSpPr>
          <p:spPr bwMode="auto">
            <a:xfrm rot="-5400000">
              <a:off x="2851313" y="290599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1.990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7" name="Rectangle 371"/>
            <p:cNvSpPr>
              <a:spLocks noChangeArrowheads="1"/>
            </p:cNvSpPr>
            <p:nvPr/>
          </p:nvSpPr>
          <p:spPr bwMode="auto">
            <a:xfrm rot="-5400000">
              <a:off x="3062418" y="2884011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2.722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48" name="Rectangle 374"/>
            <p:cNvSpPr>
              <a:spLocks noChangeArrowheads="1"/>
            </p:cNvSpPr>
            <p:nvPr/>
          </p:nvSpPr>
          <p:spPr bwMode="auto">
            <a:xfrm rot="-5400000">
              <a:off x="3262208" y="2874057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3.4442</a:t>
              </a:r>
              <a:endParaRPr lang="en-US" sz="700" b="0">
                <a:cs typeface="Arial" charset="0"/>
              </a:endParaRPr>
            </a:p>
          </p:txBody>
        </p:sp>
        <p:grpSp>
          <p:nvGrpSpPr>
            <p:cNvPr id="25849" name="Group 37"/>
            <p:cNvGrpSpPr>
              <a:grpSpLocks/>
            </p:cNvGrpSpPr>
            <p:nvPr/>
          </p:nvGrpSpPr>
          <p:grpSpPr bwMode="auto">
            <a:xfrm>
              <a:off x="1153181" y="1575467"/>
              <a:ext cx="2622513" cy="1649010"/>
              <a:chOff x="701675" y="1127125"/>
              <a:chExt cx="7907337" cy="4972051"/>
            </a:xfrm>
          </p:grpSpPr>
          <p:sp>
            <p:nvSpPr>
              <p:cNvPr id="25852" name="Line 19"/>
              <p:cNvSpPr>
                <a:spLocks noChangeShapeType="1"/>
              </p:cNvSpPr>
              <p:nvPr/>
            </p:nvSpPr>
            <p:spPr bwMode="auto">
              <a:xfrm>
                <a:off x="790575" y="6008688"/>
                <a:ext cx="7818437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3" name="Line 20"/>
              <p:cNvSpPr>
                <a:spLocks noChangeShapeType="1"/>
              </p:cNvSpPr>
              <p:nvPr/>
            </p:nvSpPr>
            <p:spPr bwMode="auto">
              <a:xfrm>
                <a:off x="9588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4" name="Line 21"/>
              <p:cNvSpPr>
                <a:spLocks noChangeShapeType="1"/>
              </p:cNvSpPr>
              <p:nvPr/>
            </p:nvSpPr>
            <p:spPr bwMode="auto">
              <a:xfrm>
                <a:off x="112236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5" name="Line 22"/>
              <p:cNvSpPr>
                <a:spLocks noChangeShapeType="1"/>
              </p:cNvSpPr>
              <p:nvPr/>
            </p:nvSpPr>
            <p:spPr bwMode="auto">
              <a:xfrm>
                <a:off x="12779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6" name="Line 23"/>
              <p:cNvSpPr>
                <a:spLocks noChangeShapeType="1"/>
              </p:cNvSpPr>
              <p:nvPr/>
            </p:nvSpPr>
            <p:spPr bwMode="auto">
              <a:xfrm>
                <a:off x="14414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7" name="Line 24"/>
              <p:cNvSpPr>
                <a:spLocks noChangeShapeType="1"/>
              </p:cNvSpPr>
              <p:nvPr/>
            </p:nvSpPr>
            <p:spPr bwMode="auto">
              <a:xfrm>
                <a:off x="17589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8" name="Line 25"/>
              <p:cNvSpPr>
                <a:spLocks noChangeShapeType="1"/>
              </p:cNvSpPr>
              <p:nvPr/>
            </p:nvSpPr>
            <p:spPr bwMode="auto">
              <a:xfrm>
                <a:off x="192246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59" name="Line 26"/>
              <p:cNvSpPr>
                <a:spLocks noChangeShapeType="1"/>
              </p:cNvSpPr>
              <p:nvPr/>
            </p:nvSpPr>
            <p:spPr bwMode="auto">
              <a:xfrm>
                <a:off x="20780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0" name="Line 27"/>
              <p:cNvSpPr>
                <a:spLocks noChangeShapeType="1"/>
              </p:cNvSpPr>
              <p:nvPr/>
            </p:nvSpPr>
            <p:spPr bwMode="auto">
              <a:xfrm>
                <a:off x="22415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1" name="Line 28"/>
              <p:cNvSpPr>
                <a:spLocks noChangeShapeType="1"/>
              </p:cNvSpPr>
              <p:nvPr/>
            </p:nvSpPr>
            <p:spPr bwMode="auto">
              <a:xfrm>
                <a:off x="25590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2" name="Line 29"/>
              <p:cNvSpPr>
                <a:spLocks noChangeShapeType="1"/>
              </p:cNvSpPr>
              <p:nvPr/>
            </p:nvSpPr>
            <p:spPr bwMode="auto">
              <a:xfrm>
                <a:off x="27162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3" name="Line 30"/>
              <p:cNvSpPr>
                <a:spLocks noChangeShapeType="1"/>
              </p:cNvSpPr>
              <p:nvPr/>
            </p:nvSpPr>
            <p:spPr bwMode="auto">
              <a:xfrm>
                <a:off x="28781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4" name="Line 31"/>
              <p:cNvSpPr>
                <a:spLocks noChangeShapeType="1"/>
              </p:cNvSpPr>
              <p:nvPr/>
            </p:nvSpPr>
            <p:spPr bwMode="auto">
              <a:xfrm>
                <a:off x="30337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5" name="Line 32"/>
              <p:cNvSpPr>
                <a:spLocks noChangeShapeType="1"/>
              </p:cNvSpPr>
              <p:nvPr/>
            </p:nvSpPr>
            <p:spPr bwMode="auto">
              <a:xfrm>
                <a:off x="33607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6" name="Line 33"/>
              <p:cNvSpPr>
                <a:spLocks noChangeShapeType="1"/>
              </p:cNvSpPr>
              <p:nvPr/>
            </p:nvSpPr>
            <p:spPr bwMode="auto">
              <a:xfrm>
                <a:off x="35163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7" name="Line 34"/>
              <p:cNvSpPr>
                <a:spLocks noChangeShapeType="1"/>
              </p:cNvSpPr>
              <p:nvPr/>
            </p:nvSpPr>
            <p:spPr bwMode="auto">
              <a:xfrm>
                <a:off x="36782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8" name="Line 35"/>
              <p:cNvSpPr>
                <a:spLocks noChangeShapeType="1"/>
              </p:cNvSpPr>
              <p:nvPr/>
            </p:nvSpPr>
            <p:spPr bwMode="auto">
              <a:xfrm>
                <a:off x="38354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9" name="Line 36"/>
              <p:cNvSpPr>
                <a:spLocks noChangeShapeType="1"/>
              </p:cNvSpPr>
              <p:nvPr/>
            </p:nvSpPr>
            <p:spPr bwMode="auto">
              <a:xfrm>
                <a:off x="41529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0" name="Line 37"/>
              <p:cNvSpPr>
                <a:spLocks noChangeShapeType="1"/>
              </p:cNvSpPr>
              <p:nvPr/>
            </p:nvSpPr>
            <p:spPr bwMode="auto">
              <a:xfrm>
                <a:off x="43164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1" name="Line 38"/>
              <p:cNvSpPr>
                <a:spLocks noChangeShapeType="1"/>
              </p:cNvSpPr>
              <p:nvPr/>
            </p:nvSpPr>
            <p:spPr bwMode="auto">
              <a:xfrm>
                <a:off x="447833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2" name="Line 39"/>
              <p:cNvSpPr>
                <a:spLocks noChangeShapeType="1"/>
              </p:cNvSpPr>
              <p:nvPr/>
            </p:nvSpPr>
            <p:spPr bwMode="auto">
              <a:xfrm>
                <a:off x="46355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3" name="Line 40"/>
              <p:cNvSpPr>
                <a:spLocks noChangeShapeType="1"/>
              </p:cNvSpPr>
              <p:nvPr/>
            </p:nvSpPr>
            <p:spPr bwMode="auto">
              <a:xfrm>
                <a:off x="49530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4" name="Line 41"/>
              <p:cNvSpPr>
                <a:spLocks noChangeShapeType="1"/>
              </p:cNvSpPr>
              <p:nvPr/>
            </p:nvSpPr>
            <p:spPr bwMode="auto">
              <a:xfrm>
                <a:off x="51165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5" name="Line 42"/>
              <p:cNvSpPr>
                <a:spLocks noChangeShapeType="1"/>
              </p:cNvSpPr>
              <p:nvPr/>
            </p:nvSpPr>
            <p:spPr bwMode="auto">
              <a:xfrm>
                <a:off x="52720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6" name="Line 43"/>
              <p:cNvSpPr>
                <a:spLocks noChangeShapeType="1"/>
              </p:cNvSpPr>
              <p:nvPr/>
            </p:nvSpPr>
            <p:spPr bwMode="auto">
              <a:xfrm>
                <a:off x="54356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7" name="Line 44"/>
              <p:cNvSpPr>
                <a:spLocks noChangeShapeType="1"/>
              </p:cNvSpPr>
              <p:nvPr/>
            </p:nvSpPr>
            <p:spPr bwMode="auto">
              <a:xfrm>
                <a:off x="57531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8" name="Line 45"/>
              <p:cNvSpPr>
                <a:spLocks noChangeShapeType="1"/>
              </p:cNvSpPr>
              <p:nvPr/>
            </p:nvSpPr>
            <p:spPr bwMode="auto">
              <a:xfrm>
                <a:off x="59166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79" name="Line 46"/>
              <p:cNvSpPr>
                <a:spLocks noChangeShapeType="1"/>
              </p:cNvSpPr>
              <p:nvPr/>
            </p:nvSpPr>
            <p:spPr bwMode="auto">
              <a:xfrm>
                <a:off x="60721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0" name="Line 47"/>
              <p:cNvSpPr>
                <a:spLocks noChangeShapeType="1"/>
              </p:cNvSpPr>
              <p:nvPr/>
            </p:nvSpPr>
            <p:spPr bwMode="auto">
              <a:xfrm>
                <a:off x="62357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1" name="Line 48"/>
              <p:cNvSpPr>
                <a:spLocks noChangeShapeType="1"/>
              </p:cNvSpPr>
              <p:nvPr/>
            </p:nvSpPr>
            <p:spPr bwMode="auto">
              <a:xfrm>
                <a:off x="65532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2" name="Line 49"/>
              <p:cNvSpPr>
                <a:spLocks noChangeShapeType="1"/>
              </p:cNvSpPr>
              <p:nvPr/>
            </p:nvSpPr>
            <p:spPr bwMode="auto">
              <a:xfrm>
                <a:off x="671671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3" name="Line 50"/>
              <p:cNvSpPr>
                <a:spLocks noChangeShapeType="1"/>
              </p:cNvSpPr>
              <p:nvPr/>
            </p:nvSpPr>
            <p:spPr bwMode="auto">
              <a:xfrm>
                <a:off x="68722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4" name="Line 51"/>
              <p:cNvSpPr>
                <a:spLocks noChangeShapeType="1"/>
              </p:cNvSpPr>
              <p:nvPr/>
            </p:nvSpPr>
            <p:spPr bwMode="auto">
              <a:xfrm>
                <a:off x="703580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5" name="Line 52"/>
              <p:cNvSpPr>
                <a:spLocks noChangeShapeType="1"/>
              </p:cNvSpPr>
              <p:nvPr/>
            </p:nvSpPr>
            <p:spPr bwMode="auto">
              <a:xfrm>
                <a:off x="73548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6" name="Line 53"/>
              <p:cNvSpPr>
                <a:spLocks noChangeShapeType="1"/>
              </p:cNvSpPr>
              <p:nvPr/>
            </p:nvSpPr>
            <p:spPr bwMode="auto">
              <a:xfrm>
                <a:off x="751046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7" name="Line 54"/>
              <p:cNvSpPr>
                <a:spLocks noChangeShapeType="1"/>
              </p:cNvSpPr>
              <p:nvPr/>
            </p:nvSpPr>
            <p:spPr bwMode="auto">
              <a:xfrm>
                <a:off x="76723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8" name="Line 55"/>
              <p:cNvSpPr>
                <a:spLocks noChangeShapeType="1"/>
              </p:cNvSpPr>
              <p:nvPr/>
            </p:nvSpPr>
            <p:spPr bwMode="auto">
              <a:xfrm>
                <a:off x="7829550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89" name="Line 56"/>
              <p:cNvSpPr>
                <a:spLocks noChangeShapeType="1"/>
              </p:cNvSpPr>
              <p:nvPr/>
            </p:nvSpPr>
            <p:spPr bwMode="auto">
              <a:xfrm>
                <a:off x="81549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0" name="Line 57"/>
              <p:cNvSpPr>
                <a:spLocks noChangeShapeType="1"/>
              </p:cNvSpPr>
              <p:nvPr/>
            </p:nvSpPr>
            <p:spPr bwMode="auto">
              <a:xfrm>
                <a:off x="8310562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1" name="Line 58"/>
              <p:cNvSpPr>
                <a:spLocks noChangeShapeType="1"/>
              </p:cNvSpPr>
              <p:nvPr/>
            </p:nvSpPr>
            <p:spPr bwMode="auto">
              <a:xfrm>
                <a:off x="8472487" y="6008688"/>
                <a:ext cx="0" cy="6350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2" name="Line 59"/>
              <p:cNvSpPr>
                <a:spLocks noChangeShapeType="1"/>
              </p:cNvSpPr>
              <p:nvPr/>
            </p:nvSpPr>
            <p:spPr bwMode="auto">
              <a:xfrm>
                <a:off x="8366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3" name="Line 60"/>
              <p:cNvSpPr>
                <a:spLocks noChangeShapeType="1"/>
              </p:cNvSpPr>
              <p:nvPr/>
            </p:nvSpPr>
            <p:spPr bwMode="auto">
              <a:xfrm>
                <a:off x="8778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4" name="Line 61"/>
              <p:cNvSpPr>
                <a:spLocks noChangeShapeType="1"/>
              </p:cNvSpPr>
              <p:nvPr/>
            </p:nvSpPr>
            <p:spPr bwMode="auto">
              <a:xfrm>
                <a:off x="9191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5" name="Line 62"/>
              <p:cNvSpPr>
                <a:spLocks noChangeShapeType="1"/>
              </p:cNvSpPr>
              <p:nvPr/>
            </p:nvSpPr>
            <p:spPr bwMode="auto">
              <a:xfrm>
                <a:off x="10001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6" name="Line 63"/>
              <p:cNvSpPr>
                <a:spLocks noChangeShapeType="1"/>
              </p:cNvSpPr>
              <p:nvPr/>
            </p:nvSpPr>
            <p:spPr bwMode="auto">
              <a:xfrm>
                <a:off x="10414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7" name="Line 64"/>
              <p:cNvSpPr>
                <a:spLocks noChangeShapeType="1"/>
              </p:cNvSpPr>
              <p:nvPr/>
            </p:nvSpPr>
            <p:spPr bwMode="auto">
              <a:xfrm>
                <a:off x="10810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8" name="Line 65"/>
              <p:cNvSpPr>
                <a:spLocks noChangeShapeType="1"/>
              </p:cNvSpPr>
              <p:nvPr/>
            </p:nvSpPr>
            <p:spPr bwMode="auto">
              <a:xfrm>
                <a:off x="11620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99" name="Line 66"/>
              <p:cNvSpPr>
                <a:spLocks noChangeShapeType="1"/>
              </p:cNvSpPr>
              <p:nvPr/>
            </p:nvSpPr>
            <p:spPr bwMode="auto">
              <a:xfrm>
                <a:off x="11969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0" name="Line 67"/>
              <p:cNvSpPr>
                <a:spLocks noChangeShapeType="1"/>
              </p:cNvSpPr>
              <p:nvPr/>
            </p:nvSpPr>
            <p:spPr bwMode="auto">
              <a:xfrm>
                <a:off x="12366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1" name="Line 68"/>
              <p:cNvSpPr>
                <a:spLocks noChangeShapeType="1"/>
              </p:cNvSpPr>
              <p:nvPr/>
            </p:nvSpPr>
            <p:spPr bwMode="auto">
              <a:xfrm>
                <a:off x="13192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2" name="Line 69"/>
              <p:cNvSpPr>
                <a:spLocks noChangeShapeType="1"/>
              </p:cNvSpPr>
              <p:nvPr/>
            </p:nvSpPr>
            <p:spPr bwMode="auto">
              <a:xfrm>
                <a:off x="13589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3" name="Line 70"/>
              <p:cNvSpPr>
                <a:spLocks noChangeShapeType="1"/>
              </p:cNvSpPr>
              <p:nvPr/>
            </p:nvSpPr>
            <p:spPr bwMode="auto">
              <a:xfrm>
                <a:off x="14001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4" name="Line 71"/>
              <p:cNvSpPr>
                <a:spLocks noChangeShapeType="1"/>
              </p:cNvSpPr>
              <p:nvPr/>
            </p:nvSpPr>
            <p:spPr bwMode="auto">
              <a:xfrm>
                <a:off x="14811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5" name="Line 72"/>
              <p:cNvSpPr>
                <a:spLocks noChangeShapeType="1"/>
              </p:cNvSpPr>
              <p:nvPr/>
            </p:nvSpPr>
            <p:spPr bwMode="auto">
              <a:xfrm>
                <a:off x="15224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6" name="Line 73"/>
              <p:cNvSpPr>
                <a:spLocks noChangeShapeType="1"/>
              </p:cNvSpPr>
              <p:nvPr/>
            </p:nvSpPr>
            <p:spPr bwMode="auto">
              <a:xfrm>
                <a:off x="15636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7" name="Line 74"/>
              <p:cNvSpPr>
                <a:spLocks noChangeShapeType="1"/>
              </p:cNvSpPr>
              <p:nvPr/>
            </p:nvSpPr>
            <p:spPr bwMode="auto">
              <a:xfrm>
                <a:off x="16383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8" name="Line 75"/>
              <p:cNvSpPr>
                <a:spLocks noChangeShapeType="1"/>
              </p:cNvSpPr>
              <p:nvPr/>
            </p:nvSpPr>
            <p:spPr bwMode="auto">
              <a:xfrm>
                <a:off x="16779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09" name="Line 76"/>
              <p:cNvSpPr>
                <a:spLocks noChangeShapeType="1"/>
              </p:cNvSpPr>
              <p:nvPr/>
            </p:nvSpPr>
            <p:spPr bwMode="auto">
              <a:xfrm>
                <a:off x="17192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0" name="Line 77"/>
              <p:cNvSpPr>
                <a:spLocks noChangeShapeType="1"/>
              </p:cNvSpPr>
              <p:nvPr/>
            </p:nvSpPr>
            <p:spPr bwMode="auto">
              <a:xfrm>
                <a:off x="18002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1" name="Line 78"/>
              <p:cNvSpPr>
                <a:spLocks noChangeShapeType="1"/>
              </p:cNvSpPr>
              <p:nvPr/>
            </p:nvSpPr>
            <p:spPr bwMode="auto">
              <a:xfrm>
                <a:off x="18415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2" name="Line 79"/>
              <p:cNvSpPr>
                <a:spLocks noChangeShapeType="1"/>
              </p:cNvSpPr>
              <p:nvPr/>
            </p:nvSpPr>
            <p:spPr bwMode="auto">
              <a:xfrm>
                <a:off x="18811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3" name="Line 80"/>
              <p:cNvSpPr>
                <a:spLocks noChangeShapeType="1"/>
              </p:cNvSpPr>
              <p:nvPr/>
            </p:nvSpPr>
            <p:spPr bwMode="auto">
              <a:xfrm>
                <a:off x="19558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4" name="Line 81"/>
              <p:cNvSpPr>
                <a:spLocks noChangeShapeType="1"/>
              </p:cNvSpPr>
              <p:nvPr/>
            </p:nvSpPr>
            <p:spPr bwMode="auto">
              <a:xfrm>
                <a:off x="19970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5" name="Line 82"/>
              <p:cNvSpPr>
                <a:spLocks noChangeShapeType="1"/>
              </p:cNvSpPr>
              <p:nvPr/>
            </p:nvSpPr>
            <p:spPr bwMode="auto">
              <a:xfrm>
                <a:off x="20383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6" name="Line 83"/>
              <p:cNvSpPr>
                <a:spLocks noChangeShapeType="1"/>
              </p:cNvSpPr>
              <p:nvPr/>
            </p:nvSpPr>
            <p:spPr bwMode="auto">
              <a:xfrm>
                <a:off x="21193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7" name="Line 84"/>
              <p:cNvSpPr>
                <a:spLocks noChangeShapeType="1"/>
              </p:cNvSpPr>
              <p:nvPr/>
            </p:nvSpPr>
            <p:spPr bwMode="auto">
              <a:xfrm>
                <a:off x="21590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8" name="Line 85"/>
              <p:cNvSpPr>
                <a:spLocks noChangeShapeType="1"/>
              </p:cNvSpPr>
              <p:nvPr/>
            </p:nvSpPr>
            <p:spPr bwMode="auto">
              <a:xfrm>
                <a:off x="22002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19" name="Line 86"/>
              <p:cNvSpPr>
                <a:spLocks noChangeShapeType="1"/>
              </p:cNvSpPr>
              <p:nvPr/>
            </p:nvSpPr>
            <p:spPr bwMode="auto">
              <a:xfrm>
                <a:off x="22812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0" name="Line 87"/>
              <p:cNvSpPr>
                <a:spLocks noChangeShapeType="1"/>
              </p:cNvSpPr>
              <p:nvPr/>
            </p:nvSpPr>
            <p:spPr bwMode="auto">
              <a:xfrm>
                <a:off x="23161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1" name="Line 88"/>
              <p:cNvSpPr>
                <a:spLocks noChangeShapeType="1"/>
              </p:cNvSpPr>
              <p:nvPr/>
            </p:nvSpPr>
            <p:spPr bwMode="auto">
              <a:xfrm>
                <a:off x="23558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2" name="Line 89"/>
              <p:cNvSpPr>
                <a:spLocks noChangeShapeType="1"/>
              </p:cNvSpPr>
              <p:nvPr/>
            </p:nvSpPr>
            <p:spPr bwMode="auto">
              <a:xfrm>
                <a:off x="24384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3" name="Line 90"/>
              <p:cNvSpPr>
                <a:spLocks noChangeShapeType="1"/>
              </p:cNvSpPr>
              <p:nvPr/>
            </p:nvSpPr>
            <p:spPr bwMode="auto">
              <a:xfrm>
                <a:off x="24780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4" name="Line 91"/>
              <p:cNvSpPr>
                <a:spLocks noChangeShapeType="1"/>
              </p:cNvSpPr>
              <p:nvPr/>
            </p:nvSpPr>
            <p:spPr bwMode="auto">
              <a:xfrm>
                <a:off x="25193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5" name="Line 92"/>
              <p:cNvSpPr>
                <a:spLocks noChangeShapeType="1"/>
              </p:cNvSpPr>
              <p:nvPr/>
            </p:nvSpPr>
            <p:spPr bwMode="auto">
              <a:xfrm>
                <a:off x="26003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6" name="Line 93"/>
              <p:cNvSpPr>
                <a:spLocks noChangeShapeType="1"/>
              </p:cNvSpPr>
              <p:nvPr/>
            </p:nvSpPr>
            <p:spPr bwMode="auto">
              <a:xfrm>
                <a:off x="26416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7" name="Line 94"/>
              <p:cNvSpPr>
                <a:spLocks noChangeShapeType="1"/>
              </p:cNvSpPr>
              <p:nvPr/>
            </p:nvSpPr>
            <p:spPr bwMode="auto">
              <a:xfrm>
                <a:off x="26749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8" name="Line 95"/>
              <p:cNvSpPr>
                <a:spLocks noChangeShapeType="1"/>
              </p:cNvSpPr>
              <p:nvPr/>
            </p:nvSpPr>
            <p:spPr bwMode="auto">
              <a:xfrm>
                <a:off x="27559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29" name="Line 96"/>
              <p:cNvSpPr>
                <a:spLocks noChangeShapeType="1"/>
              </p:cNvSpPr>
              <p:nvPr/>
            </p:nvSpPr>
            <p:spPr bwMode="auto">
              <a:xfrm>
                <a:off x="27971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0" name="Line 97"/>
              <p:cNvSpPr>
                <a:spLocks noChangeShapeType="1"/>
              </p:cNvSpPr>
              <p:nvPr/>
            </p:nvSpPr>
            <p:spPr bwMode="auto">
              <a:xfrm>
                <a:off x="28384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1" name="Line 98"/>
              <p:cNvSpPr>
                <a:spLocks noChangeShapeType="1"/>
              </p:cNvSpPr>
              <p:nvPr/>
            </p:nvSpPr>
            <p:spPr bwMode="auto">
              <a:xfrm>
                <a:off x="29194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2" name="Line 99"/>
              <p:cNvSpPr>
                <a:spLocks noChangeShapeType="1"/>
              </p:cNvSpPr>
              <p:nvPr/>
            </p:nvSpPr>
            <p:spPr bwMode="auto">
              <a:xfrm>
                <a:off x="29591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3" name="Line 100"/>
              <p:cNvSpPr>
                <a:spLocks noChangeShapeType="1"/>
              </p:cNvSpPr>
              <p:nvPr/>
            </p:nvSpPr>
            <p:spPr bwMode="auto">
              <a:xfrm>
                <a:off x="30003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4" name="Line 101"/>
              <p:cNvSpPr>
                <a:spLocks noChangeShapeType="1"/>
              </p:cNvSpPr>
              <p:nvPr/>
            </p:nvSpPr>
            <p:spPr bwMode="auto">
              <a:xfrm>
                <a:off x="30749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5" name="Line 102"/>
              <p:cNvSpPr>
                <a:spLocks noChangeShapeType="1"/>
              </p:cNvSpPr>
              <p:nvPr/>
            </p:nvSpPr>
            <p:spPr bwMode="auto">
              <a:xfrm>
                <a:off x="31162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6" name="Line 103"/>
              <p:cNvSpPr>
                <a:spLocks noChangeShapeType="1"/>
              </p:cNvSpPr>
              <p:nvPr/>
            </p:nvSpPr>
            <p:spPr bwMode="auto">
              <a:xfrm>
                <a:off x="31559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7" name="Line 104"/>
              <p:cNvSpPr>
                <a:spLocks noChangeShapeType="1"/>
              </p:cNvSpPr>
              <p:nvPr/>
            </p:nvSpPr>
            <p:spPr bwMode="auto">
              <a:xfrm>
                <a:off x="32385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8" name="Line 105"/>
              <p:cNvSpPr>
                <a:spLocks noChangeShapeType="1"/>
              </p:cNvSpPr>
              <p:nvPr/>
            </p:nvSpPr>
            <p:spPr bwMode="auto">
              <a:xfrm>
                <a:off x="32781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39" name="Line 106"/>
              <p:cNvSpPr>
                <a:spLocks noChangeShapeType="1"/>
              </p:cNvSpPr>
              <p:nvPr/>
            </p:nvSpPr>
            <p:spPr bwMode="auto">
              <a:xfrm>
                <a:off x="33194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0" name="Line 107"/>
              <p:cNvSpPr>
                <a:spLocks noChangeShapeType="1"/>
              </p:cNvSpPr>
              <p:nvPr/>
            </p:nvSpPr>
            <p:spPr bwMode="auto">
              <a:xfrm>
                <a:off x="34004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1" name="Line 108"/>
              <p:cNvSpPr>
                <a:spLocks noChangeShapeType="1"/>
              </p:cNvSpPr>
              <p:nvPr/>
            </p:nvSpPr>
            <p:spPr bwMode="auto">
              <a:xfrm>
                <a:off x="34337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2" name="Line 109"/>
              <p:cNvSpPr>
                <a:spLocks noChangeShapeType="1"/>
              </p:cNvSpPr>
              <p:nvPr/>
            </p:nvSpPr>
            <p:spPr bwMode="auto">
              <a:xfrm>
                <a:off x="34750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3" name="Line 110"/>
              <p:cNvSpPr>
                <a:spLocks noChangeShapeType="1"/>
              </p:cNvSpPr>
              <p:nvPr/>
            </p:nvSpPr>
            <p:spPr bwMode="auto">
              <a:xfrm>
                <a:off x="35560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4" name="Line 111"/>
              <p:cNvSpPr>
                <a:spLocks noChangeShapeType="1"/>
              </p:cNvSpPr>
              <p:nvPr/>
            </p:nvSpPr>
            <p:spPr bwMode="auto">
              <a:xfrm>
                <a:off x="35972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5" name="Line 112"/>
              <p:cNvSpPr>
                <a:spLocks noChangeShapeType="1"/>
              </p:cNvSpPr>
              <p:nvPr/>
            </p:nvSpPr>
            <p:spPr bwMode="auto">
              <a:xfrm>
                <a:off x="36385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6" name="Line 113"/>
              <p:cNvSpPr>
                <a:spLocks noChangeShapeType="1"/>
              </p:cNvSpPr>
              <p:nvPr/>
            </p:nvSpPr>
            <p:spPr bwMode="auto">
              <a:xfrm>
                <a:off x="37195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7" name="Line 114"/>
              <p:cNvSpPr>
                <a:spLocks noChangeShapeType="1"/>
              </p:cNvSpPr>
              <p:nvPr/>
            </p:nvSpPr>
            <p:spPr bwMode="auto">
              <a:xfrm>
                <a:off x="37607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8" name="Line 115"/>
              <p:cNvSpPr>
                <a:spLocks noChangeShapeType="1"/>
              </p:cNvSpPr>
              <p:nvPr/>
            </p:nvSpPr>
            <p:spPr bwMode="auto">
              <a:xfrm>
                <a:off x="37941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49" name="Line 116"/>
              <p:cNvSpPr>
                <a:spLocks noChangeShapeType="1"/>
              </p:cNvSpPr>
              <p:nvPr/>
            </p:nvSpPr>
            <p:spPr bwMode="auto">
              <a:xfrm>
                <a:off x="38750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0" name="Line 117"/>
              <p:cNvSpPr>
                <a:spLocks noChangeShapeType="1"/>
              </p:cNvSpPr>
              <p:nvPr/>
            </p:nvSpPr>
            <p:spPr bwMode="auto">
              <a:xfrm>
                <a:off x="39163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1" name="Line 118"/>
              <p:cNvSpPr>
                <a:spLocks noChangeShapeType="1"/>
              </p:cNvSpPr>
              <p:nvPr/>
            </p:nvSpPr>
            <p:spPr bwMode="auto">
              <a:xfrm>
                <a:off x="39560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2" name="Line 119"/>
              <p:cNvSpPr>
                <a:spLocks noChangeShapeType="1"/>
              </p:cNvSpPr>
              <p:nvPr/>
            </p:nvSpPr>
            <p:spPr bwMode="auto">
              <a:xfrm>
                <a:off x="40386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3" name="Line 120"/>
              <p:cNvSpPr>
                <a:spLocks noChangeShapeType="1"/>
              </p:cNvSpPr>
              <p:nvPr/>
            </p:nvSpPr>
            <p:spPr bwMode="auto">
              <a:xfrm>
                <a:off x="40782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4" name="Line 121"/>
              <p:cNvSpPr>
                <a:spLocks noChangeShapeType="1"/>
              </p:cNvSpPr>
              <p:nvPr/>
            </p:nvSpPr>
            <p:spPr bwMode="auto">
              <a:xfrm>
                <a:off x="41195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5" name="Line 122"/>
              <p:cNvSpPr>
                <a:spLocks noChangeShapeType="1"/>
              </p:cNvSpPr>
              <p:nvPr/>
            </p:nvSpPr>
            <p:spPr bwMode="auto">
              <a:xfrm>
                <a:off x="41941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6" name="Line 123"/>
              <p:cNvSpPr>
                <a:spLocks noChangeShapeType="1"/>
              </p:cNvSpPr>
              <p:nvPr/>
            </p:nvSpPr>
            <p:spPr bwMode="auto">
              <a:xfrm>
                <a:off x="42354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7" name="Line 124"/>
              <p:cNvSpPr>
                <a:spLocks noChangeShapeType="1"/>
              </p:cNvSpPr>
              <p:nvPr/>
            </p:nvSpPr>
            <p:spPr bwMode="auto">
              <a:xfrm>
                <a:off x="42751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8" name="Line 125"/>
              <p:cNvSpPr>
                <a:spLocks noChangeShapeType="1"/>
              </p:cNvSpPr>
              <p:nvPr/>
            </p:nvSpPr>
            <p:spPr bwMode="auto">
              <a:xfrm>
                <a:off x="43561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59" name="Line 126"/>
              <p:cNvSpPr>
                <a:spLocks noChangeShapeType="1"/>
              </p:cNvSpPr>
              <p:nvPr/>
            </p:nvSpPr>
            <p:spPr bwMode="auto">
              <a:xfrm>
                <a:off x="43973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0" name="Line 127"/>
              <p:cNvSpPr>
                <a:spLocks noChangeShapeType="1"/>
              </p:cNvSpPr>
              <p:nvPr/>
            </p:nvSpPr>
            <p:spPr bwMode="auto">
              <a:xfrm>
                <a:off x="44386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1" name="Line 128"/>
              <p:cNvSpPr>
                <a:spLocks noChangeShapeType="1"/>
              </p:cNvSpPr>
              <p:nvPr/>
            </p:nvSpPr>
            <p:spPr bwMode="auto">
              <a:xfrm>
                <a:off x="45132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2" name="Line 129"/>
              <p:cNvSpPr>
                <a:spLocks noChangeShapeType="1"/>
              </p:cNvSpPr>
              <p:nvPr/>
            </p:nvSpPr>
            <p:spPr bwMode="auto">
              <a:xfrm>
                <a:off x="45529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3" name="Line 130"/>
              <p:cNvSpPr>
                <a:spLocks noChangeShapeType="1"/>
              </p:cNvSpPr>
              <p:nvPr/>
            </p:nvSpPr>
            <p:spPr bwMode="auto">
              <a:xfrm>
                <a:off x="45942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4" name="Line 131"/>
              <p:cNvSpPr>
                <a:spLocks noChangeShapeType="1"/>
              </p:cNvSpPr>
              <p:nvPr/>
            </p:nvSpPr>
            <p:spPr bwMode="auto">
              <a:xfrm>
                <a:off x="46751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5" name="Line 132"/>
              <p:cNvSpPr>
                <a:spLocks noChangeShapeType="1"/>
              </p:cNvSpPr>
              <p:nvPr/>
            </p:nvSpPr>
            <p:spPr bwMode="auto">
              <a:xfrm>
                <a:off x="47164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6" name="Line 133"/>
              <p:cNvSpPr>
                <a:spLocks noChangeShapeType="1"/>
              </p:cNvSpPr>
              <p:nvPr/>
            </p:nvSpPr>
            <p:spPr bwMode="auto">
              <a:xfrm>
                <a:off x="47561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7" name="Line 134"/>
              <p:cNvSpPr>
                <a:spLocks noChangeShapeType="1"/>
              </p:cNvSpPr>
              <p:nvPr/>
            </p:nvSpPr>
            <p:spPr bwMode="auto">
              <a:xfrm>
                <a:off x="48387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8" name="Line 135"/>
              <p:cNvSpPr>
                <a:spLocks noChangeShapeType="1"/>
              </p:cNvSpPr>
              <p:nvPr/>
            </p:nvSpPr>
            <p:spPr bwMode="auto">
              <a:xfrm>
                <a:off x="48720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69" name="Line 136"/>
              <p:cNvSpPr>
                <a:spLocks noChangeShapeType="1"/>
              </p:cNvSpPr>
              <p:nvPr/>
            </p:nvSpPr>
            <p:spPr bwMode="auto">
              <a:xfrm>
                <a:off x="49133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0" name="Line 137"/>
              <p:cNvSpPr>
                <a:spLocks noChangeShapeType="1"/>
              </p:cNvSpPr>
              <p:nvPr/>
            </p:nvSpPr>
            <p:spPr bwMode="auto">
              <a:xfrm>
                <a:off x="49942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1" name="Line 138"/>
              <p:cNvSpPr>
                <a:spLocks noChangeShapeType="1"/>
              </p:cNvSpPr>
              <p:nvPr/>
            </p:nvSpPr>
            <p:spPr bwMode="auto">
              <a:xfrm>
                <a:off x="50355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2" name="Line 139"/>
              <p:cNvSpPr>
                <a:spLocks noChangeShapeType="1"/>
              </p:cNvSpPr>
              <p:nvPr/>
            </p:nvSpPr>
            <p:spPr bwMode="auto">
              <a:xfrm>
                <a:off x="50752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3" name="Line 140"/>
              <p:cNvSpPr>
                <a:spLocks noChangeShapeType="1"/>
              </p:cNvSpPr>
              <p:nvPr/>
            </p:nvSpPr>
            <p:spPr bwMode="auto">
              <a:xfrm>
                <a:off x="51562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4" name="Line 141"/>
              <p:cNvSpPr>
                <a:spLocks noChangeShapeType="1"/>
              </p:cNvSpPr>
              <p:nvPr/>
            </p:nvSpPr>
            <p:spPr bwMode="auto">
              <a:xfrm>
                <a:off x="51974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5" name="Line 142"/>
              <p:cNvSpPr>
                <a:spLocks noChangeShapeType="1"/>
              </p:cNvSpPr>
              <p:nvPr/>
            </p:nvSpPr>
            <p:spPr bwMode="auto">
              <a:xfrm>
                <a:off x="52387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6" name="Line 143"/>
              <p:cNvSpPr>
                <a:spLocks noChangeShapeType="1"/>
              </p:cNvSpPr>
              <p:nvPr/>
            </p:nvSpPr>
            <p:spPr bwMode="auto">
              <a:xfrm>
                <a:off x="53133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7" name="Line 144"/>
              <p:cNvSpPr>
                <a:spLocks noChangeShapeType="1"/>
              </p:cNvSpPr>
              <p:nvPr/>
            </p:nvSpPr>
            <p:spPr bwMode="auto">
              <a:xfrm>
                <a:off x="53530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8" name="Line 145"/>
              <p:cNvSpPr>
                <a:spLocks noChangeShapeType="1"/>
              </p:cNvSpPr>
              <p:nvPr/>
            </p:nvSpPr>
            <p:spPr bwMode="auto">
              <a:xfrm>
                <a:off x="53943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79" name="Line 146"/>
              <p:cNvSpPr>
                <a:spLocks noChangeShapeType="1"/>
              </p:cNvSpPr>
              <p:nvPr/>
            </p:nvSpPr>
            <p:spPr bwMode="auto">
              <a:xfrm>
                <a:off x="54752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0" name="Line 147"/>
              <p:cNvSpPr>
                <a:spLocks noChangeShapeType="1"/>
              </p:cNvSpPr>
              <p:nvPr/>
            </p:nvSpPr>
            <p:spPr bwMode="auto">
              <a:xfrm>
                <a:off x="55165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1" name="Line 148"/>
              <p:cNvSpPr>
                <a:spLocks noChangeShapeType="1"/>
              </p:cNvSpPr>
              <p:nvPr/>
            </p:nvSpPr>
            <p:spPr bwMode="auto">
              <a:xfrm>
                <a:off x="55578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2" name="Line 149"/>
              <p:cNvSpPr>
                <a:spLocks noChangeShapeType="1"/>
              </p:cNvSpPr>
              <p:nvPr/>
            </p:nvSpPr>
            <p:spPr bwMode="auto">
              <a:xfrm>
                <a:off x="56324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3" name="Line 150"/>
              <p:cNvSpPr>
                <a:spLocks noChangeShapeType="1"/>
              </p:cNvSpPr>
              <p:nvPr/>
            </p:nvSpPr>
            <p:spPr bwMode="auto">
              <a:xfrm>
                <a:off x="56721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4" name="Line 151"/>
              <p:cNvSpPr>
                <a:spLocks noChangeShapeType="1"/>
              </p:cNvSpPr>
              <p:nvPr/>
            </p:nvSpPr>
            <p:spPr bwMode="auto">
              <a:xfrm>
                <a:off x="57134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5" name="Line 152"/>
              <p:cNvSpPr>
                <a:spLocks noChangeShapeType="1"/>
              </p:cNvSpPr>
              <p:nvPr/>
            </p:nvSpPr>
            <p:spPr bwMode="auto">
              <a:xfrm>
                <a:off x="57943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6" name="Line 153"/>
              <p:cNvSpPr>
                <a:spLocks noChangeShapeType="1"/>
              </p:cNvSpPr>
              <p:nvPr/>
            </p:nvSpPr>
            <p:spPr bwMode="auto">
              <a:xfrm>
                <a:off x="58356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7" name="Line 154"/>
              <p:cNvSpPr>
                <a:spLocks noChangeShapeType="1"/>
              </p:cNvSpPr>
              <p:nvPr/>
            </p:nvSpPr>
            <p:spPr bwMode="auto">
              <a:xfrm>
                <a:off x="58753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8" name="Line 155"/>
              <p:cNvSpPr>
                <a:spLocks noChangeShapeType="1"/>
              </p:cNvSpPr>
              <p:nvPr/>
            </p:nvSpPr>
            <p:spPr bwMode="auto">
              <a:xfrm>
                <a:off x="59578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89" name="Line 156"/>
              <p:cNvSpPr>
                <a:spLocks noChangeShapeType="1"/>
              </p:cNvSpPr>
              <p:nvPr/>
            </p:nvSpPr>
            <p:spPr bwMode="auto">
              <a:xfrm>
                <a:off x="59912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0" name="Line 157"/>
              <p:cNvSpPr>
                <a:spLocks noChangeShapeType="1"/>
              </p:cNvSpPr>
              <p:nvPr/>
            </p:nvSpPr>
            <p:spPr bwMode="auto">
              <a:xfrm>
                <a:off x="60325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1" name="Line 158"/>
              <p:cNvSpPr>
                <a:spLocks noChangeShapeType="1"/>
              </p:cNvSpPr>
              <p:nvPr/>
            </p:nvSpPr>
            <p:spPr bwMode="auto">
              <a:xfrm>
                <a:off x="61134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2" name="Line 159"/>
              <p:cNvSpPr>
                <a:spLocks noChangeShapeType="1"/>
              </p:cNvSpPr>
              <p:nvPr/>
            </p:nvSpPr>
            <p:spPr bwMode="auto">
              <a:xfrm>
                <a:off x="61531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3" name="Line 160"/>
              <p:cNvSpPr>
                <a:spLocks noChangeShapeType="1"/>
              </p:cNvSpPr>
              <p:nvPr/>
            </p:nvSpPr>
            <p:spPr bwMode="auto">
              <a:xfrm>
                <a:off x="61944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4" name="Line 161"/>
              <p:cNvSpPr>
                <a:spLocks noChangeShapeType="1"/>
              </p:cNvSpPr>
              <p:nvPr/>
            </p:nvSpPr>
            <p:spPr bwMode="auto">
              <a:xfrm>
                <a:off x="62753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5" name="Line 162"/>
              <p:cNvSpPr>
                <a:spLocks noChangeShapeType="1"/>
              </p:cNvSpPr>
              <p:nvPr/>
            </p:nvSpPr>
            <p:spPr bwMode="auto">
              <a:xfrm>
                <a:off x="63166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6" name="Line 163"/>
              <p:cNvSpPr>
                <a:spLocks noChangeShapeType="1"/>
              </p:cNvSpPr>
              <p:nvPr/>
            </p:nvSpPr>
            <p:spPr bwMode="auto">
              <a:xfrm>
                <a:off x="63500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7" name="Line 164"/>
              <p:cNvSpPr>
                <a:spLocks noChangeShapeType="1"/>
              </p:cNvSpPr>
              <p:nvPr/>
            </p:nvSpPr>
            <p:spPr bwMode="auto">
              <a:xfrm>
                <a:off x="64325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8" name="Line 165"/>
              <p:cNvSpPr>
                <a:spLocks noChangeShapeType="1"/>
              </p:cNvSpPr>
              <p:nvPr/>
            </p:nvSpPr>
            <p:spPr bwMode="auto">
              <a:xfrm>
                <a:off x="64722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99" name="Line 166"/>
              <p:cNvSpPr>
                <a:spLocks noChangeShapeType="1"/>
              </p:cNvSpPr>
              <p:nvPr/>
            </p:nvSpPr>
            <p:spPr bwMode="auto">
              <a:xfrm>
                <a:off x="65135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0" name="Line 167"/>
              <p:cNvSpPr>
                <a:spLocks noChangeShapeType="1"/>
              </p:cNvSpPr>
              <p:nvPr/>
            </p:nvSpPr>
            <p:spPr bwMode="auto">
              <a:xfrm>
                <a:off x="65944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1" name="Line 168"/>
              <p:cNvSpPr>
                <a:spLocks noChangeShapeType="1"/>
              </p:cNvSpPr>
              <p:nvPr/>
            </p:nvSpPr>
            <p:spPr bwMode="auto">
              <a:xfrm>
                <a:off x="66357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2" name="Line 169"/>
              <p:cNvSpPr>
                <a:spLocks noChangeShapeType="1"/>
              </p:cNvSpPr>
              <p:nvPr/>
            </p:nvSpPr>
            <p:spPr bwMode="auto">
              <a:xfrm>
                <a:off x="66754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3" name="Line 170"/>
              <p:cNvSpPr>
                <a:spLocks noChangeShapeType="1"/>
              </p:cNvSpPr>
              <p:nvPr/>
            </p:nvSpPr>
            <p:spPr bwMode="auto">
              <a:xfrm>
                <a:off x="67500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4" name="Line 171"/>
              <p:cNvSpPr>
                <a:spLocks noChangeShapeType="1"/>
              </p:cNvSpPr>
              <p:nvPr/>
            </p:nvSpPr>
            <p:spPr bwMode="auto">
              <a:xfrm>
                <a:off x="67913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5" name="Line 172"/>
              <p:cNvSpPr>
                <a:spLocks noChangeShapeType="1"/>
              </p:cNvSpPr>
              <p:nvPr/>
            </p:nvSpPr>
            <p:spPr bwMode="auto">
              <a:xfrm>
                <a:off x="68326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6" name="Line 173"/>
              <p:cNvSpPr>
                <a:spLocks noChangeShapeType="1"/>
              </p:cNvSpPr>
              <p:nvPr/>
            </p:nvSpPr>
            <p:spPr bwMode="auto">
              <a:xfrm>
                <a:off x="69135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7" name="Line 174"/>
              <p:cNvSpPr>
                <a:spLocks noChangeShapeType="1"/>
              </p:cNvSpPr>
              <p:nvPr/>
            </p:nvSpPr>
            <p:spPr bwMode="auto">
              <a:xfrm>
                <a:off x="69532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8" name="Line 175"/>
              <p:cNvSpPr>
                <a:spLocks noChangeShapeType="1"/>
              </p:cNvSpPr>
              <p:nvPr/>
            </p:nvSpPr>
            <p:spPr bwMode="auto">
              <a:xfrm>
                <a:off x="69945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09" name="Line 176"/>
              <p:cNvSpPr>
                <a:spLocks noChangeShapeType="1"/>
              </p:cNvSpPr>
              <p:nvPr/>
            </p:nvSpPr>
            <p:spPr bwMode="auto">
              <a:xfrm>
                <a:off x="70754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0" name="Line 177"/>
              <p:cNvSpPr>
                <a:spLocks noChangeShapeType="1"/>
              </p:cNvSpPr>
              <p:nvPr/>
            </p:nvSpPr>
            <p:spPr bwMode="auto">
              <a:xfrm>
                <a:off x="71104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1" name="Line 178"/>
              <p:cNvSpPr>
                <a:spLocks noChangeShapeType="1"/>
              </p:cNvSpPr>
              <p:nvPr/>
            </p:nvSpPr>
            <p:spPr bwMode="auto">
              <a:xfrm>
                <a:off x="71501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2" name="Line 179"/>
              <p:cNvSpPr>
                <a:spLocks noChangeShapeType="1"/>
              </p:cNvSpPr>
              <p:nvPr/>
            </p:nvSpPr>
            <p:spPr bwMode="auto">
              <a:xfrm>
                <a:off x="72326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3" name="Line 180"/>
              <p:cNvSpPr>
                <a:spLocks noChangeShapeType="1"/>
              </p:cNvSpPr>
              <p:nvPr/>
            </p:nvSpPr>
            <p:spPr bwMode="auto">
              <a:xfrm>
                <a:off x="72723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4" name="Line 181"/>
              <p:cNvSpPr>
                <a:spLocks noChangeShapeType="1"/>
              </p:cNvSpPr>
              <p:nvPr/>
            </p:nvSpPr>
            <p:spPr bwMode="auto">
              <a:xfrm>
                <a:off x="73136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5" name="Line 182"/>
              <p:cNvSpPr>
                <a:spLocks noChangeShapeType="1"/>
              </p:cNvSpPr>
              <p:nvPr/>
            </p:nvSpPr>
            <p:spPr bwMode="auto">
              <a:xfrm>
                <a:off x="73945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6" name="Line 183"/>
              <p:cNvSpPr>
                <a:spLocks noChangeShapeType="1"/>
              </p:cNvSpPr>
              <p:nvPr/>
            </p:nvSpPr>
            <p:spPr bwMode="auto">
              <a:xfrm>
                <a:off x="74358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7" name="Line 184"/>
              <p:cNvSpPr>
                <a:spLocks noChangeShapeType="1"/>
              </p:cNvSpPr>
              <p:nvPr/>
            </p:nvSpPr>
            <p:spPr bwMode="auto">
              <a:xfrm>
                <a:off x="74691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8" name="Line 185"/>
              <p:cNvSpPr>
                <a:spLocks noChangeShapeType="1"/>
              </p:cNvSpPr>
              <p:nvPr/>
            </p:nvSpPr>
            <p:spPr bwMode="auto">
              <a:xfrm>
                <a:off x="75501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19" name="Line 186"/>
              <p:cNvSpPr>
                <a:spLocks noChangeShapeType="1"/>
              </p:cNvSpPr>
              <p:nvPr/>
            </p:nvSpPr>
            <p:spPr bwMode="auto">
              <a:xfrm>
                <a:off x="75914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0" name="Line 187"/>
              <p:cNvSpPr>
                <a:spLocks noChangeShapeType="1"/>
              </p:cNvSpPr>
              <p:nvPr/>
            </p:nvSpPr>
            <p:spPr bwMode="auto">
              <a:xfrm>
                <a:off x="76327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1" name="Line 188"/>
              <p:cNvSpPr>
                <a:spLocks noChangeShapeType="1"/>
              </p:cNvSpPr>
              <p:nvPr/>
            </p:nvSpPr>
            <p:spPr bwMode="auto">
              <a:xfrm>
                <a:off x="77136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2" name="Line 189"/>
              <p:cNvSpPr>
                <a:spLocks noChangeShapeType="1"/>
              </p:cNvSpPr>
              <p:nvPr/>
            </p:nvSpPr>
            <p:spPr bwMode="auto">
              <a:xfrm>
                <a:off x="77549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3" name="Line 190"/>
              <p:cNvSpPr>
                <a:spLocks noChangeShapeType="1"/>
              </p:cNvSpPr>
              <p:nvPr/>
            </p:nvSpPr>
            <p:spPr bwMode="auto">
              <a:xfrm>
                <a:off x="77946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4" name="Line 191"/>
              <p:cNvSpPr>
                <a:spLocks noChangeShapeType="1"/>
              </p:cNvSpPr>
              <p:nvPr/>
            </p:nvSpPr>
            <p:spPr bwMode="auto">
              <a:xfrm>
                <a:off x="78692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5" name="Line 192"/>
              <p:cNvSpPr>
                <a:spLocks noChangeShapeType="1"/>
              </p:cNvSpPr>
              <p:nvPr/>
            </p:nvSpPr>
            <p:spPr bwMode="auto">
              <a:xfrm>
                <a:off x="79105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6" name="Line 193"/>
              <p:cNvSpPr>
                <a:spLocks noChangeShapeType="1"/>
              </p:cNvSpPr>
              <p:nvPr/>
            </p:nvSpPr>
            <p:spPr bwMode="auto">
              <a:xfrm>
                <a:off x="79502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7" name="Line 194"/>
              <p:cNvSpPr>
                <a:spLocks noChangeShapeType="1"/>
              </p:cNvSpPr>
              <p:nvPr/>
            </p:nvSpPr>
            <p:spPr bwMode="auto">
              <a:xfrm>
                <a:off x="80327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8" name="Line 195"/>
              <p:cNvSpPr>
                <a:spLocks noChangeShapeType="1"/>
              </p:cNvSpPr>
              <p:nvPr/>
            </p:nvSpPr>
            <p:spPr bwMode="auto">
              <a:xfrm>
                <a:off x="80724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29" name="Line 196"/>
              <p:cNvSpPr>
                <a:spLocks noChangeShapeType="1"/>
              </p:cNvSpPr>
              <p:nvPr/>
            </p:nvSpPr>
            <p:spPr bwMode="auto">
              <a:xfrm>
                <a:off x="811371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0" name="Line 197"/>
              <p:cNvSpPr>
                <a:spLocks noChangeShapeType="1"/>
              </p:cNvSpPr>
              <p:nvPr/>
            </p:nvSpPr>
            <p:spPr bwMode="auto">
              <a:xfrm>
                <a:off x="81883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1" name="Line 198"/>
              <p:cNvSpPr>
                <a:spLocks noChangeShapeType="1"/>
              </p:cNvSpPr>
              <p:nvPr/>
            </p:nvSpPr>
            <p:spPr bwMode="auto">
              <a:xfrm>
                <a:off x="82296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2" name="Line 199"/>
              <p:cNvSpPr>
                <a:spLocks noChangeShapeType="1"/>
              </p:cNvSpPr>
              <p:nvPr/>
            </p:nvSpPr>
            <p:spPr bwMode="auto">
              <a:xfrm>
                <a:off x="826928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3" name="Line 200"/>
              <p:cNvSpPr>
                <a:spLocks noChangeShapeType="1"/>
              </p:cNvSpPr>
              <p:nvPr/>
            </p:nvSpPr>
            <p:spPr bwMode="auto">
              <a:xfrm>
                <a:off x="835025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4" name="Line 201"/>
              <p:cNvSpPr>
                <a:spLocks noChangeShapeType="1"/>
              </p:cNvSpPr>
              <p:nvPr/>
            </p:nvSpPr>
            <p:spPr bwMode="auto">
              <a:xfrm>
                <a:off x="839152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5" name="Line 202"/>
              <p:cNvSpPr>
                <a:spLocks noChangeShapeType="1"/>
              </p:cNvSpPr>
              <p:nvPr/>
            </p:nvSpPr>
            <p:spPr bwMode="auto">
              <a:xfrm>
                <a:off x="8432800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6" name="Line 203"/>
              <p:cNvSpPr>
                <a:spLocks noChangeShapeType="1"/>
              </p:cNvSpPr>
              <p:nvPr/>
            </p:nvSpPr>
            <p:spPr bwMode="auto">
              <a:xfrm>
                <a:off x="8513762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7" name="Line 204"/>
              <p:cNvSpPr>
                <a:spLocks noChangeShapeType="1"/>
              </p:cNvSpPr>
              <p:nvPr/>
            </p:nvSpPr>
            <p:spPr bwMode="auto">
              <a:xfrm>
                <a:off x="8555037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8" name="Line 205"/>
              <p:cNvSpPr>
                <a:spLocks noChangeShapeType="1"/>
              </p:cNvSpPr>
              <p:nvPr/>
            </p:nvSpPr>
            <p:spPr bwMode="auto">
              <a:xfrm>
                <a:off x="8588375" y="6008688"/>
                <a:ext cx="0" cy="2857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39" name="Line 206"/>
              <p:cNvSpPr>
                <a:spLocks noChangeShapeType="1"/>
              </p:cNvSpPr>
              <p:nvPr/>
            </p:nvSpPr>
            <p:spPr bwMode="auto">
              <a:xfrm>
                <a:off x="80327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0" name="Line 209"/>
              <p:cNvSpPr>
                <a:spLocks noChangeShapeType="1"/>
              </p:cNvSpPr>
              <p:nvPr/>
            </p:nvSpPr>
            <p:spPr bwMode="auto">
              <a:xfrm>
                <a:off x="15970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1" name="Line 211"/>
              <p:cNvSpPr>
                <a:spLocks noChangeShapeType="1"/>
              </p:cNvSpPr>
              <p:nvPr/>
            </p:nvSpPr>
            <p:spPr bwMode="auto">
              <a:xfrm>
                <a:off x="23971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2" name="Line 213"/>
              <p:cNvSpPr>
                <a:spLocks noChangeShapeType="1"/>
              </p:cNvSpPr>
              <p:nvPr/>
            </p:nvSpPr>
            <p:spPr bwMode="auto">
              <a:xfrm>
                <a:off x="31972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3" name="Line 215"/>
              <p:cNvSpPr>
                <a:spLocks noChangeShapeType="1"/>
              </p:cNvSpPr>
              <p:nvPr/>
            </p:nvSpPr>
            <p:spPr bwMode="auto">
              <a:xfrm>
                <a:off x="39973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4" name="Line 217"/>
              <p:cNvSpPr>
                <a:spLocks noChangeShapeType="1"/>
              </p:cNvSpPr>
              <p:nvPr/>
            </p:nvSpPr>
            <p:spPr bwMode="auto">
              <a:xfrm>
                <a:off x="47974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5" name="Line 219"/>
              <p:cNvSpPr>
                <a:spLocks noChangeShapeType="1"/>
              </p:cNvSpPr>
              <p:nvPr/>
            </p:nvSpPr>
            <p:spPr bwMode="auto">
              <a:xfrm>
                <a:off x="559752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6" name="Line 221"/>
              <p:cNvSpPr>
                <a:spLocks noChangeShapeType="1"/>
              </p:cNvSpPr>
              <p:nvPr/>
            </p:nvSpPr>
            <p:spPr bwMode="auto">
              <a:xfrm>
                <a:off x="639127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7" name="Line 223"/>
              <p:cNvSpPr>
                <a:spLocks noChangeShapeType="1"/>
              </p:cNvSpPr>
              <p:nvPr/>
            </p:nvSpPr>
            <p:spPr bwMode="auto">
              <a:xfrm>
                <a:off x="719137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8" name="Line 225"/>
              <p:cNvSpPr>
                <a:spLocks noChangeShapeType="1"/>
              </p:cNvSpPr>
              <p:nvPr/>
            </p:nvSpPr>
            <p:spPr bwMode="auto">
              <a:xfrm>
                <a:off x="7991475" y="6008688"/>
                <a:ext cx="0" cy="904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49" name="Line 228"/>
              <p:cNvSpPr>
                <a:spLocks noChangeShapeType="1"/>
              </p:cNvSpPr>
              <p:nvPr/>
            </p:nvSpPr>
            <p:spPr bwMode="auto">
              <a:xfrm flipV="1">
                <a:off x="790575" y="1127125"/>
                <a:ext cx="0" cy="487521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0" name="Line 229"/>
              <p:cNvSpPr>
                <a:spLocks noChangeShapeType="1"/>
              </p:cNvSpPr>
              <p:nvPr/>
            </p:nvSpPr>
            <p:spPr bwMode="auto">
              <a:xfrm flipH="1">
                <a:off x="728663" y="59594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1" name="Line 230"/>
              <p:cNvSpPr>
                <a:spLocks noChangeShapeType="1"/>
              </p:cNvSpPr>
              <p:nvPr/>
            </p:nvSpPr>
            <p:spPr bwMode="auto">
              <a:xfrm flipH="1">
                <a:off x="728663" y="59118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2" name="Line 231"/>
              <p:cNvSpPr>
                <a:spLocks noChangeShapeType="1"/>
              </p:cNvSpPr>
              <p:nvPr/>
            </p:nvSpPr>
            <p:spPr bwMode="auto">
              <a:xfrm flipH="1">
                <a:off x="728663" y="58626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3" name="Line 232"/>
              <p:cNvSpPr>
                <a:spLocks noChangeShapeType="1"/>
              </p:cNvSpPr>
              <p:nvPr/>
            </p:nvSpPr>
            <p:spPr bwMode="auto">
              <a:xfrm flipH="1">
                <a:off x="728663" y="58134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4" name="Line 233"/>
              <p:cNvSpPr>
                <a:spLocks noChangeShapeType="1"/>
              </p:cNvSpPr>
              <p:nvPr/>
            </p:nvSpPr>
            <p:spPr bwMode="auto">
              <a:xfrm flipH="1">
                <a:off x="728663" y="57165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5" name="Line 234"/>
              <p:cNvSpPr>
                <a:spLocks noChangeShapeType="1"/>
              </p:cNvSpPr>
              <p:nvPr/>
            </p:nvSpPr>
            <p:spPr bwMode="auto">
              <a:xfrm flipH="1">
                <a:off x="728663" y="56673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6" name="Line 235"/>
              <p:cNvSpPr>
                <a:spLocks noChangeShapeType="1"/>
              </p:cNvSpPr>
              <p:nvPr/>
            </p:nvSpPr>
            <p:spPr bwMode="auto">
              <a:xfrm flipH="1">
                <a:off x="728663" y="56181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7" name="Line 236"/>
              <p:cNvSpPr>
                <a:spLocks noChangeShapeType="1"/>
              </p:cNvSpPr>
              <p:nvPr/>
            </p:nvSpPr>
            <p:spPr bwMode="auto">
              <a:xfrm flipH="1">
                <a:off x="728663" y="55689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8" name="Line 237"/>
              <p:cNvSpPr>
                <a:spLocks noChangeShapeType="1"/>
              </p:cNvSpPr>
              <p:nvPr/>
            </p:nvSpPr>
            <p:spPr bwMode="auto">
              <a:xfrm flipH="1">
                <a:off x="728663" y="54721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59" name="Line 238"/>
              <p:cNvSpPr>
                <a:spLocks noChangeShapeType="1"/>
              </p:cNvSpPr>
              <p:nvPr/>
            </p:nvSpPr>
            <p:spPr bwMode="auto">
              <a:xfrm flipH="1">
                <a:off x="728663" y="54229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0" name="Line 239"/>
              <p:cNvSpPr>
                <a:spLocks noChangeShapeType="1"/>
              </p:cNvSpPr>
              <p:nvPr/>
            </p:nvSpPr>
            <p:spPr bwMode="auto">
              <a:xfrm flipH="1">
                <a:off x="728663" y="53736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1" name="Line 240"/>
              <p:cNvSpPr>
                <a:spLocks noChangeShapeType="1"/>
              </p:cNvSpPr>
              <p:nvPr/>
            </p:nvSpPr>
            <p:spPr bwMode="auto">
              <a:xfrm flipH="1">
                <a:off x="728663" y="53260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2" name="Line 241"/>
              <p:cNvSpPr>
                <a:spLocks noChangeShapeType="1"/>
              </p:cNvSpPr>
              <p:nvPr/>
            </p:nvSpPr>
            <p:spPr bwMode="auto">
              <a:xfrm flipH="1">
                <a:off x="728663" y="52276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3" name="Line 242"/>
              <p:cNvSpPr>
                <a:spLocks noChangeShapeType="1"/>
              </p:cNvSpPr>
              <p:nvPr/>
            </p:nvSpPr>
            <p:spPr bwMode="auto">
              <a:xfrm flipH="1">
                <a:off x="728663" y="51784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4" name="Line 243"/>
              <p:cNvSpPr>
                <a:spLocks noChangeShapeType="1"/>
              </p:cNvSpPr>
              <p:nvPr/>
            </p:nvSpPr>
            <p:spPr bwMode="auto">
              <a:xfrm flipH="1">
                <a:off x="728663" y="51308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5" name="Line 244"/>
              <p:cNvSpPr>
                <a:spLocks noChangeShapeType="1"/>
              </p:cNvSpPr>
              <p:nvPr/>
            </p:nvSpPr>
            <p:spPr bwMode="auto">
              <a:xfrm flipH="1">
                <a:off x="728663" y="50815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6" name="Line 245"/>
              <p:cNvSpPr>
                <a:spLocks noChangeShapeType="1"/>
              </p:cNvSpPr>
              <p:nvPr/>
            </p:nvSpPr>
            <p:spPr bwMode="auto">
              <a:xfrm flipH="1">
                <a:off x="728663" y="49831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7" name="Line 246"/>
              <p:cNvSpPr>
                <a:spLocks noChangeShapeType="1"/>
              </p:cNvSpPr>
              <p:nvPr/>
            </p:nvSpPr>
            <p:spPr bwMode="auto">
              <a:xfrm flipH="1">
                <a:off x="728663" y="49355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8" name="Line 247"/>
              <p:cNvSpPr>
                <a:spLocks noChangeShapeType="1"/>
              </p:cNvSpPr>
              <p:nvPr/>
            </p:nvSpPr>
            <p:spPr bwMode="auto">
              <a:xfrm flipH="1">
                <a:off x="728663" y="48863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69" name="Line 248"/>
              <p:cNvSpPr>
                <a:spLocks noChangeShapeType="1"/>
              </p:cNvSpPr>
              <p:nvPr/>
            </p:nvSpPr>
            <p:spPr bwMode="auto">
              <a:xfrm flipH="1">
                <a:off x="728663" y="48371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0" name="Line 249"/>
              <p:cNvSpPr>
                <a:spLocks noChangeShapeType="1"/>
              </p:cNvSpPr>
              <p:nvPr/>
            </p:nvSpPr>
            <p:spPr bwMode="auto">
              <a:xfrm flipH="1">
                <a:off x="728663" y="47386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1" name="Line 250"/>
              <p:cNvSpPr>
                <a:spLocks noChangeShapeType="1"/>
              </p:cNvSpPr>
              <p:nvPr/>
            </p:nvSpPr>
            <p:spPr bwMode="auto">
              <a:xfrm flipH="1">
                <a:off x="728663" y="46910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2" name="Line 251"/>
              <p:cNvSpPr>
                <a:spLocks noChangeShapeType="1"/>
              </p:cNvSpPr>
              <p:nvPr/>
            </p:nvSpPr>
            <p:spPr bwMode="auto">
              <a:xfrm flipH="1">
                <a:off x="728663" y="46418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3" name="Line 252"/>
              <p:cNvSpPr>
                <a:spLocks noChangeShapeType="1"/>
              </p:cNvSpPr>
              <p:nvPr/>
            </p:nvSpPr>
            <p:spPr bwMode="auto">
              <a:xfrm flipH="1">
                <a:off x="728663" y="45926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4" name="Line 253"/>
              <p:cNvSpPr>
                <a:spLocks noChangeShapeType="1"/>
              </p:cNvSpPr>
              <p:nvPr/>
            </p:nvSpPr>
            <p:spPr bwMode="auto">
              <a:xfrm flipH="1">
                <a:off x="728663" y="44958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5" name="Line 254"/>
              <p:cNvSpPr>
                <a:spLocks noChangeShapeType="1"/>
              </p:cNvSpPr>
              <p:nvPr/>
            </p:nvSpPr>
            <p:spPr bwMode="auto">
              <a:xfrm flipH="1">
                <a:off x="728663" y="44465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6" name="Line 255"/>
              <p:cNvSpPr>
                <a:spLocks noChangeShapeType="1"/>
              </p:cNvSpPr>
              <p:nvPr/>
            </p:nvSpPr>
            <p:spPr bwMode="auto">
              <a:xfrm flipH="1">
                <a:off x="728663" y="43973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7" name="Line 256"/>
              <p:cNvSpPr>
                <a:spLocks noChangeShapeType="1"/>
              </p:cNvSpPr>
              <p:nvPr/>
            </p:nvSpPr>
            <p:spPr bwMode="auto">
              <a:xfrm flipH="1">
                <a:off x="728663" y="43481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8" name="Line 257"/>
              <p:cNvSpPr>
                <a:spLocks noChangeShapeType="1"/>
              </p:cNvSpPr>
              <p:nvPr/>
            </p:nvSpPr>
            <p:spPr bwMode="auto">
              <a:xfrm flipH="1">
                <a:off x="728663" y="42513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79" name="Line 258"/>
              <p:cNvSpPr>
                <a:spLocks noChangeShapeType="1"/>
              </p:cNvSpPr>
              <p:nvPr/>
            </p:nvSpPr>
            <p:spPr bwMode="auto">
              <a:xfrm flipH="1">
                <a:off x="728663" y="42021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0" name="Line 259"/>
              <p:cNvSpPr>
                <a:spLocks noChangeShapeType="1"/>
              </p:cNvSpPr>
              <p:nvPr/>
            </p:nvSpPr>
            <p:spPr bwMode="auto">
              <a:xfrm flipH="1">
                <a:off x="728663" y="41529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1" name="Line 260"/>
              <p:cNvSpPr>
                <a:spLocks noChangeShapeType="1"/>
              </p:cNvSpPr>
              <p:nvPr/>
            </p:nvSpPr>
            <p:spPr bwMode="auto">
              <a:xfrm flipH="1">
                <a:off x="728663" y="41052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2" name="Line 261"/>
              <p:cNvSpPr>
                <a:spLocks noChangeShapeType="1"/>
              </p:cNvSpPr>
              <p:nvPr/>
            </p:nvSpPr>
            <p:spPr bwMode="auto">
              <a:xfrm flipH="1">
                <a:off x="728663" y="40068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3" name="Line 262"/>
              <p:cNvSpPr>
                <a:spLocks noChangeShapeType="1"/>
              </p:cNvSpPr>
              <p:nvPr/>
            </p:nvSpPr>
            <p:spPr bwMode="auto">
              <a:xfrm flipH="1">
                <a:off x="728663" y="39576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4" name="Line 263"/>
              <p:cNvSpPr>
                <a:spLocks noChangeShapeType="1"/>
              </p:cNvSpPr>
              <p:nvPr/>
            </p:nvSpPr>
            <p:spPr bwMode="auto">
              <a:xfrm flipH="1">
                <a:off x="728663" y="39100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5" name="Line 264"/>
              <p:cNvSpPr>
                <a:spLocks noChangeShapeType="1"/>
              </p:cNvSpPr>
              <p:nvPr/>
            </p:nvSpPr>
            <p:spPr bwMode="auto">
              <a:xfrm flipH="1">
                <a:off x="728663" y="38608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6" name="Line 265"/>
              <p:cNvSpPr>
                <a:spLocks noChangeShapeType="1"/>
              </p:cNvSpPr>
              <p:nvPr/>
            </p:nvSpPr>
            <p:spPr bwMode="auto">
              <a:xfrm flipH="1">
                <a:off x="728663" y="37623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7" name="Line 266"/>
              <p:cNvSpPr>
                <a:spLocks noChangeShapeType="1"/>
              </p:cNvSpPr>
              <p:nvPr/>
            </p:nvSpPr>
            <p:spPr bwMode="auto">
              <a:xfrm flipH="1">
                <a:off x="728663" y="37147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8" name="Line 267"/>
              <p:cNvSpPr>
                <a:spLocks noChangeShapeType="1"/>
              </p:cNvSpPr>
              <p:nvPr/>
            </p:nvSpPr>
            <p:spPr bwMode="auto">
              <a:xfrm flipH="1">
                <a:off x="728663" y="36655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89" name="Line 268"/>
              <p:cNvSpPr>
                <a:spLocks noChangeShapeType="1"/>
              </p:cNvSpPr>
              <p:nvPr/>
            </p:nvSpPr>
            <p:spPr bwMode="auto">
              <a:xfrm flipH="1">
                <a:off x="728663" y="36163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0" name="Line 269"/>
              <p:cNvSpPr>
                <a:spLocks noChangeShapeType="1"/>
              </p:cNvSpPr>
              <p:nvPr/>
            </p:nvSpPr>
            <p:spPr bwMode="auto">
              <a:xfrm flipH="1">
                <a:off x="728663" y="35194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1" name="Line 270"/>
              <p:cNvSpPr>
                <a:spLocks noChangeShapeType="1"/>
              </p:cNvSpPr>
              <p:nvPr/>
            </p:nvSpPr>
            <p:spPr bwMode="auto">
              <a:xfrm flipH="1">
                <a:off x="728663" y="34702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2" name="Line 271"/>
              <p:cNvSpPr>
                <a:spLocks noChangeShapeType="1"/>
              </p:cNvSpPr>
              <p:nvPr/>
            </p:nvSpPr>
            <p:spPr bwMode="auto">
              <a:xfrm flipH="1">
                <a:off x="728663" y="34210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3" name="Line 272"/>
              <p:cNvSpPr>
                <a:spLocks noChangeShapeType="1"/>
              </p:cNvSpPr>
              <p:nvPr/>
            </p:nvSpPr>
            <p:spPr bwMode="auto">
              <a:xfrm flipH="1">
                <a:off x="728663" y="33718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4" name="Line 273"/>
              <p:cNvSpPr>
                <a:spLocks noChangeShapeType="1"/>
              </p:cNvSpPr>
              <p:nvPr/>
            </p:nvSpPr>
            <p:spPr bwMode="auto">
              <a:xfrm flipH="1">
                <a:off x="728663" y="32750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5" name="Line 274"/>
              <p:cNvSpPr>
                <a:spLocks noChangeShapeType="1"/>
              </p:cNvSpPr>
              <p:nvPr/>
            </p:nvSpPr>
            <p:spPr bwMode="auto">
              <a:xfrm flipH="1">
                <a:off x="728663" y="32258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6" name="Line 275"/>
              <p:cNvSpPr>
                <a:spLocks noChangeShapeType="1"/>
              </p:cNvSpPr>
              <p:nvPr/>
            </p:nvSpPr>
            <p:spPr bwMode="auto">
              <a:xfrm flipH="1">
                <a:off x="728663" y="31765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7" name="Line 276"/>
              <p:cNvSpPr>
                <a:spLocks noChangeShapeType="1"/>
              </p:cNvSpPr>
              <p:nvPr/>
            </p:nvSpPr>
            <p:spPr bwMode="auto">
              <a:xfrm flipH="1">
                <a:off x="728663" y="31289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8" name="Line 277"/>
              <p:cNvSpPr>
                <a:spLocks noChangeShapeType="1"/>
              </p:cNvSpPr>
              <p:nvPr/>
            </p:nvSpPr>
            <p:spPr bwMode="auto">
              <a:xfrm flipH="1">
                <a:off x="728663" y="30305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99" name="Line 278"/>
              <p:cNvSpPr>
                <a:spLocks noChangeShapeType="1"/>
              </p:cNvSpPr>
              <p:nvPr/>
            </p:nvSpPr>
            <p:spPr bwMode="auto">
              <a:xfrm flipH="1">
                <a:off x="728663" y="29813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0" name="Line 279"/>
              <p:cNvSpPr>
                <a:spLocks noChangeShapeType="1"/>
              </p:cNvSpPr>
              <p:nvPr/>
            </p:nvSpPr>
            <p:spPr bwMode="auto">
              <a:xfrm flipH="1">
                <a:off x="728663" y="29337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1" name="Line 280"/>
              <p:cNvSpPr>
                <a:spLocks noChangeShapeType="1"/>
              </p:cNvSpPr>
              <p:nvPr/>
            </p:nvSpPr>
            <p:spPr bwMode="auto">
              <a:xfrm flipH="1">
                <a:off x="728663" y="28844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2" name="Line 281"/>
              <p:cNvSpPr>
                <a:spLocks noChangeShapeType="1"/>
              </p:cNvSpPr>
              <p:nvPr/>
            </p:nvSpPr>
            <p:spPr bwMode="auto">
              <a:xfrm flipH="1">
                <a:off x="728663" y="27860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3" name="Line 282"/>
              <p:cNvSpPr>
                <a:spLocks noChangeShapeType="1"/>
              </p:cNvSpPr>
              <p:nvPr/>
            </p:nvSpPr>
            <p:spPr bwMode="auto">
              <a:xfrm flipH="1">
                <a:off x="728663" y="27384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4" name="Line 283"/>
              <p:cNvSpPr>
                <a:spLocks noChangeShapeType="1"/>
              </p:cNvSpPr>
              <p:nvPr/>
            </p:nvSpPr>
            <p:spPr bwMode="auto">
              <a:xfrm flipH="1">
                <a:off x="728663" y="26892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5" name="Line 284"/>
              <p:cNvSpPr>
                <a:spLocks noChangeShapeType="1"/>
              </p:cNvSpPr>
              <p:nvPr/>
            </p:nvSpPr>
            <p:spPr bwMode="auto">
              <a:xfrm flipH="1">
                <a:off x="728663" y="26400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6" name="Line 285"/>
              <p:cNvSpPr>
                <a:spLocks noChangeShapeType="1"/>
              </p:cNvSpPr>
              <p:nvPr/>
            </p:nvSpPr>
            <p:spPr bwMode="auto">
              <a:xfrm flipH="1">
                <a:off x="728663" y="25431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7" name="Line 286"/>
              <p:cNvSpPr>
                <a:spLocks noChangeShapeType="1"/>
              </p:cNvSpPr>
              <p:nvPr/>
            </p:nvSpPr>
            <p:spPr bwMode="auto">
              <a:xfrm flipH="1">
                <a:off x="728663" y="24939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8" name="Line 287"/>
              <p:cNvSpPr>
                <a:spLocks noChangeShapeType="1"/>
              </p:cNvSpPr>
              <p:nvPr/>
            </p:nvSpPr>
            <p:spPr bwMode="auto">
              <a:xfrm flipH="1">
                <a:off x="728663" y="24447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09" name="Line 288"/>
              <p:cNvSpPr>
                <a:spLocks noChangeShapeType="1"/>
              </p:cNvSpPr>
              <p:nvPr/>
            </p:nvSpPr>
            <p:spPr bwMode="auto">
              <a:xfrm flipH="1">
                <a:off x="728663" y="23955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0" name="Line 289"/>
              <p:cNvSpPr>
                <a:spLocks noChangeShapeType="1"/>
              </p:cNvSpPr>
              <p:nvPr/>
            </p:nvSpPr>
            <p:spPr bwMode="auto">
              <a:xfrm flipH="1">
                <a:off x="728663" y="22987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1" name="Line 290"/>
              <p:cNvSpPr>
                <a:spLocks noChangeShapeType="1"/>
              </p:cNvSpPr>
              <p:nvPr/>
            </p:nvSpPr>
            <p:spPr bwMode="auto">
              <a:xfrm flipH="1">
                <a:off x="728663" y="22494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2" name="Line 291"/>
              <p:cNvSpPr>
                <a:spLocks noChangeShapeType="1"/>
              </p:cNvSpPr>
              <p:nvPr/>
            </p:nvSpPr>
            <p:spPr bwMode="auto">
              <a:xfrm flipH="1">
                <a:off x="728663" y="22002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3" name="Line 292"/>
              <p:cNvSpPr>
                <a:spLocks noChangeShapeType="1"/>
              </p:cNvSpPr>
              <p:nvPr/>
            </p:nvSpPr>
            <p:spPr bwMode="auto">
              <a:xfrm flipH="1">
                <a:off x="728663" y="21526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4" name="Line 293"/>
              <p:cNvSpPr>
                <a:spLocks noChangeShapeType="1"/>
              </p:cNvSpPr>
              <p:nvPr/>
            </p:nvSpPr>
            <p:spPr bwMode="auto">
              <a:xfrm flipH="1">
                <a:off x="728663" y="20542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5" name="Line 294"/>
              <p:cNvSpPr>
                <a:spLocks noChangeShapeType="1"/>
              </p:cNvSpPr>
              <p:nvPr/>
            </p:nvSpPr>
            <p:spPr bwMode="auto">
              <a:xfrm flipH="1">
                <a:off x="728663" y="20050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6" name="Line 295"/>
              <p:cNvSpPr>
                <a:spLocks noChangeShapeType="1"/>
              </p:cNvSpPr>
              <p:nvPr/>
            </p:nvSpPr>
            <p:spPr bwMode="auto">
              <a:xfrm flipH="1">
                <a:off x="728663" y="19573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7" name="Line 296"/>
              <p:cNvSpPr>
                <a:spLocks noChangeShapeType="1"/>
              </p:cNvSpPr>
              <p:nvPr/>
            </p:nvSpPr>
            <p:spPr bwMode="auto">
              <a:xfrm flipH="1">
                <a:off x="728663" y="19081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8" name="Line 297"/>
              <p:cNvSpPr>
                <a:spLocks noChangeShapeType="1"/>
              </p:cNvSpPr>
              <p:nvPr/>
            </p:nvSpPr>
            <p:spPr bwMode="auto">
              <a:xfrm flipH="1">
                <a:off x="728663" y="18097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19" name="Line 298"/>
              <p:cNvSpPr>
                <a:spLocks noChangeShapeType="1"/>
              </p:cNvSpPr>
              <p:nvPr/>
            </p:nvSpPr>
            <p:spPr bwMode="auto">
              <a:xfrm flipH="1">
                <a:off x="728663" y="17621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0" name="Line 299"/>
              <p:cNvSpPr>
                <a:spLocks noChangeShapeType="1"/>
              </p:cNvSpPr>
              <p:nvPr/>
            </p:nvSpPr>
            <p:spPr bwMode="auto">
              <a:xfrm flipH="1">
                <a:off x="728663" y="171291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1" name="Line 300"/>
              <p:cNvSpPr>
                <a:spLocks noChangeShapeType="1"/>
              </p:cNvSpPr>
              <p:nvPr/>
            </p:nvSpPr>
            <p:spPr bwMode="auto">
              <a:xfrm flipH="1">
                <a:off x="728663" y="166370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2" name="Line 301"/>
              <p:cNvSpPr>
                <a:spLocks noChangeShapeType="1"/>
              </p:cNvSpPr>
              <p:nvPr/>
            </p:nvSpPr>
            <p:spPr bwMode="auto">
              <a:xfrm flipH="1">
                <a:off x="728663" y="15668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3" name="Line 302"/>
              <p:cNvSpPr>
                <a:spLocks noChangeShapeType="1"/>
              </p:cNvSpPr>
              <p:nvPr/>
            </p:nvSpPr>
            <p:spPr bwMode="auto">
              <a:xfrm flipH="1">
                <a:off x="728663" y="1517650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4" name="Line 303"/>
              <p:cNvSpPr>
                <a:spLocks noChangeShapeType="1"/>
              </p:cNvSpPr>
              <p:nvPr/>
            </p:nvSpPr>
            <p:spPr bwMode="auto">
              <a:xfrm flipH="1">
                <a:off x="728663" y="14684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5" name="Line 304"/>
              <p:cNvSpPr>
                <a:spLocks noChangeShapeType="1"/>
              </p:cNvSpPr>
              <p:nvPr/>
            </p:nvSpPr>
            <p:spPr bwMode="auto">
              <a:xfrm flipH="1">
                <a:off x="728663" y="141922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6" name="Line 305"/>
              <p:cNvSpPr>
                <a:spLocks noChangeShapeType="1"/>
              </p:cNvSpPr>
              <p:nvPr/>
            </p:nvSpPr>
            <p:spPr bwMode="auto">
              <a:xfrm flipH="1">
                <a:off x="728663" y="132238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7" name="Line 306"/>
              <p:cNvSpPr>
                <a:spLocks noChangeShapeType="1"/>
              </p:cNvSpPr>
              <p:nvPr/>
            </p:nvSpPr>
            <p:spPr bwMode="auto">
              <a:xfrm flipH="1">
                <a:off x="728663" y="1273175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8" name="Line 307"/>
              <p:cNvSpPr>
                <a:spLocks noChangeShapeType="1"/>
              </p:cNvSpPr>
              <p:nvPr/>
            </p:nvSpPr>
            <p:spPr bwMode="auto">
              <a:xfrm flipH="1">
                <a:off x="728663" y="1223963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29" name="Line 308"/>
              <p:cNvSpPr>
                <a:spLocks noChangeShapeType="1"/>
              </p:cNvSpPr>
              <p:nvPr/>
            </p:nvSpPr>
            <p:spPr bwMode="auto">
              <a:xfrm flipH="1">
                <a:off x="728663" y="1176338"/>
                <a:ext cx="6191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0" name="Line 309"/>
              <p:cNvSpPr>
                <a:spLocks noChangeShapeType="1"/>
              </p:cNvSpPr>
              <p:nvPr/>
            </p:nvSpPr>
            <p:spPr bwMode="auto">
              <a:xfrm flipH="1">
                <a:off x="701675" y="60023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1" name="Line 311"/>
              <p:cNvSpPr>
                <a:spLocks noChangeShapeType="1"/>
              </p:cNvSpPr>
              <p:nvPr/>
            </p:nvSpPr>
            <p:spPr bwMode="auto">
              <a:xfrm flipH="1">
                <a:off x="701675" y="576421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2" name="Line 313"/>
              <p:cNvSpPr>
                <a:spLocks noChangeShapeType="1"/>
              </p:cNvSpPr>
              <p:nvPr/>
            </p:nvSpPr>
            <p:spPr bwMode="auto">
              <a:xfrm flipH="1">
                <a:off x="701675" y="55213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3" name="Line 315"/>
              <p:cNvSpPr>
                <a:spLocks noChangeShapeType="1"/>
              </p:cNvSpPr>
              <p:nvPr/>
            </p:nvSpPr>
            <p:spPr bwMode="auto">
              <a:xfrm flipH="1">
                <a:off x="701675" y="5276850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4" name="Line 317"/>
              <p:cNvSpPr>
                <a:spLocks noChangeShapeType="1"/>
              </p:cNvSpPr>
              <p:nvPr/>
            </p:nvSpPr>
            <p:spPr bwMode="auto">
              <a:xfrm flipH="1">
                <a:off x="701675" y="503237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5" name="Line 319"/>
              <p:cNvSpPr>
                <a:spLocks noChangeShapeType="1"/>
              </p:cNvSpPr>
              <p:nvPr/>
            </p:nvSpPr>
            <p:spPr bwMode="auto">
              <a:xfrm flipH="1">
                <a:off x="701675" y="4787900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6" name="Line 321"/>
              <p:cNvSpPr>
                <a:spLocks noChangeShapeType="1"/>
              </p:cNvSpPr>
              <p:nvPr/>
            </p:nvSpPr>
            <p:spPr bwMode="auto">
              <a:xfrm flipH="1">
                <a:off x="701675" y="45434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7" name="Line 323"/>
              <p:cNvSpPr>
                <a:spLocks noChangeShapeType="1"/>
              </p:cNvSpPr>
              <p:nvPr/>
            </p:nvSpPr>
            <p:spPr bwMode="auto">
              <a:xfrm flipH="1">
                <a:off x="701675" y="43005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8" name="Line 325"/>
              <p:cNvSpPr>
                <a:spLocks noChangeShapeType="1"/>
              </p:cNvSpPr>
              <p:nvPr/>
            </p:nvSpPr>
            <p:spPr bwMode="auto">
              <a:xfrm flipH="1">
                <a:off x="701675" y="405606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39" name="Line 327"/>
              <p:cNvSpPr>
                <a:spLocks noChangeShapeType="1"/>
              </p:cNvSpPr>
              <p:nvPr/>
            </p:nvSpPr>
            <p:spPr bwMode="auto">
              <a:xfrm flipH="1">
                <a:off x="701675" y="381158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0" name="Line 329"/>
              <p:cNvSpPr>
                <a:spLocks noChangeShapeType="1"/>
              </p:cNvSpPr>
              <p:nvPr/>
            </p:nvSpPr>
            <p:spPr bwMode="auto">
              <a:xfrm flipH="1">
                <a:off x="701675" y="356711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1" name="Line 331"/>
              <p:cNvSpPr>
                <a:spLocks noChangeShapeType="1"/>
              </p:cNvSpPr>
              <p:nvPr/>
            </p:nvSpPr>
            <p:spPr bwMode="auto">
              <a:xfrm flipH="1">
                <a:off x="701675" y="33242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2" name="Line 333"/>
              <p:cNvSpPr>
                <a:spLocks noChangeShapeType="1"/>
              </p:cNvSpPr>
              <p:nvPr/>
            </p:nvSpPr>
            <p:spPr bwMode="auto">
              <a:xfrm flipH="1">
                <a:off x="701675" y="3079750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3" name="Line 335"/>
              <p:cNvSpPr>
                <a:spLocks noChangeShapeType="1"/>
              </p:cNvSpPr>
              <p:nvPr/>
            </p:nvSpPr>
            <p:spPr bwMode="auto">
              <a:xfrm flipH="1">
                <a:off x="701675" y="283527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4" name="Line 337"/>
              <p:cNvSpPr>
                <a:spLocks noChangeShapeType="1"/>
              </p:cNvSpPr>
              <p:nvPr/>
            </p:nvSpPr>
            <p:spPr bwMode="auto">
              <a:xfrm flipH="1">
                <a:off x="701675" y="2590800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5" name="Line 339"/>
              <p:cNvSpPr>
                <a:spLocks noChangeShapeType="1"/>
              </p:cNvSpPr>
              <p:nvPr/>
            </p:nvSpPr>
            <p:spPr bwMode="auto">
              <a:xfrm flipH="1">
                <a:off x="701675" y="234791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6" name="Line 341"/>
              <p:cNvSpPr>
                <a:spLocks noChangeShapeType="1"/>
              </p:cNvSpPr>
              <p:nvPr/>
            </p:nvSpPr>
            <p:spPr bwMode="auto">
              <a:xfrm flipH="1">
                <a:off x="701675" y="21034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7" name="Line 343"/>
              <p:cNvSpPr>
                <a:spLocks noChangeShapeType="1"/>
              </p:cNvSpPr>
              <p:nvPr/>
            </p:nvSpPr>
            <p:spPr bwMode="auto">
              <a:xfrm flipH="1">
                <a:off x="701675" y="185896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8" name="Line 345"/>
              <p:cNvSpPr>
                <a:spLocks noChangeShapeType="1"/>
              </p:cNvSpPr>
              <p:nvPr/>
            </p:nvSpPr>
            <p:spPr bwMode="auto">
              <a:xfrm flipH="1">
                <a:off x="701675" y="161448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49" name="Line 347"/>
              <p:cNvSpPr>
                <a:spLocks noChangeShapeType="1"/>
              </p:cNvSpPr>
              <p:nvPr/>
            </p:nvSpPr>
            <p:spPr bwMode="auto">
              <a:xfrm flipH="1">
                <a:off x="701675" y="1371600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50" name="Line 349"/>
              <p:cNvSpPr>
                <a:spLocks noChangeShapeType="1"/>
              </p:cNvSpPr>
              <p:nvPr/>
            </p:nvSpPr>
            <p:spPr bwMode="auto">
              <a:xfrm flipH="1">
                <a:off x="701675" y="11271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51" name="Freeform 352"/>
              <p:cNvSpPr>
                <a:spLocks/>
              </p:cNvSpPr>
              <p:nvPr/>
            </p:nvSpPr>
            <p:spPr bwMode="auto">
              <a:xfrm>
                <a:off x="790575" y="1127125"/>
                <a:ext cx="7818437" cy="4875213"/>
              </a:xfrm>
              <a:custGeom>
                <a:avLst/>
                <a:gdLst>
                  <a:gd name="T0" fmla="*/ 2147483647 w 1153"/>
                  <a:gd name="T1" fmla="*/ 2147483647 h 699"/>
                  <a:gd name="T2" fmla="*/ 2147483647 w 1153"/>
                  <a:gd name="T3" fmla="*/ 2147483647 h 699"/>
                  <a:gd name="T4" fmla="*/ 2147483647 w 1153"/>
                  <a:gd name="T5" fmla="*/ 2147483647 h 699"/>
                  <a:gd name="T6" fmla="*/ 2147483647 w 1153"/>
                  <a:gd name="T7" fmla="*/ 2147483647 h 699"/>
                  <a:gd name="T8" fmla="*/ 2147483647 w 1153"/>
                  <a:gd name="T9" fmla="*/ 2147483647 h 699"/>
                  <a:gd name="T10" fmla="*/ 2147483647 w 1153"/>
                  <a:gd name="T11" fmla="*/ 2147483647 h 699"/>
                  <a:gd name="T12" fmla="*/ 2147483647 w 1153"/>
                  <a:gd name="T13" fmla="*/ 2147483647 h 699"/>
                  <a:gd name="T14" fmla="*/ 2147483647 w 1153"/>
                  <a:gd name="T15" fmla="*/ 2147483647 h 699"/>
                  <a:gd name="T16" fmla="*/ 2147483647 w 1153"/>
                  <a:gd name="T17" fmla="*/ 2147483647 h 699"/>
                  <a:gd name="T18" fmla="*/ 2147483647 w 1153"/>
                  <a:gd name="T19" fmla="*/ 2147483647 h 699"/>
                  <a:gd name="T20" fmla="*/ 2147483647 w 1153"/>
                  <a:gd name="T21" fmla="*/ 2147483647 h 699"/>
                  <a:gd name="T22" fmla="*/ 2147483647 w 1153"/>
                  <a:gd name="T23" fmla="*/ 2147483647 h 699"/>
                  <a:gd name="T24" fmla="*/ 2147483647 w 1153"/>
                  <a:gd name="T25" fmla="*/ 2147483647 h 699"/>
                  <a:gd name="T26" fmla="*/ 2147483647 w 1153"/>
                  <a:gd name="T27" fmla="*/ 2147483647 h 699"/>
                  <a:gd name="T28" fmla="*/ 2147483647 w 1153"/>
                  <a:gd name="T29" fmla="*/ 2147483647 h 699"/>
                  <a:gd name="T30" fmla="*/ 2147483647 w 1153"/>
                  <a:gd name="T31" fmla="*/ 2147483647 h 699"/>
                  <a:gd name="T32" fmla="*/ 2147483647 w 1153"/>
                  <a:gd name="T33" fmla="*/ 2147483647 h 699"/>
                  <a:gd name="T34" fmla="*/ 2147483647 w 1153"/>
                  <a:gd name="T35" fmla="*/ 2147483647 h 699"/>
                  <a:gd name="T36" fmla="*/ 2147483647 w 1153"/>
                  <a:gd name="T37" fmla="*/ 2147483647 h 699"/>
                  <a:gd name="T38" fmla="*/ 2147483647 w 1153"/>
                  <a:gd name="T39" fmla="*/ 2147483647 h 699"/>
                  <a:gd name="T40" fmla="*/ 2147483647 w 1153"/>
                  <a:gd name="T41" fmla="*/ 2147483647 h 699"/>
                  <a:gd name="T42" fmla="*/ 2147483647 w 1153"/>
                  <a:gd name="T43" fmla="*/ 2147483647 h 699"/>
                  <a:gd name="T44" fmla="*/ 2147483647 w 1153"/>
                  <a:gd name="T45" fmla="*/ 2147483647 h 699"/>
                  <a:gd name="T46" fmla="*/ 2147483647 w 1153"/>
                  <a:gd name="T47" fmla="*/ 2147483647 h 699"/>
                  <a:gd name="T48" fmla="*/ 2147483647 w 1153"/>
                  <a:gd name="T49" fmla="*/ 2147483647 h 699"/>
                  <a:gd name="T50" fmla="*/ 2147483647 w 1153"/>
                  <a:gd name="T51" fmla="*/ 2147483647 h 699"/>
                  <a:gd name="T52" fmla="*/ 2147483647 w 1153"/>
                  <a:gd name="T53" fmla="*/ 2147483647 h 699"/>
                  <a:gd name="T54" fmla="*/ 2147483647 w 1153"/>
                  <a:gd name="T55" fmla="*/ 2147483647 h 699"/>
                  <a:gd name="T56" fmla="*/ 2147483647 w 1153"/>
                  <a:gd name="T57" fmla="*/ 2147483647 h 699"/>
                  <a:gd name="T58" fmla="*/ 2147483647 w 1153"/>
                  <a:gd name="T59" fmla="*/ 2147483647 h 699"/>
                  <a:gd name="T60" fmla="*/ 2147483647 w 1153"/>
                  <a:gd name="T61" fmla="*/ 2147483647 h 699"/>
                  <a:gd name="T62" fmla="*/ 2147483647 w 1153"/>
                  <a:gd name="T63" fmla="*/ 2147483647 h 699"/>
                  <a:gd name="T64" fmla="*/ 2147483647 w 1153"/>
                  <a:gd name="T65" fmla="*/ 2147483647 h 699"/>
                  <a:gd name="T66" fmla="*/ 2147483647 w 1153"/>
                  <a:gd name="T67" fmla="*/ 2147483647 h 699"/>
                  <a:gd name="T68" fmla="*/ 2147483647 w 1153"/>
                  <a:gd name="T69" fmla="*/ 2147483647 h 699"/>
                  <a:gd name="T70" fmla="*/ 2147483647 w 1153"/>
                  <a:gd name="T71" fmla="*/ 2147483647 h 699"/>
                  <a:gd name="T72" fmla="*/ 2147483647 w 1153"/>
                  <a:gd name="T73" fmla="*/ 2147483647 h 699"/>
                  <a:gd name="T74" fmla="*/ 2147483647 w 1153"/>
                  <a:gd name="T75" fmla="*/ 2147483647 h 699"/>
                  <a:gd name="T76" fmla="*/ 2147483647 w 1153"/>
                  <a:gd name="T77" fmla="*/ 2147483647 h 699"/>
                  <a:gd name="T78" fmla="*/ 2147483647 w 1153"/>
                  <a:gd name="T79" fmla="*/ 2147483647 h 699"/>
                  <a:gd name="T80" fmla="*/ 2147483647 w 1153"/>
                  <a:gd name="T81" fmla="*/ 2147483647 h 699"/>
                  <a:gd name="T82" fmla="*/ 2147483647 w 1153"/>
                  <a:gd name="T83" fmla="*/ 2147483647 h 699"/>
                  <a:gd name="T84" fmla="*/ 2147483647 w 1153"/>
                  <a:gd name="T85" fmla="*/ 2147483647 h 699"/>
                  <a:gd name="T86" fmla="*/ 2147483647 w 1153"/>
                  <a:gd name="T87" fmla="*/ 2147483647 h 699"/>
                  <a:gd name="T88" fmla="*/ 2147483647 w 1153"/>
                  <a:gd name="T89" fmla="*/ 2147483647 h 699"/>
                  <a:gd name="T90" fmla="*/ 2147483647 w 1153"/>
                  <a:gd name="T91" fmla="*/ 2147483647 h 699"/>
                  <a:gd name="T92" fmla="*/ 2147483647 w 1153"/>
                  <a:gd name="T93" fmla="*/ 2147483647 h 699"/>
                  <a:gd name="T94" fmla="*/ 2147483647 w 1153"/>
                  <a:gd name="T95" fmla="*/ 2147483647 h 699"/>
                  <a:gd name="T96" fmla="*/ 2147483647 w 1153"/>
                  <a:gd name="T97" fmla="*/ 2147483647 h 699"/>
                  <a:gd name="T98" fmla="*/ 2147483647 w 1153"/>
                  <a:gd name="T99" fmla="*/ 2147483647 h 699"/>
                  <a:gd name="T100" fmla="*/ 2147483647 w 1153"/>
                  <a:gd name="T101" fmla="*/ 2147483647 h 699"/>
                  <a:gd name="T102" fmla="*/ 2147483647 w 1153"/>
                  <a:gd name="T103" fmla="*/ 2147483647 h 699"/>
                  <a:gd name="T104" fmla="*/ 2147483647 w 1153"/>
                  <a:gd name="T105" fmla="*/ 2147483647 h 699"/>
                  <a:gd name="T106" fmla="*/ 2147483647 w 1153"/>
                  <a:gd name="T107" fmla="*/ 2147483647 h 699"/>
                  <a:gd name="T108" fmla="*/ 2147483647 w 1153"/>
                  <a:gd name="T109" fmla="*/ 2147483647 h 699"/>
                  <a:gd name="T110" fmla="*/ 2147483647 w 1153"/>
                  <a:gd name="T111" fmla="*/ 2147483647 h 699"/>
                  <a:gd name="T112" fmla="*/ 2147483647 w 1153"/>
                  <a:gd name="T113" fmla="*/ 2147483647 h 699"/>
                  <a:gd name="T114" fmla="*/ 2147483647 w 1153"/>
                  <a:gd name="T115" fmla="*/ 2147483647 h 699"/>
                  <a:gd name="T116" fmla="*/ 2147483647 w 1153"/>
                  <a:gd name="T117" fmla="*/ 2147483647 h 699"/>
                  <a:gd name="T118" fmla="*/ 2147483647 w 1153"/>
                  <a:gd name="T119" fmla="*/ 2147483647 h 699"/>
                  <a:gd name="T120" fmla="*/ 2147483647 w 1153"/>
                  <a:gd name="T121" fmla="*/ 2147483647 h 699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w 1153"/>
                  <a:gd name="T184" fmla="*/ 0 h 699"/>
                  <a:gd name="T185" fmla="*/ 1153 w 1153"/>
                  <a:gd name="T186" fmla="*/ 699 h 699"/>
                </a:gdLst>
                <a:ahLst/>
                <a:cxnLst>
                  <a:cxn ang="T122">
                    <a:pos x="T0" y="T1"/>
                  </a:cxn>
                  <a:cxn ang="T123">
                    <a:pos x="T2" y="T3"/>
                  </a:cxn>
                  <a:cxn ang="T124">
                    <a:pos x="T4" y="T5"/>
                  </a:cxn>
                  <a:cxn ang="T125">
                    <a:pos x="T6" y="T7"/>
                  </a:cxn>
                  <a:cxn ang="T126">
                    <a:pos x="T8" y="T9"/>
                  </a:cxn>
                  <a:cxn ang="T127">
                    <a:pos x="T10" y="T11"/>
                  </a:cxn>
                  <a:cxn ang="T128">
                    <a:pos x="T12" y="T13"/>
                  </a:cxn>
                  <a:cxn ang="T129">
                    <a:pos x="T14" y="T15"/>
                  </a:cxn>
                  <a:cxn ang="T130">
                    <a:pos x="T16" y="T17"/>
                  </a:cxn>
                  <a:cxn ang="T131">
                    <a:pos x="T18" y="T19"/>
                  </a:cxn>
                  <a:cxn ang="T132">
                    <a:pos x="T20" y="T21"/>
                  </a:cxn>
                  <a:cxn ang="T133">
                    <a:pos x="T22" y="T23"/>
                  </a:cxn>
                  <a:cxn ang="T134">
                    <a:pos x="T24" y="T25"/>
                  </a:cxn>
                  <a:cxn ang="T135">
                    <a:pos x="T26" y="T27"/>
                  </a:cxn>
                  <a:cxn ang="T136">
                    <a:pos x="T28" y="T29"/>
                  </a:cxn>
                  <a:cxn ang="T137">
                    <a:pos x="T30" y="T31"/>
                  </a:cxn>
                  <a:cxn ang="T138">
                    <a:pos x="T32" y="T33"/>
                  </a:cxn>
                  <a:cxn ang="T139">
                    <a:pos x="T34" y="T35"/>
                  </a:cxn>
                  <a:cxn ang="T140">
                    <a:pos x="T36" y="T37"/>
                  </a:cxn>
                  <a:cxn ang="T141">
                    <a:pos x="T38" y="T39"/>
                  </a:cxn>
                  <a:cxn ang="T142">
                    <a:pos x="T40" y="T41"/>
                  </a:cxn>
                  <a:cxn ang="T143">
                    <a:pos x="T42" y="T43"/>
                  </a:cxn>
                  <a:cxn ang="T144">
                    <a:pos x="T44" y="T45"/>
                  </a:cxn>
                  <a:cxn ang="T145">
                    <a:pos x="T46" y="T47"/>
                  </a:cxn>
                  <a:cxn ang="T146">
                    <a:pos x="T48" y="T49"/>
                  </a:cxn>
                  <a:cxn ang="T147">
                    <a:pos x="T50" y="T51"/>
                  </a:cxn>
                  <a:cxn ang="T148">
                    <a:pos x="T52" y="T53"/>
                  </a:cxn>
                  <a:cxn ang="T149">
                    <a:pos x="T54" y="T55"/>
                  </a:cxn>
                  <a:cxn ang="T150">
                    <a:pos x="T56" y="T57"/>
                  </a:cxn>
                  <a:cxn ang="T151">
                    <a:pos x="T58" y="T59"/>
                  </a:cxn>
                  <a:cxn ang="T152">
                    <a:pos x="T60" y="T61"/>
                  </a:cxn>
                  <a:cxn ang="T153">
                    <a:pos x="T62" y="T63"/>
                  </a:cxn>
                  <a:cxn ang="T154">
                    <a:pos x="T64" y="T65"/>
                  </a:cxn>
                  <a:cxn ang="T155">
                    <a:pos x="T66" y="T67"/>
                  </a:cxn>
                  <a:cxn ang="T156">
                    <a:pos x="T68" y="T69"/>
                  </a:cxn>
                  <a:cxn ang="T157">
                    <a:pos x="T70" y="T71"/>
                  </a:cxn>
                  <a:cxn ang="T158">
                    <a:pos x="T72" y="T73"/>
                  </a:cxn>
                  <a:cxn ang="T159">
                    <a:pos x="T74" y="T75"/>
                  </a:cxn>
                  <a:cxn ang="T160">
                    <a:pos x="T76" y="T77"/>
                  </a:cxn>
                  <a:cxn ang="T161">
                    <a:pos x="T78" y="T79"/>
                  </a:cxn>
                  <a:cxn ang="T162">
                    <a:pos x="T80" y="T81"/>
                  </a:cxn>
                  <a:cxn ang="T163">
                    <a:pos x="T82" y="T83"/>
                  </a:cxn>
                  <a:cxn ang="T164">
                    <a:pos x="T84" y="T85"/>
                  </a:cxn>
                  <a:cxn ang="T165">
                    <a:pos x="T86" y="T87"/>
                  </a:cxn>
                  <a:cxn ang="T166">
                    <a:pos x="T88" y="T89"/>
                  </a:cxn>
                  <a:cxn ang="T167">
                    <a:pos x="T90" y="T91"/>
                  </a:cxn>
                  <a:cxn ang="T168">
                    <a:pos x="T92" y="T93"/>
                  </a:cxn>
                  <a:cxn ang="T169">
                    <a:pos x="T94" y="T95"/>
                  </a:cxn>
                  <a:cxn ang="T170">
                    <a:pos x="T96" y="T97"/>
                  </a:cxn>
                  <a:cxn ang="T171">
                    <a:pos x="T98" y="T99"/>
                  </a:cxn>
                  <a:cxn ang="T172">
                    <a:pos x="T100" y="T101"/>
                  </a:cxn>
                  <a:cxn ang="T173">
                    <a:pos x="T102" y="T103"/>
                  </a:cxn>
                  <a:cxn ang="T174">
                    <a:pos x="T104" y="T105"/>
                  </a:cxn>
                  <a:cxn ang="T175">
                    <a:pos x="T106" y="T107"/>
                  </a:cxn>
                  <a:cxn ang="T176">
                    <a:pos x="T108" y="T109"/>
                  </a:cxn>
                  <a:cxn ang="T177">
                    <a:pos x="T110" y="T111"/>
                  </a:cxn>
                  <a:cxn ang="T178">
                    <a:pos x="T112" y="T113"/>
                  </a:cxn>
                  <a:cxn ang="T179">
                    <a:pos x="T114" y="T115"/>
                  </a:cxn>
                  <a:cxn ang="T180">
                    <a:pos x="T116" y="T117"/>
                  </a:cxn>
                  <a:cxn ang="T181">
                    <a:pos x="T118" y="T119"/>
                  </a:cxn>
                  <a:cxn ang="T182">
                    <a:pos x="T120" y="T121"/>
                  </a:cxn>
                </a:cxnLst>
                <a:rect l="T183" t="T184" r="T185" b="T186"/>
                <a:pathLst>
                  <a:path w="1153" h="699">
                    <a:moveTo>
                      <a:pt x="0" y="699"/>
                    </a:moveTo>
                    <a:lnTo>
                      <a:pt x="0" y="699"/>
                    </a:lnTo>
                    <a:lnTo>
                      <a:pt x="1" y="699"/>
                    </a:lnTo>
                    <a:lnTo>
                      <a:pt x="3" y="699"/>
                    </a:lnTo>
                    <a:lnTo>
                      <a:pt x="4" y="699"/>
                    </a:lnTo>
                    <a:lnTo>
                      <a:pt x="5" y="699"/>
                    </a:lnTo>
                    <a:lnTo>
                      <a:pt x="6" y="699"/>
                    </a:lnTo>
                    <a:lnTo>
                      <a:pt x="7" y="699"/>
                    </a:lnTo>
                    <a:lnTo>
                      <a:pt x="9" y="699"/>
                    </a:lnTo>
                    <a:lnTo>
                      <a:pt x="10" y="699"/>
                    </a:lnTo>
                    <a:lnTo>
                      <a:pt x="11" y="699"/>
                    </a:lnTo>
                    <a:lnTo>
                      <a:pt x="12" y="699"/>
                    </a:lnTo>
                    <a:lnTo>
                      <a:pt x="13" y="699"/>
                    </a:lnTo>
                    <a:lnTo>
                      <a:pt x="15" y="699"/>
                    </a:lnTo>
                    <a:lnTo>
                      <a:pt x="16" y="699"/>
                    </a:lnTo>
                    <a:lnTo>
                      <a:pt x="17" y="699"/>
                    </a:lnTo>
                    <a:lnTo>
                      <a:pt x="18" y="699"/>
                    </a:lnTo>
                    <a:lnTo>
                      <a:pt x="20" y="699"/>
                    </a:lnTo>
                    <a:lnTo>
                      <a:pt x="21" y="699"/>
                    </a:lnTo>
                    <a:lnTo>
                      <a:pt x="30" y="699"/>
                    </a:lnTo>
                    <a:lnTo>
                      <a:pt x="32" y="699"/>
                    </a:lnTo>
                    <a:lnTo>
                      <a:pt x="33" y="699"/>
                    </a:lnTo>
                    <a:lnTo>
                      <a:pt x="34" y="699"/>
                    </a:lnTo>
                    <a:lnTo>
                      <a:pt x="35" y="699"/>
                    </a:lnTo>
                    <a:lnTo>
                      <a:pt x="37" y="699"/>
                    </a:lnTo>
                    <a:lnTo>
                      <a:pt x="38" y="699"/>
                    </a:lnTo>
                    <a:lnTo>
                      <a:pt x="39" y="699"/>
                    </a:lnTo>
                    <a:lnTo>
                      <a:pt x="40" y="699"/>
                    </a:lnTo>
                    <a:lnTo>
                      <a:pt x="41" y="699"/>
                    </a:lnTo>
                    <a:lnTo>
                      <a:pt x="43" y="699"/>
                    </a:lnTo>
                    <a:lnTo>
                      <a:pt x="44" y="699"/>
                    </a:lnTo>
                    <a:lnTo>
                      <a:pt x="45" y="699"/>
                    </a:lnTo>
                    <a:lnTo>
                      <a:pt x="46" y="699"/>
                    </a:lnTo>
                    <a:lnTo>
                      <a:pt x="47" y="699"/>
                    </a:lnTo>
                    <a:lnTo>
                      <a:pt x="49" y="699"/>
                    </a:lnTo>
                    <a:lnTo>
                      <a:pt x="50" y="699"/>
                    </a:lnTo>
                    <a:lnTo>
                      <a:pt x="51" y="699"/>
                    </a:lnTo>
                    <a:lnTo>
                      <a:pt x="52" y="699"/>
                    </a:lnTo>
                    <a:lnTo>
                      <a:pt x="54" y="699"/>
                    </a:lnTo>
                    <a:lnTo>
                      <a:pt x="55" y="699"/>
                    </a:lnTo>
                    <a:lnTo>
                      <a:pt x="56" y="699"/>
                    </a:lnTo>
                    <a:lnTo>
                      <a:pt x="57" y="699"/>
                    </a:lnTo>
                    <a:lnTo>
                      <a:pt x="58" y="699"/>
                    </a:lnTo>
                    <a:lnTo>
                      <a:pt x="60" y="699"/>
                    </a:lnTo>
                    <a:lnTo>
                      <a:pt x="61" y="699"/>
                    </a:lnTo>
                    <a:lnTo>
                      <a:pt x="62" y="699"/>
                    </a:lnTo>
                    <a:lnTo>
                      <a:pt x="63" y="699"/>
                    </a:lnTo>
                    <a:lnTo>
                      <a:pt x="64" y="699"/>
                    </a:lnTo>
                    <a:lnTo>
                      <a:pt x="66" y="699"/>
                    </a:lnTo>
                    <a:lnTo>
                      <a:pt x="67" y="699"/>
                    </a:lnTo>
                    <a:lnTo>
                      <a:pt x="73" y="699"/>
                    </a:lnTo>
                    <a:lnTo>
                      <a:pt x="74" y="699"/>
                    </a:lnTo>
                    <a:lnTo>
                      <a:pt x="75" y="699"/>
                    </a:lnTo>
                    <a:lnTo>
                      <a:pt x="77" y="699"/>
                    </a:lnTo>
                    <a:lnTo>
                      <a:pt x="78" y="699"/>
                    </a:lnTo>
                    <a:lnTo>
                      <a:pt x="79" y="699"/>
                    </a:lnTo>
                    <a:lnTo>
                      <a:pt x="80" y="699"/>
                    </a:lnTo>
                    <a:lnTo>
                      <a:pt x="81" y="699"/>
                    </a:lnTo>
                    <a:lnTo>
                      <a:pt x="83" y="699"/>
                    </a:lnTo>
                    <a:lnTo>
                      <a:pt x="84" y="699"/>
                    </a:lnTo>
                    <a:lnTo>
                      <a:pt x="85" y="699"/>
                    </a:lnTo>
                    <a:lnTo>
                      <a:pt x="86" y="699"/>
                    </a:lnTo>
                    <a:lnTo>
                      <a:pt x="87" y="699"/>
                    </a:lnTo>
                    <a:lnTo>
                      <a:pt x="89" y="699"/>
                    </a:lnTo>
                    <a:lnTo>
                      <a:pt x="90" y="699"/>
                    </a:lnTo>
                    <a:lnTo>
                      <a:pt x="91" y="699"/>
                    </a:lnTo>
                    <a:lnTo>
                      <a:pt x="92" y="699"/>
                    </a:lnTo>
                    <a:lnTo>
                      <a:pt x="94" y="699"/>
                    </a:lnTo>
                    <a:lnTo>
                      <a:pt x="95" y="699"/>
                    </a:lnTo>
                    <a:lnTo>
                      <a:pt x="96" y="699"/>
                    </a:lnTo>
                    <a:lnTo>
                      <a:pt x="97" y="699"/>
                    </a:lnTo>
                    <a:lnTo>
                      <a:pt x="98" y="699"/>
                    </a:lnTo>
                    <a:lnTo>
                      <a:pt x="100" y="699"/>
                    </a:lnTo>
                    <a:lnTo>
                      <a:pt x="101" y="699"/>
                    </a:lnTo>
                    <a:lnTo>
                      <a:pt x="102" y="699"/>
                    </a:lnTo>
                    <a:lnTo>
                      <a:pt x="103" y="699"/>
                    </a:lnTo>
                    <a:lnTo>
                      <a:pt x="104" y="699"/>
                    </a:lnTo>
                    <a:lnTo>
                      <a:pt x="106" y="699"/>
                    </a:lnTo>
                    <a:lnTo>
                      <a:pt x="107" y="699"/>
                    </a:lnTo>
                    <a:lnTo>
                      <a:pt x="108" y="699"/>
                    </a:lnTo>
                    <a:lnTo>
                      <a:pt x="109" y="699"/>
                    </a:lnTo>
                    <a:lnTo>
                      <a:pt x="111" y="699"/>
                    </a:lnTo>
                    <a:lnTo>
                      <a:pt x="112" y="699"/>
                    </a:lnTo>
                    <a:lnTo>
                      <a:pt x="113" y="699"/>
                    </a:lnTo>
                    <a:lnTo>
                      <a:pt x="114" y="699"/>
                    </a:lnTo>
                    <a:lnTo>
                      <a:pt x="115" y="699"/>
                    </a:lnTo>
                    <a:lnTo>
                      <a:pt x="117" y="699"/>
                    </a:lnTo>
                    <a:lnTo>
                      <a:pt x="118" y="699"/>
                    </a:lnTo>
                    <a:lnTo>
                      <a:pt x="119" y="698"/>
                    </a:lnTo>
                    <a:lnTo>
                      <a:pt x="120" y="698"/>
                    </a:lnTo>
                    <a:lnTo>
                      <a:pt x="121" y="698"/>
                    </a:lnTo>
                    <a:lnTo>
                      <a:pt x="123" y="699"/>
                    </a:lnTo>
                    <a:lnTo>
                      <a:pt x="124" y="699"/>
                    </a:lnTo>
                    <a:lnTo>
                      <a:pt x="125" y="699"/>
                    </a:lnTo>
                    <a:lnTo>
                      <a:pt x="126" y="699"/>
                    </a:lnTo>
                    <a:lnTo>
                      <a:pt x="128" y="699"/>
                    </a:lnTo>
                    <a:lnTo>
                      <a:pt x="129" y="699"/>
                    </a:lnTo>
                    <a:lnTo>
                      <a:pt x="130" y="699"/>
                    </a:lnTo>
                    <a:lnTo>
                      <a:pt x="131" y="699"/>
                    </a:lnTo>
                    <a:lnTo>
                      <a:pt x="132" y="699"/>
                    </a:lnTo>
                    <a:lnTo>
                      <a:pt x="134" y="699"/>
                    </a:lnTo>
                    <a:lnTo>
                      <a:pt x="135" y="699"/>
                    </a:lnTo>
                    <a:lnTo>
                      <a:pt x="136" y="699"/>
                    </a:lnTo>
                    <a:lnTo>
                      <a:pt x="137" y="699"/>
                    </a:lnTo>
                    <a:lnTo>
                      <a:pt x="138" y="699"/>
                    </a:lnTo>
                    <a:lnTo>
                      <a:pt x="140" y="699"/>
                    </a:lnTo>
                    <a:lnTo>
                      <a:pt x="141" y="699"/>
                    </a:lnTo>
                    <a:lnTo>
                      <a:pt x="142" y="699"/>
                    </a:lnTo>
                    <a:lnTo>
                      <a:pt x="143" y="699"/>
                    </a:lnTo>
                    <a:lnTo>
                      <a:pt x="145" y="699"/>
                    </a:lnTo>
                    <a:lnTo>
                      <a:pt x="146" y="699"/>
                    </a:lnTo>
                    <a:lnTo>
                      <a:pt x="147" y="699"/>
                    </a:lnTo>
                    <a:lnTo>
                      <a:pt x="148" y="699"/>
                    </a:lnTo>
                    <a:lnTo>
                      <a:pt x="149" y="699"/>
                    </a:lnTo>
                    <a:lnTo>
                      <a:pt x="151" y="699"/>
                    </a:lnTo>
                    <a:lnTo>
                      <a:pt x="152" y="699"/>
                    </a:lnTo>
                    <a:lnTo>
                      <a:pt x="153" y="699"/>
                    </a:lnTo>
                    <a:lnTo>
                      <a:pt x="154" y="699"/>
                    </a:lnTo>
                    <a:lnTo>
                      <a:pt x="155" y="699"/>
                    </a:lnTo>
                    <a:lnTo>
                      <a:pt x="157" y="699"/>
                    </a:lnTo>
                    <a:lnTo>
                      <a:pt x="158" y="699"/>
                    </a:lnTo>
                    <a:lnTo>
                      <a:pt x="159" y="699"/>
                    </a:lnTo>
                    <a:lnTo>
                      <a:pt x="160" y="699"/>
                    </a:lnTo>
                    <a:lnTo>
                      <a:pt x="162" y="699"/>
                    </a:lnTo>
                    <a:lnTo>
                      <a:pt x="163" y="699"/>
                    </a:lnTo>
                    <a:lnTo>
                      <a:pt x="164" y="699"/>
                    </a:lnTo>
                    <a:lnTo>
                      <a:pt x="165" y="699"/>
                    </a:lnTo>
                    <a:lnTo>
                      <a:pt x="166" y="699"/>
                    </a:lnTo>
                    <a:lnTo>
                      <a:pt x="168" y="699"/>
                    </a:lnTo>
                    <a:lnTo>
                      <a:pt x="169" y="699"/>
                    </a:lnTo>
                    <a:lnTo>
                      <a:pt x="170" y="697"/>
                    </a:lnTo>
                    <a:lnTo>
                      <a:pt x="171" y="683"/>
                    </a:lnTo>
                    <a:lnTo>
                      <a:pt x="172" y="623"/>
                    </a:lnTo>
                    <a:lnTo>
                      <a:pt x="174" y="528"/>
                    </a:lnTo>
                    <a:lnTo>
                      <a:pt x="175" y="454"/>
                    </a:lnTo>
                    <a:lnTo>
                      <a:pt x="176" y="453"/>
                    </a:lnTo>
                    <a:lnTo>
                      <a:pt x="177" y="526"/>
                    </a:lnTo>
                    <a:lnTo>
                      <a:pt x="179" y="620"/>
                    </a:lnTo>
                    <a:lnTo>
                      <a:pt x="180" y="681"/>
                    </a:lnTo>
                    <a:lnTo>
                      <a:pt x="181" y="697"/>
                    </a:lnTo>
                    <a:lnTo>
                      <a:pt x="182" y="699"/>
                    </a:lnTo>
                    <a:lnTo>
                      <a:pt x="183" y="699"/>
                    </a:lnTo>
                    <a:lnTo>
                      <a:pt x="185" y="699"/>
                    </a:lnTo>
                    <a:lnTo>
                      <a:pt x="186" y="699"/>
                    </a:lnTo>
                    <a:lnTo>
                      <a:pt x="187" y="699"/>
                    </a:lnTo>
                    <a:lnTo>
                      <a:pt x="188" y="699"/>
                    </a:lnTo>
                    <a:lnTo>
                      <a:pt x="198" y="699"/>
                    </a:lnTo>
                    <a:lnTo>
                      <a:pt x="199" y="699"/>
                    </a:lnTo>
                    <a:lnTo>
                      <a:pt x="200" y="699"/>
                    </a:lnTo>
                    <a:lnTo>
                      <a:pt x="202" y="699"/>
                    </a:lnTo>
                    <a:lnTo>
                      <a:pt x="203" y="699"/>
                    </a:lnTo>
                    <a:lnTo>
                      <a:pt x="204" y="699"/>
                    </a:lnTo>
                    <a:lnTo>
                      <a:pt x="205" y="699"/>
                    </a:lnTo>
                    <a:lnTo>
                      <a:pt x="206" y="698"/>
                    </a:lnTo>
                    <a:lnTo>
                      <a:pt x="208" y="698"/>
                    </a:lnTo>
                    <a:lnTo>
                      <a:pt x="209" y="699"/>
                    </a:lnTo>
                    <a:lnTo>
                      <a:pt x="210" y="699"/>
                    </a:lnTo>
                    <a:lnTo>
                      <a:pt x="211" y="699"/>
                    </a:lnTo>
                    <a:lnTo>
                      <a:pt x="213" y="699"/>
                    </a:lnTo>
                    <a:lnTo>
                      <a:pt x="214" y="699"/>
                    </a:lnTo>
                    <a:lnTo>
                      <a:pt x="215" y="699"/>
                    </a:lnTo>
                    <a:lnTo>
                      <a:pt x="216" y="699"/>
                    </a:lnTo>
                    <a:lnTo>
                      <a:pt x="217" y="699"/>
                    </a:lnTo>
                    <a:lnTo>
                      <a:pt x="219" y="699"/>
                    </a:lnTo>
                    <a:lnTo>
                      <a:pt x="220" y="699"/>
                    </a:lnTo>
                    <a:lnTo>
                      <a:pt x="221" y="699"/>
                    </a:lnTo>
                    <a:lnTo>
                      <a:pt x="222" y="699"/>
                    </a:lnTo>
                    <a:lnTo>
                      <a:pt x="224" y="699"/>
                    </a:lnTo>
                    <a:lnTo>
                      <a:pt x="225" y="699"/>
                    </a:lnTo>
                    <a:lnTo>
                      <a:pt x="226" y="698"/>
                    </a:lnTo>
                    <a:lnTo>
                      <a:pt x="227" y="698"/>
                    </a:lnTo>
                    <a:lnTo>
                      <a:pt x="228" y="699"/>
                    </a:lnTo>
                    <a:lnTo>
                      <a:pt x="230" y="695"/>
                    </a:lnTo>
                    <a:lnTo>
                      <a:pt x="231" y="669"/>
                    </a:lnTo>
                    <a:lnTo>
                      <a:pt x="232" y="593"/>
                    </a:lnTo>
                    <a:lnTo>
                      <a:pt x="233" y="502"/>
                    </a:lnTo>
                    <a:lnTo>
                      <a:pt x="234" y="456"/>
                    </a:lnTo>
                    <a:lnTo>
                      <a:pt x="236" y="488"/>
                    </a:lnTo>
                    <a:lnTo>
                      <a:pt x="237" y="574"/>
                    </a:lnTo>
                    <a:lnTo>
                      <a:pt x="238" y="656"/>
                    </a:lnTo>
                    <a:lnTo>
                      <a:pt x="239" y="693"/>
                    </a:lnTo>
                    <a:lnTo>
                      <a:pt x="241" y="698"/>
                    </a:lnTo>
                    <a:lnTo>
                      <a:pt x="242" y="698"/>
                    </a:lnTo>
                    <a:lnTo>
                      <a:pt x="243" y="698"/>
                    </a:lnTo>
                    <a:lnTo>
                      <a:pt x="244" y="698"/>
                    </a:lnTo>
                    <a:lnTo>
                      <a:pt x="245" y="698"/>
                    </a:lnTo>
                    <a:lnTo>
                      <a:pt x="247" y="699"/>
                    </a:lnTo>
                    <a:lnTo>
                      <a:pt x="248" y="699"/>
                    </a:lnTo>
                    <a:lnTo>
                      <a:pt x="249" y="699"/>
                    </a:lnTo>
                    <a:lnTo>
                      <a:pt x="250" y="699"/>
                    </a:lnTo>
                    <a:lnTo>
                      <a:pt x="251" y="699"/>
                    </a:lnTo>
                    <a:lnTo>
                      <a:pt x="253" y="699"/>
                    </a:lnTo>
                    <a:lnTo>
                      <a:pt x="254" y="699"/>
                    </a:lnTo>
                    <a:lnTo>
                      <a:pt x="255" y="699"/>
                    </a:lnTo>
                    <a:lnTo>
                      <a:pt x="279" y="699"/>
                    </a:lnTo>
                    <a:lnTo>
                      <a:pt x="281" y="699"/>
                    </a:lnTo>
                    <a:lnTo>
                      <a:pt x="282" y="699"/>
                    </a:lnTo>
                    <a:lnTo>
                      <a:pt x="283" y="699"/>
                    </a:lnTo>
                    <a:lnTo>
                      <a:pt x="284" y="699"/>
                    </a:lnTo>
                    <a:lnTo>
                      <a:pt x="286" y="698"/>
                    </a:lnTo>
                    <a:lnTo>
                      <a:pt x="287" y="696"/>
                    </a:lnTo>
                    <a:lnTo>
                      <a:pt x="288" y="690"/>
                    </a:lnTo>
                    <a:lnTo>
                      <a:pt x="289" y="679"/>
                    </a:lnTo>
                    <a:lnTo>
                      <a:pt x="290" y="658"/>
                    </a:lnTo>
                    <a:lnTo>
                      <a:pt x="292" y="622"/>
                    </a:lnTo>
                    <a:lnTo>
                      <a:pt x="293" y="587"/>
                    </a:lnTo>
                    <a:lnTo>
                      <a:pt x="294" y="582"/>
                    </a:lnTo>
                    <a:lnTo>
                      <a:pt x="295" y="613"/>
                    </a:lnTo>
                    <a:lnTo>
                      <a:pt x="296" y="658"/>
                    </a:lnTo>
                    <a:lnTo>
                      <a:pt x="298" y="690"/>
                    </a:lnTo>
                    <a:lnTo>
                      <a:pt x="299" y="699"/>
                    </a:lnTo>
                    <a:lnTo>
                      <a:pt x="300" y="699"/>
                    </a:lnTo>
                    <a:lnTo>
                      <a:pt x="301" y="699"/>
                    </a:lnTo>
                    <a:lnTo>
                      <a:pt x="303" y="699"/>
                    </a:lnTo>
                    <a:lnTo>
                      <a:pt x="304" y="699"/>
                    </a:lnTo>
                    <a:lnTo>
                      <a:pt x="305" y="699"/>
                    </a:lnTo>
                    <a:lnTo>
                      <a:pt x="306" y="699"/>
                    </a:lnTo>
                    <a:lnTo>
                      <a:pt x="307" y="699"/>
                    </a:lnTo>
                    <a:lnTo>
                      <a:pt x="309" y="699"/>
                    </a:lnTo>
                    <a:lnTo>
                      <a:pt x="310" y="699"/>
                    </a:lnTo>
                    <a:lnTo>
                      <a:pt x="311" y="699"/>
                    </a:lnTo>
                    <a:lnTo>
                      <a:pt x="312" y="699"/>
                    </a:lnTo>
                    <a:lnTo>
                      <a:pt x="314" y="699"/>
                    </a:lnTo>
                    <a:lnTo>
                      <a:pt x="315" y="699"/>
                    </a:lnTo>
                    <a:lnTo>
                      <a:pt x="316" y="699"/>
                    </a:lnTo>
                    <a:lnTo>
                      <a:pt x="317" y="699"/>
                    </a:lnTo>
                    <a:lnTo>
                      <a:pt x="318" y="699"/>
                    </a:lnTo>
                    <a:lnTo>
                      <a:pt x="320" y="699"/>
                    </a:lnTo>
                    <a:lnTo>
                      <a:pt x="321" y="699"/>
                    </a:lnTo>
                    <a:lnTo>
                      <a:pt x="322" y="699"/>
                    </a:lnTo>
                    <a:lnTo>
                      <a:pt x="323" y="699"/>
                    </a:lnTo>
                    <a:lnTo>
                      <a:pt x="324" y="699"/>
                    </a:lnTo>
                    <a:lnTo>
                      <a:pt x="326" y="699"/>
                    </a:lnTo>
                    <a:lnTo>
                      <a:pt x="327" y="699"/>
                    </a:lnTo>
                    <a:lnTo>
                      <a:pt x="328" y="699"/>
                    </a:lnTo>
                    <a:lnTo>
                      <a:pt x="329" y="699"/>
                    </a:lnTo>
                    <a:lnTo>
                      <a:pt x="331" y="699"/>
                    </a:lnTo>
                    <a:lnTo>
                      <a:pt x="332" y="699"/>
                    </a:lnTo>
                    <a:lnTo>
                      <a:pt x="333" y="699"/>
                    </a:lnTo>
                    <a:lnTo>
                      <a:pt x="334" y="699"/>
                    </a:lnTo>
                    <a:lnTo>
                      <a:pt x="335" y="699"/>
                    </a:lnTo>
                    <a:lnTo>
                      <a:pt x="337" y="699"/>
                    </a:lnTo>
                    <a:lnTo>
                      <a:pt x="338" y="699"/>
                    </a:lnTo>
                    <a:lnTo>
                      <a:pt x="339" y="699"/>
                    </a:lnTo>
                    <a:lnTo>
                      <a:pt x="340" y="699"/>
                    </a:lnTo>
                    <a:lnTo>
                      <a:pt x="342" y="699"/>
                    </a:lnTo>
                    <a:lnTo>
                      <a:pt x="343" y="699"/>
                    </a:lnTo>
                    <a:lnTo>
                      <a:pt x="344" y="699"/>
                    </a:lnTo>
                    <a:lnTo>
                      <a:pt x="345" y="699"/>
                    </a:lnTo>
                    <a:lnTo>
                      <a:pt x="346" y="699"/>
                    </a:lnTo>
                    <a:lnTo>
                      <a:pt x="348" y="699"/>
                    </a:lnTo>
                    <a:lnTo>
                      <a:pt x="349" y="696"/>
                    </a:lnTo>
                    <a:lnTo>
                      <a:pt x="350" y="686"/>
                    </a:lnTo>
                    <a:lnTo>
                      <a:pt x="351" y="673"/>
                    </a:lnTo>
                    <a:lnTo>
                      <a:pt x="352" y="665"/>
                    </a:lnTo>
                    <a:lnTo>
                      <a:pt x="354" y="670"/>
                    </a:lnTo>
                    <a:lnTo>
                      <a:pt x="355" y="683"/>
                    </a:lnTo>
                    <a:lnTo>
                      <a:pt x="356" y="696"/>
                    </a:lnTo>
                    <a:lnTo>
                      <a:pt x="357" y="699"/>
                    </a:lnTo>
                    <a:lnTo>
                      <a:pt x="359" y="699"/>
                    </a:lnTo>
                    <a:lnTo>
                      <a:pt x="360" y="698"/>
                    </a:lnTo>
                    <a:lnTo>
                      <a:pt x="361" y="698"/>
                    </a:lnTo>
                    <a:lnTo>
                      <a:pt x="362" y="699"/>
                    </a:lnTo>
                    <a:lnTo>
                      <a:pt x="363" y="699"/>
                    </a:lnTo>
                    <a:lnTo>
                      <a:pt x="365" y="699"/>
                    </a:lnTo>
                    <a:lnTo>
                      <a:pt x="366" y="699"/>
                    </a:lnTo>
                    <a:lnTo>
                      <a:pt x="367" y="699"/>
                    </a:lnTo>
                    <a:lnTo>
                      <a:pt x="368" y="699"/>
                    </a:lnTo>
                    <a:lnTo>
                      <a:pt x="370" y="699"/>
                    </a:lnTo>
                    <a:lnTo>
                      <a:pt x="371" y="699"/>
                    </a:lnTo>
                    <a:lnTo>
                      <a:pt x="372" y="698"/>
                    </a:lnTo>
                    <a:lnTo>
                      <a:pt x="373" y="698"/>
                    </a:lnTo>
                    <a:lnTo>
                      <a:pt x="374" y="697"/>
                    </a:lnTo>
                    <a:lnTo>
                      <a:pt x="376" y="698"/>
                    </a:lnTo>
                    <a:lnTo>
                      <a:pt x="377" y="699"/>
                    </a:lnTo>
                    <a:lnTo>
                      <a:pt x="378" y="699"/>
                    </a:lnTo>
                    <a:lnTo>
                      <a:pt x="379" y="699"/>
                    </a:lnTo>
                    <a:lnTo>
                      <a:pt x="381" y="699"/>
                    </a:lnTo>
                    <a:lnTo>
                      <a:pt x="382" y="699"/>
                    </a:lnTo>
                    <a:lnTo>
                      <a:pt x="383" y="699"/>
                    </a:lnTo>
                    <a:lnTo>
                      <a:pt x="384" y="699"/>
                    </a:lnTo>
                    <a:lnTo>
                      <a:pt x="385" y="699"/>
                    </a:lnTo>
                    <a:lnTo>
                      <a:pt x="387" y="699"/>
                    </a:lnTo>
                    <a:lnTo>
                      <a:pt x="388" y="699"/>
                    </a:lnTo>
                    <a:lnTo>
                      <a:pt x="389" y="699"/>
                    </a:lnTo>
                    <a:lnTo>
                      <a:pt x="390" y="699"/>
                    </a:lnTo>
                    <a:lnTo>
                      <a:pt x="391" y="699"/>
                    </a:lnTo>
                    <a:lnTo>
                      <a:pt x="393" y="699"/>
                    </a:lnTo>
                    <a:lnTo>
                      <a:pt x="394" y="699"/>
                    </a:lnTo>
                    <a:lnTo>
                      <a:pt x="395" y="699"/>
                    </a:lnTo>
                    <a:lnTo>
                      <a:pt x="396" y="699"/>
                    </a:lnTo>
                    <a:lnTo>
                      <a:pt x="398" y="699"/>
                    </a:lnTo>
                    <a:lnTo>
                      <a:pt x="399" y="699"/>
                    </a:lnTo>
                    <a:lnTo>
                      <a:pt x="400" y="699"/>
                    </a:lnTo>
                    <a:lnTo>
                      <a:pt x="401" y="699"/>
                    </a:lnTo>
                    <a:lnTo>
                      <a:pt x="402" y="698"/>
                    </a:lnTo>
                    <a:lnTo>
                      <a:pt x="404" y="697"/>
                    </a:lnTo>
                    <a:lnTo>
                      <a:pt x="405" y="696"/>
                    </a:lnTo>
                    <a:lnTo>
                      <a:pt x="406" y="696"/>
                    </a:lnTo>
                    <a:lnTo>
                      <a:pt x="407" y="696"/>
                    </a:lnTo>
                    <a:lnTo>
                      <a:pt x="409" y="696"/>
                    </a:lnTo>
                    <a:lnTo>
                      <a:pt x="410" y="697"/>
                    </a:lnTo>
                    <a:lnTo>
                      <a:pt x="411" y="697"/>
                    </a:lnTo>
                    <a:lnTo>
                      <a:pt x="412" y="697"/>
                    </a:lnTo>
                    <a:lnTo>
                      <a:pt x="413" y="698"/>
                    </a:lnTo>
                    <a:lnTo>
                      <a:pt x="415" y="699"/>
                    </a:lnTo>
                    <a:lnTo>
                      <a:pt x="416" y="699"/>
                    </a:lnTo>
                    <a:lnTo>
                      <a:pt x="417" y="699"/>
                    </a:lnTo>
                    <a:lnTo>
                      <a:pt x="418" y="699"/>
                    </a:lnTo>
                    <a:lnTo>
                      <a:pt x="420" y="699"/>
                    </a:lnTo>
                    <a:lnTo>
                      <a:pt x="421" y="699"/>
                    </a:lnTo>
                    <a:lnTo>
                      <a:pt x="422" y="699"/>
                    </a:lnTo>
                    <a:lnTo>
                      <a:pt x="423" y="699"/>
                    </a:lnTo>
                    <a:lnTo>
                      <a:pt x="424" y="699"/>
                    </a:lnTo>
                    <a:lnTo>
                      <a:pt x="426" y="699"/>
                    </a:lnTo>
                    <a:lnTo>
                      <a:pt x="427" y="699"/>
                    </a:lnTo>
                    <a:lnTo>
                      <a:pt x="428" y="699"/>
                    </a:lnTo>
                    <a:lnTo>
                      <a:pt x="429" y="699"/>
                    </a:lnTo>
                    <a:lnTo>
                      <a:pt x="430" y="699"/>
                    </a:lnTo>
                    <a:lnTo>
                      <a:pt x="432" y="699"/>
                    </a:lnTo>
                    <a:lnTo>
                      <a:pt x="433" y="699"/>
                    </a:lnTo>
                    <a:lnTo>
                      <a:pt x="438" y="699"/>
                    </a:lnTo>
                    <a:lnTo>
                      <a:pt x="439" y="699"/>
                    </a:lnTo>
                    <a:lnTo>
                      <a:pt x="440" y="699"/>
                    </a:lnTo>
                    <a:lnTo>
                      <a:pt x="441" y="699"/>
                    </a:lnTo>
                    <a:lnTo>
                      <a:pt x="443" y="699"/>
                    </a:lnTo>
                    <a:lnTo>
                      <a:pt x="444" y="699"/>
                    </a:lnTo>
                    <a:lnTo>
                      <a:pt x="445" y="699"/>
                    </a:lnTo>
                    <a:lnTo>
                      <a:pt x="446" y="699"/>
                    </a:lnTo>
                    <a:lnTo>
                      <a:pt x="448" y="699"/>
                    </a:lnTo>
                    <a:lnTo>
                      <a:pt x="449" y="699"/>
                    </a:lnTo>
                    <a:lnTo>
                      <a:pt x="450" y="699"/>
                    </a:lnTo>
                    <a:lnTo>
                      <a:pt x="451" y="699"/>
                    </a:lnTo>
                    <a:lnTo>
                      <a:pt x="452" y="699"/>
                    </a:lnTo>
                    <a:lnTo>
                      <a:pt x="454" y="699"/>
                    </a:lnTo>
                    <a:lnTo>
                      <a:pt x="455" y="699"/>
                    </a:lnTo>
                    <a:lnTo>
                      <a:pt x="456" y="698"/>
                    </a:lnTo>
                    <a:lnTo>
                      <a:pt x="457" y="698"/>
                    </a:lnTo>
                    <a:lnTo>
                      <a:pt x="459" y="698"/>
                    </a:lnTo>
                    <a:lnTo>
                      <a:pt x="460" y="699"/>
                    </a:lnTo>
                    <a:lnTo>
                      <a:pt x="461" y="699"/>
                    </a:lnTo>
                    <a:lnTo>
                      <a:pt x="462" y="699"/>
                    </a:lnTo>
                    <a:lnTo>
                      <a:pt x="463" y="699"/>
                    </a:lnTo>
                    <a:lnTo>
                      <a:pt x="465" y="699"/>
                    </a:lnTo>
                    <a:lnTo>
                      <a:pt x="466" y="699"/>
                    </a:lnTo>
                    <a:lnTo>
                      <a:pt x="467" y="699"/>
                    </a:lnTo>
                    <a:lnTo>
                      <a:pt x="468" y="699"/>
                    </a:lnTo>
                    <a:lnTo>
                      <a:pt x="470" y="699"/>
                    </a:lnTo>
                    <a:lnTo>
                      <a:pt x="471" y="699"/>
                    </a:lnTo>
                    <a:lnTo>
                      <a:pt x="472" y="699"/>
                    </a:lnTo>
                    <a:lnTo>
                      <a:pt x="473" y="699"/>
                    </a:lnTo>
                    <a:lnTo>
                      <a:pt x="474" y="699"/>
                    </a:lnTo>
                    <a:lnTo>
                      <a:pt x="476" y="699"/>
                    </a:lnTo>
                    <a:lnTo>
                      <a:pt x="477" y="699"/>
                    </a:lnTo>
                    <a:lnTo>
                      <a:pt x="478" y="699"/>
                    </a:lnTo>
                    <a:lnTo>
                      <a:pt x="479" y="699"/>
                    </a:lnTo>
                    <a:lnTo>
                      <a:pt x="480" y="699"/>
                    </a:lnTo>
                    <a:lnTo>
                      <a:pt x="482" y="699"/>
                    </a:lnTo>
                    <a:lnTo>
                      <a:pt x="488" y="699"/>
                    </a:lnTo>
                    <a:lnTo>
                      <a:pt x="489" y="699"/>
                    </a:lnTo>
                    <a:lnTo>
                      <a:pt x="490" y="699"/>
                    </a:lnTo>
                    <a:lnTo>
                      <a:pt x="491" y="699"/>
                    </a:lnTo>
                    <a:lnTo>
                      <a:pt x="493" y="699"/>
                    </a:lnTo>
                    <a:lnTo>
                      <a:pt x="494" y="699"/>
                    </a:lnTo>
                    <a:lnTo>
                      <a:pt x="495" y="699"/>
                    </a:lnTo>
                    <a:lnTo>
                      <a:pt x="496" y="699"/>
                    </a:lnTo>
                    <a:lnTo>
                      <a:pt x="498" y="699"/>
                    </a:lnTo>
                    <a:lnTo>
                      <a:pt x="499" y="699"/>
                    </a:lnTo>
                    <a:lnTo>
                      <a:pt x="500" y="699"/>
                    </a:lnTo>
                    <a:lnTo>
                      <a:pt x="501" y="699"/>
                    </a:lnTo>
                    <a:lnTo>
                      <a:pt x="502" y="699"/>
                    </a:lnTo>
                    <a:lnTo>
                      <a:pt x="504" y="699"/>
                    </a:lnTo>
                    <a:lnTo>
                      <a:pt x="515" y="699"/>
                    </a:lnTo>
                    <a:lnTo>
                      <a:pt x="516" y="699"/>
                    </a:lnTo>
                    <a:lnTo>
                      <a:pt x="517" y="699"/>
                    </a:lnTo>
                    <a:lnTo>
                      <a:pt x="518" y="699"/>
                    </a:lnTo>
                    <a:lnTo>
                      <a:pt x="520" y="699"/>
                    </a:lnTo>
                    <a:lnTo>
                      <a:pt x="521" y="699"/>
                    </a:lnTo>
                    <a:lnTo>
                      <a:pt x="522" y="699"/>
                    </a:lnTo>
                    <a:lnTo>
                      <a:pt x="523" y="698"/>
                    </a:lnTo>
                    <a:lnTo>
                      <a:pt x="524" y="698"/>
                    </a:lnTo>
                    <a:lnTo>
                      <a:pt x="526" y="697"/>
                    </a:lnTo>
                    <a:lnTo>
                      <a:pt x="527" y="692"/>
                    </a:lnTo>
                    <a:lnTo>
                      <a:pt x="528" y="684"/>
                    </a:lnTo>
                    <a:lnTo>
                      <a:pt x="529" y="678"/>
                    </a:lnTo>
                    <a:lnTo>
                      <a:pt x="531" y="678"/>
                    </a:lnTo>
                    <a:lnTo>
                      <a:pt x="532" y="685"/>
                    </a:lnTo>
                    <a:lnTo>
                      <a:pt x="533" y="694"/>
                    </a:lnTo>
                    <a:lnTo>
                      <a:pt x="534" y="699"/>
                    </a:lnTo>
                    <a:lnTo>
                      <a:pt x="535" y="699"/>
                    </a:lnTo>
                    <a:lnTo>
                      <a:pt x="537" y="699"/>
                    </a:lnTo>
                    <a:lnTo>
                      <a:pt x="538" y="699"/>
                    </a:lnTo>
                    <a:lnTo>
                      <a:pt x="539" y="699"/>
                    </a:lnTo>
                    <a:lnTo>
                      <a:pt x="540" y="699"/>
                    </a:lnTo>
                    <a:lnTo>
                      <a:pt x="542" y="699"/>
                    </a:lnTo>
                    <a:lnTo>
                      <a:pt x="543" y="699"/>
                    </a:lnTo>
                    <a:lnTo>
                      <a:pt x="544" y="699"/>
                    </a:lnTo>
                    <a:lnTo>
                      <a:pt x="545" y="699"/>
                    </a:lnTo>
                    <a:lnTo>
                      <a:pt x="546" y="699"/>
                    </a:lnTo>
                    <a:lnTo>
                      <a:pt x="548" y="699"/>
                    </a:lnTo>
                    <a:lnTo>
                      <a:pt x="549" y="699"/>
                    </a:lnTo>
                    <a:lnTo>
                      <a:pt x="550" y="699"/>
                    </a:lnTo>
                    <a:lnTo>
                      <a:pt x="551" y="699"/>
                    </a:lnTo>
                    <a:lnTo>
                      <a:pt x="553" y="699"/>
                    </a:lnTo>
                    <a:lnTo>
                      <a:pt x="554" y="699"/>
                    </a:lnTo>
                    <a:lnTo>
                      <a:pt x="555" y="699"/>
                    </a:lnTo>
                    <a:lnTo>
                      <a:pt x="556" y="699"/>
                    </a:lnTo>
                    <a:lnTo>
                      <a:pt x="557" y="699"/>
                    </a:lnTo>
                    <a:lnTo>
                      <a:pt x="559" y="699"/>
                    </a:lnTo>
                    <a:lnTo>
                      <a:pt x="560" y="699"/>
                    </a:lnTo>
                    <a:lnTo>
                      <a:pt x="561" y="699"/>
                    </a:lnTo>
                    <a:lnTo>
                      <a:pt x="562" y="699"/>
                    </a:lnTo>
                    <a:lnTo>
                      <a:pt x="564" y="699"/>
                    </a:lnTo>
                    <a:lnTo>
                      <a:pt x="565" y="699"/>
                    </a:lnTo>
                    <a:lnTo>
                      <a:pt x="566" y="699"/>
                    </a:lnTo>
                    <a:lnTo>
                      <a:pt x="578" y="699"/>
                    </a:lnTo>
                    <a:lnTo>
                      <a:pt x="579" y="699"/>
                    </a:lnTo>
                    <a:lnTo>
                      <a:pt x="581" y="699"/>
                    </a:lnTo>
                    <a:lnTo>
                      <a:pt x="582" y="699"/>
                    </a:lnTo>
                    <a:lnTo>
                      <a:pt x="583" y="698"/>
                    </a:lnTo>
                    <a:lnTo>
                      <a:pt x="584" y="683"/>
                    </a:lnTo>
                    <a:lnTo>
                      <a:pt x="585" y="549"/>
                    </a:lnTo>
                    <a:lnTo>
                      <a:pt x="587" y="303"/>
                    </a:lnTo>
                    <a:lnTo>
                      <a:pt x="588" y="66"/>
                    </a:lnTo>
                    <a:lnTo>
                      <a:pt x="589" y="0"/>
                    </a:lnTo>
                    <a:lnTo>
                      <a:pt x="590" y="156"/>
                    </a:lnTo>
                    <a:lnTo>
                      <a:pt x="592" y="417"/>
                    </a:lnTo>
                    <a:lnTo>
                      <a:pt x="593" y="622"/>
                    </a:lnTo>
                    <a:lnTo>
                      <a:pt x="594" y="695"/>
                    </a:lnTo>
                    <a:lnTo>
                      <a:pt x="595" y="699"/>
                    </a:lnTo>
                    <a:lnTo>
                      <a:pt x="596" y="699"/>
                    </a:lnTo>
                    <a:lnTo>
                      <a:pt x="598" y="699"/>
                    </a:lnTo>
                    <a:lnTo>
                      <a:pt x="599" y="699"/>
                    </a:lnTo>
                    <a:lnTo>
                      <a:pt x="600" y="699"/>
                    </a:lnTo>
                    <a:lnTo>
                      <a:pt x="601" y="699"/>
                    </a:lnTo>
                    <a:lnTo>
                      <a:pt x="603" y="699"/>
                    </a:lnTo>
                    <a:lnTo>
                      <a:pt x="604" y="699"/>
                    </a:lnTo>
                    <a:lnTo>
                      <a:pt x="605" y="699"/>
                    </a:lnTo>
                    <a:lnTo>
                      <a:pt x="606" y="699"/>
                    </a:lnTo>
                    <a:lnTo>
                      <a:pt x="607" y="699"/>
                    </a:lnTo>
                    <a:lnTo>
                      <a:pt x="609" y="699"/>
                    </a:lnTo>
                    <a:lnTo>
                      <a:pt x="610" y="699"/>
                    </a:lnTo>
                    <a:lnTo>
                      <a:pt x="611" y="699"/>
                    </a:lnTo>
                    <a:lnTo>
                      <a:pt x="612" y="699"/>
                    </a:lnTo>
                    <a:lnTo>
                      <a:pt x="614" y="699"/>
                    </a:lnTo>
                    <a:lnTo>
                      <a:pt x="615" y="699"/>
                    </a:lnTo>
                    <a:lnTo>
                      <a:pt x="616" y="699"/>
                    </a:lnTo>
                    <a:lnTo>
                      <a:pt x="617" y="699"/>
                    </a:lnTo>
                    <a:lnTo>
                      <a:pt x="618" y="699"/>
                    </a:lnTo>
                    <a:lnTo>
                      <a:pt x="620" y="699"/>
                    </a:lnTo>
                    <a:lnTo>
                      <a:pt x="621" y="699"/>
                    </a:lnTo>
                    <a:lnTo>
                      <a:pt x="622" y="699"/>
                    </a:lnTo>
                    <a:lnTo>
                      <a:pt x="623" y="699"/>
                    </a:lnTo>
                    <a:lnTo>
                      <a:pt x="625" y="699"/>
                    </a:lnTo>
                    <a:lnTo>
                      <a:pt x="626" y="699"/>
                    </a:lnTo>
                    <a:lnTo>
                      <a:pt x="627" y="699"/>
                    </a:lnTo>
                    <a:lnTo>
                      <a:pt x="628" y="699"/>
                    </a:lnTo>
                    <a:lnTo>
                      <a:pt x="629" y="699"/>
                    </a:lnTo>
                    <a:lnTo>
                      <a:pt x="631" y="699"/>
                    </a:lnTo>
                    <a:lnTo>
                      <a:pt x="632" y="699"/>
                    </a:lnTo>
                    <a:lnTo>
                      <a:pt x="633" y="699"/>
                    </a:lnTo>
                    <a:lnTo>
                      <a:pt x="634" y="699"/>
                    </a:lnTo>
                    <a:lnTo>
                      <a:pt x="636" y="699"/>
                    </a:lnTo>
                    <a:lnTo>
                      <a:pt x="637" y="699"/>
                    </a:lnTo>
                    <a:lnTo>
                      <a:pt x="638" y="698"/>
                    </a:lnTo>
                    <a:lnTo>
                      <a:pt x="639" y="698"/>
                    </a:lnTo>
                    <a:lnTo>
                      <a:pt x="641" y="697"/>
                    </a:lnTo>
                    <a:lnTo>
                      <a:pt x="642" y="697"/>
                    </a:lnTo>
                    <a:lnTo>
                      <a:pt x="643" y="691"/>
                    </a:lnTo>
                    <a:lnTo>
                      <a:pt x="644" y="613"/>
                    </a:lnTo>
                    <a:lnTo>
                      <a:pt x="645" y="413"/>
                    </a:lnTo>
                    <a:lnTo>
                      <a:pt x="647" y="175"/>
                    </a:lnTo>
                    <a:lnTo>
                      <a:pt x="648" y="50"/>
                    </a:lnTo>
                    <a:lnTo>
                      <a:pt x="649" y="132"/>
                    </a:lnTo>
                    <a:lnTo>
                      <a:pt x="650" y="358"/>
                    </a:lnTo>
                    <a:lnTo>
                      <a:pt x="652" y="577"/>
                    </a:lnTo>
                    <a:lnTo>
                      <a:pt x="653" y="688"/>
                    </a:lnTo>
                    <a:lnTo>
                      <a:pt x="654" y="699"/>
                    </a:lnTo>
                    <a:lnTo>
                      <a:pt x="655" y="699"/>
                    </a:lnTo>
                    <a:lnTo>
                      <a:pt x="656" y="699"/>
                    </a:lnTo>
                    <a:lnTo>
                      <a:pt x="658" y="699"/>
                    </a:lnTo>
                    <a:lnTo>
                      <a:pt x="659" y="699"/>
                    </a:lnTo>
                    <a:lnTo>
                      <a:pt x="660" y="699"/>
                    </a:lnTo>
                    <a:lnTo>
                      <a:pt x="661" y="699"/>
                    </a:lnTo>
                    <a:lnTo>
                      <a:pt x="663" y="699"/>
                    </a:lnTo>
                    <a:lnTo>
                      <a:pt x="664" y="699"/>
                    </a:lnTo>
                    <a:lnTo>
                      <a:pt x="665" y="699"/>
                    </a:lnTo>
                    <a:lnTo>
                      <a:pt x="666" y="698"/>
                    </a:lnTo>
                    <a:lnTo>
                      <a:pt x="667" y="699"/>
                    </a:lnTo>
                    <a:lnTo>
                      <a:pt x="669" y="699"/>
                    </a:lnTo>
                    <a:lnTo>
                      <a:pt x="670" y="699"/>
                    </a:lnTo>
                    <a:lnTo>
                      <a:pt x="671" y="699"/>
                    </a:lnTo>
                    <a:lnTo>
                      <a:pt x="672" y="699"/>
                    </a:lnTo>
                    <a:lnTo>
                      <a:pt x="674" y="699"/>
                    </a:lnTo>
                    <a:lnTo>
                      <a:pt x="675" y="699"/>
                    </a:lnTo>
                    <a:lnTo>
                      <a:pt x="676" y="699"/>
                    </a:lnTo>
                    <a:lnTo>
                      <a:pt x="677" y="699"/>
                    </a:lnTo>
                    <a:lnTo>
                      <a:pt x="678" y="699"/>
                    </a:lnTo>
                    <a:lnTo>
                      <a:pt x="680" y="699"/>
                    </a:lnTo>
                    <a:lnTo>
                      <a:pt x="681" y="699"/>
                    </a:lnTo>
                    <a:lnTo>
                      <a:pt x="682" y="699"/>
                    </a:lnTo>
                    <a:lnTo>
                      <a:pt x="683" y="699"/>
                    </a:lnTo>
                    <a:lnTo>
                      <a:pt x="685" y="699"/>
                    </a:lnTo>
                    <a:lnTo>
                      <a:pt x="686" y="699"/>
                    </a:lnTo>
                    <a:lnTo>
                      <a:pt x="693" y="699"/>
                    </a:lnTo>
                    <a:lnTo>
                      <a:pt x="694" y="699"/>
                    </a:lnTo>
                    <a:lnTo>
                      <a:pt x="696" y="699"/>
                    </a:lnTo>
                    <a:lnTo>
                      <a:pt x="697" y="699"/>
                    </a:lnTo>
                    <a:lnTo>
                      <a:pt x="698" y="699"/>
                    </a:lnTo>
                    <a:lnTo>
                      <a:pt x="699" y="699"/>
                    </a:lnTo>
                    <a:lnTo>
                      <a:pt x="700" y="699"/>
                    </a:lnTo>
                    <a:lnTo>
                      <a:pt x="702" y="697"/>
                    </a:lnTo>
                    <a:lnTo>
                      <a:pt x="703" y="679"/>
                    </a:lnTo>
                    <a:lnTo>
                      <a:pt x="704" y="599"/>
                    </a:lnTo>
                    <a:lnTo>
                      <a:pt x="705" y="484"/>
                    </a:lnTo>
                    <a:lnTo>
                      <a:pt x="707" y="403"/>
                    </a:lnTo>
                    <a:lnTo>
                      <a:pt x="708" y="413"/>
                    </a:lnTo>
                    <a:lnTo>
                      <a:pt x="709" y="508"/>
                    </a:lnTo>
                    <a:lnTo>
                      <a:pt x="710" y="619"/>
                    </a:lnTo>
                    <a:lnTo>
                      <a:pt x="711" y="687"/>
                    </a:lnTo>
                    <a:lnTo>
                      <a:pt x="713" y="699"/>
                    </a:lnTo>
                    <a:lnTo>
                      <a:pt x="714" y="699"/>
                    </a:lnTo>
                    <a:lnTo>
                      <a:pt x="715" y="699"/>
                    </a:lnTo>
                    <a:lnTo>
                      <a:pt x="716" y="699"/>
                    </a:lnTo>
                    <a:lnTo>
                      <a:pt x="718" y="699"/>
                    </a:lnTo>
                    <a:lnTo>
                      <a:pt x="719" y="699"/>
                    </a:lnTo>
                    <a:lnTo>
                      <a:pt x="720" y="699"/>
                    </a:lnTo>
                    <a:lnTo>
                      <a:pt x="721" y="699"/>
                    </a:lnTo>
                    <a:lnTo>
                      <a:pt x="722" y="699"/>
                    </a:lnTo>
                    <a:lnTo>
                      <a:pt x="724" y="699"/>
                    </a:lnTo>
                    <a:lnTo>
                      <a:pt x="725" y="699"/>
                    </a:lnTo>
                    <a:lnTo>
                      <a:pt x="726" y="699"/>
                    </a:lnTo>
                    <a:lnTo>
                      <a:pt x="727" y="699"/>
                    </a:lnTo>
                    <a:lnTo>
                      <a:pt x="729" y="699"/>
                    </a:lnTo>
                    <a:lnTo>
                      <a:pt x="730" y="699"/>
                    </a:lnTo>
                    <a:lnTo>
                      <a:pt x="731" y="699"/>
                    </a:lnTo>
                    <a:lnTo>
                      <a:pt x="733" y="699"/>
                    </a:lnTo>
                    <a:lnTo>
                      <a:pt x="735" y="699"/>
                    </a:lnTo>
                    <a:lnTo>
                      <a:pt x="736" y="699"/>
                    </a:lnTo>
                    <a:lnTo>
                      <a:pt x="737" y="699"/>
                    </a:lnTo>
                    <a:lnTo>
                      <a:pt x="738" y="699"/>
                    </a:lnTo>
                    <a:lnTo>
                      <a:pt x="740" y="699"/>
                    </a:lnTo>
                    <a:lnTo>
                      <a:pt x="741" y="699"/>
                    </a:lnTo>
                    <a:lnTo>
                      <a:pt x="742" y="699"/>
                    </a:lnTo>
                    <a:lnTo>
                      <a:pt x="743" y="699"/>
                    </a:lnTo>
                    <a:lnTo>
                      <a:pt x="745" y="699"/>
                    </a:lnTo>
                    <a:lnTo>
                      <a:pt x="746" y="699"/>
                    </a:lnTo>
                    <a:lnTo>
                      <a:pt x="747" y="699"/>
                    </a:lnTo>
                    <a:lnTo>
                      <a:pt x="748" y="699"/>
                    </a:lnTo>
                    <a:lnTo>
                      <a:pt x="749" y="699"/>
                    </a:lnTo>
                    <a:lnTo>
                      <a:pt x="751" y="699"/>
                    </a:lnTo>
                    <a:lnTo>
                      <a:pt x="752" y="699"/>
                    </a:lnTo>
                    <a:lnTo>
                      <a:pt x="753" y="699"/>
                    </a:lnTo>
                    <a:lnTo>
                      <a:pt x="754" y="699"/>
                    </a:lnTo>
                    <a:lnTo>
                      <a:pt x="756" y="698"/>
                    </a:lnTo>
                    <a:lnTo>
                      <a:pt x="757" y="697"/>
                    </a:lnTo>
                    <a:lnTo>
                      <a:pt x="758" y="697"/>
                    </a:lnTo>
                    <a:lnTo>
                      <a:pt x="759" y="697"/>
                    </a:lnTo>
                    <a:lnTo>
                      <a:pt x="760" y="698"/>
                    </a:lnTo>
                    <a:lnTo>
                      <a:pt x="762" y="694"/>
                    </a:lnTo>
                    <a:lnTo>
                      <a:pt x="763" y="674"/>
                    </a:lnTo>
                    <a:lnTo>
                      <a:pt x="764" y="636"/>
                    </a:lnTo>
                    <a:lnTo>
                      <a:pt x="765" y="603"/>
                    </a:lnTo>
                    <a:lnTo>
                      <a:pt x="767" y="600"/>
                    </a:lnTo>
                    <a:lnTo>
                      <a:pt x="768" y="629"/>
                    </a:lnTo>
                    <a:lnTo>
                      <a:pt x="769" y="669"/>
                    </a:lnTo>
                    <a:lnTo>
                      <a:pt x="770" y="694"/>
                    </a:lnTo>
                    <a:lnTo>
                      <a:pt x="771" y="699"/>
                    </a:lnTo>
                    <a:lnTo>
                      <a:pt x="773" y="699"/>
                    </a:lnTo>
                    <a:lnTo>
                      <a:pt x="774" y="699"/>
                    </a:lnTo>
                    <a:lnTo>
                      <a:pt x="775" y="699"/>
                    </a:lnTo>
                    <a:lnTo>
                      <a:pt x="776" y="699"/>
                    </a:lnTo>
                    <a:lnTo>
                      <a:pt x="778" y="699"/>
                    </a:lnTo>
                    <a:lnTo>
                      <a:pt x="779" y="699"/>
                    </a:lnTo>
                    <a:lnTo>
                      <a:pt x="780" y="699"/>
                    </a:lnTo>
                    <a:lnTo>
                      <a:pt x="781" y="699"/>
                    </a:lnTo>
                    <a:lnTo>
                      <a:pt x="782" y="699"/>
                    </a:lnTo>
                    <a:lnTo>
                      <a:pt x="784" y="699"/>
                    </a:lnTo>
                    <a:lnTo>
                      <a:pt x="785" y="699"/>
                    </a:lnTo>
                    <a:lnTo>
                      <a:pt x="786" y="699"/>
                    </a:lnTo>
                    <a:lnTo>
                      <a:pt x="787" y="699"/>
                    </a:lnTo>
                    <a:lnTo>
                      <a:pt x="789" y="699"/>
                    </a:lnTo>
                    <a:lnTo>
                      <a:pt x="790" y="699"/>
                    </a:lnTo>
                    <a:lnTo>
                      <a:pt x="791" y="699"/>
                    </a:lnTo>
                    <a:lnTo>
                      <a:pt x="792" y="699"/>
                    </a:lnTo>
                    <a:lnTo>
                      <a:pt x="794" y="699"/>
                    </a:lnTo>
                    <a:lnTo>
                      <a:pt x="795" y="699"/>
                    </a:lnTo>
                    <a:lnTo>
                      <a:pt x="796" y="699"/>
                    </a:lnTo>
                    <a:lnTo>
                      <a:pt x="797" y="699"/>
                    </a:lnTo>
                    <a:lnTo>
                      <a:pt x="798" y="699"/>
                    </a:lnTo>
                    <a:lnTo>
                      <a:pt x="800" y="699"/>
                    </a:lnTo>
                    <a:lnTo>
                      <a:pt x="801" y="699"/>
                    </a:lnTo>
                    <a:lnTo>
                      <a:pt x="802" y="699"/>
                    </a:lnTo>
                    <a:lnTo>
                      <a:pt x="803" y="699"/>
                    </a:lnTo>
                    <a:lnTo>
                      <a:pt x="805" y="698"/>
                    </a:lnTo>
                    <a:lnTo>
                      <a:pt x="806" y="698"/>
                    </a:lnTo>
                    <a:lnTo>
                      <a:pt x="807" y="698"/>
                    </a:lnTo>
                    <a:lnTo>
                      <a:pt x="808" y="699"/>
                    </a:lnTo>
                    <a:lnTo>
                      <a:pt x="809" y="699"/>
                    </a:lnTo>
                    <a:lnTo>
                      <a:pt x="811" y="699"/>
                    </a:lnTo>
                    <a:lnTo>
                      <a:pt x="812" y="698"/>
                    </a:lnTo>
                    <a:lnTo>
                      <a:pt x="813" y="698"/>
                    </a:lnTo>
                    <a:lnTo>
                      <a:pt x="814" y="699"/>
                    </a:lnTo>
                    <a:lnTo>
                      <a:pt x="816" y="699"/>
                    </a:lnTo>
                    <a:lnTo>
                      <a:pt x="817" y="699"/>
                    </a:lnTo>
                    <a:lnTo>
                      <a:pt x="818" y="699"/>
                    </a:lnTo>
                    <a:lnTo>
                      <a:pt x="819" y="699"/>
                    </a:lnTo>
                    <a:lnTo>
                      <a:pt x="820" y="699"/>
                    </a:lnTo>
                    <a:lnTo>
                      <a:pt x="822" y="698"/>
                    </a:lnTo>
                    <a:lnTo>
                      <a:pt x="823" y="694"/>
                    </a:lnTo>
                    <a:lnTo>
                      <a:pt x="824" y="689"/>
                    </a:lnTo>
                    <a:lnTo>
                      <a:pt x="825" y="687"/>
                    </a:lnTo>
                    <a:lnTo>
                      <a:pt x="827" y="690"/>
                    </a:lnTo>
                    <a:lnTo>
                      <a:pt x="828" y="694"/>
                    </a:lnTo>
                    <a:lnTo>
                      <a:pt x="829" y="698"/>
                    </a:lnTo>
                    <a:lnTo>
                      <a:pt x="830" y="699"/>
                    </a:lnTo>
                    <a:lnTo>
                      <a:pt x="832" y="699"/>
                    </a:lnTo>
                    <a:lnTo>
                      <a:pt x="833" y="699"/>
                    </a:lnTo>
                    <a:lnTo>
                      <a:pt x="834" y="699"/>
                    </a:lnTo>
                    <a:lnTo>
                      <a:pt x="835" y="699"/>
                    </a:lnTo>
                    <a:lnTo>
                      <a:pt x="836" y="699"/>
                    </a:lnTo>
                    <a:lnTo>
                      <a:pt x="838" y="699"/>
                    </a:lnTo>
                    <a:lnTo>
                      <a:pt x="839" y="699"/>
                    </a:lnTo>
                    <a:lnTo>
                      <a:pt x="840" y="699"/>
                    </a:lnTo>
                    <a:lnTo>
                      <a:pt x="841" y="699"/>
                    </a:lnTo>
                    <a:lnTo>
                      <a:pt x="843" y="699"/>
                    </a:lnTo>
                    <a:lnTo>
                      <a:pt x="844" y="699"/>
                    </a:lnTo>
                    <a:lnTo>
                      <a:pt x="845" y="699"/>
                    </a:lnTo>
                    <a:lnTo>
                      <a:pt x="846" y="699"/>
                    </a:lnTo>
                    <a:lnTo>
                      <a:pt x="847" y="699"/>
                    </a:lnTo>
                    <a:lnTo>
                      <a:pt x="849" y="699"/>
                    </a:lnTo>
                    <a:lnTo>
                      <a:pt x="850" y="699"/>
                    </a:lnTo>
                    <a:lnTo>
                      <a:pt x="851" y="699"/>
                    </a:lnTo>
                    <a:lnTo>
                      <a:pt x="852" y="699"/>
                    </a:lnTo>
                    <a:lnTo>
                      <a:pt x="854" y="699"/>
                    </a:lnTo>
                    <a:lnTo>
                      <a:pt x="855" y="699"/>
                    </a:lnTo>
                    <a:lnTo>
                      <a:pt x="856" y="699"/>
                    </a:lnTo>
                    <a:lnTo>
                      <a:pt x="857" y="699"/>
                    </a:lnTo>
                    <a:lnTo>
                      <a:pt x="859" y="699"/>
                    </a:lnTo>
                    <a:lnTo>
                      <a:pt x="860" y="699"/>
                    </a:lnTo>
                    <a:lnTo>
                      <a:pt x="861" y="699"/>
                    </a:lnTo>
                    <a:lnTo>
                      <a:pt x="862" y="699"/>
                    </a:lnTo>
                    <a:lnTo>
                      <a:pt x="863" y="699"/>
                    </a:lnTo>
                    <a:lnTo>
                      <a:pt x="865" y="699"/>
                    </a:lnTo>
                    <a:lnTo>
                      <a:pt x="866" y="699"/>
                    </a:lnTo>
                    <a:lnTo>
                      <a:pt x="867" y="699"/>
                    </a:lnTo>
                    <a:lnTo>
                      <a:pt x="868" y="698"/>
                    </a:lnTo>
                    <a:lnTo>
                      <a:pt x="870" y="698"/>
                    </a:lnTo>
                    <a:lnTo>
                      <a:pt x="871" y="698"/>
                    </a:lnTo>
                    <a:lnTo>
                      <a:pt x="872" y="698"/>
                    </a:lnTo>
                    <a:lnTo>
                      <a:pt x="873" y="698"/>
                    </a:lnTo>
                    <a:lnTo>
                      <a:pt x="874" y="697"/>
                    </a:lnTo>
                    <a:lnTo>
                      <a:pt x="876" y="695"/>
                    </a:lnTo>
                    <a:lnTo>
                      <a:pt x="877" y="692"/>
                    </a:lnTo>
                    <a:lnTo>
                      <a:pt x="878" y="691"/>
                    </a:lnTo>
                    <a:lnTo>
                      <a:pt x="879" y="691"/>
                    </a:lnTo>
                    <a:lnTo>
                      <a:pt x="881" y="694"/>
                    </a:lnTo>
                    <a:lnTo>
                      <a:pt x="882" y="698"/>
                    </a:lnTo>
                    <a:lnTo>
                      <a:pt x="883" y="698"/>
                    </a:lnTo>
                    <a:lnTo>
                      <a:pt x="884" y="699"/>
                    </a:lnTo>
                    <a:lnTo>
                      <a:pt x="885" y="699"/>
                    </a:lnTo>
                    <a:lnTo>
                      <a:pt x="887" y="699"/>
                    </a:lnTo>
                    <a:lnTo>
                      <a:pt x="888" y="699"/>
                    </a:lnTo>
                    <a:lnTo>
                      <a:pt x="889" y="699"/>
                    </a:lnTo>
                    <a:lnTo>
                      <a:pt x="890" y="699"/>
                    </a:lnTo>
                    <a:lnTo>
                      <a:pt x="892" y="698"/>
                    </a:lnTo>
                    <a:lnTo>
                      <a:pt x="893" y="695"/>
                    </a:lnTo>
                    <a:lnTo>
                      <a:pt x="894" y="693"/>
                    </a:lnTo>
                    <a:lnTo>
                      <a:pt x="895" y="694"/>
                    </a:lnTo>
                    <a:lnTo>
                      <a:pt x="897" y="696"/>
                    </a:lnTo>
                    <a:lnTo>
                      <a:pt x="898" y="698"/>
                    </a:lnTo>
                    <a:lnTo>
                      <a:pt x="899" y="699"/>
                    </a:lnTo>
                    <a:lnTo>
                      <a:pt x="900" y="699"/>
                    </a:lnTo>
                    <a:lnTo>
                      <a:pt x="901" y="699"/>
                    </a:lnTo>
                    <a:lnTo>
                      <a:pt x="903" y="699"/>
                    </a:lnTo>
                    <a:lnTo>
                      <a:pt x="904" y="699"/>
                    </a:lnTo>
                    <a:lnTo>
                      <a:pt x="905" y="699"/>
                    </a:lnTo>
                    <a:lnTo>
                      <a:pt x="906" y="699"/>
                    </a:lnTo>
                    <a:lnTo>
                      <a:pt x="908" y="698"/>
                    </a:lnTo>
                    <a:lnTo>
                      <a:pt x="909" y="696"/>
                    </a:lnTo>
                    <a:lnTo>
                      <a:pt x="910" y="692"/>
                    </a:lnTo>
                    <a:lnTo>
                      <a:pt x="911" y="689"/>
                    </a:lnTo>
                    <a:lnTo>
                      <a:pt x="912" y="690"/>
                    </a:lnTo>
                    <a:lnTo>
                      <a:pt x="914" y="694"/>
                    </a:lnTo>
                    <a:lnTo>
                      <a:pt x="915" y="698"/>
                    </a:lnTo>
                    <a:lnTo>
                      <a:pt x="916" y="699"/>
                    </a:lnTo>
                    <a:lnTo>
                      <a:pt x="917" y="699"/>
                    </a:lnTo>
                    <a:lnTo>
                      <a:pt x="919" y="699"/>
                    </a:lnTo>
                    <a:lnTo>
                      <a:pt x="920" y="699"/>
                    </a:lnTo>
                    <a:lnTo>
                      <a:pt x="921" y="699"/>
                    </a:lnTo>
                    <a:lnTo>
                      <a:pt x="922" y="699"/>
                    </a:lnTo>
                    <a:lnTo>
                      <a:pt x="924" y="699"/>
                    </a:lnTo>
                    <a:lnTo>
                      <a:pt x="925" y="698"/>
                    </a:lnTo>
                    <a:lnTo>
                      <a:pt x="926" y="696"/>
                    </a:lnTo>
                    <a:lnTo>
                      <a:pt x="927" y="695"/>
                    </a:lnTo>
                    <a:lnTo>
                      <a:pt x="928" y="694"/>
                    </a:lnTo>
                    <a:lnTo>
                      <a:pt x="930" y="695"/>
                    </a:lnTo>
                    <a:lnTo>
                      <a:pt x="931" y="697"/>
                    </a:lnTo>
                    <a:lnTo>
                      <a:pt x="932" y="699"/>
                    </a:lnTo>
                    <a:lnTo>
                      <a:pt x="933" y="699"/>
                    </a:lnTo>
                    <a:lnTo>
                      <a:pt x="935" y="699"/>
                    </a:lnTo>
                    <a:lnTo>
                      <a:pt x="936" y="699"/>
                    </a:lnTo>
                    <a:lnTo>
                      <a:pt x="937" y="699"/>
                    </a:lnTo>
                    <a:lnTo>
                      <a:pt x="938" y="699"/>
                    </a:lnTo>
                    <a:lnTo>
                      <a:pt x="940" y="699"/>
                    </a:lnTo>
                    <a:lnTo>
                      <a:pt x="941" y="699"/>
                    </a:lnTo>
                    <a:lnTo>
                      <a:pt x="942" y="697"/>
                    </a:lnTo>
                    <a:lnTo>
                      <a:pt x="943" y="693"/>
                    </a:lnTo>
                    <a:lnTo>
                      <a:pt x="944" y="691"/>
                    </a:lnTo>
                    <a:lnTo>
                      <a:pt x="946" y="691"/>
                    </a:lnTo>
                    <a:lnTo>
                      <a:pt x="947" y="694"/>
                    </a:lnTo>
                    <a:lnTo>
                      <a:pt x="948" y="697"/>
                    </a:lnTo>
                    <a:lnTo>
                      <a:pt x="949" y="699"/>
                    </a:lnTo>
                    <a:lnTo>
                      <a:pt x="951" y="699"/>
                    </a:lnTo>
                    <a:lnTo>
                      <a:pt x="952" y="699"/>
                    </a:lnTo>
                    <a:lnTo>
                      <a:pt x="953" y="699"/>
                    </a:lnTo>
                    <a:lnTo>
                      <a:pt x="954" y="699"/>
                    </a:lnTo>
                    <a:lnTo>
                      <a:pt x="955" y="699"/>
                    </a:lnTo>
                    <a:lnTo>
                      <a:pt x="957" y="699"/>
                    </a:lnTo>
                    <a:lnTo>
                      <a:pt x="958" y="699"/>
                    </a:lnTo>
                    <a:lnTo>
                      <a:pt x="959" y="698"/>
                    </a:lnTo>
                    <a:lnTo>
                      <a:pt x="960" y="696"/>
                    </a:lnTo>
                    <a:lnTo>
                      <a:pt x="962" y="695"/>
                    </a:lnTo>
                    <a:lnTo>
                      <a:pt x="963" y="696"/>
                    </a:lnTo>
                    <a:lnTo>
                      <a:pt x="964" y="697"/>
                    </a:lnTo>
                    <a:lnTo>
                      <a:pt x="965" y="698"/>
                    </a:lnTo>
                    <a:lnTo>
                      <a:pt x="967" y="699"/>
                    </a:lnTo>
                    <a:lnTo>
                      <a:pt x="968" y="699"/>
                    </a:lnTo>
                    <a:lnTo>
                      <a:pt x="969" y="699"/>
                    </a:lnTo>
                    <a:lnTo>
                      <a:pt x="970" y="699"/>
                    </a:lnTo>
                    <a:lnTo>
                      <a:pt x="971" y="699"/>
                    </a:lnTo>
                    <a:lnTo>
                      <a:pt x="973" y="699"/>
                    </a:lnTo>
                    <a:lnTo>
                      <a:pt x="974" y="699"/>
                    </a:lnTo>
                    <a:lnTo>
                      <a:pt x="975" y="699"/>
                    </a:lnTo>
                    <a:lnTo>
                      <a:pt x="976" y="699"/>
                    </a:lnTo>
                    <a:lnTo>
                      <a:pt x="978" y="698"/>
                    </a:lnTo>
                    <a:lnTo>
                      <a:pt x="979" y="698"/>
                    </a:lnTo>
                    <a:lnTo>
                      <a:pt x="980" y="698"/>
                    </a:lnTo>
                    <a:lnTo>
                      <a:pt x="981" y="699"/>
                    </a:lnTo>
                    <a:lnTo>
                      <a:pt x="982" y="699"/>
                    </a:lnTo>
                    <a:lnTo>
                      <a:pt x="984" y="699"/>
                    </a:lnTo>
                    <a:lnTo>
                      <a:pt x="985" y="699"/>
                    </a:lnTo>
                    <a:lnTo>
                      <a:pt x="986" y="699"/>
                    </a:lnTo>
                    <a:lnTo>
                      <a:pt x="987" y="699"/>
                    </a:lnTo>
                    <a:lnTo>
                      <a:pt x="989" y="699"/>
                    </a:lnTo>
                    <a:lnTo>
                      <a:pt x="990" y="699"/>
                    </a:lnTo>
                    <a:lnTo>
                      <a:pt x="991" y="699"/>
                    </a:lnTo>
                    <a:lnTo>
                      <a:pt x="992" y="699"/>
                    </a:lnTo>
                    <a:lnTo>
                      <a:pt x="994" y="698"/>
                    </a:lnTo>
                    <a:lnTo>
                      <a:pt x="995" y="697"/>
                    </a:lnTo>
                    <a:lnTo>
                      <a:pt x="996" y="696"/>
                    </a:lnTo>
                    <a:lnTo>
                      <a:pt x="997" y="696"/>
                    </a:lnTo>
                    <a:lnTo>
                      <a:pt x="998" y="697"/>
                    </a:lnTo>
                    <a:lnTo>
                      <a:pt x="1000" y="698"/>
                    </a:lnTo>
                    <a:lnTo>
                      <a:pt x="1001" y="699"/>
                    </a:lnTo>
                    <a:lnTo>
                      <a:pt x="1002" y="699"/>
                    </a:lnTo>
                    <a:lnTo>
                      <a:pt x="1003" y="699"/>
                    </a:lnTo>
                    <a:lnTo>
                      <a:pt x="1005" y="699"/>
                    </a:lnTo>
                    <a:lnTo>
                      <a:pt x="1006" y="699"/>
                    </a:lnTo>
                    <a:lnTo>
                      <a:pt x="1007" y="699"/>
                    </a:lnTo>
                    <a:lnTo>
                      <a:pt x="1008" y="699"/>
                    </a:lnTo>
                    <a:lnTo>
                      <a:pt x="1010" y="699"/>
                    </a:lnTo>
                    <a:lnTo>
                      <a:pt x="1011" y="699"/>
                    </a:lnTo>
                    <a:lnTo>
                      <a:pt x="1012" y="699"/>
                    </a:lnTo>
                    <a:lnTo>
                      <a:pt x="1013" y="698"/>
                    </a:lnTo>
                    <a:lnTo>
                      <a:pt x="1014" y="698"/>
                    </a:lnTo>
                    <a:lnTo>
                      <a:pt x="1016" y="698"/>
                    </a:lnTo>
                    <a:lnTo>
                      <a:pt x="1017" y="698"/>
                    </a:lnTo>
                    <a:lnTo>
                      <a:pt x="1018" y="698"/>
                    </a:lnTo>
                    <a:lnTo>
                      <a:pt x="1019" y="699"/>
                    </a:lnTo>
                    <a:lnTo>
                      <a:pt x="1021" y="699"/>
                    </a:lnTo>
                    <a:lnTo>
                      <a:pt x="1022" y="699"/>
                    </a:lnTo>
                    <a:lnTo>
                      <a:pt x="1023" y="699"/>
                    </a:lnTo>
                    <a:lnTo>
                      <a:pt x="1024" y="699"/>
                    </a:lnTo>
                    <a:lnTo>
                      <a:pt x="1026" y="699"/>
                    </a:lnTo>
                    <a:lnTo>
                      <a:pt x="1027" y="699"/>
                    </a:lnTo>
                    <a:lnTo>
                      <a:pt x="1028" y="699"/>
                    </a:lnTo>
                    <a:lnTo>
                      <a:pt x="1029" y="699"/>
                    </a:lnTo>
                    <a:lnTo>
                      <a:pt x="1030" y="699"/>
                    </a:lnTo>
                    <a:lnTo>
                      <a:pt x="1032" y="699"/>
                    </a:lnTo>
                    <a:lnTo>
                      <a:pt x="1033" y="699"/>
                    </a:lnTo>
                    <a:lnTo>
                      <a:pt x="1034" y="699"/>
                    </a:lnTo>
                    <a:lnTo>
                      <a:pt x="1035" y="699"/>
                    </a:lnTo>
                    <a:lnTo>
                      <a:pt x="1037" y="699"/>
                    </a:lnTo>
                    <a:lnTo>
                      <a:pt x="1038" y="699"/>
                    </a:lnTo>
                    <a:lnTo>
                      <a:pt x="1039" y="699"/>
                    </a:lnTo>
                    <a:lnTo>
                      <a:pt x="1040" y="699"/>
                    </a:lnTo>
                    <a:lnTo>
                      <a:pt x="1041" y="699"/>
                    </a:lnTo>
                    <a:lnTo>
                      <a:pt x="1043" y="699"/>
                    </a:lnTo>
                    <a:lnTo>
                      <a:pt x="1044" y="699"/>
                    </a:lnTo>
                    <a:lnTo>
                      <a:pt x="1045" y="699"/>
                    </a:lnTo>
                    <a:lnTo>
                      <a:pt x="1046" y="699"/>
                    </a:lnTo>
                    <a:lnTo>
                      <a:pt x="1048" y="699"/>
                    </a:lnTo>
                    <a:lnTo>
                      <a:pt x="1049" y="699"/>
                    </a:lnTo>
                    <a:lnTo>
                      <a:pt x="1050" y="699"/>
                    </a:lnTo>
                    <a:lnTo>
                      <a:pt x="1051" y="699"/>
                    </a:lnTo>
                    <a:lnTo>
                      <a:pt x="1053" y="699"/>
                    </a:lnTo>
                    <a:lnTo>
                      <a:pt x="1054" y="699"/>
                    </a:lnTo>
                    <a:lnTo>
                      <a:pt x="1055" y="699"/>
                    </a:lnTo>
                    <a:lnTo>
                      <a:pt x="1056" y="699"/>
                    </a:lnTo>
                    <a:lnTo>
                      <a:pt x="1057" y="699"/>
                    </a:lnTo>
                    <a:lnTo>
                      <a:pt x="1059" y="699"/>
                    </a:lnTo>
                    <a:lnTo>
                      <a:pt x="1060" y="699"/>
                    </a:lnTo>
                    <a:lnTo>
                      <a:pt x="1061" y="699"/>
                    </a:lnTo>
                    <a:lnTo>
                      <a:pt x="1062" y="699"/>
                    </a:lnTo>
                    <a:lnTo>
                      <a:pt x="1064" y="699"/>
                    </a:lnTo>
                    <a:lnTo>
                      <a:pt x="1065" y="699"/>
                    </a:lnTo>
                    <a:lnTo>
                      <a:pt x="1066" y="699"/>
                    </a:lnTo>
                    <a:lnTo>
                      <a:pt x="1067" y="699"/>
                    </a:lnTo>
                    <a:lnTo>
                      <a:pt x="1069" y="699"/>
                    </a:lnTo>
                    <a:lnTo>
                      <a:pt x="1070" y="699"/>
                    </a:lnTo>
                    <a:lnTo>
                      <a:pt x="1071" y="699"/>
                    </a:lnTo>
                    <a:lnTo>
                      <a:pt x="1072" y="699"/>
                    </a:lnTo>
                    <a:lnTo>
                      <a:pt x="1073" y="699"/>
                    </a:lnTo>
                    <a:lnTo>
                      <a:pt x="1075" y="698"/>
                    </a:lnTo>
                    <a:lnTo>
                      <a:pt x="1076" y="698"/>
                    </a:lnTo>
                    <a:lnTo>
                      <a:pt x="1077" y="699"/>
                    </a:lnTo>
                    <a:lnTo>
                      <a:pt x="1078" y="699"/>
                    </a:lnTo>
                    <a:lnTo>
                      <a:pt x="1080" y="699"/>
                    </a:lnTo>
                    <a:lnTo>
                      <a:pt x="1081" y="699"/>
                    </a:lnTo>
                    <a:lnTo>
                      <a:pt x="1082" y="699"/>
                    </a:lnTo>
                    <a:lnTo>
                      <a:pt x="1083" y="699"/>
                    </a:lnTo>
                    <a:lnTo>
                      <a:pt x="1085" y="699"/>
                    </a:lnTo>
                    <a:lnTo>
                      <a:pt x="1101" y="699"/>
                    </a:lnTo>
                    <a:lnTo>
                      <a:pt x="1102" y="699"/>
                    </a:lnTo>
                    <a:lnTo>
                      <a:pt x="1103" y="699"/>
                    </a:lnTo>
                    <a:lnTo>
                      <a:pt x="1104" y="699"/>
                    </a:lnTo>
                    <a:lnTo>
                      <a:pt x="1105" y="699"/>
                    </a:lnTo>
                    <a:lnTo>
                      <a:pt x="1107" y="699"/>
                    </a:lnTo>
                    <a:lnTo>
                      <a:pt x="1108" y="699"/>
                    </a:lnTo>
                    <a:lnTo>
                      <a:pt x="1109" y="699"/>
                    </a:lnTo>
                    <a:lnTo>
                      <a:pt x="1110" y="698"/>
                    </a:lnTo>
                    <a:lnTo>
                      <a:pt x="1112" y="698"/>
                    </a:lnTo>
                    <a:lnTo>
                      <a:pt x="1113" y="699"/>
                    </a:lnTo>
                    <a:lnTo>
                      <a:pt x="1114" y="698"/>
                    </a:lnTo>
                    <a:lnTo>
                      <a:pt x="1115" y="698"/>
                    </a:lnTo>
                    <a:lnTo>
                      <a:pt x="1117" y="699"/>
                    </a:lnTo>
                    <a:lnTo>
                      <a:pt x="1118" y="699"/>
                    </a:lnTo>
                    <a:lnTo>
                      <a:pt x="1119" y="699"/>
                    </a:lnTo>
                    <a:lnTo>
                      <a:pt x="1120" y="699"/>
                    </a:lnTo>
                    <a:lnTo>
                      <a:pt x="1121" y="699"/>
                    </a:lnTo>
                    <a:lnTo>
                      <a:pt x="1123" y="699"/>
                    </a:lnTo>
                    <a:lnTo>
                      <a:pt x="1124" y="699"/>
                    </a:lnTo>
                    <a:lnTo>
                      <a:pt x="1125" y="699"/>
                    </a:lnTo>
                    <a:lnTo>
                      <a:pt x="1126" y="699"/>
                    </a:lnTo>
                    <a:lnTo>
                      <a:pt x="1128" y="699"/>
                    </a:lnTo>
                    <a:lnTo>
                      <a:pt x="1129" y="699"/>
                    </a:lnTo>
                    <a:lnTo>
                      <a:pt x="1130" y="699"/>
                    </a:lnTo>
                    <a:lnTo>
                      <a:pt x="1131" y="699"/>
                    </a:lnTo>
                    <a:lnTo>
                      <a:pt x="1133" y="699"/>
                    </a:lnTo>
                    <a:lnTo>
                      <a:pt x="1134" y="699"/>
                    </a:lnTo>
                    <a:lnTo>
                      <a:pt x="1135" y="699"/>
                    </a:lnTo>
                    <a:lnTo>
                      <a:pt x="1136" y="699"/>
                    </a:lnTo>
                    <a:lnTo>
                      <a:pt x="1137" y="699"/>
                    </a:lnTo>
                    <a:lnTo>
                      <a:pt x="1140" y="699"/>
                    </a:lnTo>
                    <a:lnTo>
                      <a:pt x="1141" y="699"/>
                    </a:lnTo>
                    <a:lnTo>
                      <a:pt x="1142" y="699"/>
                    </a:lnTo>
                    <a:lnTo>
                      <a:pt x="1144" y="699"/>
                    </a:lnTo>
                    <a:lnTo>
                      <a:pt x="1145" y="699"/>
                    </a:lnTo>
                    <a:lnTo>
                      <a:pt x="1146" y="699"/>
                    </a:lnTo>
                    <a:lnTo>
                      <a:pt x="1147" y="699"/>
                    </a:lnTo>
                    <a:lnTo>
                      <a:pt x="1149" y="699"/>
                    </a:lnTo>
                    <a:lnTo>
                      <a:pt x="1150" y="699"/>
                    </a:lnTo>
                    <a:lnTo>
                      <a:pt x="1151" y="696"/>
                    </a:lnTo>
                    <a:lnTo>
                      <a:pt x="1152" y="693"/>
                    </a:lnTo>
                    <a:lnTo>
                      <a:pt x="1153" y="69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52" name="Line 373"/>
              <p:cNvSpPr>
                <a:spLocks noChangeShapeType="1"/>
              </p:cNvSpPr>
              <p:nvPr/>
            </p:nvSpPr>
            <p:spPr bwMode="auto">
              <a:xfrm flipV="1">
                <a:off x="6981897" y="5800864"/>
                <a:ext cx="34129" cy="117335"/>
              </a:xfrm>
              <a:prstGeom prst="line">
                <a:avLst/>
              </a:prstGeom>
              <a:noFill/>
              <a:ln w="12700" cap="rnd">
                <a:solidFill>
                  <a:srgbClr val="00B0F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53" name="Line 376"/>
              <p:cNvSpPr>
                <a:spLocks noChangeShapeType="1"/>
              </p:cNvSpPr>
              <p:nvPr/>
            </p:nvSpPr>
            <p:spPr bwMode="auto">
              <a:xfrm flipV="1">
                <a:off x="7550149" y="5772741"/>
                <a:ext cx="68261" cy="194672"/>
              </a:xfrm>
              <a:prstGeom prst="line">
                <a:avLst/>
              </a:prstGeom>
              <a:noFill/>
              <a:ln w="12700" cap="rnd">
                <a:solidFill>
                  <a:srgbClr val="00B0F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25850" name="Rectangle 377"/>
            <p:cNvSpPr>
              <a:spLocks noChangeArrowheads="1"/>
            </p:cNvSpPr>
            <p:nvPr/>
          </p:nvSpPr>
          <p:spPr bwMode="auto">
            <a:xfrm rot="-5400000">
              <a:off x="1265485" y="2931263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06.008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851" name="Rectangle 379"/>
            <p:cNvSpPr>
              <a:spLocks noChangeArrowheads="1"/>
            </p:cNvSpPr>
            <p:nvPr/>
          </p:nvSpPr>
          <p:spPr bwMode="auto">
            <a:xfrm rot="-5400000">
              <a:off x="3505757" y="2917573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914.4191</a:t>
              </a:r>
              <a:endParaRPr lang="en-US" sz="700" b="0">
                <a:cs typeface="Arial" charset="0"/>
              </a:endParaRPr>
            </a:p>
          </p:txBody>
        </p:sp>
      </p:grpSp>
      <p:grpSp>
        <p:nvGrpSpPr>
          <p:cNvPr id="25607" name="Group 2"/>
          <p:cNvGrpSpPr>
            <a:grpSpLocks/>
          </p:cNvGrpSpPr>
          <p:nvPr/>
        </p:nvGrpSpPr>
        <p:grpSpPr bwMode="auto">
          <a:xfrm>
            <a:off x="3944943" y="1517650"/>
            <a:ext cx="2760657" cy="2213014"/>
            <a:chOff x="3945183" y="1194751"/>
            <a:chExt cx="2760489" cy="2213670"/>
          </a:xfrm>
        </p:grpSpPr>
        <p:sp>
          <p:nvSpPr>
            <p:cNvPr id="25612" name="Rectangle 73"/>
            <p:cNvSpPr>
              <a:spLocks noChangeArrowheads="1"/>
            </p:cNvSpPr>
            <p:nvPr/>
          </p:nvSpPr>
          <p:spPr bwMode="auto">
            <a:xfrm>
              <a:off x="4216280" y="3223464"/>
              <a:ext cx="4719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3" name="Rectangle 75"/>
            <p:cNvSpPr>
              <a:spLocks noChangeArrowheads="1"/>
            </p:cNvSpPr>
            <p:nvPr/>
          </p:nvSpPr>
          <p:spPr bwMode="auto">
            <a:xfrm>
              <a:off x="4355342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4" name="Rectangle 77"/>
            <p:cNvSpPr>
              <a:spLocks noChangeArrowheads="1"/>
            </p:cNvSpPr>
            <p:nvPr/>
          </p:nvSpPr>
          <p:spPr bwMode="auto">
            <a:xfrm>
              <a:off x="4545289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5" name="Rectangle 79"/>
            <p:cNvSpPr>
              <a:spLocks noChangeArrowheads="1"/>
            </p:cNvSpPr>
            <p:nvPr/>
          </p:nvSpPr>
          <p:spPr bwMode="auto">
            <a:xfrm>
              <a:off x="4734734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7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6" name="Rectangle 81"/>
            <p:cNvSpPr>
              <a:spLocks noChangeArrowheads="1"/>
            </p:cNvSpPr>
            <p:nvPr/>
          </p:nvSpPr>
          <p:spPr bwMode="auto">
            <a:xfrm>
              <a:off x="4924681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8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7" name="Rectangle 83"/>
            <p:cNvSpPr>
              <a:spLocks noChangeArrowheads="1"/>
            </p:cNvSpPr>
            <p:nvPr/>
          </p:nvSpPr>
          <p:spPr bwMode="auto">
            <a:xfrm>
              <a:off x="5116638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8" name="Rectangle 85"/>
            <p:cNvSpPr>
              <a:spLocks noChangeArrowheads="1"/>
            </p:cNvSpPr>
            <p:nvPr/>
          </p:nvSpPr>
          <p:spPr bwMode="auto">
            <a:xfrm>
              <a:off x="5306083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19" name="Rectangle 87"/>
            <p:cNvSpPr>
              <a:spLocks noChangeArrowheads="1"/>
            </p:cNvSpPr>
            <p:nvPr/>
          </p:nvSpPr>
          <p:spPr bwMode="auto">
            <a:xfrm>
              <a:off x="5496031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1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0" name="Rectangle 89"/>
            <p:cNvSpPr>
              <a:spLocks noChangeArrowheads="1"/>
            </p:cNvSpPr>
            <p:nvPr/>
          </p:nvSpPr>
          <p:spPr bwMode="auto">
            <a:xfrm>
              <a:off x="5685475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1" name="Rectangle 91"/>
            <p:cNvSpPr>
              <a:spLocks noChangeArrowheads="1"/>
            </p:cNvSpPr>
            <p:nvPr/>
          </p:nvSpPr>
          <p:spPr bwMode="auto">
            <a:xfrm>
              <a:off x="5877432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3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2" name="Rectangle 93"/>
            <p:cNvSpPr>
              <a:spLocks noChangeArrowheads="1"/>
            </p:cNvSpPr>
            <p:nvPr/>
          </p:nvSpPr>
          <p:spPr bwMode="auto">
            <a:xfrm>
              <a:off x="6067380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3" name="Rectangle 95"/>
            <p:cNvSpPr>
              <a:spLocks noChangeArrowheads="1"/>
            </p:cNvSpPr>
            <p:nvPr/>
          </p:nvSpPr>
          <p:spPr bwMode="auto">
            <a:xfrm>
              <a:off x="6256825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4" name="Rectangle 97"/>
            <p:cNvSpPr>
              <a:spLocks noChangeArrowheads="1"/>
            </p:cNvSpPr>
            <p:nvPr/>
          </p:nvSpPr>
          <p:spPr bwMode="auto">
            <a:xfrm>
              <a:off x="6446772" y="3226026"/>
              <a:ext cx="14908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5" name="Rectangle 98"/>
            <p:cNvSpPr>
              <a:spLocks noChangeArrowheads="1"/>
            </p:cNvSpPr>
            <p:nvPr/>
          </p:nvSpPr>
          <p:spPr bwMode="auto">
            <a:xfrm>
              <a:off x="5376465" y="3285273"/>
              <a:ext cx="171010" cy="1231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000000"/>
                  </a:solidFill>
                  <a:cs typeface="Arial" charset="0"/>
                </a:rPr>
                <a:t>m/z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25626" name="Rectangle 181"/>
            <p:cNvSpPr>
              <a:spLocks noChangeArrowheads="1"/>
            </p:cNvSpPr>
            <p:nvPr/>
          </p:nvSpPr>
          <p:spPr bwMode="auto">
            <a:xfrm>
              <a:off x="4176407" y="3166179"/>
              <a:ext cx="1573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7" name="Rectangle 189"/>
            <p:cNvSpPr>
              <a:spLocks noChangeArrowheads="1"/>
            </p:cNvSpPr>
            <p:nvPr/>
          </p:nvSpPr>
          <p:spPr bwMode="auto">
            <a:xfrm>
              <a:off x="4160677" y="2847087"/>
              <a:ext cx="3146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2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8" name="Rectangle 197"/>
            <p:cNvSpPr>
              <a:spLocks noChangeArrowheads="1"/>
            </p:cNvSpPr>
            <p:nvPr/>
          </p:nvSpPr>
          <p:spPr bwMode="auto">
            <a:xfrm>
              <a:off x="4160677" y="2525484"/>
              <a:ext cx="3146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4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29" name="Rectangle 205"/>
            <p:cNvSpPr>
              <a:spLocks noChangeArrowheads="1"/>
            </p:cNvSpPr>
            <p:nvPr/>
          </p:nvSpPr>
          <p:spPr bwMode="auto">
            <a:xfrm>
              <a:off x="4160677" y="2204382"/>
              <a:ext cx="3146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6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0" name="Rectangle 214"/>
            <p:cNvSpPr>
              <a:spLocks noChangeArrowheads="1"/>
            </p:cNvSpPr>
            <p:nvPr/>
          </p:nvSpPr>
          <p:spPr bwMode="auto">
            <a:xfrm>
              <a:off x="4160677" y="1882778"/>
              <a:ext cx="31460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1" name="Rectangle 222"/>
            <p:cNvSpPr>
              <a:spLocks noChangeArrowheads="1"/>
            </p:cNvSpPr>
            <p:nvPr/>
          </p:nvSpPr>
          <p:spPr bwMode="auto">
            <a:xfrm>
              <a:off x="4144947" y="1561677"/>
              <a:ext cx="47189" cy="34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10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2" name="Rectangle 223"/>
            <p:cNvSpPr>
              <a:spLocks noChangeArrowheads="1"/>
            </p:cNvSpPr>
            <p:nvPr/>
          </p:nvSpPr>
          <p:spPr bwMode="auto">
            <a:xfrm rot="16200000">
              <a:off x="3512863" y="2325993"/>
              <a:ext cx="987743" cy="123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0000"/>
                  </a:solidFill>
                  <a:cs typeface="Arial" charset="0"/>
                </a:rPr>
                <a:t>Relative Abundance</a:t>
              </a:r>
              <a:endParaRPr lang="en-US" sz="800" dirty="0">
                <a:cs typeface="Arial" charset="0"/>
              </a:endParaRPr>
            </a:p>
          </p:txBody>
        </p:sp>
        <p:sp>
          <p:nvSpPr>
            <p:cNvPr id="25633" name="Rectangle 225"/>
            <p:cNvSpPr>
              <a:spLocks noChangeArrowheads="1"/>
            </p:cNvSpPr>
            <p:nvPr/>
          </p:nvSpPr>
          <p:spPr bwMode="auto">
            <a:xfrm rot="-5400000">
              <a:off x="5281752" y="132764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cs typeface="Arial" charset="0"/>
                </a:rPr>
                <a:t>860.4501</a:t>
              </a:r>
              <a:endParaRPr lang="en-US" sz="700">
                <a:cs typeface="Arial" charset="0"/>
              </a:endParaRPr>
            </a:p>
          </p:txBody>
        </p:sp>
        <p:sp>
          <p:nvSpPr>
            <p:cNvPr id="25634" name="Rectangle 227"/>
            <p:cNvSpPr>
              <a:spLocks noChangeArrowheads="1"/>
            </p:cNvSpPr>
            <p:nvPr/>
          </p:nvSpPr>
          <p:spPr bwMode="auto">
            <a:xfrm rot="-5400000">
              <a:off x="4613419" y="1348242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cs typeface="Arial" charset="0"/>
                </a:rPr>
                <a:t>856.9413</a:t>
              </a:r>
              <a:endParaRPr lang="en-US" sz="700">
                <a:cs typeface="Arial" charset="0"/>
              </a:endParaRPr>
            </a:p>
          </p:txBody>
        </p:sp>
        <p:sp>
          <p:nvSpPr>
            <p:cNvPr id="25635" name="Rectangle 229"/>
            <p:cNvSpPr>
              <a:spLocks noChangeArrowheads="1"/>
            </p:cNvSpPr>
            <p:nvPr/>
          </p:nvSpPr>
          <p:spPr bwMode="auto">
            <a:xfrm rot="-5400000">
              <a:off x="5377753" y="1630651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0.9518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6" name="Rectangle 232"/>
            <p:cNvSpPr>
              <a:spLocks noChangeArrowheads="1"/>
            </p:cNvSpPr>
            <p:nvPr/>
          </p:nvSpPr>
          <p:spPr bwMode="auto">
            <a:xfrm rot="-5400000">
              <a:off x="4805422" y="223601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7.944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7" name="Rectangle 235"/>
            <p:cNvSpPr>
              <a:spLocks noChangeArrowheads="1"/>
            </p:cNvSpPr>
            <p:nvPr/>
          </p:nvSpPr>
          <p:spPr bwMode="auto">
            <a:xfrm rot="-5400000">
              <a:off x="5473755" y="2353757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1.452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8" name="Rectangle 238"/>
            <p:cNvSpPr>
              <a:spLocks noChangeArrowheads="1"/>
            </p:cNvSpPr>
            <p:nvPr/>
          </p:nvSpPr>
          <p:spPr bwMode="auto">
            <a:xfrm rot="-5400000">
              <a:off x="4902405" y="2688266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8.4462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39" name="Rectangle 241"/>
            <p:cNvSpPr>
              <a:spLocks noChangeArrowheads="1"/>
            </p:cNvSpPr>
            <p:nvPr/>
          </p:nvSpPr>
          <p:spPr bwMode="auto">
            <a:xfrm rot="-5400000">
              <a:off x="5571903" y="2738516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1.954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0" name="Rectangle 244"/>
            <p:cNvSpPr>
              <a:spLocks noChangeArrowheads="1"/>
            </p:cNvSpPr>
            <p:nvPr/>
          </p:nvSpPr>
          <p:spPr bwMode="auto">
            <a:xfrm rot="-5400000">
              <a:off x="4518400" y="2832987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6.454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1" name="Rectangle 247"/>
            <p:cNvSpPr>
              <a:spLocks noChangeArrowheads="1"/>
            </p:cNvSpPr>
            <p:nvPr/>
          </p:nvSpPr>
          <p:spPr bwMode="auto">
            <a:xfrm rot="-5400000">
              <a:off x="5019604" y="2805280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8.9469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2" name="Rectangle 250"/>
            <p:cNvSpPr>
              <a:spLocks noChangeArrowheads="1"/>
            </p:cNvSpPr>
            <p:nvPr/>
          </p:nvSpPr>
          <p:spPr bwMode="auto">
            <a:xfrm rot="-5400000">
              <a:off x="5185386" y="2863389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9.9490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3" name="Rectangle 253"/>
            <p:cNvSpPr>
              <a:spLocks noChangeArrowheads="1"/>
            </p:cNvSpPr>
            <p:nvPr/>
          </p:nvSpPr>
          <p:spPr bwMode="auto">
            <a:xfrm rot="-5400000">
              <a:off x="4330235" y="2881228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55.4484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4" name="Rectangle 256"/>
            <p:cNvSpPr>
              <a:spLocks noChangeArrowheads="1"/>
            </p:cNvSpPr>
            <p:nvPr/>
          </p:nvSpPr>
          <p:spPr bwMode="auto">
            <a:xfrm rot="-5400000">
              <a:off x="5898327" y="2888926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3.6985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5" name="Rectangle 258"/>
            <p:cNvSpPr>
              <a:spLocks noChangeArrowheads="1"/>
            </p:cNvSpPr>
            <p:nvPr/>
          </p:nvSpPr>
          <p:spPr bwMode="auto">
            <a:xfrm rot="-5400000">
              <a:off x="5666877" y="2902493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2.4541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6" name="Rectangle 261"/>
            <p:cNvSpPr>
              <a:spLocks noChangeArrowheads="1"/>
            </p:cNvSpPr>
            <p:nvPr/>
          </p:nvSpPr>
          <p:spPr bwMode="auto">
            <a:xfrm rot="-5400000">
              <a:off x="6055186" y="2872915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4.3706</a:t>
              </a:r>
              <a:endParaRPr lang="en-US" sz="700" b="0">
                <a:cs typeface="Arial" charset="0"/>
              </a:endParaRPr>
            </a:p>
          </p:txBody>
        </p:sp>
        <p:sp>
          <p:nvSpPr>
            <p:cNvPr id="25647" name="Rectangle 264"/>
            <p:cNvSpPr>
              <a:spLocks noChangeArrowheads="1"/>
            </p:cNvSpPr>
            <p:nvPr/>
          </p:nvSpPr>
          <p:spPr bwMode="auto">
            <a:xfrm rot="-5400000">
              <a:off x="6326965" y="2932644"/>
              <a:ext cx="37350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b="0">
                  <a:solidFill>
                    <a:srgbClr val="000000"/>
                  </a:solidFill>
                  <a:cs typeface="Arial" charset="0"/>
                </a:rPr>
                <a:t>865.9556</a:t>
              </a:r>
              <a:endParaRPr lang="en-US" sz="700" b="0">
                <a:cs typeface="Arial" charset="0"/>
              </a:endParaRPr>
            </a:p>
          </p:txBody>
        </p:sp>
        <p:grpSp>
          <p:nvGrpSpPr>
            <p:cNvPr id="25648" name="Group 379"/>
            <p:cNvGrpSpPr>
              <a:grpSpLocks/>
            </p:cNvGrpSpPr>
            <p:nvPr/>
          </p:nvGrpSpPr>
          <p:grpSpPr bwMode="auto">
            <a:xfrm>
              <a:off x="4192137" y="1586803"/>
              <a:ext cx="2513535" cy="1636662"/>
              <a:chOff x="666750" y="1141413"/>
              <a:chExt cx="7940676" cy="5170488"/>
            </a:xfrm>
          </p:grpSpPr>
          <p:sp>
            <p:nvSpPr>
              <p:cNvPr id="25649" name="Line 19"/>
              <p:cNvSpPr>
                <a:spLocks noChangeShapeType="1"/>
              </p:cNvSpPr>
              <p:nvPr/>
            </p:nvSpPr>
            <p:spPr bwMode="auto">
              <a:xfrm>
                <a:off x="755651" y="6218238"/>
                <a:ext cx="785177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0" name="Line 20"/>
              <p:cNvSpPr>
                <a:spLocks noChangeShapeType="1"/>
              </p:cNvSpPr>
              <p:nvPr/>
            </p:nvSpPr>
            <p:spPr bwMode="auto">
              <a:xfrm>
                <a:off x="9398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1" name="Line 21"/>
              <p:cNvSpPr>
                <a:spLocks noChangeShapeType="1"/>
              </p:cNvSpPr>
              <p:nvPr/>
            </p:nvSpPr>
            <p:spPr bwMode="auto">
              <a:xfrm>
                <a:off x="10620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2" name="Line 22"/>
              <p:cNvSpPr>
                <a:spLocks noChangeShapeType="1"/>
              </p:cNvSpPr>
              <p:nvPr/>
            </p:nvSpPr>
            <p:spPr bwMode="auto">
              <a:xfrm>
                <a:off x="11779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3" name="Line 23"/>
              <p:cNvSpPr>
                <a:spLocks noChangeShapeType="1"/>
              </p:cNvSpPr>
              <p:nvPr/>
            </p:nvSpPr>
            <p:spPr bwMode="auto">
              <a:xfrm>
                <a:off x="13001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4" name="Line 24"/>
              <p:cNvSpPr>
                <a:spLocks noChangeShapeType="1"/>
              </p:cNvSpPr>
              <p:nvPr/>
            </p:nvSpPr>
            <p:spPr bwMode="auto">
              <a:xfrm>
                <a:off x="15382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5" name="Line 25"/>
              <p:cNvSpPr>
                <a:spLocks noChangeShapeType="1"/>
              </p:cNvSpPr>
              <p:nvPr/>
            </p:nvSpPr>
            <p:spPr bwMode="auto">
              <a:xfrm>
                <a:off x="16621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6" name="Line 26"/>
              <p:cNvSpPr>
                <a:spLocks noChangeShapeType="1"/>
              </p:cNvSpPr>
              <p:nvPr/>
            </p:nvSpPr>
            <p:spPr bwMode="auto">
              <a:xfrm>
                <a:off x="17843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7" name="Line 27"/>
              <p:cNvSpPr>
                <a:spLocks noChangeShapeType="1"/>
              </p:cNvSpPr>
              <p:nvPr/>
            </p:nvSpPr>
            <p:spPr bwMode="auto">
              <a:xfrm>
                <a:off x="19002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8" name="Line 28"/>
              <p:cNvSpPr>
                <a:spLocks noChangeShapeType="1"/>
              </p:cNvSpPr>
              <p:nvPr/>
            </p:nvSpPr>
            <p:spPr bwMode="auto">
              <a:xfrm>
                <a:off x="21447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9" name="Line 29"/>
              <p:cNvSpPr>
                <a:spLocks noChangeShapeType="1"/>
              </p:cNvSpPr>
              <p:nvPr/>
            </p:nvSpPr>
            <p:spPr bwMode="auto">
              <a:xfrm>
                <a:off x="22606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0" name="Line 30"/>
              <p:cNvSpPr>
                <a:spLocks noChangeShapeType="1"/>
              </p:cNvSpPr>
              <p:nvPr/>
            </p:nvSpPr>
            <p:spPr bwMode="auto">
              <a:xfrm>
                <a:off x="23828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1" name="Line 31"/>
              <p:cNvSpPr>
                <a:spLocks noChangeShapeType="1"/>
              </p:cNvSpPr>
              <p:nvPr/>
            </p:nvSpPr>
            <p:spPr bwMode="auto">
              <a:xfrm>
                <a:off x="24987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2" name="Line 32"/>
              <p:cNvSpPr>
                <a:spLocks noChangeShapeType="1"/>
              </p:cNvSpPr>
              <p:nvPr/>
            </p:nvSpPr>
            <p:spPr bwMode="auto">
              <a:xfrm>
                <a:off x="27447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3" name="Line 33"/>
              <p:cNvSpPr>
                <a:spLocks noChangeShapeType="1"/>
              </p:cNvSpPr>
              <p:nvPr/>
            </p:nvSpPr>
            <p:spPr bwMode="auto">
              <a:xfrm>
                <a:off x="28606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4" name="Line 34"/>
              <p:cNvSpPr>
                <a:spLocks noChangeShapeType="1"/>
              </p:cNvSpPr>
              <p:nvPr/>
            </p:nvSpPr>
            <p:spPr bwMode="auto">
              <a:xfrm>
                <a:off x="29829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5" name="Line 35"/>
              <p:cNvSpPr>
                <a:spLocks noChangeShapeType="1"/>
              </p:cNvSpPr>
              <p:nvPr/>
            </p:nvSpPr>
            <p:spPr bwMode="auto">
              <a:xfrm>
                <a:off x="31051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6" name="Line 36"/>
              <p:cNvSpPr>
                <a:spLocks noChangeShapeType="1"/>
              </p:cNvSpPr>
              <p:nvPr/>
            </p:nvSpPr>
            <p:spPr bwMode="auto">
              <a:xfrm>
                <a:off x="33432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7" name="Line 37"/>
              <p:cNvSpPr>
                <a:spLocks noChangeShapeType="1"/>
              </p:cNvSpPr>
              <p:nvPr/>
            </p:nvSpPr>
            <p:spPr bwMode="auto">
              <a:xfrm>
                <a:off x="34655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8" name="Line 38"/>
              <p:cNvSpPr>
                <a:spLocks noChangeShapeType="1"/>
              </p:cNvSpPr>
              <p:nvPr/>
            </p:nvSpPr>
            <p:spPr bwMode="auto">
              <a:xfrm>
                <a:off x="35814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9" name="Line 39"/>
              <p:cNvSpPr>
                <a:spLocks noChangeShapeType="1"/>
              </p:cNvSpPr>
              <p:nvPr/>
            </p:nvSpPr>
            <p:spPr bwMode="auto">
              <a:xfrm>
                <a:off x="37052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0" name="Line 40"/>
              <p:cNvSpPr>
                <a:spLocks noChangeShapeType="1"/>
              </p:cNvSpPr>
              <p:nvPr/>
            </p:nvSpPr>
            <p:spPr bwMode="auto">
              <a:xfrm>
                <a:off x="39433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1" name="Line 41"/>
              <p:cNvSpPr>
                <a:spLocks noChangeShapeType="1"/>
              </p:cNvSpPr>
              <p:nvPr/>
            </p:nvSpPr>
            <p:spPr bwMode="auto">
              <a:xfrm>
                <a:off x="40655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2" name="Line 42"/>
              <p:cNvSpPr>
                <a:spLocks noChangeShapeType="1"/>
              </p:cNvSpPr>
              <p:nvPr/>
            </p:nvSpPr>
            <p:spPr bwMode="auto">
              <a:xfrm>
                <a:off x="41878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3" name="Line 43"/>
              <p:cNvSpPr>
                <a:spLocks noChangeShapeType="1"/>
              </p:cNvSpPr>
              <p:nvPr/>
            </p:nvSpPr>
            <p:spPr bwMode="auto">
              <a:xfrm>
                <a:off x="43037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4" name="Line 44"/>
              <p:cNvSpPr>
                <a:spLocks noChangeShapeType="1"/>
              </p:cNvSpPr>
              <p:nvPr/>
            </p:nvSpPr>
            <p:spPr bwMode="auto">
              <a:xfrm>
                <a:off x="45481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5" name="Line 45"/>
              <p:cNvSpPr>
                <a:spLocks noChangeShapeType="1"/>
              </p:cNvSpPr>
              <p:nvPr/>
            </p:nvSpPr>
            <p:spPr bwMode="auto">
              <a:xfrm>
                <a:off x="46640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6" name="Line 46"/>
              <p:cNvSpPr>
                <a:spLocks noChangeShapeType="1"/>
              </p:cNvSpPr>
              <p:nvPr/>
            </p:nvSpPr>
            <p:spPr bwMode="auto">
              <a:xfrm>
                <a:off x="47879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7" name="Line 47"/>
              <p:cNvSpPr>
                <a:spLocks noChangeShapeType="1"/>
              </p:cNvSpPr>
              <p:nvPr/>
            </p:nvSpPr>
            <p:spPr bwMode="auto">
              <a:xfrm>
                <a:off x="49037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8" name="Line 48"/>
              <p:cNvSpPr>
                <a:spLocks noChangeShapeType="1"/>
              </p:cNvSpPr>
              <p:nvPr/>
            </p:nvSpPr>
            <p:spPr bwMode="auto">
              <a:xfrm>
                <a:off x="51482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79" name="Line 49"/>
              <p:cNvSpPr>
                <a:spLocks noChangeShapeType="1"/>
              </p:cNvSpPr>
              <p:nvPr/>
            </p:nvSpPr>
            <p:spPr bwMode="auto">
              <a:xfrm>
                <a:off x="52641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0" name="Line 50"/>
              <p:cNvSpPr>
                <a:spLocks noChangeShapeType="1"/>
              </p:cNvSpPr>
              <p:nvPr/>
            </p:nvSpPr>
            <p:spPr bwMode="auto">
              <a:xfrm>
                <a:off x="53863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1" name="Line 51"/>
              <p:cNvSpPr>
                <a:spLocks noChangeShapeType="1"/>
              </p:cNvSpPr>
              <p:nvPr/>
            </p:nvSpPr>
            <p:spPr bwMode="auto">
              <a:xfrm>
                <a:off x="55086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2" name="Line 52"/>
              <p:cNvSpPr>
                <a:spLocks noChangeShapeType="1"/>
              </p:cNvSpPr>
              <p:nvPr/>
            </p:nvSpPr>
            <p:spPr bwMode="auto">
              <a:xfrm>
                <a:off x="57467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3" name="Line 53"/>
              <p:cNvSpPr>
                <a:spLocks noChangeShapeType="1"/>
              </p:cNvSpPr>
              <p:nvPr/>
            </p:nvSpPr>
            <p:spPr bwMode="auto">
              <a:xfrm>
                <a:off x="58705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4" name="Line 54"/>
              <p:cNvSpPr>
                <a:spLocks noChangeShapeType="1"/>
              </p:cNvSpPr>
              <p:nvPr/>
            </p:nvSpPr>
            <p:spPr bwMode="auto">
              <a:xfrm>
                <a:off x="59864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5" name="Line 55"/>
              <p:cNvSpPr>
                <a:spLocks noChangeShapeType="1"/>
              </p:cNvSpPr>
              <p:nvPr/>
            </p:nvSpPr>
            <p:spPr bwMode="auto">
              <a:xfrm>
                <a:off x="61087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6" name="Line 56"/>
              <p:cNvSpPr>
                <a:spLocks noChangeShapeType="1"/>
              </p:cNvSpPr>
              <p:nvPr/>
            </p:nvSpPr>
            <p:spPr bwMode="auto">
              <a:xfrm>
                <a:off x="63468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7" name="Line 57"/>
              <p:cNvSpPr>
                <a:spLocks noChangeShapeType="1"/>
              </p:cNvSpPr>
              <p:nvPr/>
            </p:nvSpPr>
            <p:spPr bwMode="auto">
              <a:xfrm>
                <a:off x="64690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8" name="Line 58"/>
              <p:cNvSpPr>
                <a:spLocks noChangeShapeType="1"/>
              </p:cNvSpPr>
              <p:nvPr/>
            </p:nvSpPr>
            <p:spPr bwMode="auto">
              <a:xfrm>
                <a:off x="659130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9" name="Line 59"/>
              <p:cNvSpPr>
                <a:spLocks noChangeShapeType="1"/>
              </p:cNvSpPr>
              <p:nvPr/>
            </p:nvSpPr>
            <p:spPr bwMode="auto">
              <a:xfrm>
                <a:off x="67071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0" name="Line 60"/>
              <p:cNvSpPr>
                <a:spLocks noChangeShapeType="1"/>
              </p:cNvSpPr>
              <p:nvPr/>
            </p:nvSpPr>
            <p:spPr bwMode="auto">
              <a:xfrm>
                <a:off x="69532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1" name="Line 61"/>
              <p:cNvSpPr>
                <a:spLocks noChangeShapeType="1"/>
              </p:cNvSpPr>
              <p:nvPr/>
            </p:nvSpPr>
            <p:spPr bwMode="auto">
              <a:xfrm>
                <a:off x="70691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2" name="Line 62"/>
              <p:cNvSpPr>
                <a:spLocks noChangeShapeType="1"/>
              </p:cNvSpPr>
              <p:nvPr/>
            </p:nvSpPr>
            <p:spPr bwMode="auto">
              <a:xfrm>
                <a:off x="71913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3" name="Line 63"/>
              <p:cNvSpPr>
                <a:spLocks noChangeShapeType="1"/>
              </p:cNvSpPr>
              <p:nvPr/>
            </p:nvSpPr>
            <p:spPr bwMode="auto">
              <a:xfrm>
                <a:off x="73072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4" name="Line 64"/>
              <p:cNvSpPr>
                <a:spLocks noChangeShapeType="1"/>
              </p:cNvSpPr>
              <p:nvPr/>
            </p:nvSpPr>
            <p:spPr bwMode="auto">
              <a:xfrm>
                <a:off x="75517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5" name="Line 65"/>
              <p:cNvSpPr>
                <a:spLocks noChangeShapeType="1"/>
              </p:cNvSpPr>
              <p:nvPr/>
            </p:nvSpPr>
            <p:spPr bwMode="auto">
              <a:xfrm>
                <a:off x="766762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6" name="Line 66"/>
              <p:cNvSpPr>
                <a:spLocks noChangeShapeType="1"/>
              </p:cNvSpPr>
              <p:nvPr/>
            </p:nvSpPr>
            <p:spPr bwMode="auto">
              <a:xfrm>
                <a:off x="778986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7" name="Line 67"/>
              <p:cNvSpPr>
                <a:spLocks noChangeShapeType="1"/>
              </p:cNvSpPr>
              <p:nvPr/>
            </p:nvSpPr>
            <p:spPr bwMode="auto">
              <a:xfrm>
                <a:off x="791368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8" name="Line 68"/>
              <p:cNvSpPr>
                <a:spLocks noChangeShapeType="1"/>
              </p:cNvSpPr>
              <p:nvPr/>
            </p:nvSpPr>
            <p:spPr bwMode="auto">
              <a:xfrm>
                <a:off x="8151813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99" name="Line 69"/>
              <p:cNvSpPr>
                <a:spLocks noChangeShapeType="1"/>
              </p:cNvSpPr>
              <p:nvPr/>
            </p:nvSpPr>
            <p:spPr bwMode="auto">
              <a:xfrm>
                <a:off x="8274051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0" name="Line 70"/>
              <p:cNvSpPr>
                <a:spLocks noChangeShapeType="1"/>
              </p:cNvSpPr>
              <p:nvPr/>
            </p:nvSpPr>
            <p:spPr bwMode="auto">
              <a:xfrm>
                <a:off x="8389938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1" name="Line 71"/>
              <p:cNvSpPr>
                <a:spLocks noChangeShapeType="1"/>
              </p:cNvSpPr>
              <p:nvPr/>
            </p:nvSpPr>
            <p:spPr bwMode="auto">
              <a:xfrm>
                <a:off x="8512176" y="6218238"/>
                <a:ext cx="0" cy="650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2" name="Line 72"/>
              <p:cNvSpPr>
                <a:spLocks noChangeShapeType="1"/>
              </p:cNvSpPr>
              <p:nvPr/>
            </p:nvSpPr>
            <p:spPr bwMode="auto">
              <a:xfrm>
                <a:off x="817563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3" name="Line 74"/>
              <p:cNvSpPr>
                <a:spLocks noChangeShapeType="1"/>
              </p:cNvSpPr>
              <p:nvPr/>
            </p:nvSpPr>
            <p:spPr bwMode="auto">
              <a:xfrm>
                <a:off x="1422401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4" name="Line 76"/>
              <p:cNvSpPr>
                <a:spLocks noChangeShapeType="1"/>
              </p:cNvSpPr>
              <p:nvPr/>
            </p:nvSpPr>
            <p:spPr bwMode="auto">
              <a:xfrm>
                <a:off x="2022476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5" name="Line 78"/>
              <p:cNvSpPr>
                <a:spLocks noChangeShapeType="1"/>
              </p:cNvSpPr>
              <p:nvPr/>
            </p:nvSpPr>
            <p:spPr bwMode="auto">
              <a:xfrm>
                <a:off x="2620963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6" name="Line 80"/>
              <p:cNvSpPr>
                <a:spLocks noChangeShapeType="1"/>
              </p:cNvSpPr>
              <p:nvPr/>
            </p:nvSpPr>
            <p:spPr bwMode="auto">
              <a:xfrm>
                <a:off x="3221038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7" name="Line 82"/>
              <p:cNvSpPr>
                <a:spLocks noChangeShapeType="1"/>
              </p:cNvSpPr>
              <p:nvPr/>
            </p:nvSpPr>
            <p:spPr bwMode="auto">
              <a:xfrm>
                <a:off x="3827463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8" name="Line 84"/>
              <p:cNvSpPr>
                <a:spLocks noChangeShapeType="1"/>
              </p:cNvSpPr>
              <p:nvPr/>
            </p:nvSpPr>
            <p:spPr bwMode="auto">
              <a:xfrm>
                <a:off x="4425951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09" name="Line 86"/>
              <p:cNvSpPr>
                <a:spLocks noChangeShapeType="1"/>
              </p:cNvSpPr>
              <p:nvPr/>
            </p:nvSpPr>
            <p:spPr bwMode="auto">
              <a:xfrm>
                <a:off x="5026026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0" name="Line 88"/>
              <p:cNvSpPr>
                <a:spLocks noChangeShapeType="1"/>
              </p:cNvSpPr>
              <p:nvPr/>
            </p:nvSpPr>
            <p:spPr bwMode="auto">
              <a:xfrm>
                <a:off x="5624513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1" name="Line 90"/>
              <p:cNvSpPr>
                <a:spLocks noChangeShapeType="1"/>
              </p:cNvSpPr>
              <p:nvPr/>
            </p:nvSpPr>
            <p:spPr bwMode="auto">
              <a:xfrm>
                <a:off x="6230938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2" name="Line 92"/>
              <p:cNvSpPr>
                <a:spLocks noChangeShapeType="1"/>
              </p:cNvSpPr>
              <p:nvPr/>
            </p:nvSpPr>
            <p:spPr bwMode="auto">
              <a:xfrm>
                <a:off x="6831013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3" name="Line 94"/>
              <p:cNvSpPr>
                <a:spLocks noChangeShapeType="1"/>
              </p:cNvSpPr>
              <p:nvPr/>
            </p:nvSpPr>
            <p:spPr bwMode="auto">
              <a:xfrm>
                <a:off x="7429501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4" name="Line 96"/>
              <p:cNvSpPr>
                <a:spLocks noChangeShapeType="1"/>
              </p:cNvSpPr>
              <p:nvPr/>
            </p:nvSpPr>
            <p:spPr bwMode="auto">
              <a:xfrm>
                <a:off x="8029576" y="6218238"/>
                <a:ext cx="0" cy="93663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5" name="Line 99"/>
              <p:cNvSpPr>
                <a:spLocks noChangeShapeType="1"/>
              </p:cNvSpPr>
              <p:nvPr/>
            </p:nvSpPr>
            <p:spPr bwMode="auto">
              <a:xfrm flipV="1">
                <a:off x="755651" y="1141413"/>
                <a:ext cx="0" cy="506888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6" name="Line 100"/>
              <p:cNvSpPr>
                <a:spLocks noChangeShapeType="1"/>
              </p:cNvSpPr>
              <p:nvPr/>
            </p:nvSpPr>
            <p:spPr bwMode="auto">
              <a:xfrm flipH="1">
                <a:off x="693738" y="6167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7" name="Line 101"/>
              <p:cNvSpPr>
                <a:spLocks noChangeShapeType="1"/>
              </p:cNvSpPr>
              <p:nvPr/>
            </p:nvSpPr>
            <p:spPr bwMode="auto">
              <a:xfrm flipH="1">
                <a:off x="693738" y="6116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8" name="Line 102"/>
              <p:cNvSpPr>
                <a:spLocks noChangeShapeType="1"/>
              </p:cNvSpPr>
              <p:nvPr/>
            </p:nvSpPr>
            <p:spPr bwMode="auto">
              <a:xfrm flipH="1">
                <a:off x="693738" y="6065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9" name="Line 103"/>
              <p:cNvSpPr>
                <a:spLocks noChangeShapeType="1"/>
              </p:cNvSpPr>
              <p:nvPr/>
            </p:nvSpPr>
            <p:spPr bwMode="auto">
              <a:xfrm flipH="1">
                <a:off x="693738" y="6015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0" name="Line 104"/>
              <p:cNvSpPr>
                <a:spLocks noChangeShapeType="1"/>
              </p:cNvSpPr>
              <p:nvPr/>
            </p:nvSpPr>
            <p:spPr bwMode="auto">
              <a:xfrm flipH="1">
                <a:off x="693738" y="5913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1" name="Line 105"/>
              <p:cNvSpPr>
                <a:spLocks noChangeShapeType="1"/>
              </p:cNvSpPr>
              <p:nvPr/>
            </p:nvSpPr>
            <p:spPr bwMode="auto">
              <a:xfrm flipH="1">
                <a:off x="693738" y="5862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2" name="Line 106"/>
              <p:cNvSpPr>
                <a:spLocks noChangeShapeType="1"/>
              </p:cNvSpPr>
              <p:nvPr/>
            </p:nvSpPr>
            <p:spPr bwMode="auto">
              <a:xfrm flipH="1">
                <a:off x="693738" y="5811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3" name="Line 107"/>
              <p:cNvSpPr>
                <a:spLocks noChangeShapeType="1"/>
              </p:cNvSpPr>
              <p:nvPr/>
            </p:nvSpPr>
            <p:spPr bwMode="auto">
              <a:xfrm flipH="1">
                <a:off x="693738" y="5761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4" name="Line 108"/>
              <p:cNvSpPr>
                <a:spLocks noChangeShapeType="1"/>
              </p:cNvSpPr>
              <p:nvPr/>
            </p:nvSpPr>
            <p:spPr bwMode="auto">
              <a:xfrm flipH="1">
                <a:off x="693738" y="5659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5" name="Line 109"/>
              <p:cNvSpPr>
                <a:spLocks noChangeShapeType="1"/>
              </p:cNvSpPr>
              <p:nvPr/>
            </p:nvSpPr>
            <p:spPr bwMode="auto">
              <a:xfrm flipH="1">
                <a:off x="693738" y="5608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6" name="Line 110"/>
              <p:cNvSpPr>
                <a:spLocks noChangeShapeType="1"/>
              </p:cNvSpPr>
              <p:nvPr/>
            </p:nvSpPr>
            <p:spPr bwMode="auto">
              <a:xfrm flipH="1">
                <a:off x="693738" y="5557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7" name="Line 111"/>
              <p:cNvSpPr>
                <a:spLocks noChangeShapeType="1"/>
              </p:cNvSpPr>
              <p:nvPr/>
            </p:nvSpPr>
            <p:spPr bwMode="auto">
              <a:xfrm flipH="1">
                <a:off x="693738" y="5507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8" name="Line 112"/>
              <p:cNvSpPr>
                <a:spLocks noChangeShapeType="1"/>
              </p:cNvSpPr>
              <p:nvPr/>
            </p:nvSpPr>
            <p:spPr bwMode="auto">
              <a:xfrm flipH="1">
                <a:off x="693738" y="5405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9" name="Line 113"/>
              <p:cNvSpPr>
                <a:spLocks noChangeShapeType="1"/>
              </p:cNvSpPr>
              <p:nvPr/>
            </p:nvSpPr>
            <p:spPr bwMode="auto">
              <a:xfrm flipH="1">
                <a:off x="693738" y="5354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0" name="Line 114"/>
              <p:cNvSpPr>
                <a:spLocks noChangeShapeType="1"/>
              </p:cNvSpPr>
              <p:nvPr/>
            </p:nvSpPr>
            <p:spPr bwMode="auto">
              <a:xfrm flipH="1">
                <a:off x="693738" y="5303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1" name="Line 115"/>
              <p:cNvSpPr>
                <a:spLocks noChangeShapeType="1"/>
              </p:cNvSpPr>
              <p:nvPr/>
            </p:nvSpPr>
            <p:spPr bwMode="auto">
              <a:xfrm flipH="1">
                <a:off x="693738" y="5253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2" name="Line 116"/>
              <p:cNvSpPr>
                <a:spLocks noChangeShapeType="1"/>
              </p:cNvSpPr>
              <p:nvPr/>
            </p:nvSpPr>
            <p:spPr bwMode="auto">
              <a:xfrm flipH="1">
                <a:off x="693738" y="5151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3" name="Line 117"/>
              <p:cNvSpPr>
                <a:spLocks noChangeShapeType="1"/>
              </p:cNvSpPr>
              <p:nvPr/>
            </p:nvSpPr>
            <p:spPr bwMode="auto">
              <a:xfrm flipH="1">
                <a:off x="693738" y="5100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4" name="Line 118"/>
              <p:cNvSpPr>
                <a:spLocks noChangeShapeType="1"/>
              </p:cNvSpPr>
              <p:nvPr/>
            </p:nvSpPr>
            <p:spPr bwMode="auto">
              <a:xfrm flipH="1">
                <a:off x="693738" y="5049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5" name="Line 119"/>
              <p:cNvSpPr>
                <a:spLocks noChangeShapeType="1"/>
              </p:cNvSpPr>
              <p:nvPr/>
            </p:nvSpPr>
            <p:spPr bwMode="auto">
              <a:xfrm flipH="1">
                <a:off x="693738" y="4999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6" name="Line 120"/>
              <p:cNvSpPr>
                <a:spLocks noChangeShapeType="1"/>
              </p:cNvSpPr>
              <p:nvPr/>
            </p:nvSpPr>
            <p:spPr bwMode="auto">
              <a:xfrm flipH="1">
                <a:off x="693738" y="4897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7" name="Line 121"/>
              <p:cNvSpPr>
                <a:spLocks noChangeShapeType="1"/>
              </p:cNvSpPr>
              <p:nvPr/>
            </p:nvSpPr>
            <p:spPr bwMode="auto">
              <a:xfrm flipH="1">
                <a:off x="693738" y="4846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8" name="Line 122"/>
              <p:cNvSpPr>
                <a:spLocks noChangeShapeType="1"/>
              </p:cNvSpPr>
              <p:nvPr/>
            </p:nvSpPr>
            <p:spPr bwMode="auto">
              <a:xfrm flipH="1">
                <a:off x="693738" y="4795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39" name="Line 123"/>
              <p:cNvSpPr>
                <a:spLocks noChangeShapeType="1"/>
              </p:cNvSpPr>
              <p:nvPr/>
            </p:nvSpPr>
            <p:spPr bwMode="auto">
              <a:xfrm flipH="1">
                <a:off x="693738" y="4745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0" name="Line 124"/>
              <p:cNvSpPr>
                <a:spLocks noChangeShapeType="1"/>
              </p:cNvSpPr>
              <p:nvPr/>
            </p:nvSpPr>
            <p:spPr bwMode="auto">
              <a:xfrm flipH="1">
                <a:off x="693738" y="4643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1" name="Line 125"/>
              <p:cNvSpPr>
                <a:spLocks noChangeShapeType="1"/>
              </p:cNvSpPr>
              <p:nvPr/>
            </p:nvSpPr>
            <p:spPr bwMode="auto">
              <a:xfrm flipH="1">
                <a:off x="693738" y="4592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2" name="Line 126"/>
              <p:cNvSpPr>
                <a:spLocks noChangeShapeType="1"/>
              </p:cNvSpPr>
              <p:nvPr/>
            </p:nvSpPr>
            <p:spPr bwMode="auto">
              <a:xfrm flipH="1">
                <a:off x="693738" y="4541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3" name="Line 127"/>
              <p:cNvSpPr>
                <a:spLocks noChangeShapeType="1"/>
              </p:cNvSpPr>
              <p:nvPr/>
            </p:nvSpPr>
            <p:spPr bwMode="auto">
              <a:xfrm flipH="1">
                <a:off x="693738" y="4491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4" name="Line 128"/>
              <p:cNvSpPr>
                <a:spLocks noChangeShapeType="1"/>
              </p:cNvSpPr>
              <p:nvPr/>
            </p:nvSpPr>
            <p:spPr bwMode="auto">
              <a:xfrm flipH="1">
                <a:off x="693738" y="4389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5" name="Line 129"/>
              <p:cNvSpPr>
                <a:spLocks noChangeShapeType="1"/>
              </p:cNvSpPr>
              <p:nvPr/>
            </p:nvSpPr>
            <p:spPr bwMode="auto">
              <a:xfrm flipH="1">
                <a:off x="693738" y="4338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6" name="Line 130"/>
              <p:cNvSpPr>
                <a:spLocks noChangeShapeType="1"/>
              </p:cNvSpPr>
              <p:nvPr/>
            </p:nvSpPr>
            <p:spPr bwMode="auto">
              <a:xfrm flipH="1">
                <a:off x="693738" y="4287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7" name="Line 131"/>
              <p:cNvSpPr>
                <a:spLocks noChangeShapeType="1"/>
              </p:cNvSpPr>
              <p:nvPr/>
            </p:nvSpPr>
            <p:spPr bwMode="auto">
              <a:xfrm flipH="1">
                <a:off x="693738" y="4237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8" name="Line 132"/>
              <p:cNvSpPr>
                <a:spLocks noChangeShapeType="1"/>
              </p:cNvSpPr>
              <p:nvPr/>
            </p:nvSpPr>
            <p:spPr bwMode="auto">
              <a:xfrm flipH="1">
                <a:off x="693738" y="41354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9" name="Line 133"/>
              <p:cNvSpPr>
                <a:spLocks noChangeShapeType="1"/>
              </p:cNvSpPr>
              <p:nvPr/>
            </p:nvSpPr>
            <p:spPr bwMode="auto">
              <a:xfrm flipH="1">
                <a:off x="693738" y="40846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0" name="Line 134"/>
              <p:cNvSpPr>
                <a:spLocks noChangeShapeType="1"/>
              </p:cNvSpPr>
              <p:nvPr/>
            </p:nvSpPr>
            <p:spPr bwMode="auto">
              <a:xfrm flipH="1">
                <a:off x="693738" y="40338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1" name="Line 135"/>
              <p:cNvSpPr>
                <a:spLocks noChangeShapeType="1"/>
              </p:cNvSpPr>
              <p:nvPr/>
            </p:nvSpPr>
            <p:spPr bwMode="auto">
              <a:xfrm flipH="1">
                <a:off x="693738" y="3983038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2" name="Line 136"/>
              <p:cNvSpPr>
                <a:spLocks noChangeShapeType="1"/>
              </p:cNvSpPr>
              <p:nvPr/>
            </p:nvSpPr>
            <p:spPr bwMode="auto">
              <a:xfrm flipH="1">
                <a:off x="693738" y="3883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3" name="Line 137"/>
              <p:cNvSpPr>
                <a:spLocks noChangeShapeType="1"/>
              </p:cNvSpPr>
              <p:nvPr/>
            </p:nvSpPr>
            <p:spPr bwMode="auto">
              <a:xfrm flipH="1">
                <a:off x="693738" y="3832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4" name="Line 138"/>
              <p:cNvSpPr>
                <a:spLocks noChangeShapeType="1"/>
              </p:cNvSpPr>
              <p:nvPr/>
            </p:nvSpPr>
            <p:spPr bwMode="auto">
              <a:xfrm flipH="1">
                <a:off x="693738" y="3781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5" name="Line 139"/>
              <p:cNvSpPr>
                <a:spLocks noChangeShapeType="1"/>
              </p:cNvSpPr>
              <p:nvPr/>
            </p:nvSpPr>
            <p:spPr bwMode="auto">
              <a:xfrm flipH="1">
                <a:off x="693738" y="3730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6" name="Line 140"/>
              <p:cNvSpPr>
                <a:spLocks noChangeShapeType="1"/>
              </p:cNvSpPr>
              <p:nvPr/>
            </p:nvSpPr>
            <p:spPr bwMode="auto">
              <a:xfrm flipH="1">
                <a:off x="693738" y="3629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7" name="Line 141"/>
              <p:cNvSpPr>
                <a:spLocks noChangeShapeType="1"/>
              </p:cNvSpPr>
              <p:nvPr/>
            </p:nvSpPr>
            <p:spPr bwMode="auto">
              <a:xfrm flipH="1">
                <a:off x="693738" y="3578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8" name="Line 142"/>
              <p:cNvSpPr>
                <a:spLocks noChangeShapeType="1"/>
              </p:cNvSpPr>
              <p:nvPr/>
            </p:nvSpPr>
            <p:spPr bwMode="auto">
              <a:xfrm flipH="1">
                <a:off x="693738" y="3527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59" name="Line 143"/>
              <p:cNvSpPr>
                <a:spLocks noChangeShapeType="1"/>
              </p:cNvSpPr>
              <p:nvPr/>
            </p:nvSpPr>
            <p:spPr bwMode="auto">
              <a:xfrm flipH="1">
                <a:off x="693738" y="3476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0" name="Line 144"/>
              <p:cNvSpPr>
                <a:spLocks noChangeShapeType="1"/>
              </p:cNvSpPr>
              <p:nvPr/>
            </p:nvSpPr>
            <p:spPr bwMode="auto">
              <a:xfrm flipH="1">
                <a:off x="693738" y="3375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1" name="Line 145"/>
              <p:cNvSpPr>
                <a:spLocks noChangeShapeType="1"/>
              </p:cNvSpPr>
              <p:nvPr/>
            </p:nvSpPr>
            <p:spPr bwMode="auto">
              <a:xfrm flipH="1">
                <a:off x="693738" y="3324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2" name="Line 146"/>
              <p:cNvSpPr>
                <a:spLocks noChangeShapeType="1"/>
              </p:cNvSpPr>
              <p:nvPr/>
            </p:nvSpPr>
            <p:spPr bwMode="auto">
              <a:xfrm flipH="1">
                <a:off x="693738" y="3273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3" name="Line 147"/>
              <p:cNvSpPr>
                <a:spLocks noChangeShapeType="1"/>
              </p:cNvSpPr>
              <p:nvPr/>
            </p:nvSpPr>
            <p:spPr bwMode="auto">
              <a:xfrm flipH="1">
                <a:off x="693738" y="3222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4" name="Line 148"/>
              <p:cNvSpPr>
                <a:spLocks noChangeShapeType="1"/>
              </p:cNvSpPr>
              <p:nvPr/>
            </p:nvSpPr>
            <p:spPr bwMode="auto">
              <a:xfrm flipH="1">
                <a:off x="693738" y="3121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5" name="Line 149"/>
              <p:cNvSpPr>
                <a:spLocks noChangeShapeType="1"/>
              </p:cNvSpPr>
              <p:nvPr/>
            </p:nvSpPr>
            <p:spPr bwMode="auto">
              <a:xfrm flipH="1">
                <a:off x="693738" y="3070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6" name="Line 150"/>
              <p:cNvSpPr>
                <a:spLocks noChangeShapeType="1"/>
              </p:cNvSpPr>
              <p:nvPr/>
            </p:nvSpPr>
            <p:spPr bwMode="auto">
              <a:xfrm flipH="1">
                <a:off x="693738" y="3019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7" name="Line 151"/>
              <p:cNvSpPr>
                <a:spLocks noChangeShapeType="1"/>
              </p:cNvSpPr>
              <p:nvPr/>
            </p:nvSpPr>
            <p:spPr bwMode="auto">
              <a:xfrm flipH="1">
                <a:off x="693738" y="2968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8" name="Line 152"/>
              <p:cNvSpPr>
                <a:spLocks noChangeShapeType="1"/>
              </p:cNvSpPr>
              <p:nvPr/>
            </p:nvSpPr>
            <p:spPr bwMode="auto">
              <a:xfrm flipH="1">
                <a:off x="693738" y="2867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69" name="Line 153"/>
              <p:cNvSpPr>
                <a:spLocks noChangeShapeType="1"/>
              </p:cNvSpPr>
              <p:nvPr/>
            </p:nvSpPr>
            <p:spPr bwMode="auto">
              <a:xfrm flipH="1">
                <a:off x="693738" y="2816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0" name="Line 154"/>
              <p:cNvSpPr>
                <a:spLocks noChangeShapeType="1"/>
              </p:cNvSpPr>
              <p:nvPr/>
            </p:nvSpPr>
            <p:spPr bwMode="auto">
              <a:xfrm flipH="1">
                <a:off x="693738" y="2765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1" name="Line 155"/>
              <p:cNvSpPr>
                <a:spLocks noChangeShapeType="1"/>
              </p:cNvSpPr>
              <p:nvPr/>
            </p:nvSpPr>
            <p:spPr bwMode="auto">
              <a:xfrm flipH="1">
                <a:off x="693738" y="2714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2" name="Line 156"/>
              <p:cNvSpPr>
                <a:spLocks noChangeShapeType="1"/>
              </p:cNvSpPr>
              <p:nvPr/>
            </p:nvSpPr>
            <p:spPr bwMode="auto">
              <a:xfrm flipH="1">
                <a:off x="693738" y="2613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3" name="Line 157"/>
              <p:cNvSpPr>
                <a:spLocks noChangeShapeType="1"/>
              </p:cNvSpPr>
              <p:nvPr/>
            </p:nvSpPr>
            <p:spPr bwMode="auto">
              <a:xfrm flipH="1">
                <a:off x="693738" y="2562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4" name="Line 158"/>
              <p:cNvSpPr>
                <a:spLocks noChangeShapeType="1"/>
              </p:cNvSpPr>
              <p:nvPr/>
            </p:nvSpPr>
            <p:spPr bwMode="auto">
              <a:xfrm flipH="1">
                <a:off x="693738" y="2511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5" name="Line 159"/>
              <p:cNvSpPr>
                <a:spLocks noChangeShapeType="1"/>
              </p:cNvSpPr>
              <p:nvPr/>
            </p:nvSpPr>
            <p:spPr bwMode="auto">
              <a:xfrm flipH="1">
                <a:off x="693738" y="2460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6" name="Line 160"/>
              <p:cNvSpPr>
                <a:spLocks noChangeShapeType="1"/>
              </p:cNvSpPr>
              <p:nvPr/>
            </p:nvSpPr>
            <p:spPr bwMode="auto">
              <a:xfrm flipH="1">
                <a:off x="693738" y="2359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7" name="Line 161"/>
              <p:cNvSpPr>
                <a:spLocks noChangeShapeType="1"/>
              </p:cNvSpPr>
              <p:nvPr/>
            </p:nvSpPr>
            <p:spPr bwMode="auto">
              <a:xfrm flipH="1">
                <a:off x="693738" y="2308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8" name="Line 162"/>
              <p:cNvSpPr>
                <a:spLocks noChangeShapeType="1"/>
              </p:cNvSpPr>
              <p:nvPr/>
            </p:nvSpPr>
            <p:spPr bwMode="auto">
              <a:xfrm flipH="1">
                <a:off x="693738" y="2257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9" name="Line 163"/>
              <p:cNvSpPr>
                <a:spLocks noChangeShapeType="1"/>
              </p:cNvSpPr>
              <p:nvPr/>
            </p:nvSpPr>
            <p:spPr bwMode="auto">
              <a:xfrm flipH="1">
                <a:off x="693738" y="2206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0" name="Line 164"/>
              <p:cNvSpPr>
                <a:spLocks noChangeShapeType="1"/>
              </p:cNvSpPr>
              <p:nvPr/>
            </p:nvSpPr>
            <p:spPr bwMode="auto">
              <a:xfrm flipH="1">
                <a:off x="693738" y="2105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1" name="Line 165"/>
              <p:cNvSpPr>
                <a:spLocks noChangeShapeType="1"/>
              </p:cNvSpPr>
              <p:nvPr/>
            </p:nvSpPr>
            <p:spPr bwMode="auto">
              <a:xfrm flipH="1">
                <a:off x="693738" y="2054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2" name="Line 166"/>
              <p:cNvSpPr>
                <a:spLocks noChangeShapeType="1"/>
              </p:cNvSpPr>
              <p:nvPr/>
            </p:nvSpPr>
            <p:spPr bwMode="auto">
              <a:xfrm flipH="1">
                <a:off x="693738" y="2003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3" name="Line 167"/>
              <p:cNvSpPr>
                <a:spLocks noChangeShapeType="1"/>
              </p:cNvSpPr>
              <p:nvPr/>
            </p:nvSpPr>
            <p:spPr bwMode="auto">
              <a:xfrm flipH="1">
                <a:off x="693738" y="1952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4" name="Line 168"/>
              <p:cNvSpPr>
                <a:spLocks noChangeShapeType="1"/>
              </p:cNvSpPr>
              <p:nvPr/>
            </p:nvSpPr>
            <p:spPr bwMode="auto">
              <a:xfrm flipH="1">
                <a:off x="693738" y="1851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5" name="Line 169"/>
              <p:cNvSpPr>
                <a:spLocks noChangeShapeType="1"/>
              </p:cNvSpPr>
              <p:nvPr/>
            </p:nvSpPr>
            <p:spPr bwMode="auto">
              <a:xfrm flipH="1">
                <a:off x="693738" y="1800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6" name="Line 170"/>
              <p:cNvSpPr>
                <a:spLocks noChangeShapeType="1"/>
              </p:cNvSpPr>
              <p:nvPr/>
            </p:nvSpPr>
            <p:spPr bwMode="auto">
              <a:xfrm flipH="1">
                <a:off x="693738" y="1749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7" name="Line 171"/>
              <p:cNvSpPr>
                <a:spLocks noChangeShapeType="1"/>
              </p:cNvSpPr>
              <p:nvPr/>
            </p:nvSpPr>
            <p:spPr bwMode="auto">
              <a:xfrm flipH="1">
                <a:off x="693738" y="1698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8" name="Line 172"/>
              <p:cNvSpPr>
                <a:spLocks noChangeShapeType="1"/>
              </p:cNvSpPr>
              <p:nvPr/>
            </p:nvSpPr>
            <p:spPr bwMode="auto">
              <a:xfrm flipH="1">
                <a:off x="693738" y="15970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9" name="Line 173"/>
              <p:cNvSpPr>
                <a:spLocks noChangeShapeType="1"/>
              </p:cNvSpPr>
              <p:nvPr/>
            </p:nvSpPr>
            <p:spPr bwMode="auto">
              <a:xfrm flipH="1">
                <a:off x="693738" y="15462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0" name="Line 174"/>
              <p:cNvSpPr>
                <a:spLocks noChangeShapeType="1"/>
              </p:cNvSpPr>
              <p:nvPr/>
            </p:nvSpPr>
            <p:spPr bwMode="auto">
              <a:xfrm flipH="1">
                <a:off x="693738" y="14954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1" name="Line 175"/>
              <p:cNvSpPr>
                <a:spLocks noChangeShapeType="1"/>
              </p:cNvSpPr>
              <p:nvPr/>
            </p:nvSpPr>
            <p:spPr bwMode="auto">
              <a:xfrm flipH="1">
                <a:off x="693738" y="1444626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2" name="Line 176"/>
              <p:cNvSpPr>
                <a:spLocks noChangeShapeType="1"/>
              </p:cNvSpPr>
              <p:nvPr/>
            </p:nvSpPr>
            <p:spPr bwMode="auto">
              <a:xfrm flipH="1">
                <a:off x="693738" y="1344613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3" name="Line 177"/>
              <p:cNvSpPr>
                <a:spLocks noChangeShapeType="1"/>
              </p:cNvSpPr>
              <p:nvPr/>
            </p:nvSpPr>
            <p:spPr bwMode="auto">
              <a:xfrm flipH="1">
                <a:off x="693738" y="1293813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4" name="Line 178"/>
              <p:cNvSpPr>
                <a:spLocks noChangeShapeType="1"/>
              </p:cNvSpPr>
              <p:nvPr/>
            </p:nvSpPr>
            <p:spPr bwMode="auto">
              <a:xfrm flipH="1">
                <a:off x="693738" y="1243013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5" name="Line 179"/>
              <p:cNvSpPr>
                <a:spLocks noChangeShapeType="1"/>
              </p:cNvSpPr>
              <p:nvPr/>
            </p:nvSpPr>
            <p:spPr bwMode="auto">
              <a:xfrm flipH="1">
                <a:off x="693738" y="1192213"/>
                <a:ext cx="6191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6" name="Line 180"/>
              <p:cNvSpPr>
                <a:spLocks noChangeShapeType="1"/>
              </p:cNvSpPr>
              <p:nvPr/>
            </p:nvSpPr>
            <p:spPr bwMode="auto">
              <a:xfrm flipH="1">
                <a:off x="666751" y="6210301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7" name="Line 182"/>
              <p:cNvSpPr>
                <a:spLocks noChangeShapeType="1"/>
              </p:cNvSpPr>
              <p:nvPr/>
            </p:nvSpPr>
            <p:spPr bwMode="auto">
              <a:xfrm flipH="1">
                <a:off x="666751" y="5964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8" name="Line 184"/>
              <p:cNvSpPr>
                <a:spLocks noChangeShapeType="1"/>
              </p:cNvSpPr>
              <p:nvPr/>
            </p:nvSpPr>
            <p:spPr bwMode="auto">
              <a:xfrm flipH="1">
                <a:off x="666751" y="5710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99" name="Line 186"/>
              <p:cNvSpPr>
                <a:spLocks noChangeShapeType="1"/>
              </p:cNvSpPr>
              <p:nvPr/>
            </p:nvSpPr>
            <p:spPr bwMode="auto">
              <a:xfrm flipH="1">
                <a:off x="666751" y="5456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0" name="Line 188"/>
              <p:cNvSpPr>
                <a:spLocks noChangeShapeType="1"/>
              </p:cNvSpPr>
              <p:nvPr/>
            </p:nvSpPr>
            <p:spPr bwMode="auto">
              <a:xfrm flipH="1">
                <a:off x="666751" y="5202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1" name="Line 190"/>
              <p:cNvSpPr>
                <a:spLocks noChangeShapeType="1"/>
              </p:cNvSpPr>
              <p:nvPr/>
            </p:nvSpPr>
            <p:spPr bwMode="auto">
              <a:xfrm flipH="1">
                <a:off x="666751" y="4948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2" name="Line 192"/>
              <p:cNvSpPr>
                <a:spLocks noChangeShapeType="1"/>
              </p:cNvSpPr>
              <p:nvPr/>
            </p:nvSpPr>
            <p:spPr bwMode="auto">
              <a:xfrm flipH="1">
                <a:off x="666751" y="4694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3" name="Line 194"/>
              <p:cNvSpPr>
                <a:spLocks noChangeShapeType="1"/>
              </p:cNvSpPr>
              <p:nvPr/>
            </p:nvSpPr>
            <p:spPr bwMode="auto">
              <a:xfrm flipH="1">
                <a:off x="666751" y="4440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4" name="Line 196"/>
              <p:cNvSpPr>
                <a:spLocks noChangeShapeType="1"/>
              </p:cNvSpPr>
              <p:nvPr/>
            </p:nvSpPr>
            <p:spPr bwMode="auto">
              <a:xfrm flipH="1">
                <a:off x="666751" y="4186238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5" name="Line 198"/>
              <p:cNvSpPr>
                <a:spLocks noChangeShapeType="1"/>
              </p:cNvSpPr>
              <p:nvPr/>
            </p:nvSpPr>
            <p:spPr bwMode="auto">
              <a:xfrm flipH="1">
                <a:off x="666751" y="3933826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6" name="Line 200"/>
              <p:cNvSpPr>
                <a:spLocks noChangeShapeType="1"/>
              </p:cNvSpPr>
              <p:nvPr/>
            </p:nvSpPr>
            <p:spPr bwMode="auto">
              <a:xfrm flipH="1">
                <a:off x="666751" y="3679826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7" name="Line 202"/>
              <p:cNvSpPr>
                <a:spLocks noChangeShapeType="1"/>
              </p:cNvSpPr>
              <p:nvPr/>
            </p:nvSpPr>
            <p:spPr bwMode="auto">
              <a:xfrm flipH="1">
                <a:off x="666751" y="3425826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8" name="Line 204"/>
              <p:cNvSpPr>
                <a:spLocks noChangeShapeType="1"/>
              </p:cNvSpPr>
              <p:nvPr/>
            </p:nvSpPr>
            <p:spPr bwMode="auto">
              <a:xfrm flipH="1">
                <a:off x="666751" y="3171826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9" name="Line 206"/>
              <p:cNvSpPr>
                <a:spLocks noChangeShapeType="1"/>
              </p:cNvSpPr>
              <p:nvPr/>
            </p:nvSpPr>
            <p:spPr bwMode="auto">
              <a:xfrm flipH="1">
                <a:off x="666751" y="2917826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0" name="Line 209"/>
              <p:cNvSpPr>
                <a:spLocks noChangeShapeType="1"/>
              </p:cNvSpPr>
              <p:nvPr/>
            </p:nvSpPr>
            <p:spPr bwMode="auto">
              <a:xfrm flipH="1">
                <a:off x="666750" y="2663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1" name="Line 211"/>
              <p:cNvSpPr>
                <a:spLocks noChangeShapeType="1"/>
              </p:cNvSpPr>
              <p:nvPr/>
            </p:nvSpPr>
            <p:spPr bwMode="auto">
              <a:xfrm flipH="1">
                <a:off x="666750" y="2409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2" name="Line 213"/>
              <p:cNvSpPr>
                <a:spLocks noChangeShapeType="1"/>
              </p:cNvSpPr>
              <p:nvPr/>
            </p:nvSpPr>
            <p:spPr bwMode="auto">
              <a:xfrm flipH="1">
                <a:off x="666750" y="2155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3" name="Line 215"/>
              <p:cNvSpPr>
                <a:spLocks noChangeShapeType="1"/>
              </p:cNvSpPr>
              <p:nvPr/>
            </p:nvSpPr>
            <p:spPr bwMode="auto">
              <a:xfrm flipH="1">
                <a:off x="666750" y="1901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4" name="Line 217"/>
              <p:cNvSpPr>
                <a:spLocks noChangeShapeType="1"/>
              </p:cNvSpPr>
              <p:nvPr/>
            </p:nvSpPr>
            <p:spPr bwMode="auto">
              <a:xfrm flipH="1">
                <a:off x="666750" y="1647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5" name="Line 219"/>
              <p:cNvSpPr>
                <a:spLocks noChangeShapeType="1"/>
              </p:cNvSpPr>
              <p:nvPr/>
            </p:nvSpPr>
            <p:spPr bwMode="auto">
              <a:xfrm flipH="1">
                <a:off x="666750" y="1393825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6" name="Line 221"/>
              <p:cNvSpPr>
                <a:spLocks noChangeShapeType="1"/>
              </p:cNvSpPr>
              <p:nvPr/>
            </p:nvSpPr>
            <p:spPr bwMode="auto">
              <a:xfrm flipH="1">
                <a:off x="666750" y="1141413"/>
                <a:ext cx="8890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7" name="Freeform 224"/>
              <p:cNvSpPr>
                <a:spLocks/>
              </p:cNvSpPr>
              <p:nvPr/>
            </p:nvSpPr>
            <p:spPr bwMode="auto">
              <a:xfrm>
                <a:off x="755650" y="1141413"/>
                <a:ext cx="7851775" cy="5068888"/>
              </a:xfrm>
              <a:custGeom>
                <a:avLst/>
                <a:gdLst>
                  <a:gd name="T0" fmla="*/ 2147483647 w 1153"/>
                  <a:gd name="T1" fmla="*/ 2147483647 h 699"/>
                  <a:gd name="T2" fmla="*/ 2147483647 w 1153"/>
                  <a:gd name="T3" fmla="*/ 2147483647 h 699"/>
                  <a:gd name="T4" fmla="*/ 2147483647 w 1153"/>
                  <a:gd name="T5" fmla="*/ 2147483647 h 699"/>
                  <a:gd name="T6" fmla="*/ 2147483647 w 1153"/>
                  <a:gd name="T7" fmla="*/ 2147483647 h 699"/>
                  <a:gd name="T8" fmla="*/ 2147483647 w 1153"/>
                  <a:gd name="T9" fmla="*/ 2147483647 h 699"/>
                  <a:gd name="T10" fmla="*/ 2147483647 w 1153"/>
                  <a:gd name="T11" fmla="*/ 2147483647 h 699"/>
                  <a:gd name="T12" fmla="*/ 2147483647 w 1153"/>
                  <a:gd name="T13" fmla="*/ 2147483647 h 699"/>
                  <a:gd name="T14" fmla="*/ 2147483647 w 1153"/>
                  <a:gd name="T15" fmla="*/ 2147483647 h 699"/>
                  <a:gd name="T16" fmla="*/ 2147483647 w 1153"/>
                  <a:gd name="T17" fmla="*/ 2147483647 h 699"/>
                  <a:gd name="T18" fmla="*/ 2147483647 w 1153"/>
                  <a:gd name="T19" fmla="*/ 2147483647 h 699"/>
                  <a:gd name="T20" fmla="*/ 2147483647 w 1153"/>
                  <a:gd name="T21" fmla="*/ 2147483647 h 699"/>
                  <a:gd name="T22" fmla="*/ 2147483647 w 1153"/>
                  <a:gd name="T23" fmla="*/ 2147483647 h 699"/>
                  <a:gd name="T24" fmla="*/ 2147483647 w 1153"/>
                  <a:gd name="T25" fmla="*/ 2147483647 h 699"/>
                  <a:gd name="T26" fmla="*/ 2147483647 w 1153"/>
                  <a:gd name="T27" fmla="*/ 2147483647 h 699"/>
                  <a:gd name="T28" fmla="*/ 2147483647 w 1153"/>
                  <a:gd name="T29" fmla="*/ 2147483647 h 699"/>
                  <a:gd name="T30" fmla="*/ 2147483647 w 1153"/>
                  <a:gd name="T31" fmla="*/ 2147483647 h 699"/>
                  <a:gd name="T32" fmla="*/ 2147483647 w 1153"/>
                  <a:gd name="T33" fmla="*/ 2147483647 h 699"/>
                  <a:gd name="T34" fmla="*/ 2147483647 w 1153"/>
                  <a:gd name="T35" fmla="*/ 2147483647 h 699"/>
                  <a:gd name="T36" fmla="*/ 2147483647 w 1153"/>
                  <a:gd name="T37" fmla="*/ 2147483647 h 699"/>
                  <a:gd name="T38" fmla="*/ 2147483647 w 1153"/>
                  <a:gd name="T39" fmla="*/ 2147483647 h 699"/>
                  <a:gd name="T40" fmla="*/ 2147483647 w 1153"/>
                  <a:gd name="T41" fmla="*/ 2147483647 h 699"/>
                  <a:gd name="T42" fmla="*/ 2147483647 w 1153"/>
                  <a:gd name="T43" fmla="*/ 2147483647 h 699"/>
                  <a:gd name="T44" fmla="*/ 2147483647 w 1153"/>
                  <a:gd name="T45" fmla="*/ 2147483647 h 699"/>
                  <a:gd name="T46" fmla="*/ 2147483647 w 1153"/>
                  <a:gd name="T47" fmla="*/ 2147483647 h 699"/>
                  <a:gd name="T48" fmla="*/ 2147483647 w 1153"/>
                  <a:gd name="T49" fmla="*/ 2147483647 h 699"/>
                  <a:gd name="T50" fmla="*/ 2147483647 w 1153"/>
                  <a:gd name="T51" fmla="*/ 2147483647 h 699"/>
                  <a:gd name="T52" fmla="*/ 2147483647 w 1153"/>
                  <a:gd name="T53" fmla="*/ 2147483647 h 699"/>
                  <a:gd name="T54" fmla="*/ 2147483647 w 1153"/>
                  <a:gd name="T55" fmla="*/ 2147483647 h 699"/>
                  <a:gd name="T56" fmla="*/ 2147483647 w 1153"/>
                  <a:gd name="T57" fmla="*/ 2147483647 h 699"/>
                  <a:gd name="T58" fmla="*/ 2147483647 w 1153"/>
                  <a:gd name="T59" fmla="*/ 2147483647 h 699"/>
                  <a:gd name="T60" fmla="*/ 2147483647 w 1153"/>
                  <a:gd name="T61" fmla="*/ 2147483647 h 699"/>
                  <a:gd name="T62" fmla="*/ 2147483647 w 1153"/>
                  <a:gd name="T63" fmla="*/ 2147483647 h 699"/>
                  <a:gd name="T64" fmla="*/ 2147483647 w 1153"/>
                  <a:gd name="T65" fmla="*/ 2147483647 h 699"/>
                  <a:gd name="T66" fmla="*/ 2147483647 w 1153"/>
                  <a:gd name="T67" fmla="*/ 2147483647 h 699"/>
                  <a:gd name="T68" fmla="*/ 2147483647 w 1153"/>
                  <a:gd name="T69" fmla="*/ 2147483647 h 699"/>
                  <a:gd name="T70" fmla="*/ 2147483647 w 1153"/>
                  <a:gd name="T71" fmla="*/ 2147483647 h 699"/>
                  <a:gd name="T72" fmla="*/ 2147483647 w 1153"/>
                  <a:gd name="T73" fmla="*/ 2147483647 h 699"/>
                  <a:gd name="T74" fmla="*/ 2147483647 w 1153"/>
                  <a:gd name="T75" fmla="*/ 2147483647 h 699"/>
                  <a:gd name="T76" fmla="*/ 2147483647 w 1153"/>
                  <a:gd name="T77" fmla="*/ 2147483647 h 699"/>
                  <a:gd name="T78" fmla="*/ 2147483647 w 1153"/>
                  <a:gd name="T79" fmla="*/ 2147483647 h 699"/>
                  <a:gd name="T80" fmla="*/ 2147483647 w 1153"/>
                  <a:gd name="T81" fmla="*/ 2147483647 h 699"/>
                  <a:gd name="T82" fmla="*/ 2147483647 w 1153"/>
                  <a:gd name="T83" fmla="*/ 2147483647 h 699"/>
                  <a:gd name="T84" fmla="*/ 2147483647 w 1153"/>
                  <a:gd name="T85" fmla="*/ 2147483647 h 699"/>
                  <a:gd name="T86" fmla="*/ 2147483647 w 1153"/>
                  <a:gd name="T87" fmla="*/ 2147483647 h 699"/>
                  <a:gd name="T88" fmla="*/ 2147483647 w 1153"/>
                  <a:gd name="T89" fmla="*/ 2147483647 h 699"/>
                  <a:gd name="T90" fmla="*/ 2147483647 w 1153"/>
                  <a:gd name="T91" fmla="*/ 2147483647 h 699"/>
                  <a:gd name="T92" fmla="*/ 2147483647 w 1153"/>
                  <a:gd name="T93" fmla="*/ 2147483647 h 699"/>
                  <a:gd name="T94" fmla="*/ 2147483647 w 1153"/>
                  <a:gd name="T95" fmla="*/ 2147483647 h 699"/>
                  <a:gd name="T96" fmla="*/ 2147483647 w 1153"/>
                  <a:gd name="T97" fmla="*/ 2147483647 h 699"/>
                  <a:gd name="T98" fmla="*/ 2147483647 w 1153"/>
                  <a:gd name="T99" fmla="*/ 2147483647 h 699"/>
                  <a:gd name="T100" fmla="*/ 2147483647 w 1153"/>
                  <a:gd name="T101" fmla="*/ 2147483647 h 699"/>
                  <a:gd name="T102" fmla="*/ 2147483647 w 1153"/>
                  <a:gd name="T103" fmla="*/ 2147483647 h 699"/>
                  <a:gd name="T104" fmla="*/ 2147483647 w 1153"/>
                  <a:gd name="T105" fmla="*/ 2147483647 h 699"/>
                  <a:gd name="T106" fmla="*/ 2147483647 w 1153"/>
                  <a:gd name="T107" fmla="*/ 2147483647 h 699"/>
                  <a:gd name="T108" fmla="*/ 2147483647 w 1153"/>
                  <a:gd name="T109" fmla="*/ 2147483647 h 699"/>
                  <a:gd name="T110" fmla="*/ 2147483647 w 1153"/>
                  <a:gd name="T111" fmla="*/ 2147483647 h 699"/>
                  <a:gd name="T112" fmla="*/ 2147483647 w 1153"/>
                  <a:gd name="T113" fmla="*/ 2147483647 h 699"/>
                  <a:gd name="T114" fmla="*/ 2147483647 w 1153"/>
                  <a:gd name="T115" fmla="*/ 2147483647 h 699"/>
                  <a:gd name="T116" fmla="*/ 2147483647 w 1153"/>
                  <a:gd name="T117" fmla="*/ 2147483647 h 699"/>
                  <a:gd name="T118" fmla="*/ 2147483647 w 1153"/>
                  <a:gd name="T119" fmla="*/ 2147483647 h 699"/>
                  <a:gd name="T120" fmla="*/ 2147483647 w 1153"/>
                  <a:gd name="T121" fmla="*/ 2147483647 h 699"/>
                  <a:gd name="T122" fmla="*/ 2147483647 w 1153"/>
                  <a:gd name="T123" fmla="*/ 2147483647 h 699"/>
                  <a:gd name="T124" fmla="*/ 2147483647 w 1153"/>
                  <a:gd name="T125" fmla="*/ 2147483647 h 699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60000 65536"/>
                  <a:gd name="T145" fmla="*/ 0 60000 65536"/>
                  <a:gd name="T146" fmla="*/ 0 60000 65536"/>
                  <a:gd name="T147" fmla="*/ 0 60000 65536"/>
                  <a:gd name="T148" fmla="*/ 0 60000 65536"/>
                  <a:gd name="T149" fmla="*/ 0 60000 65536"/>
                  <a:gd name="T150" fmla="*/ 0 60000 65536"/>
                  <a:gd name="T151" fmla="*/ 0 60000 65536"/>
                  <a:gd name="T152" fmla="*/ 0 60000 65536"/>
                  <a:gd name="T153" fmla="*/ 0 60000 65536"/>
                  <a:gd name="T154" fmla="*/ 0 60000 65536"/>
                  <a:gd name="T155" fmla="*/ 0 60000 65536"/>
                  <a:gd name="T156" fmla="*/ 0 60000 65536"/>
                  <a:gd name="T157" fmla="*/ 0 60000 65536"/>
                  <a:gd name="T158" fmla="*/ 0 60000 65536"/>
                  <a:gd name="T159" fmla="*/ 0 60000 65536"/>
                  <a:gd name="T160" fmla="*/ 0 60000 65536"/>
                  <a:gd name="T161" fmla="*/ 0 60000 65536"/>
                  <a:gd name="T162" fmla="*/ 0 60000 65536"/>
                  <a:gd name="T163" fmla="*/ 0 60000 65536"/>
                  <a:gd name="T164" fmla="*/ 0 60000 65536"/>
                  <a:gd name="T165" fmla="*/ 0 60000 65536"/>
                  <a:gd name="T166" fmla="*/ 0 60000 65536"/>
                  <a:gd name="T167" fmla="*/ 0 60000 65536"/>
                  <a:gd name="T168" fmla="*/ 0 60000 65536"/>
                  <a:gd name="T169" fmla="*/ 0 60000 65536"/>
                  <a:gd name="T170" fmla="*/ 0 60000 65536"/>
                  <a:gd name="T171" fmla="*/ 0 60000 65536"/>
                  <a:gd name="T172" fmla="*/ 0 60000 65536"/>
                  <a:gd name="T173" fmla="*/ 0 60000 65536"/>
                  <a:gd name="T174" fmla="*/ 0 60000 65536"/>
                  <a:gd name="T175" fmla="*/ 0 60000 65536"/>
                  <a:gd name="T176" fmla="*/ 0 60000 65536"/>
                  <a:gd name="T177" fmla="*/ 0 60000 65536"/>
                  <a:gd name="T178" fmla="*/ 0 60000 65536"/>
                  <a:gd name="T179" fmla="*/ 0 60000 65536"/>
                  <a:gd name="T180" fmla="*/ 0 60000 65536"/>
                  <a:gd name="T181" fmla="*/ 0 60000 65536"/>
                  <a:gd name="T182" fmla="*/ 0 60000 65536"/>
                  <a:gd name="T183" fmla="*/ 0 60000 65536"/>
                  <a:gd name="T184" fmla="*/ 0 60000 65536"/>
                  <a:gd name="T185" fmla="*/ 0 60000 65536"/>
                  <a:gd name="T186" fmla="*/ 0 60000 65536"/>
                  <a:gd name="T187" fmla="*/ 0 60000 65536"/>
                  <a:gd name="T188" fmla="*/ 0 60000 65536"/>
                  <a:gd name="T189" fmla="*/ 0 w 1153"/>
                  <a:gd name="T190" fmla="*/ 0 h 699"/>
                  <a:gd name="T191" fmla="*/ 1153 w 1153"/>
                  <a:gd name="T192" fmla="*/ 699 h 699"/>
                </a:gdLst>
                <a:ahLst/>
                <a:cxnLst>
                  <a:cxn ang="T126">
                    <a:pos x="T0" y="T1"/>
                  </a:cxn>
                  <a:cxn ang="T127">
                    <a:pos x="T2" y="T3"/>
                  </a:cxn>
                  <a:cxn ang="T128">
                    <a:pos x="T4" y="T5"/>
                  </a:cxn>
                  <a:cxn ang="T129">
                    <a:pos x="T6" y="T7"/>
                  </a:cxn>
                  <a:cxn ang="T130">
                    <a:pos x="T8" y="T9"/>
                  </a:cxn>
                  <a:cxn ang="T131">
                    <a:pos x="T10" y="T11"/>
                  </a:cxn>
                  <a:cxn ang="T132">
                    <a:pos x="T12" y="T13"/>
                  </a:cxn>
                  <a:cxn ang="T133">
                    <a:pos x="T14" y="T15"/>
                  </a:cxn>
                  <a:cxn ang="T134">
                    <a:pos x="T16" y="T17"/>
                  </a:cxn>
                  <a:cxn ang="T135">
                    <a:pos x="T18" y="T19"/>
                  </a:cxn>
                  <a:cxn ang="T136">
                    <a:pos x="T20" y="T21"/>
                  </a:cxn>
                  <a:cxn ang="T137">
                    <a:pos x="T22" y="T23"/>
                  </a:cxn>
                  <a:cxn ang="T138">
                    <a:pos x="T24" y="T25"/>
                  </a:cxn>
                  <a:cxn ang="T139">
                    <a:pos x="T26" y="T27"/>
                  </a:cxn>
                  <a:cxn ang="T140">
                    <a:pos x="T28" y="T29"/>
                  </a:cxn>
                  <a:cxn ang="T141">
                    <a:pos x="T30" y="T31"/>
                  </a:cxn>
                  <a:cxn ang="T142">
                    <a:pos x="T32" y="T33"/>
                  </a:cxn>
                  <a:cxn ang="T143">
                    <a:pos x="T34" y="T35"/>
                  </a:cxn>
                  <a:cxn ang="T144">
                    <a:pos x="T36" y="T37"/>
                  </a:cxn>
                  <a:cxn ang="T145">
                    <a:pos x="T38" y="T39"/>
                  </a:cxn>
                  <a:cxn ang="T146">
                    <a:pos x="T40" y="T41"/>
                  </a:cxn>
                  <a:cxn ang="T147">
                    <a:pos x="T42" y="T43"/>
                  </a:cxn>
                  <a:cxn ang="T148">
                    <a:pos x="T44" y="T45"/>
                  </a:cxn>
                  <a:cxn ang="T149">
                    <a:pos x="T46" y="T47"/>
                  </a:cxn>
                  <a:cxn ang="T150">
                    <a:pos x="T48" y="T49"/>
                  </a:cxn>
                  <a:cxn ang="T151">
                    <a:pos x="T50" y="T51"/>
                  </a:cxn>
                  <a:cxn ang="T152">
                    <a:pos x="T52" y="T53"/>
                  </a:cxn>
                  <a:cxn ang="T153">
                    <a:pos x="T54" y="T55"/>
                  </a:cxn>
                  <a:cxn ang="T154">
                    <a:pos x="T56" y="T57"/>
                  </a:cxn>
                  <a:cxn ang="T155">
                    <a:pos x="T58" y="T59"/>
                  </a:cxn>
                  <a:cxn ang="T156">
                    <a:pos x="T60" y="T61"/>
                  </a:cxn>
                  <a:cxn ang="T157">
                    <a:pos x="T62" y="T63"/>
                  </a:cxn>
                  <a:cxn ang="T158">
                    <a:pos x="T64" y="T65"/>
                  </a:cxn>
                  <a:cxn ang="T159">
                    <a:pos x="T66" y="T67"/>
                  </a:cxn>
                  <a:cxn ang="T160">
                    <a:pos x="T68" y="T69"/>
                  </a:cxn>
                  <a:cxn ang="T161">
                    <a:pos x="T70" y="T71"/>
                  </a:cxn>
                  <a:cxn ang="T162">
                    <a:pos x="T72" y="T73"/>
                  </a:cxn>
                  <a:cxn ang="T163">
                    <a:pos x="T74" y="T75"/>
                  </a:cxn>
                  <a:cxn ang="T164">
                    <a:pos x="T76" y="T77"/>
                  </a:cxn>
                  <a:cxn ang="T165">
                    <a:pos x="T78" y="T79"/>
                  </a:cxn>
                  <a:cxn ang="T166">
                    <a:pos x="T80" y="T81"/>
                  </a:cxn>
                  <a:cxn ang="T167">
                    <a:pos x="T82" y="T83"/>
                  </a:cxn>
                  <a:cxn ang="T168">
                    <a:pos x="T84" y="T85"/>
                  </a:cxn>
                  <a:cxn ang="T169">
                    <a:pos x="T86" y="T87"/>
                  </a:cxn>
                  <a:cxn ang="T170">
                    <a:pos x="T88" y="T89"/>
                  </a:cxn>
                  <a:cxn ang="T171">
                    <a:pos x="T90" y="T91"/>
                  </a:cxn>
                  <a:cxn ang="T172">
                    <a:pos x="T92" y="T93"/>
                  </a:cxn>
                  <a:cxn ang="T173">
                    <a:pos x="T94" y="T95"/>
                  </a:cxn>
                  <a:cxn ang="T174">
                    <a:pos x="T96" y="T97"/>
                  </a:cxn>
                  <a:cxn ang="T175">
                    <a:pos x="T98" y="T99"/>
                  </a:cxn>
                  <a:cxn ang="T176">
                    <a:pos x="T100" y="T101"/>
                  </a:cxn>
                  <a:cxn ang="T177">
                    <a:pos x="T102" y="T103"/>
                  </a:cxn>
                  <a:cxn ang="T178">
                    <a:pos x="T104" y="T105"/>
                  </a:cxn>
                  <a:cxn ang="T179">
                    <a:pos x="T106" y="T107"/>
                  </a:cxn>
                  <a:cxn ang="T180">
                    <a:pos x="T108" y="T109"/>
                  </a:cxn>
                  <a:cxn ang="T181">
                    <a:pos x="T110" y="T111"/>
                  </a:cxn>
                  <a:cxn ang="T182">
                    <a:pos x="T112" y="T113"/>
                  </a:cxn>
                  <a:cxn ang="T183">
                    <a:pos x="T114" y="T115"/>
                  </a:cxn>
                  <a:cxn ang="T184">
                    <a:pos x="T116" y="T117"/>
                  </a:cxn>
                  <a:cxn ang="T185">
                    <a:pos x="T118" y="T119"/>
                  </a:cxn>
                  <a:cxn ang="T186">
                    <a:pos x="T120" y="T121"/>
                  </a:cxn>
                  <a:cxn ang="T187">
                    <a:pos x="T122" y="T123"/>
                  </a:cxn>
                  <a:cxn ang="T188">
                    <a:pos x="T124" y="T125"/>
                  </a:cxn>
                </a:cxnLst>
                <a:rect l="T189" t="T190" r="T191" b="T192"/>
                <a:pathLst>
                  <a:path w="1153" h="699">
                    <a:moveTo>
                      <a:pt x="0" y="698"/>
                    </a:moveTo>
                    <a:lnTo>
                      <a:pt x="0" y="698"/>
                    </a:lnTo>
                    <a:lnTo>
                      <a:pt x="1" y="698"/>
                    </a:lnTo>
                    <a:lnTo>
                      <a:pt x="2" y="698"/>
                    </a:lnTo>
                    <a:lnTo>
                      <a:pt x="3" y="698"/>
                    </a:lnTo>
                    <a:lnTo>
                      <a:pt x="4" y="698"/>
                    </a:lnTo>
                    <a:lnTo>
                      <a:pt x="4" y="699"/>
                    </a:lnTo>
                    <a:lnTo>
                      <a:pt x="5" y="699"/>
                    </a:lnTo>
                    <a:lnTo>
                      <a:pt x="6" y="699"/>
                    </a:lnTo>
                    <a:lnTo>
                      <a:pt x="7" y="699"/>
                    </a:lnTo>
                    <a:lnTo>
                      <a:pt x="8" y="699"/>
                    </a:lnTo>
                    <a:lnTo>
                      <a:pt x="9" y="699"/>
                    </a:lnTo>
                    <a:lnTo>
                      <a:pt x="17" y="699"/>
                    </a:lnTo>
                    <a:lnTo>
                      <a:pt x="18" y="699"/>
                    </a:lnTo>
                    <a:lnTo>
                      <a:pt x="19" y="699"/>
                    </a:lnTo>
                    <a:lnTo>
                      <a:pt x="20" y="699"/>
                    </a:lnTo>
                    <a:lnTo>
                      <a:pt x="21" y="699"/>
                    </a:lnTo>
                    <a:lnTo>
                      <a:pt x="22" y="699"/>
                    </a:lnTo>
                    <a:lnTo>
                      <a:pt x="23" y="699"/>
                    </a:lnTo>
                    <a:lnTo>
                      <a:pt x="24" y="699"/>
                    </a:lnTo>
                    <a:lnTo>
                      <a:pt x="25" y="699"/>
                    </a:lnTo>
                    <a:lnTo>
                      <a:pt x="26" y="699"/>
                    </a:lnTo>
                    <a:lnTo>
                      <a:pt x="27" y="699"/>
                    </a:lnTo>
                    <a:lnTo>
                      <a:pt x="28" y="699"/>
                    </a:lnTo>
                    <a:lnTo>
                      <a:pt x="29" y="699"/>
                    </a:lnTo>
                    <a:lnTo>
                      <a:pt x="30" y="699"/>
                    </a:lnTo>
                    <a:lnTo>
                      <a:pt x="31" y="699"/>
                    </a:lnTo>
                    <a:lnTo>
                      <a:pt x="32" y="699"/>
                    </a:lnTo>
                    <a:lnTo>
                      <a:pt x="33" y="699"/>
                    </a:lnTo>
                    <a:lnTo>
                      <a:pt x="34" y="699"/>
                    </a:lnTo>
                    <a:lnTo>
                      <a:pt x="35" y="699"/>
                    </a:lnTo>
                    <a:lnTo>
                      <a:pt x="36" y="699"/>
                    </a:lnTo>
                    <a:lnTo>
                      <a:pt x="37" y="699"/>
                    </a:lnTo>
                    <a:lnTo>
                      <a:pt x="38" y="699"/>
                    </a:lnTo>
                    <a:lnTo>
                      <a:pt x="39" y="699"/>
                    </a:lnTo>
                    <a:lnTo>
                      <a:pt x="40" y="699"/>
                    </a:lnTo>
                    <a:lnTo>
                      <a:pt x="41" y="699"/>
                    </a:lnTo>
                    <a:lnTo>
                      <a:pt x="42" y="699"/>
                    </a:lnTo>
                    <a:lnTo>
                      <a:pt x="43" y="698"/>
                    </a:lnTo>
                    <a:lnTo>
                      <a:pt x="44" y="698"/>
                    </a:lnTo>
                    <a:lnTo>
                      <a:pt x="45" y="698"/>
                    </a:lnTo>
                    <a:lnTo>
                      <a:pt x="46" y="698"/>
                    </a:lnTo>
                    <a:lnTo>
                      <a:pt x="47" y="698"/>
                    </a:lnTo>
                    <a:lnTo>
                      <a:pt x="48" y="699"/>
                    </a:lnTo>
                    <a:lnTo>
                      <a:pt x="49" y="699"/>
                    </a:lnTo>
                    <a:lnTo>
                      <a:pt x="49" y="698"/>
                    </a:lnTo>
                    <a:lnTo>
                      <a:pt x="50" y="698"/>
                    </a:lnTo>
                    <a:lnTo>
                      <a:pt x="51" y="699"/>
                    </a:lnTo>
                    <a:lnTo>
                      <a:pt x="52" y="699"/>
                    </a:lnTo>
                    <a:lnTo>
                      <a:pt x="53" y="699"/>
                    </a:lnTo>
                    <a:lnTo>
                      <a:pt x="54" y="699"/>
                    </a:lnTo>
                    <a:lnTo>
                      <a:pt x="55" y="699"/>
                    </a:lnTo>
                    <a:lnTo>
                      <a:pt x="56" y="699"/>
                    </a:lnTo>
                    <a:lnTo>
                      <a:pt x="57" y="699"/>
                    </a:lnTo>
                    <a:lnTo>
                      <a:pt x="63" y="699"/>
                    </a:lnTo>
                    <a:lnTo>
                      <a:pt x="64" y="699"/>
                    </a:lnTo>
                    <a:lnTo>
                      <a:pt x="65" y="699"/>
                    </a:lnTo>
                    <a:lnTo>
                      <a:pt x="66" y="699"/>
                    </a:lnTo>
                    <a:lnTo>
                      <a:pt x="67" y="699"/>
                    </a:lnTo>
                    <a:lnTo>
                      <a:pt x="68" y="699"/>
                    </a:lnTo>
                    <a:lnTo>
                      <a:pt x="69" y="699"/>
                    </a:lnTo>
                    <a:lnTo>
                      <a:pt x="70" y="699"/>
                    </a:lnTo>
                    <a:lnTo>
                      <a:pt x="71" y="699"/>
                    </a:lnTo>
                    <a:lnTo>
                      <a:pt x="72" y="699"/>
                    </a:lnTo>
                    <a:lnTo>
                      <a:pt x="73" y="699"/>
                    </a:lnTo>
                    <a:lnTo>
                      <a:pt x="74" y="699"/>
                    </a:lnTo>
                    <a:lnTo>
                      <a:pt x="75" y="699"/>
                    </a:lnTo>
                    <a:lnTo>
                      <a:pt x="76" y="699"/>
                    </a:lnTo>
                    <a:lnTo>
                      <a:pt x="77" y="699"/>
                    </a:lnTo>
                    <a:lnTo>
                      <a:pt x="78" y="699"/>
                    </a:lnTo>
                    <a:lnTo>
                      <a:pt x="79" y="699"/>
                    </a:lnTo>
                    <a:lnTo>
                      <a:pt x="80" y="699"/>
                    </a:lnTo>
                    <a:lnTo>
                      <a:pt x="81" y="699"/>
                    </a:lnTo>
                    <a:lnTo>
                      <a:pt x="82" y="699"/>
                    </a:lnTo>
                    <a:lnTo>
                      <a:pt x="83" y="699"/>
                    </a:lnTo>
                    <a:lnTo>
                      <a:pt x="84" y="699"/>
                    </a:lnTo>
                    <a:lnTo>
                      <a:pt x="85" y="699"/>
                    </a:lnTo>
                    <a:lnTo>
                      <a:pt x="86" y="699"/>
                    </a:lnTo>
                    <a:lnTo>
                      <a:pt x="87" y="699"/>
                    </a:lnTo>
                    <a:lnTo>
                      <a:pt x="88" y="698"/>
                    </a:lnTo>
                    <a:lnTo>
                      <a:pt x="89" y="698"/>
                    </a:lnTo>
                    <a:lnTo>
                      <a:pt x="89" y="699"/>
                    </a:lnTo>
                    <a:lnTo>
                      <a:pt x="90" y="699"/>
                    </a:lnTo>
                    <a:lnTo>
                      <a:pt x="91" y="699"/>
                    </a:lnTo>
                    <a:lnTo>
                      <a:pt x="92" y="699"/>
                    </a:lnTo>
                    <a:lnTo>
                      <a:pt x="93" y="699"/>
                    </a:lnTo>
                    <a:lnTo>
                      <a:pt x="94" y="699"/>
                    </a:lnTo>
                    <a:lnTo>
                      <a:pt x="95" y="699"/>
                    </a:lnTo>
                    <a:lnTo>
                      <a:pt x="96" y="699"/>
                    </a:lnTo>
                    <a:lnTo>
                      <a:pt x="97" y="699"/>
                    </a:lnTo>
                    <a:lnTo>
                      <a:pt x="98" y="699"/>
                    </a:lnTo>
                    <a:lnTo>
                      <a:pt x="99" y="699"/>
                    </a:lnTo>
                    <a:lnTo>
                      <a:pt x="100" y="699"/>
                    </a:lnTo>
                    <a:lnTo>
                      <a:pt x="101" y="699"/>
                    </a:lnTo>
                    <a:lnTo>
                      <a:pt x="102" y="699"/>
                    </a:lnTo>
                    <a:lnTo>
                      <a:pt x="103" y="699"/>
                    </a:lnTo>
                    <a:lnTo>
                      <a:pt x="104" y="699"/>
                    </a:lnTo>
                    <a:lnTo>
                      <a:pt x="105" y="699"/>
                    </a:lnTo>
                    <a:lnTo>
                      <a:pt x="106" y="699"/>
                    </a:lnTo>
                    <a:lnTo>
                      <a:pt x="107" y="699"/>
                    </a:lnTo>
                    <a:lnTo>
                      <a:pt x="108" y="699"/>
                    </a:lnTo>
                    <a:lnTo>
                      <a:pt x="109" y="699"/>
                    </a:lnTo>
                    <a:lnTo>
                      <a:pt x="110" y="699"/>
                    </a:lnTo>
                    <a:lnTo>
                      <a:pt x="111" y="699"/>
                    </a:lnTo>
                    <a:lnTo>
                      <a:pt x="112" y="699"/>
                    </a:lnTo>
                    <a:lnTo>
                      <a:pt x="113" y="699"/>
                    </a:lnTo>
                    <a:lnTo>
                      <a:pt x="114" y="699"/>
                    </a:lnTo>
                    <a:lnTo>
                      <a:pt x="115" y="699"/>
                    </a:lnTo>
                    <a:lnTo>
                      <a:pt x="116" y="699"/>
                    </a:lnTo>
                    <a:lnTo>
                      <a:pt x="117" y="699"/>
                    </a:lnTo>
                    <a:lnTo>
                      <a:pt x="118" y="699"/>
                    </a:lnTo>
                    <a:lnTo>
                      <a:pt x="119" y="699"/>
                    </a:lnTo>
                    <a:lnTo>
                      <a:pt x="120" y="699"/>
                    </a:lnTo>
                    <a:lnTo>
                      <a:pt x="121" y="699"/>
                    </a:lnTo>
                    <a:lnTo>
                      <a:pt x="122" y="699"/>
                    </a:lnTo>
                    <a:lnTo>
                      <a:pt x="123" y="699"/>
                    </a:lnTo>
                    <a:lnTo>
                      <a:pt x="124" y="699"/>
                    </a:lnTo>
                    <a:lnTo>
                      <a:pt x="125" y="699"/>
                    </a:lnTo>
                    <a:lnTo>
                      <a:pt x="126" y="699"/>
                    </a:lnTo>
                    <a:lnTo>
                      <a:pt x="129" y="699"/>
                    </a:lnTo>
                    <a:lnTo>
                      <a:pt x="130" y="699"/>
                    </a:lnTo>
                    <a:lnTo>
                      <a:pt x="131" y="699"/>
                    </a:lnTo>
                    <a:lnTo>
                      <a:pt x="132" y="699"/>
                    </a:lnTo>
                    <a:lnTo>
                      <a:pt x="133" y="699"/>
                    </a:lnTo>
                    <a:lnTo>
                      <a:pt x="134" y="699"/>
                    </a:lnTo>
                    <a:lnTo>
                      <a:pt x="134" y="697"/>
                    </a:lnTo>
                    <a:lnTo>
                      <a:pt x="135" y="692"/>
                    </a:lnTo>
                    <a:lnTo>
                      <a:pt x="136" y="684"/>
                    </a:lnTo>
                    <a:lnTo>
                      <a:pt x="137" y="678"/>
                    </a:lnTo>
                    <a:lnTo>
                      <a:pt x="138" y="679"/>
                    </a:lnTo>
                    <a:lnTo>
                      <a:pt x="139" y="687"/>
                    </a:lnTo>
                    <a:lnTo>
                      <a:pt x="139" y="695"/>
                    </a:lnTo>
                    <a:lnTo>
                      <a:pt x="140" y="699"/>
                    </a:lnTo>
                    <a:lnTo>
                      <a:pt x="141" y="699"/>
                    </a:lnTo>
                    <a:lnTo>
                      <a:pt x="142" y="699"/>
                    </a:lnTo>
                    <a:lnTo>
                      <a:pt x="143" y="699"/>
                    </a:lnTo>
                    <a:lnTo>
                      <a:pt x="144" y="699"/>
                    </a:lnTo>
                    <a:lnTo>
                      <a:pt x="145" y="699"/>
                    </a:lnTo>
                    <a:lnTo>
                      <a:pt x="146" y="699"/>
                    </a:lnTo>
                    <a:lnTo>
                      <a:pt x="147" y="699"/>
                    </a:lnTo>
                    <a:lnTo>
                      <a:pt x="148" y="699"/>
                    </a:lnTo>
                    <a:lnTo>
                      <a:pt x="149" y="699"/>
                    </a:lnTo>
                    <a:lnTo>
                      <a:pt x="150" y="699"/>
                    </a:lnTo>
                    <a:lnTo>
                      <a:pt x="151" y="699"/>
                    </a:lnTo>
                    <a:lnTo>
                      <a:pt x="152" y="699"/>
                    </a:lnTo>
                    <a:lnTo>
                      <a:pt x="153" y="699"/>
                    </a:lnTo>
                    <a:lnTo>
                      <a:pt x="154" y="699"/>
                    </a:lnTo>
                    <a:lnTo>
                      <a:pt x="155" y="699"/>
                    </a:lnTo>
                    <a:lnTo>
                      <a:pt x="156" y="699"/>
                    </a:lnTo>
                    <a:lnTo>
                      <a:pt x="157" y="699"/>
                    </a:lnTo>
                    <a:lnTo>
                      <a:pt x="158" y="699"/>
                    </a:lnTo>
                    <a:lnTo>
                      <a:pt x="159" y="699"/>
                    </a:lnTo>
                    <a:lnTo>
                      <a:pt x="160" y="699"/>
                    </a:lnTo>
                    <a:lnTo>
                      <a:pt x="163" y="699"/>
                    </a:lnTo>
                    <a:lnTo>
                      <a:pt x="164" y="699"/>
                    </a:lnTo>
                    <a:lnTo>
                      <a:pt x="165" y="699"/>
                    </a:lnTo>
                    <a:lnTo>
                      <a:pt x="166" y="699"/>
                    </a:lnTo>
                    <a:lnTo>
                      <a:pt x="167" y="699"/>
                    </a:lnTo>
                    <a:lnTo>
                      <a:pt x="168" y="699"/>
                    </a:lnTo>
                    <a:lnTo>
                      <a:pt x="169" y="699"/>
                    </a:lnTo>
                    <a:lnTo>
                      <a:pt x="170" y="699"/>
                    </a:lnTo>
                    <a:lnTo>
                      <a:pt x="171" y="699"/>
                    </a:lnTo>
                    <a:lnTo>
                      <a:pt x="172" y="699"/>
                    </a:lnTo>
                    <a:lnTo>
                      <a:pt x="173" y="699"/>
                    </a:lnTo>
                    <a:lnTo>
                      <a:pt x="174" y="699"/>
                    </a:lnTo>
                    <a:lnTo>
                      <a:pt x="175" y="699"/>
                    </a:lnTo>
                    <a:lnTo>
                      <a:pt x="176" y="699"/>
                    </a:lnTo>
                    <a:lnTo>
                      <a:pt x="177" y="699"/>
                    </a:lnTo>
                    <a:lnTo>
                      <a:pt x="178" y="699"/>
                    </a:lnTo>
                    <a:lnTo>
                      <a:pt x="179" y="699"/>
                    </a:lnTo>
                    <a:lnTo>
                      <a:pt x="180" y="695"/>
                    </a:lnTo>
                    <a:lnTo>
                      <a:pt x="180" y="688"/>
                    </a:lnTo>
                    <a:lnTo>
                      <a:pt x="181" y="683"/>
                    </a:lnTo>
                    <a:lnTo>
                      <a:pt x="182" y="684"/>
                    </a:lnTo>
                    <a:lnTo>
                      <a:pt x="183" y="690"/>
                    </a:lnTo>
                    <a:lnTo>
                      <a:pt x="184" y="696"/>
                    </a:lnTo>
                    <a:lnTo>
                      <a:pt x="185" y="699"/>
                    </a:lnTo>
                    <a:lnTo>
                      <a:pt x="186" y="699"/>
                    </a:lnTo>
                    <a:lnTo>
                      <a:pt x="187" y="699"/>
                    </a:lnTo>
                    <a:lnTo>
                      <a:pt x="188" y="699"/>
                    </a:lnTo>
                    <a:lnTo>
                      <a:pt x="189" y="699"/>
                    </a:lnTo>
                    <a:lnTo>
                      <a:pt x="190" y="699"/>
                    </a:lnTo>
                    <a:lnTo>
                      <a:pt x="191" y="699"/>
                    </a:lnTo>
                    <a:lnTo>
                      <a:pt x="192" y="699"/>
                    </a:lnTo>
                    <a:lnTo>
                      <a:pt x="193" y="699"/>
                    </a:lnTo>
                    <a:lnTo>
                      <a:pt x="194" y="699"/>
                    </a:lnTo>
                    <a:lnTo>
                      <a:pt x="195" y="699"/>
                    </a:lnTo>
                    <a:lnTo>
                      <a:pt x="196" y="699"/>
                    </a:lnTo>
                    <a:lnTo>
                      <a:pt x="197" y="699"/>
                    </a:lnTo>
                    <a:lnTo>
                      <a:pt x="198" y="699"/>
                    </a:lnTo>
                    <a:lnTo>
                      <a:pt x="199" y="699"/>
                    </a:lnTo>
                    <a:lnTo>
                      <a:pt x="200" y="699"/>
                    </a:lnTo>
                    <a:lnTo>
                      <a:pt x="207" y="699"/>
                    </a:lnTo>
                    <a:lnTo>
                      <a:pt x="208" y="699"/>
                    </a:lnTo>
                    <a:lnTo>
                      <a:pt x="209" y="699"/>
                    </a:lnTo>
                    <a:lnTo>
                      <a:pt x="210" y="699"/>
                    </a:lnTo>
                    <a:lnTo>
                      <a:pt x="211" y="699"/>
                    </a:lnTo>
                    <a:lnTo>
                      <a:pt x="212" y="698"/>
                    </a:lnTo>
                    <a:lnTo>
                      <a:pt x="213" y="698"/>
                    </a:lnTo>
                    <a:lnTo>
                      <a:pt x="214" y="698"/>
                    </a:lnTo>
                    <a:lnTo>
                      <a:pt x="215" y="698"/>
                    </a:lnTo>
                    <a:lnTo>
                      <a:pt x="215" y="699"/>
                    </a:lnTo>
                    <a:lnTo>
                      <a:pt x="216" y="699"/>
                    </a:lnTo>
                    <a:lnTo>
                      <a:pt x="217" y="699"/>
                    </a:lnTo>
                    <a:lnTo>
                      <a:pt x="218" y="699"/>
                    </a:lnTo>
                    <a:lnTo>
                      <a:pt x="219" y="699"/>
                    </a:lnTo>
                    <a:lnTo>
                      <a:pt x="220" y="699"/>
                    </a:lnTo>
                    <a:lnTo>
                      <a:pt x="221" y="699"/>
                    </a:lnTo>
                    <a:lnTo>
                      <a:pt x="222" y="699"/>
                    </a:lnTo>
                    <a:lnTo>
                      <a:pt x="223" y="697"/>
                    </a:lnTo>
                    <a:lnTo>
                      <a:pt x="224" y="689"/>
                    </a:lnTo>
                    <a:lnTo>
                      <a:pt x="225" y="674"/>
                    </a:lnTo>
                    <a:lnTo>
                      <a:pt x="225" y="659"/>
                    </a:lnTo>
                    <a:lnTo>
                      <a:pt x="226" y="657"/>
                    </a:lnTo>
                    <a:lnTo>
                      <a:pt x="227" y="670"/>
                    </a:lnTo>
                    <a:lnTo>
                      <a:pt x="228" y="687"/>
                    </a:lnTo>
                    <a:lnTo>
                      <a:pt x="229" y="697"/>
                    </a:lnTo>
                    <a:lnTo>
                      <a:pt x="230" y="699"/>
                    </a:lnTo>
                    <a:lnTo>
                      <a:pt x="231" y="699"/>
                    </a:lnTo>
                    <a:lnTo>
                      <a:pt x="232" y="699"/>
                    </a:lnTo>
                    <a:lnTo>
                      <a:pt x="233" y="699"/>
                    </a:lnTo>
                    <a:lnTo>
                      <a:pt x="234" y="699"/>
                    </a:lnTo>
                    <a:lnTo>
                      <a:pt x="236" y="699"/>
                    </a:lnTo>
                    <a:lnTo>
                      <a:pt x="237" y="699"/>
                    </a:lnTo>
                    <a:lnTo>
                      <a:pt x="238" y="699"/>
                    </a:lnTo>
                    <a:lnTo>
                      <a:pt x="239" y="699"/>
                    </a:lnTo>
                    <a:lnTo>
                      <a:pt x="240" y="699"/>
                    </a:lnTo>
                    <a:lnTo>
                      <a:pt x="241" y="699"/>
                    </a:lnTo>
                    <a:lnTo>
                      <a:pt x="242" y="699"/>
                    </a:lnTo>
                    <a:lnTo>
                      <a:pt x="243" y="699"/>
                    </a:lnTo>
                    <a:lnTo>
                      <a:pt x="244" y="699"/>
                    </a:lnTo>
                    <a:lnTo>
                      <a:pt x="245" y="699"/>
                    </a:lnTo>
                    <a:lnTo>
                      <a:pt x="246" y="699"/>
                    </a:lnTo>
                    <a:lnTo>
                      <a:pt x="247" y="699"/>
                    </a:lnTo>
                    <a:lnTo>
                      <a:pt x="248" y="699"/>
                    </a:lnTo>
                    <a:lnTo>
                      <a:pt x="249" y="699"/>
                    </a:lnTo>
                    <a:lnTo>
                      <a:pt x="250" y="699"/>
                    </a:lnTo>
                    <a:lnTo>
                      <a:pt x="251" y="699"/>
                    </a:lnTo>
                    <a:lnTo>
                      <a:pt x="252" y="699"/>
                    </a:lnTo>
                    <a:lnTo>
                      <a:pt x="253" y="699"/>
                    </a:lnTo>
                    <a:lnTo>
                      <a:pt x="254" y="699"/>
                    </a:lnTo>
                    <a:lnTo>
                      <a:pt x="255" y="699"/>
                    </a:lnTo>
                    <a:lnTo>
                      <a:pt x="256" y="699"/>
                    </a:lnTo>
                    <a:lnTo>
                      <a:pt x="257" y="699"/>
                    </a:lnTo>
                    <a:lnTo>
                      <a:pt x="258" y="699"/>
                    </a:lnTo>
                    <a:lnTo>
                      <a:pt x="259" y="699"/>
                    </a:lnTo>
                    <a:lnTo>
                      <a:pt x="260" y="699"/>
                    </a:lnTo>
                    <a:lnTo>
                      <a:pt x="261" y="699"/>
                    </a:lnTo>
                    <a:lnTo>
                      <a:pt x="262" y="699"/>
                    </a:lnTo>
                    <a:lnTo>
                      <a:pt x="263" y="699"/>
                    </a:lnTo>
                    <a:lnTo>
                      <a:pt x="264" y="699"/>
                    </a:lnTo>
                    <a:lnTo>
                      <a:pt x="265" y="699"/>
                    </a:lnTo>
                    <a:lnTo>
                      <a:pt x="266" y="694"/>
                    </a:lnTo>
                    <a:lnTo>
                      <a:pt x="266" y="601"/>
                    </a:lnTo>
                    <a:lnTo>
                      <a:pt x="267" y="384"/>
                    </a:lnTo>
                    <a:lnTo>
                      <a:pt x="268" y="131"/>
                    </a:lnTo>
                    <a:lnTo>
                      <a:pt x="269" y="9"/>
                    </a:lnTo>
                    <a:lnTo>
                      <a:pt x="270" y="112"/>
                    </a:lnTo>
                    <a:lnTo>
                      <a:pt x="271" y="360"/>
                    </a:lnTo>
                    <a:lnTo>
                      <a:pt x="271" y="587"/>
                    </a:lnTo>
                    <a:lnTo>
                      <a:pt x="272" y="690"/>
                    </a:lnTo>
                    <a:lnTo>
                      <a:pt x="273" y="699"/>
                    </a:lnTo>
                    <a:lnTo>
                      <a:pt x="274" y="699"/>
                    </a:lnTo>
                    <a:lnTo>
                      <a:pt x="275" y="699"/>
                    </a:lnTo>
                    <a:lnTo>
                      <a:pt x="276" y="699"/>
                    </a:lnTo>
                    <a:lnTo>
                      <a:pt x="277" y="699"/>
                    </a:lnTo>
                    <a:lnTo>
                      <a:pt x="278" y="699"/>
                    </a:lnTo>
                    <a:lnTo>
                      <a:pt x="279" y="699"/>
                    </a:lnTo>
                    <a:lnTo>
                      <a:pt x="280" y="699"/>
                    </a:lnTo>
                    <a:lnTo>
                      <a:pt x="281" y="699"/>
                    </a:lnTo>
                    <a:lnTo>
                      <a:pt x="282" y="699"/>
                    </a:lnTo>
                    <a:lnTo>
                      <a:pt x="283" y="699"/>
                    </a:lnTo>
                    <a:lnTo>
                      <a:pt x="284" y="699"/>
                    </a:lnTo>
                    <a:lnTo>
                      <a:pt x="285" y="699"/>
                    </a:lnTo>
                    <a:lnTo>
                      <a:pt x="286" y="699"/>
                    </a:lnTo>
                    <a:lnTo>
                      <a:pt x="287" y="699"/>
                    </a:lnTo>
                    <a:lnTo>
                      <a:pt x="288" y="699"/>
                    </a:lnTo>
                    <a:lnTo>
                      <a:pt x="289" y="699"/>
                    </a:lnTo>
                    <a:lnTo>
                      <a:pt x="290" y="699"/>
                    </a:lnTo>
                    <a:lnTo>
                      <a:pt x="291" y="699"/>
                    </a:lnTo>
                    <a:lnTo>
                      <a:pt x="292" y="699"/>
                    </a:lnTo>
                    <a:lnTo>
                      <a:pt x="293" y="699"/>
                    </a:lnTo>
                    <a:lnTo>
                      <a:pt x="294" y="699"/>
                    </a:lnTo>
                    <a:lnTo>
                      <a:pt x="295" y="699"/>
                    </a:lnTo>
                    <a:lnTo>
                      <a:pt x="296" y="699"/>
                    </a:lnTo>
                    <a:lnTo>
                      <a:pt x="297" y="699"/>
                    </a:lnTo>
                    <a:lnTo>
                      <a:pt x="298" y="699"/>
                    </a:lnTo>
                    <a:lnTo>
                      <a:pt x="299" y="699"/>
                    </a:lnTo>
                    <a:lnTo>
                      <a:pt x="300" y="699"/>
                    </a:lnTo>
                    <a:lnTo>
                      <a:pt x="301" y="699"/>
                    </a:lnTo>
                    <a:lnTo>
                      <a:pt x="302" y="699"/>
                    </a:lnTo>
                    <a:lnTo>
                      <a:pt x="303" y="699"/>
                    </a:lnTo>
                    <a:lnTo>
                      <a:pt x="304" y="699"/>
                    </a:lnTo>
                    <a:lnTo>
                      <a:pt x="305" y="699"/>
                    </a:lnTo>
                    <a:lnTo>
                      <a:pt x="306" y="699"/>
                    </a:lnTo>
                    <a:lnTo>
                      <a:pt x="307" y="699"/>
                    </a:lnTo>
                    <a:lnTo>
                      <a:pt x="308" y="699"/>
                    </a:lnTo>
                    <a:lnTo>
                      <a:pt x="309" y="697"/>
                    </a:lnTo>
                    <a:lnTo>
                      <a:pt x="310" y="688"/>
                    </a:lnTo>
                    <a:lnTo>
                      <a:pt x="311" y="587"/>
                    </a:lnTo>
                    <a:lnTo>
                      <a:pt x="312" y="375"/>
                    </a:lnTo>
                    <a:lnTo>
                      <a:pt x="312" y="147"/>
                    </a:lnTo>
                    <a:lnTo>
                      <a:pt x="313" y="54"/>
                    </a:lnTo>
                    <a:lnTo>
                      <a:pt x="314" y="169"/>
                    </a:lnTo>
                    <a:lnTo>
                      <a:pt x="315" y="405"/>
                    </a:lnTo>
                    <a:lnTo>
                      <a:pt x="316" y="608"/>
                    </a:lnTo>
                    <a:lnTo>
                      <a:pt x="317" y="695"/>
                    </a:lnTo>
                    <a:lnTo>
                      <a:pt x="317" y="699"/>
                    </a:lnTo>
                    <a:lnTo>
                      <a:pt x="318" y="699"/>
                    </a:lnTo>
                    <a:lnTo>
                      <a:pt x="319" y="699"/>
                    </a:lnTo>
                    <a:lnTo>
                      <a:pt x="320" y="699"/>
                    </a:lnTo>
                    <a:lnTo>
                      <a:pt x="321" y="699"/>
                    </a:lnTo>
                    <a:lnTo>
                      <a:pt x="322" y="699"/>
                    </a:lnTo>
                    <a:lnTo>
                      <a:pt x="323" y="699"/>
                    </a:lnTo>
                    <a:lnTo>
                      <a:pt x="324" y="699"/>
                    </a:lnTo>
                    <a:lnTo>
                      <a:pt x="325" y="699"/>
                    </a:lnTo>
                    <a:lnTo>
                      <a:pt x="326" y="699"/>
                    </a:lnTo>
                    <a:lnTo>
                      <a:pt x="327" y="699"/>
                    </a:lnTo>
                    <a:lnTo>
                      <a:pt x="328" y="699"/>
                    </a:lnTo>
                    <a:lnTo>
                      <a:pt x="329" y="699"/>
                    </a:lnTo>
                    <a:lnTo>
                      <a:pt x="330" y="699"/>
                    </a:lnTo>
                    <a:lnTo>
                      <a:pt x="331" y="699"/>
                    </a:lnTo>
                    <a:lnTo>
                      <a:pt x="332" y="699"/>
                    </a:lnTo>
                    <a:lnTo>
                      <a:pt x="333" y="699"/>
                    </a:lnTo>
                    <a:lnTo>
                      <a:pt x="334" y="699"/>
                    </a:lnTo>
                    <a:lnTo>
                      <a:pt x="335" y="699"/>
                    </a:lnTo>
                    <a:lnTo>
                      <a:pt x="336" y="699"/>
                    </a:lnTo>
                    <a:lnTo>
                      <a:pt x="337" y="699"/>
                    </a:lnTo>
                    <a:lnTo>
                      <a:pt x="338" y="699"/>
                    </a:lnTo>
                    <a:lnTo>
                      <a:pt x="339" y="699"/>
                    </a:lnTo>
                    <a:lnTo>
                      <a:pt x="340" y="699"/>
                    </a:lnTo>
                    <a:lnTo>
                      <a:pt x="341" y="699"/>
                    </a:lnTo>
                    <a:lnTo>
                      <a:pt x="342" y="699"/>
                    </a:lnTo>
                    <a:lnTo>
                      <a:pt x="343" y="699"/>
                    </a:lnTo>
                    <a:lnTo>
                      <a:pt x="344" y="699"/>
                    </a:lnTo>
                    <a:lnTo>
                      <a:pt x="345" y="699"/>
                    </a:lnTo>
                    <a:lnTo>
                      <a:pt x="346" y="699"/>
                    </a:lnTo>
                    <a:lnTo>
                      <a:pt x="347" y="699"/>
                    </a:lnTo>
                    <a:lnTo>
                      <a:pt x="348" y="695"/>
                    </a:lnTo>
                    <a:lnTo>
                      <a:pt x="348" y="678"/>
                    </a:lnTo>
                    <a:lnTo>
                      <a:pt x="349" y="654"/>
                    </a:lnTo>
                    <a:lnTo>
                      <a:pt x="350" y="640"/>
                    </a:lnTo>
                    <a:lnTo>
                      <a:pt x="351" y="646"/>
                    </a:lnTo>
                    <a:lnTo>
                      <a:pt x="352" y="669"/>
                    </a:lnTo>
                    <a:lnTo>
                      <a:pt x="353" y="691"/>
                    </a:lnTo>
                    <a:lnTo>
                      <a:pt x="353" y="698"/>
                    </a:lnTo>
                    <a:lnTo>
                      <a:pt x="354" y="691"/>
                    </a:lnTo>
                    <a:lnTo>
                      <a:pt x="355" y="635"/>
                    </a:lnTo>
                    <a:lnTo>
                      <a:pt x="356" y="528"/>
                    </a:lnTo>
                    <a:lnTo>
                      <a:pt x="357" y="425"/>
                    </a:lnTo>
                    <a:lnTo>
                      <a:pt x="358" y="397"/>
                    </a:lnTo>
                    <a:lnTo>
                      <a:pt x="358" y="465"/>
                    </a:lnTo>
                    <a:lnTo>
                      <a:pt x="359" y="578"/>
                    </a:lnTo>
                    <a:lnTo>
                      <a:pt x="360" y="667"/>
                    </a:lnTo>
                    <a:lnTo>
                      <a:pt x="361" y="696"/>
                    </a:lnTo>
                    <a:lnTo>
                      <a:pt x="362" y="699"/>
                    </a:lnTo>
                    <a:lnTo>
                      <a:pt x="363" y="699"/>
                    </a:lnTo>
                    <a:lnTo>
                      <a:pt x="364" y="699"/>
                    </a:lnTo>
                    <a:lnTo>
                      <a:pt x="365" y="699"/>
                    </a:lnTo>
                    <a:lnTo>
                      <a:pt x="366" y="699"/>
                    </a:lnTo>
                    <a:lnTo>
                      <a:pt x="367" y="699"/>
                    </a:lnTo>
                    <a:lnTo>
                      <a:pt x="368" y="699"/>
                    </a:lnTo>
                    <a:lnTo>
                      <a:pt x="369" y="699"/>
                    </a:lnTo>
                    <a:lnTo>
                      <a:pt x="370" y="699"/>
                    </a:lnTo>
                    <a:lnTo>
                      <a:pt x="371" y="699"/>
                    </a:lnTo>
                    <a:lnTo>
                      <a:pt x="372" y="699"/>
                    </a:lnTo>
                    <a:lnTo>
                      <a:pt x="373" y="699"/>
                    </a:lnTo>
                    <a:lnTo>
                      <a:pt x="388" y="699"/>
                    </a:lnTo>
                    <a:lnTo>
                      <a:pt x="389" y="699"/>
                    </a:lnTo>
                    <a:lnTo>
                      <a:pt x="390" y="699"/>
                    </a:lnTo>
                    <a:lnTo>
                      <a:pt x="391" y="698"/>
                    </a:lnTo>
                    <a:lnTo>
                      <a:pt x="392" y="692"/>
                    </a:lnTo>
                    <a:lnTo>
                      <a:pt x="393" y="675"/>
                    </a:lnTo>
                    <a:lnTo>
                      <a:pt x="394" y="655"/>
                    </a:lnTo>
                    <a:lnTo>
                      <a:pt x="395" y="647"/>
                    </a:lnTo>
                    <a:lnTo>
                      <a:pt x="395" y="656"/>
                    </a:lnTo>
                    <a:lnTo>
                      <a:pt x="396" y="677"/>
                    </a:lnTo>
                    <a:lnTo>
                      <a:pt x="397" y="694"/>
                    </a:lnTo>
                    <a:lnTo>
                      <a:pt x="398" y="697"/>
                    </a:lnTo>
                    <a:lnTo>
                      <a:pt x="399" y="693"/>
                    </a:lnTo>
                    <a:lnTo>
                      <a:pt x="400" y="673"/>
                    </a:lnTo>
                    <a:lnTo>
                      <a:pt x="400" y="633"/>
                    </a:lnTo>
                    <a:lnTo>
                      <a:pt x="401" y="598"/>
                    </a:lnTo>
                    <a:lnTo>
                      <a:pt x="402" y="594"/>
                    </a:lnTo>
                    <a:lnTo>
                      <a:pt x="403" y="624"/>
                    </a:lnTo>
                    <a:lnTo>
                      <a:pt x="404" y="666"/>
                    </a:lnTo>
                    <a:lnTo>
                      <a:pt x="405" y="693"/>
                    </a:lnTo>
                    <a:lnTo>
                      <a:pt x="405" y="698"/>
                    </a:lnTo>
                    <a:lnTo>
                      <a:pt x="406" y="699"/>
                    </a:lnTo>
                    <a:lnTo>
                      <a:pt x="407" y="699"/>
                    </a:lnTo>
                    <a:lnTo>
                      <a:pt x="408" y="699"/>
                    </a:lnTo>
                    <a:lnTo>
                      <a:pt x="409" y="699"/>
                    </a:lnTo>
                    <a:lnTo>
                      <a:pt x="410" y="699"/>
                    </a:lnTo>
                    <a:lnTo>
                      <a:pt x="411" y="699"/>
                    </a:lnTo>
                    <a:lnTo>
                      <a:pt x="412" y="699"/>
                    </a:lnTo>
                    <a:lnTo>
                      <a:pt x="413" y="699"/>
                    </a:lnTo>
                    <a:lnTo>
                      <a:pt x="414" y="699"/>
                    </a:lnTo>
                    <a:lnTo>
                      <a:pt x="415" y="699"/>
                    </a:lnTo>
                    <a:lnTo>
                      <a:pt x="416" y="699"/>
                    </a:lnTo>
                    <a:lnTo>
                      <a:pt x="417" y="699"/>
                    </a:lnTo>
                    <a:lnTo>
                      <a:pt x="419" y="699"/>
                    </a:lnTo>
                    <a:lnTo>
                      <a:pt x="420" y="699"/>
                    </a:lnTo>
                    <a:lnTo>
                      <a:pt x="421" y="699"/>
                    </a:lnTo>
                    <a:lnTo>
                      <a:pt x="422" y="698"/>
                    </a:lnTo>
                    <a:lnTo>
                      <a:pt x="423" y="696"/>
                    </a:lnTo>
                    <a:lnTo>
                      <a:pt x="424" y="695"/>
                    </a:lnTo>
                    <a:lnTo>
                      <a:pt x="425" y="695"/>
                    </a:lnTo>
                    <a:lnTo>
                      <a:pt x="426" y="697"/>
                    </a:lnTo>
                    <a:lnTo>
                      <a:pt x="426" y="698"/>
                    </a:lnTo>
                    <a:lnTo>
                      <a:pt x="427" y="699"/>
                    </a:lnTo>
                    <a:lnTo>
                      <a:pt x="428" y="699"/>
                    </a:lnTo>
                    <a:lnTo>
                      <a:pt x="429" y="699"/>
                    </a:lnTo>
                    <a:lnTo>
                      <a:pt x="430" y="699"/>
                    </a:lnTo>
                    <a:lnTo>
                      <a:pt x="431" y="699"/>
                    </a:lnTo>
                    <a:lnTo>
                      <a:pt x="432" y="699"/>
                    </a:lnTo>
                    <a:lnTo>
                      <a:pt x="433" y="699"/>
                    </a:lnTo>
                    <a:lnTo>
                      <a:pt x="434" y="699"/>
                    </a:lnTo>
                    <a:lnTo>
                      <a:pt x="435" y="699"/>
                    </a:lnTo>
                    <a:lnTo>
                      <a:pt x="436" y="699"/>
                    </a:lnTo>
                    <a:lnTo>
                      <a:pt x="436" y="695"/>
                    </a:lnTo>
                    <a:lnTo>
                      <a:pt x="437" y="686"/>
                    </a:lnTo>
                    <a:lnTo>
                      <a:pt x="438" y="677"/>
                    </a:lnTo>
                    <a:lnTo>
                      <a:pt x="439" y="674"/>
                    </a:lnTo>
                    <a:lnTo>
                      <a:pt x="440" y="680"/>
                    </a:lnTo>
                    <a:lnTo>
                      <a:pt x="441" y="688"/>
                    </a:lnTo>
                    <a:lnTo>
                      <a:pt x="442" y="688"/>
                    </a:lnTo>
                    <a:lnTo>
                      <a:pt x="442" y="684"/>
                    </a:lnTo>
                    <a:lnTo>
                      <a:pt x="443" y="681"/>
                    </a:lnTo>
                    <a:lnTo>
                      <a:pt x="444" y="677"/>
                    </a:lnTo>
                    <a:lnTo>
                      <a:pt x="445" y="669"/>
                    </a:lnTo>
                    <a:lnTo>
                      <a:pt x="446" y="663"/>
                    </a:lnTo>
                    <a:lnTo>
                      <a:pt x="447" y="665"/>
                    </a:lnTo>
                    <a:lnTo>
                      <a:pt x="447" y="676"/>
                    </a:lnTo>
                    <a:lnTo>
                      <a:pt x="448" y="689"/>
                    </a:lnTo>
                    <a:lnTo>
                      <a:pt x="449" y="697"/>
                    </a:lnTo>
                    <a:lnTo>
                      <a:pt x="450" y="698"/>
                    </a:lnTo>
                    <a:lnTo>
                      <a:pt x="451" y="699"/>
                    </a:lnTo>
                    <a:lnTo>
                      <a:pt x="452" y="699"/>
                    </a:lnTo>
                    <a:lnTo>
                      <a:pt x="453" y="699"/>
                    </a:lnTo>
                    <a:lnTo>
                      <a:pt x="454" y="699"/>
                    </a:lnTo>
                    <a:lnTo>
                      <a:pt x="455" y="699"/>
                    </a:lnTo>
                    <a:lnTo>
                      <a:pt x="456" y="699"/>
                    </a:lnTo>
                    <a:lnTo>
                      <a:pt x="457" y="699"/>
                    </a:lnTo>
                    <a:lnTo>
                      <a:pt x="458" y="699"/>
                    </a:lnTo>
                    <a:lnTo>
                      <a:pt x="459" y="699"/>
                    </a:lnTo>
                    <a:lnTo>
                      <a:pt x="460" y="699"/>
                    </a:lnTo>
                    <a:lnTo>
                      <a:pt x="461" y="699"/>
                    </a:lnTo>
                    <a:lnTo>
                      <a:pt x="462" y="699"/>
                    </a:lnTo>
                    <a:lnTo>
                      <a:pt x="463" y="699"/>
                    </a:lnTo>
                    <a:lnTo>
                      <a:pt x="464" y="699"/>
                    </a:lnTo>
                    <a:lnTo>
                      <a:pt x="465" y="699"/>
                    </a:lnTo>
                    <a:lnTo>
                      <a:pt x="466" y="699"/>
                    </a:lnTo>
                    <a:lnTo>
                      <a:pt x="467" y="699"/>
                    </a:lnTo>
                    <a:lnTo>
                      <a:pt x="468" y="698"/>
                    </a:lnTo>
                    <a:lnTo>
                      <a:pt x="468" y="697"/>
                    </a:lnTo>
                    <a:lnTo>
                      <a:pt x="469" y="698"/>
                    </a:lnTo>
                    <a:lnTo>
                      <a:pt x="470" y="699"/>
                    </a:lnTo>
                    <a:lnTo>
                      <a:pt x="471" y="699"/>
                    </a:lnTo>
                    <a:lnTo>
                      <a:pt x="472" y="699"/>
                    </a:lnTo>
                    <a:lnTo>
                      <a:pt x="473" y="699"/>
                    </a:lnTo>
                    <a:lnTo>
                      <a:pt x="474" y="699"/>
                    </a:lnTo>
                    <a:lnTo>
                      <a:pt x="475" y="699"/>
                    </a:lnTo>
                    <a:lnTo>
                      <a:pt x="476" y="699"/>
                    </a:lnTo>
                    <a:lnTo>
                      <a:pt x="477" y="699"/>
                    </a:lnTo>
                    <a:lnTo>
                      <a:pt x="478" y="699"/>
                    </a:lnTo>
                    <a:lnTo>
                      <a:pt x="479" y="698"/>
                    </a:lnTo>
                    <a:lnTo>
                      <a:pt x="480" y="698"/>
                    </a:lnTo>
                    <a:lnTo>
                      <a:pt x="481" y="697"/>
                    </a:lnTo>
                    <a:lnTo>
                      <a:pt x="482" y="695"/>
                    </a:lnTo>
                    <a:lnTo>
                      <a:pt x="483" y="693"/>
                    </a:lnTo>
                    <a:lnTo>
                      <a:pt x="483" y="694"/>
                    </a:lnTo>
                    <a:lnTo>
                      <a:pt x="484" y="695"/>
                    </a:lnTo>
                    <a:lnTo>
                      <a:pt x="485" y="693"/>
                    </a:lnTo>
                    <a:lnTo>
                      <a:pt x="486" y="689"/>
                    </a:lnTo>
                    <a:lnTo>
                      <a:pt x="487" y="686"/>
                    </a:lnTo>
                    <a:lnTo>
                      <a:pt x="488" y="686"/>
                    </a:lnTo>
                    <a:lnTo>
                      <a:pt x="489" y="690"/>
                    </a:lnTo>
                    <a:lnTo>
                      <a:pt x="489" y="693"/>
                    </a:lnTo>
                    <a:lnTo>
                      <a:pt x="490" y="695"/>
                    </a:lnTo>
                    <a:lnTo>
                      <a:pt x="491" y="697"/>
                    </a:lnTo>
                    <a:lnTo>
                      <a:pt x="492" y="698"/>
                    </a:lnTo>
                    <a:lnTo>
                      <a:pt x="493" y="699"/>
                    </a:lnTo>
                    <a:lnTo>
                      <a:pt x="494" y="699"/>
                    </a:lnTo>
                    <a:lnTo>
                      <a:pt x="495" y="699"/>
                    </a:lnTo>
                    <a:lnTo>
                      <a:pt x="496" y="699"/>
                    </a:lnTo>
                    <a:lnTo>
                      <a:pt x="497" y="699"/>
                    </a:lnTo>
                    <a:lnTo>
                      <a:pt x="498" y="699"/>
                    </a:lnTo>
                    <a:lnTo>
                      <a:pt x="503" y="699"/>
                    </a:lnTo>
                    <a:lnTo>
                      <a:pt x="504" y="699"/>
                    </a:lnTo>
                    <a:lnTo>
                      <a:pt x="505" y="699"/>
                    </a:lnTo>
                    <a:lnTo>
                      <a:pt x="506" y="699"/>
                    </a:lnTo>
                    <a:lnTo>
                      <a:pt x="507" y="699"/>
                    </a:lnTo>
                    <a:lnTo>
                      <a:pt x="508" y="699"/>
                    </a:lnTo>
                    <a:lnTo>
                      <a:pt x="509" y="699"/>
                    </a:lnTo>
                    <a:lnTo>
                      <a:pt x="510" y="699"/>
                    </a:lnTo>
                    <a:lnTo>
                      <a:pt x="511" y="699"/>
                    </a:lnTo>
                    <a:lnTo>
                      <a:pt x="512" y="699"/>
                    </a:lnTo>
                    <a:lnTo>
                      <a:pt x="513" y="699"/>
                    </a:lnTo>
                    <a:lnTo>
                      <a:pt x="514" y="699"/>
                    </a:lnTo>
                    <a:lnTo>
                      <a:pt x="515" y="699"/>
                    </a:lnTo>
                    <a:lnTo>
                      <a:pt x="516" y="699"/>
                    </a:lnTo>
                    <a:lnTo>
                      <a:pt x="517" y="699"/>
                    </a:lnTo>
                    <a:lnTo>
                      <a:pt x="518" y="699"/>
                    </a:lnTo>
                    <a:lnTo>
                      <a:pt x="519" y="698"/>
                    </a:lnTo>
                    <a:lnTo>
                      <a:pt x="520" y="699"/>
                    </a:lnTo>
                    <a:lnTo>
                      <a:pt x="521" y="699"/>
                    </a:lnTo>
                    <a:lnTo>
                      <a:pt x="522" y="699"/>
                    </a:lnTo>
                    <a:lnTo>
                      <a:pt x="523" y="699"/>
                    </a:lnTo>
                    <a:lnTo>
                      <a:pt x="524" y="699"/>
                    </a:lnTo>
                    <a:lnTo>
                      <a:pt x="525" y="699"/>
                    </a:lnTo>
                    <a:lnTo>
                      <a:pt x="526" y="699"/>
                    </a:lnTo>
                    <a:lnTo>
                      <a:pt x="527" y="699"/>
                    </a:lnTo>
                    <a:lnTo>
                      <a:pt x="528" y="698"/>
                    </a:lnTo>
                    <a:lnTo>
                      <a:pt x="529" y="698"/>
                    </a:lnTo>
                    <a:lnTo>
                      <a:pt x="530" y="696"/>
                    </a:lnTo>
                    <a:lnTo>
                      <a:pt x="531" y="693"/>
                    </a:lnTo>
                    <a:lnTo>
                      <a:pt x="531" y="689"/>
                    </a:lnTo>
                    <a:lnTo>
                      <a:pt x="532" y="684"/>
                    </a:lnTo>
                    <a:lnTo>
                      <a:pt x="533" y="677"/>
                    </a:lnTo>
                    <a:lnTo>
                      <a:pt x="534" y="670"/>
                    </a:lnTo>
                    <a:lnTo>
                      <a:pt x="535" y="670"/>
                    </a:lnTo>
                    <a:lnTo>
                      <a:pt x="536" y="678"/>
                    </a:lnTo>
                    <a:lnTo>
                      <a:pt x="536" y="689"/>
                    </a:lnTo>
                    <a:lnTo>
                      <a:pt x="537" y="697"/>
                    </a:lnTo>
                    <a:lnTo>
                      <a:pt x="538" y="698"/>
                    </a:lnTo>
                    <a:lnTo>
                      <a:pt x="539" y="699"/>
                    </a:lnTo>
                    <a:lnTo>
                      <a:pt x="540" y="699"/>
                    </a:lnTo>
                    <a:lnTo>
                      <a:pt x="541" y="699"/>
                    </a:lnTo>
                    <a:lnTo>
                      <a:pt x="542" y="699"/>
                    </a:lnTo>
                    <a:lnTo>
                      <a:pt x="543" y="699"/>
                    </a:lnTo>
                    <a:lnTo>
                      <a:pt x="544" y="699"/>
                    </a:lnTo>
                    <a:lnTo>
                      <a:pt x="545" y="699"/>
                    </a:lnTo>
                    <a:lnTo>
                      <a:pt x="546" y="699"/>
                    </a:lnTo>
                    <a:lnTo>
                      <a:pt x="547" y="699"/>
                    </a:lnTo>
                    <a:lnTo>
                      <a:pt x="548" y="699"/>
                    </a:lnTo>
                    <a:lnTo>
                      <a:pt x="550" y="699"/>
                    </a:lnTo>
                    <a:lnTo>
                      <a:pt x="551" y="699"/>
                    </a:lnTo>
                    <a:lnTo>
                      <a:pt x="552" y="699"/>
                    </a:lnTo>
                    <a:lnTo>
                      <a:pt x="553" y="699"/>
                    </a:lnTo>
                    <a:lnTo>
                      <a:pt x="554" y="699"/>
                    </a:lnTo>
                    <a:lnTo>
                      <a:pt x="555" y="699"/>
                    </a:lnTo>
                    <a:lnTo>
                      <a:pt x="556" y="699"/>
                    </a:lnTo>
                    <a:lnTo>
                      <a:pt x="557" y="699"/>
                    </a:lnTo>
                    <a:lnTo>
                      <a:pt x="558" y="699"/>
                    </a:lnTo>
                    <a:lnTo>
                      <a:pt x="559" y="699"/>
                    </a:lnTo>
                    <a:lnTo>
                      <a:pt x="560" y="699"/>
                    </a:lnTo>
                    <a:lnTo>
                      <a:pt x="561" y="699"/>
                    </a:lnTo>
                    <a:lnTo>
                      <a:pt x="568" y="699"/>
                    </a:lnTo>
                    <a:lnTo>
                      <a:pt x="569" y="699"/>
                    </a:lnTo>
                    <a:lnTo>
                      <a:pt x="570" y="699"/>
                    </a:lnTo>
                    <a:lnTo>
                      <a:pt x="571" y="699"/>
                    </a:lnTo>
                    <a:lnTo>
                      <a:pt x="572" y="699"/>
                    </a:lnTo>
                    <a:lnTo>
                      <a:pt x="573" y="699"/>
                    </a:lnTo>
                    <a:lnTo>
                      <a:pt x="573" y="698"/>
                    </a:lnTo>
                    <a:lnTo>
                      <a:pt x="574" y="696"/>
                    </a:lnTo>
                    <a:lnTo>
                      <a:pt x="575" y="688"/>
                    </a:lnTo>
                    <a:lnTo>
                      <a:pt x="576" y="606"/>
                    </a:lnTo>
                    <a:lnTo>
                      <a:pt x="577" y="399"/>
                    </a:lnTo>
                    <a:lnTo>
                      <a:pt x="578" y="143"/>
                    </a:lnTo>
                    <a:lnTo>
                      <a:pt x="578" y="0"/>
                    </a:lnTo>
                    <a:lnTo>
                      <a:pt x="579" y="80"/>
                    </a:lnTo>
                    <a:lnTo>
                      <a:pt x="580" y="321"/>
                    </a:lnTo>
                    <a:lnTo>
                      <a:pt x="581" y="560"/>
                    </a:lnTo>
                    <a:lnTo>
                      <a:pt x="582" y="684"/>
                    </a:lnTo>
                    <a:lnTo>
                      <a:pt x="583" y="698"/>
                    </a:lnTo>
                    <a:lnTo>
                      <a:pt x="584" y="699"/>
                    </a:lnTo>
                    <a:lnTo>
                      <a:pt x="585" y="699"/>
                    </a:lnTo>
                    <a:lnTo>
                      <a:pt x="586" y="699"/>
                    </a:lnTo>
                    <a:lnTo>
                      <a:pt x="587" y="699"/>
                    </a:lnTo>
                    <a:lnTo>
                      <a:pt x="588" y="699"/>
                    </a:lnTo>
                    <a:lnTo>
                      <a:pt x="589" y="699"/>
                    </a:lnTo>
                    <a:lnTo>
                      <a:pt x="590" y="699"/>
                    </a:lnTo>
                    <a:lnTo>
                      <a:pt x="591" y="699"/>
                    </a:lnTo>
                    <a:lnTo>
                      <a:pt x="592" y="699"/>
                    </a:lnTo>
                    <a:lnTo>
                      <a:pt x="593" y="699"/>
                    </a:lnTo>
                    <a:lnTo>
                      <a:pt x="594" y="699"/>
                    </a:lnTo>
                    <a:lnTo>
                      <a:pt x="595" y="699"/>
                    </a:lnTo>
                    <a:lnTo>
                      <a:pt x="596" y="699"/>
                    </a:lnTo>
                    <a:lnTo>
                      <a:pt x="597" y="699"/>
                    </a:lnTo>
                    <a:lnTo>
                      <a:pt x="598" y="699"/>
                    </a:lnTo>
                    <a:lnTo>
                      <a:pt x="599" y="699"/>
                    </a:lnTo>
                    <a:lnTo>
                      <a:pt x="600" y="699"/>
                    </a:lnTo>
                    <a:lnTo>
                      <a:pt x="601" y="699"/>
                    </a:lnTo>
                    <a:lnTo>
                      <a:pt x="602" y="699"/>
                    </a:lnTo>
                    <a:lnTo>
                      <a:pt x="603" y="699"/>
                    </a:lnTo>
                    <a:lnTo>
                      <a:pt x="604" y="699"/>
                    </a:lnTo>
                    <a:lnTo>
                      <a:pt x="605" y="699"/>
                    </a:lnTo>
                    <a:lnTo>
                      <a:pt x="606" y="699"/>
                    </a:lnTo>
                    <a:lnTo>
                      <a:pt x="607" y="699"/>
                    </a:lnTo>
                    <a:lnTo>
                      <a:pt x="608" y="699"/>
                    </a:lnTo>
                    <a:lnTo>
                      <a:pt x="609" y="699"/>
                    </a:lnTo>
                    <a:lnTo>
                      <a:pt x="610" y="699"/>
                    </a:lnTo>
                    <a:lnTo>
                      <a:pt x="611" y="699"/>
                    </a:lnTo>
                    <a:lnTo>
                      <a:pt x="612" y="699"/>
                    </a:lnTo>
                    <a:lnTo>
                      <a:pt x="614" y="699"/>
                    </a:lnTo>
                    <a:lnTo>
                      <a:pt x="615" y="699"/>
                    </a:lnTo>
                    <a:lnTo>
                      <a:pt x="616" y="699"/>
                    </a:lnTo>
                    <a:lnTo>
                      <a:pt x="617" y="699"/>
                    </a:lnTo>
                    <a:lnTo>
                      <a:pt x="618" y="699"/>
                    </a:lnTo>
                    <a:lnTo>
                      <a:pt x="619" y="696"/>
                    </a:lnTo>
                    <a:lnTo>
                      <a:pt x="620" y="677"/>
                    </a:lnTo>
                    <a:lnTo>
                      <a:pt x="621" y="561"/>
                    </a:lnTo>
                    <a:lnTo>
                      <a:pt x="621" y="359"/>
                    </a:lnTo>
                    <a:lnTo>
                      <a:pt x="622" y="172"/>
                    </a:lnTo>
                    <a:lnTo>
                      <a:pt x="623" y="132"/>
                    </a:lnTo>
                    <a:lnTo>
                      <a:pt x="624" y="269"/>
                    </a:lnTo>
                    <a:lnTo>
                      <a:pt x="625" y="483"/>
                    </a:lnTo>
                    <a:lnTo>
                      <a:pt x="626" y="643"/>
                    </a:lnTo>
                    <a:lnTo>
                      <a:pt x="626" y="697"/>
                    </a:lnTo>
                    <a:lnTo>
                      <a:pt x="627" y="699"/>
                    </a:lnTo>
                    <a:lnTo>
                      <a:pt x="628" y="699"/>
                    </a:lnTo>
                    <a:lnTo>
                      <a:pt x="629" y="699"/>
                    </a:lnTo>
                    <a:lnTo>
                      <a:pt x="630" y="699"/>
                    </a:lnTo>
                    <a:lnTo>
                      <a:pt x="631" y="699"/>
                    </a:lnTo>
                    <a:lnTo>
                      <a:pt x="632" y="699"/>
                    </a:lnTo>
                    <a:lnTo>
                      <a:pt x="633" y="698"/>
                    </a:lnTo>
                    <a:lnTo>
                      <a:pt x="634" y="698"/>
                    </a:lnTo>
                    <a:lnTo>
                      <a:pt x="635" y="697"/>
                    </a:lnTo>
                    <a:lnTo>
                      <a:pt x="636" y="696"/>
                    </a:lnTo>
                    <a:lnTo>
                      <a:pt x="637" y="695"/>
                    </a:lnTo>
                    <a:lnTo>
                      <a:pt x="637" y="696"/>
                    </a:lnTo>
                    <a:lnTo>
                      <a:pt x="638" y="696"/>
                    </a:lnTo>
                    <a:lnTo>
                      <a:pt x="639" y="697"/>
                    </a:lnTo>
                    <a:lnTo>
                      <a:pt x="640" y="697"/>
                    </a:lnTo>
                    <a:lnTo>
                      <a:pt x="641" y="698"/>
                    </a:lnTo>
                    <a:lnTo>
                      <a:pt x="642" y="698"/>
                    </a:lnTo>
                    <a:lnTo>
                      <a:pt x="642" y="697"/>
                    </a:lnTo>
                    <a:lnTo>
                      <a:pt x="643" y="697"/>
                    </a:lnTo>
                    <a:lnTo>
                      <a:pt x="644" y="697"/>
                    </a:lnTo>
                    <a:lnTo>
                      <a:pt x="645" y="697"/>
                    </a:lnTo>
                    <a:lnTo>
                      <a:pt x="646" y="698"/>
                    </a:lnTo>
                    <a:lnTo>
                      <a:pt x="647" y="698"/>
                    </a:lnTo>
                    <a:lnTo>
                      <a:pt x="648" y="698"/>
                    </a:lnTo>
                    <a:lnTo>
                      <a:pt x="648" y="699"/>
                    </a:lnTo>
                    <a:lnTo>
                      <a:pt x="649" y="699"/>
                    </a:lnTo>
                    <a:lnTo>
                      <a:pt x="650" y="699"/>
                    </a:lnTo>
                    <a:lnTo>
                      <a:pt x="651" y="699"/>
                    </a:lnTo>
                    <a:lnTo>
                      <a:pt x="652" y="699"/>
                    </a:lnTo>
                    <a:lnTo>
                      <a:pt x="653" y="699"/>
                    </a:lnTo>
                    <a:lnTo>
                      <a:pt x="654" y="699"/>
                    </a:lnTo>
                    <a:lnTo>
                      <a:pt x="655" y="699"/>
                    </a:lnTo>
                    <a:lnTo>
                      <a:pt x="656" y="699"/>
                    </a:lnTo>
                    <a:lnTo>
                      <a:pt x="657" y="699"/>
                    </a:lnTo>
                    <a:lnTo>
                      <a:pt x="658" y="699"/>
                    </a:lnTo>
                    <a:lnTo>
                      <a:pt x="659" y="699"/>
                    </a:lnTo>
                    <a:lnTo>
                      <a:pt x="660" y="699"/>
                    </a:lnTo>
                    <a:lnTo>
                      <a:pt x="661" y="699"/>
                    </a:lnTo>
                    <a:lnTo>
                      <a:pt x="662" y="699"/>
                    </a:lnTo>
                    <a:lnTo>
                      <a:pt x="663" y="699"/>
                    </a:lnTo>
                    <a:lnTo>
                      <a:pt x="664" y="695"/>
                    </a:lnTo>
                    <a:lnTo>
                      <a:pt x="664" y="674"/>
                    </a:lnTo>
                    <a:lnTo>
                      <a:pt x="665" y="601"/>
                    </a:lnTo>
                    <a:lnTo>
                      <a:pt x="666" y="505"/>
                    </a:lnTo>
                    <a:lnTo>
                      <a:pt x="667" y="447"/>
                    </a:lnTo>
                    <a:lnTo>
                      <a:pt x="668" y="470"/>
                    </a:lnTo>
                    <a:lnTo>
                      <a:pt x="669" y="556"/>
                    </a:lnTo>
                    <a:lnTo>
                      <a:pt x="669" y="645"/>
                    </a:lnTo>
                    <a:lnTo>
                      <a:pt x="670" y="691"/>
                    </a:lnTo>
                    <a:lnTo>
                      <a:pt x="671" y="698"/>
                    </a:lnTo>
                    <a:lnTo>
                      <a:pt x="672" y="699"/>
                    </a:lnTo>
                    <a:lnTo>
                      <a:pt x="673" y="699"/>
                    </a:lnTo>
                    <a:lnTo>
                      <a:pt x="674" y="699"/>
                    </a:lnTo>
                    <a:lnTo>
                      <a:pt x="675" y="699"/>
                    </a:lnTo>
                    <a:lnTo>
                      <a:pt x="676" y="699"/>
                    </a:lnTo>
                    <a:lnTo>
                      <a:pt x="696" y="699"/>
                    </a:lnTo>
                    <a:lnTo>
                      <a:pt x="697" y="699"/>
                    </a:lnTo>
                    <a:lnTo>
                      <a:pt x="698" y="699"/>
                    </a:lnTo>
                    <a:lnTo>
                      <a:pt x="699" y="699"/>
                    </a:lnTo>
                    <a:lnTo>
                      <a:pt x="700" y="699"/>
                    </a:lnTo>
                    <a:lnTo>
                      <a:pt x="701" y="699"/>
                    </a:lnTo>
                    <a:lnTo>
                      <a:pt x="702" y="699"/>
                    </a:lnTo>
                    <a:lnTo>
                      <a:pt x="703" y="699"/>
                    </a:lnTo>
                    <a:lnTo>
                      <a:pt x="704" y="699"/>
                    </a:lnTo>
                    <a:lnTo>
                      <a:pt x="705" y="699"/>
                    </a:lnTo>
                    <a:lnTo>
                      <a:pt x="706" y="699"/>
                    </a:lnTo>
                    <a:lnTo>
                      <a:pt x="707" y="699"/>
                    </a:lnTo>
                    <a:lnTo>
                      <a:pt x="708" y="696"/>
                    </a:lnTo>
                    <a:lnTo>
                      <a:pt x="709" y="682"/>
                    </a:lnTo>
                    <a:lnTo>
                      <a:pt x="710" y="652"/>
                    </a:lnTo>
                    <a:lnTo>
                      <a:pt x="711" y="622"/>
                    </a:lnTo>
                    <a:lnTo>
                      <a:pt x="712" y="616"/>
                    </a:lnTo>
                    <a:lnTo>
                      <a:pt x="712" y="637"/>
                    </a:lnTo>
                    <a:lnTo>
                      <a:pt x="713" y="669"/>
                    </a:lnTo>
                    <a:lnTo>
                      <a:pt x="714" y="693"/>
                    </a:lnTo>
                    <a:lnTo>
                      <a:pt x="715" y="699"/>
                    </a:lnTo>
                    <a:lnTo>
                      <a:pt x="716" y="699"/>
                    </a:lnTo>
                    <a:lnTo>
                      <a:pt x="717" y="699"/>
                    </a:lnTo>
                    <a:lnTo>
                      <a:pt x="718" y="699"/>
                    </a:lnTo>
                    <a:lnTo>
                      <a:pt x="719" y="699"/>
                    </a:lnTo>
                    <a:lnTo>
                      <a:pt x="720" y="699"/>
                    </a:lnTo>
                    <a:lnTo>
                      <a:pt x="729" y="699"/>
                    </a:lnTo>
                    <a:lnTo>
                      <a:pt x="730" y="699"/>
                    </a:lnTo>
                    <a:lnTo>
                      <a:pt x="731" y="699"/>
                    </a:lnTo>
                    <a:lnTo>
                      <a:pt x="732" y="699"/>
                    </a:lnTo>
                    <a:lnTo>
                      <a:pt x="733" y="699"/>
                    </a:lnTo>
                    <a:lnTo>
                      <a:pt x="734" y="699"/>
                    </a:lnTo>
                    <a:lnTo>
                      <a:pt x="735" y="699"/>
                    </a:lnTo>
                    <a:lnTo>
                      <a:pt x="736" y="699"/>
                    </a:lnTo>
                    <a:lnTo>
                      <a:pt x="737" y="699"/>
                    </a:lnTo>
                    <a:lnTo>
                      <a:pt x="738" y="699"/>
                    </a:lnTo>
                    <a:lnTo>
                      <a:pt x="739" y="699"/>
                    </a:lnTo>
                    <a:lnTo>
                      <a:pt x="740" y="699"/>
                    </a:lnTo>
                    <a:lnTo>
                      <a:pt x="741" y="699"/>
                    </a:lnTo>
                    <a:lnTo>
                      <a:pt x="742" y="699"/>
                    </a:lnTo>
                    <a:lnTo>
                      <a:pt x="743" y="699"/>
                    </a:lnTo>
                    <a:lnTo>
                      <a:pt x="744" y="699"/>
                    </a:lnTo>
                    <a:lnTo>
                      <a:pt x="745" y="699"/>
                    </a:lnTo>
                    <a:lnTo>
                      <a:pt x="746" y="698"/>
                    </a:lnTo>
                    <a:lnTo>
                      <a:pt x="747" y="698"/>
                    </a:lnTo>
                    <a:lnTo>
                      <a:pt x="748" y="698"/>
                    </a:lnTo>
                    <a:lnTo>
                      <a:pt x="749" y="698"/>
                    </a:lnTo>
                    <a:lnTo>
                      <a:pt x="750" y="698"/>
                    </a:lnTo>
                    <a:lnTo>
                      <a:pt x="751" y="698"/>
                    </a:lnTo>
                    <a:lnTo>
                      <a:pt x="752" y="698"/>
                    </a:lnTo>
                    <a:lnTo>
                      <a:pt x="753" y="697"/>
                    </a:lnTo>
                    <a:lnTo>
                      <a:pt x="754" y="693"/>
                    </a:lnTo>
                    <a:lnTo>
                      <a:pt x="755" y="688"/>
                    </a:lnTo>
                    <a:lnTo>
                      <a:pt x="756" y="686"/>
                    </a:lnTo>
                    <a:lnTo>
                      <a:pt x="756" y="689"/>
                    </a:lnTo>
                    <a:lnTo>
                      <a:pt x="757" y="694"/>
                    </a:lnTo>
                    <a:lnTo>
                      <a:pt x="758" y="698"/>
                    </a:lnTo>
                    <a:lnTo>
                      <a:pt x="759" y="699"/>
                    </a:lnTo>
                    <a:lnTo>
                      <a:pt x="760" y="699"/>
                    </a:lnTo>
                    <a:lnTo>
                      <a:pt x="761" y="699"/>
                    </a:lnTo>
                    <a:lnTo>
                      <a:pt x="762" y="699"/>
                    </a:lnTo>
                    <a:lnTo>
                      <a:pt x="763" y="699"/>
                    </a:lnTo>
                    <a:lnTo>
                      <a:pt x="766" y="699"/>
                    </a:lnTo>
                    <a:lnTo>
                      <a:pt x="767" y="699"/>
                    </a:lnTo>
                    <a:lnTo>
                      <a:pt x="768" y="699"/>
                    </a:lnTo>
                    <a:lnTo>
                      <a:pt x="769" y="699"/>
                    </a:lnTo>
                    <a:lnTo>
                      <a:pt x="770" y="699"/>
                    </a:lnTo>
                    <a:lnTo>
                      <a:pt x="771" y="699"/>
                    </a:lnTo>
                    <a:lnTo>
                      <a:pt x="772" y="699"/>
                    </a:lnTo>
                    <a:lnTo>
                      <a:pt x="773" y="699"/>
                    </a:lnTo>
                    <a:lnTo>
                      <a:pt x="774" y="699"/>
                    </a:lnTo>
                    <a:lnTo>
                      <a:pt x="775" y="699"/>
                    </a:lnTo>
                    <a:lnTo>
                      <a:pt x="776" y="699"/>
                    </a:lnTo>
                    <a:lnTo>
                      <a:pt x="777" y="699"/>
                    </a:lnTo>
                    <a:lnTo>
                      <a:pt x="778" y="699"/>
                    </a:lnTo>
                    <a:lnTo>
                      <a:pt x="779" y="699"/>
                    </a:lnTo>
                    <a:lnTo>
                      <a:pt x="780" y="699"/>
                    </a:lnTo>
                    <a:lnTo>
                      <a:pt x="781" y="699"/>
                    </a:lnTo>
                    <a:lnTo>
                      <a:pt x="782" y="699"/>
                    </a:lnTo>
                    <a:lnTo>
                      <a:pt x="783" y="699"/>
                    </a:lnTo>
                    <a:lnTo>
                      <a:pt x="784" y="699"/>
                    </a:lnTo>
                    <a:lnTo>
                      <a:pt x="785" y="699"/>
                    </a:lnTo>
                    <a:lnTo>
                      <a:pt x="786" y="699"/>
                    </a:lnTo>
                    <a:lnTo>
                      <a:pt x="787" y="699"/>
                    </a:lnTo>
                    <a:lnTo>
                      <a:pt x="788" y="699"/>
                    </a:lnTo>
                    <a:lnTo>
                      <a:pt x="789" y="699"/>
                    </a:lnTo>
                    <a:lnTo>
                      <a:pt x="790" y="699"/>
                    </a:lnTo>
                    <a:lnTo>
                      <a:pt x="791" y="699"/>
                    </a:lnTo>
                    <a:lnTo>
                      <a:pt x="792" y="699"/>
                    </a:lnTo>
                    <a:lnTo>
                      <a:pt x="793" y="699"/>
                    </a:lnTo>
                    <a:lnTo>
                      <a:pt x="794" y="699"/>
                    </a:lnTo>
                    <a:lnTo>
                      <a:pt x="795" y="699"/>
                    </a:lnTo>
                    <a:lnTo>
                      <a:pt x="796" y="699"/>
                    </a:lnTo>
                    <a:lnTo>
                      <a:pt x="797" y="699"/>
                    </a:lnTo>
                    <a:lnTo>
                      <a:pt x="798" y="699"/>
                    </a:lnTo>
                    <a:lnTo>
                      <a:pt x="799" y="699"/>
                    </a:lnTo>
                    <a:lnTo>
                      <a:pt x="800" y="699"/>
                    </a:lnTo>
                    <a:lnTo>
                      <a:pt x="801" y="699"/>
                    </a:lnTo>
                    <a:lnTo>
                      <a:pt x="802" y="699"/>
                    </a:lnTo>
                    <a:lnTo>
                      <a:pt x="803" y="699"/>
                    </a:lnTo>
                    <a:lnTo>
                      <a:pt x="804" y="699"/>
                    </a:lnTo>
                    <a:lnTo>
                      <a:pt x="805" y="699"/>
                    </a:lnTo>
                    <a:lnTo>
                      <a:pt x="806" y="699"/>
                    </a:lnTo>
                    <a:lnTo>
                      <a:pt x="807" y="699"/>
                    </a:lnTo>
                    <a:lnTo>
                      <a:pt x="808" y="699"/>
                    </a:lnTo>
                    <a:lnTo>
                      <a:pt x="809" y="699"/>
                    </a:lnTo>
                    <a:lnTo>
                      <a:pt x="810" y="699"/>
                    </a:lnTo>
                    <a:lnTo>
                      <a:pt x="811" y="699"/>
                    </a:lnTo>
                    <a:lnTo>
                      <a:pt x="812" y="699"/>
                    </a:lnTo>
                    <a:lnTo>
                      <a:pt x="813" y="699"/>
                    </a:lnTo>
                    <a:lnTo>
                      <a:pt x="814" y="699"/>
                    </a:lnTo>
                    <a:lnTo>
                      <a:pt x="815" y="699"/>
                    </a:lnTo>
                    <a:lnTo>
                      <a:pt x="816" y="699"/>
                    </a:lnTo>
                    <a:lnTo>
                      <a:pt x="817" y="699"/>
                    </a:lnTo>
                    <a:lnTo>
                      <a:pt x="818" y="699"/>
                    </a:lnTo>
                    <a:lnTo>
                      <a:pt x="819" y="699"/>
                    </a:lnTo>
                    <a:lnTo>
                      <a:pt x="820" y="699"/>
                    </a:lnTo>
                    <a:lnTo>
                      <a:pt x="821" y="699"/>
                    </a:lnTo>
                    <a:lnTo>
                      <a:pt x="829" y="699"/>
                    </a:lnTo>
                    <a:lnTo>
                      <a:pt x="830" y="699"/>
                    </a:lnTo>
                    <a:lnTo>
                      <a:pt x="831" y="699"/>
                    </a:lnTo>
                    <a:lnTo>
                      <a:pt x="832" y="699"/>
                    </a:lnTo>
                    <a:lnTo>
                      <a:pt x="833" y="698"/>
                    </a:lnTo>
                    <a:lnTo>
                      <a:pt x="834" y="693"/>
                    </a:lnTo>
                    <a:lnTo>
                      <a:pt x="835" y="687"/>
                    </a:lnTo>
                    <a:lnTo>
                      <a:pt x="836" y="683"/>
                    </a:lnTo>
                    <a:lnTo>
                      <a:pt x="837" y="686"/>
                    </a:lnTo>
                    <a:lnTo>
                      <a:pt x="837" y="692"/>
                    </a:lnTo>
                    <a:lnTo>
                      <a:pt x="838" y="697"/>
                    </a:lnTo>
                    <a:lnTo>
                      <a:pt x="839" y="697"/>
                    </a:lnTo>
                    <a:lnTo>
                      <a:pt x="840" y="696"/>
                    </a:lnTo>
                    <a:lnTo>
                      <a:pt x="841" y="696"/>
                    </a:lnTo>
                    <a:lnTo>
                      <a:pt x="842" y="696"/>
                    </a:lnTo>
                    <a:lnTo>
                      <a:pt x="843" y="697"/>
                    </a:lnTo>
                    <a:lnTo>
                      <a:pt x="843" y="699"/>
                    </a:lnTo>
                    <a:lnTo>
                      <a:pt x="844" y="699"/>
                    </a:lnTo>
                    <a:lnTo>
                      <a:pt x="845" y="699"/>
                    </a:lnTo>
                    <a:lnTo>
                      <a:pt x="846" y="699"/>
                    </a:lnTo>
                    <a:lnTo>
                      <a:pt x="847" y="699"/>
                    </a:lnTo>
                    <a:lnTo>
                      <a:pt x="848" y="699"/>
                    </a:lnTo>
                    <a:lnTo>
                      <a:pt x="849" y="699"/>
                    </a:lnTo>
                    <a:lnTo>
                      <a:pt x="850" y="699"/>
                    </a:lnTo>
                    <a:lnTo>
                      <a:pt x="851" y="699"/>
                    </a:lnTo>
                    <a:lnTo>
                      <a:pt x="852" y="699"/>
                    </a:lnTo>
                    <a:lnTo>
                      <a:pt x="853" y="699"/>
                    </a:lnTo>
                    <a:lnTo>
                      <a:pt x="854" y="699"/>
                    </a:lnTo>
                    <a:lnTo>
                      <a:pt x="855" y="699"/>
                    </a:lnTo>
                    <a:lnTo>
                      <a:pt x="856" y="699"/>
                    </a:lnTo>
                    <a:lnTo>
                      <a:pt x="857" y="699"/>
                    </a:lnTo>
                    <a:lnTo>
                      <a:pt x="858" y="699"/>
                    </a:lnTo>
                    <a:lnTo>
                      <a:pt x="859" y="699"/>
                    </a:lnTo>
                    <a:lnTo>
                      <a:pt x="860" y="699"/>
                    </a:lnTo>
                    <a:lnTo>
                      <a:pt x="861" y="699"/>
                    </a:lnTo>
                    <a:lnTo>
                      <a:pt x="862" y="698"/>
                    </a:lnTo>
                    <a:lnTo>
                      <a:pt x="863" y="696"/>
                    </a:lnTo>
                    <a:lnTo>
                      <a:pt x="864" y="689"/>
                    </a:lnTo>
                    <a:lnTo>
                      <a:pt x="865" y="683"/>
                    </a:lnTo>
                    <a:lnTo>
                      <a:pt x="865" y="680"/>
                    </a:lnTo>
                    <a:lnTo>
                      <a:pt x="866" y="685"/>
                    </a:lnTo>
                    <a:lnTo>
                      <a:pt x="867" y="692"/>
                    </a:lnTo>
                    <a:lnTo>
                      <a:pt x="868" y="698"/>
                    </a:lnTo>
                    <a:lnTo>
                      <a:pt x="869" y="699"/>
                    </a:lnTo>
                    <a:lnTo>
                      <a:pt x="870" y="699"/>
                    </a:lnTo>
                    <a:lnTo>
                      <a:pt x="871" y="699"/>
                    </a:lnTo>
                    <a:lnTo>
                      <a:pt x="872" y="699"/>
                    </a:lnTo>
                    <a:lnTo>
                      <a:pt x="873" y="699"/>
                    </a:lnTo>
                    <a:lnTo>
                      <a:pt x="879" y="699"/>
                    </a:lnTo>
                    <a:lnTo>
                      <a:pt x="880" y="699"/>
                    </a:lnTo>
                    <a:lnTo>
                      <a:pt x="881" y="699"/>
                    </a:lnTo>
                    <a:lnTo>
                      <a:pt x="882" y="699"/>
                    </a:lnTo>
                    <a:lnTo>
                      <a:pt x="883" y="698"/>
                    </a:lnTo>
                    <a:lnTo>
                      <a:pt x="884" y="698"/>
                    </a:lnTo>
                    <a:lnTo>
                      <a:pt x="885" y="698"/>
                    </a:lnTo>
                    <a:lnTo>
                      <a:pt x="886" y="698"/>
                    </a:lnTo>
                    <a:lnTo>
                      <a:pt x="887" y="699"/>
                    </a:lnTo>
                    <a:lnTo>
                      <a:pt x="888" y="699"/>
                    </a:lnTo>
                    <a:lnTo>
                      <a:pt x="889" y="699"/>
                    </a:lnTo>
                    <a:lnTo>
                      <a:pt x="890" y="699"/>
                    </a:lnTo>
                    <a:lnTo>
                      <a:pt x="891" y="699"/>
                    </a:lnTo>
                    <a:lnTo>
                      <a:pt x="892" y="699"/>
                    </a:lnTo>
                    <a:lnTo>
                      <a:pt x="893" y="698"/>
                    </a:lnTo>
                    <a:lnTo>
                      <a:pt x="893" y="693"/>
                    </a:lnTo>
                    <a:lnTo>
                      <a:pt x="894" y="688"/>
                    </a:lnTo>
                    <a:lnTo>
                      <a:pt x="895" y="687"/>
                    </a:lnTo>
                    <a:lnTo>
                      <a:pt x="896" y="690"/>
                    </a:lnTo>
                    <a:lnTo>
                      <a:pt x="897" y="695"/>
                    </a:lnTo>
                    <a:lnTo>
                      <a:pt x="898" y="699"/>
                    </a:lnTo>
                    <a:lnTo>
                      <a:pt x="899" y="699"/>
                    </a:lnTo>
                    <a:lnTo>
                      <a:pt x="900" y="699"/>
                    </a:lnTo>
                    <a:lnTo>
                      <a:pt x="901" y="699"/>
                    </a:lnTo>
                    <a:lnTo>
                      <a:pt x="902" y="699"/>
                    </a:lnTo>
                    <a:lnTo>
                      <a:pt x="903" y="699"/>
                    </a:lnTo>
                    <a:lnTo>
                      <a:pt x="904" y="699"/>
                    </a:lnTo>
                    <a:lnTo>
                      <a:pt x="905" y="699"/>
                    </a:lnTo>
                    <a:lnTo>
                      <a:pt x="906" y="699"/>
                    </a:lnTo>
                    <a:lnTo>
                      <a:pt x="907" y="699"/>
                    </a:lnTo>
                    <a:lnTo>
                      <a:pt x="908" y="699"/>
                    </a:lnTo>
                    <a:lnTo>
                      <a:pt x="909" y="699"/>
                    </a:lnTo>
                    <a:lnTo>
                      <a:pt x="918" y="699"/>
                    </a:lnTo>
                    <a:lnTo>
                      <a:pt x="919" y="699"/>
                    </a:lnTo>
                    <a:lnTo>
                      <a:pt x="920" y="699"/>
                    </a:lnTo>
                    <a:lnTo>
                      <a:pt x="921" y="699"/>
                    </a:lnTo>
                    <a:lnTo>
                      <a:pt x="922" y="699"/>
                    </a:lnTo>
                    <a:lnTo>
                      <a:pt x="923" y="696"/>
                    </a:lnTo>
                    <a:lnTo>
                      <a:pt x="924" y="694"/>
                    </a:lnTo>
                    <a:lnTo>
                      <a:pt x="925" y="693"/>
                    </a:lnTo>
                    <a:lnTo>
                      <a:pt x="926" y="694"/>
                    </a:lnTo>
                    <a:lnTo>
                      <a:pt x="926" y="697"/>
                    </a:lnTo>
                    <a:lnTo>
                      <a:pt x="927" y="698"/>
                    </a:lnTo>
                    <a:lnTo>
                      <a:pt x="928" y="698"/>
                    </a:lnTo>
                    <a:lnTo>
                      <a:pt x="929" y="697"/>
                    </a:lnTo>
                    <a:lnTo>
                      <a:pt x="930" y="697"/>
                    </a:lnTo>
                    <a:lnTo>
                      <a:pt x="931" y="698"/>
                    </a:lnTo>
                    <a:lnTo>
                      <a:pt x="931" y="699"/>
                    </a:lnTo>
                    <a:lnTo>
                      <a:pt x="932" y="699"/>
                    </a:lnTo>
                    <a:lnTo>
                      <a:pt x="933" y="699"/>
                    </a:lnTo>
                    <a:lnTo>
                      <a:pt x="934" y="699"/>
                    </a:lnTo>
                    <a:lnTo>
                      <a:pt x="935" y="699"/>
                    </a:lnTo>
                    <a:lnTo>
                      <a:pt x="936" y="699"/>
                    </a:lnTo>
                    <a:lnTo>
                      <a:pt x="937" y="699"/>
                    </a:lnTo>
                    <a:lnTo>
                      <a:pt x="938" y="699"/>
                    </a:lnTo>
                    <a:lnTo>
                      <a:pt x="939" y="699"/>
                    </a:lnTo>
                    <a:lnTo>
                      <a:pt x="940" y="699"/>
                    </a:lnTo>
                    <a:lnTo>
                      <a:pt x="941" y="699"/>
                    </a:lnTo>
                    <a:lnTo>
                      <a:pt x="942" y="699"/>
                    </a:lnTo>
                    <a:lnTo>
                      <a:pt x="943" y="699"/>
                    </a:lnTo>
                    <a:lnTo>
                      <a:pt x="944" y="699"/>
                    </a:lnTo>
                    <a:lnTo>
                      <a:pt x="945" y="699"/>
                    </a:lnTo>
                    <a:lnTo>
                      <a:pt x="946" y="699"/>
                    </a:lnTo>
                    <a:lnTo>
                      <a:pt x="947" y="699"/>
                    </a:lnTo>
                    <a:lnTo>
                      <a:pt x="948" y="699"/>
                    </a:lnTo>
                    <a:lnTo>
                      <a:pt x="949" y="699"/>
                    </a:lnTo>
                    <a:lnTo>
                      <a:pt x="950" y="699"/>
                    </a:lnTo>
                    <a:lnTo>
                      <a:pt x="951" y="699"/>
                    </a:lnTo>
                    <a:lnTo>
                      <a:pt x="952" y="699"/>
                    </a:lnTo>
                    <a:lnTo>
                      <a:pt x="953" y="699"/>
                    </a:lnTo>
                    <a:lnTo>
                      <a:pt x="954" y="699"/>
                    </a:lnTo>
                    <a:lnTo>
                      <a:pt x="955" y="699"/>
                    </a:lnTo>
                    <a:lnTo>
                      <a:pt x="956" y="699"/>
                    </a:lnTo>
                    <a:lnTo>
                      <a:pt x="957" y="699"/>
                    </a:lnTo>
                    <a:lnTo>
                      <a:pt x="958" y="699"/>
                    </a:lnTo>
                    <a:lnTo>
                      <a:pt x="959" y="699"/>
                    </a:lnTo>
                    <a:lnTo>
                      <a:pt x="968" y="699"/>
                    </a:lnTo>
                    <a:lnTo>
                      <a:pt x="969" y="699"/>
                    </a:lnTo>
                    <a:lnTo>
                      <a:pt x="970" y="699"/>
                    </a:lnTo>
                    <a:lnTo>
                      <a:pt x="971" y="699"/>
                    </a:lnTo>
                    <a:lnTo>
                      <a:pt x="972" y="699"/>
                    </a:lnTo>
                    <a:lnTo>
                      <a:pt x="973" y="699"/>
                    </a:lnTo>
                    <a:lnTo>
                      <a:pt x="974" y="699"/>
                    </a:lnTo>
                    <a:lnTo>
                      <a:pt x="975" y="699"/>
                    </a:lnTo>
                    <a:lnTo>
                      <a:pt x="976" y="699"/>
                    </a:lnTo>
                    <a:lnTo>
                      <a:pt x="977" y="699"/>
                    </a:lnTo>
                    <a:lnTo>
                      <a:pt x="978" y="699"/>
                    </a:lnTo>
                    <a:lnTo>
                      <a:pt x="979" y="699"/>
                    </a:lnTo>
                    <a:lnTo>
                      <a:pt x="980" y="699"/>
                    </a:lnTo>
                    <a:lnTo>
                      <a:pt x="981" y="699"/>
                    </a:lnTo>
                    <a:lnTo>
                      <a:pt x="982" y="699"/>
                    </a:lnTo>
                    <a:lnTo>
                      <a:pt x="983" y="699"/>
                    </a:lnTo>
                    <a:lnTo>
                      <a:pt x="984" y="699"/>
                    </a:lnTo>
                    <a:lnTo>
                      <a:pt x="985" y="699"/>
                    </a:lnTo>
                    <a:lnTo>
                      <a:pt x="986" y="699"/>
                    </a:lnTo>
                    <a:lnTo>
                      <a:pt x="987" y="699"/>
                    </a:lnTo>
                    <a:lnTo>
                      <a:pt x="998" y="699"/>
                    </a:lnTo>
                    <a:lnTo>
                      <a:pt x="999" y="699"/>
                    </a:lnTo>
                    <a:lnTo>
                      <a:pt x="1000" y="699"/>
                    </a:lnTo>
                    <a:lnTo>
                      <a:pt x="1001" y="699"/>
                    </a:lnTo>
                    <a:lnTo>
                      <a:pt x="1002" y="699"/>
                    </a:lnTo>
                    <a:lnTo>
                      <a:pt x="1003" y="699"/>
                    </a:lnTo>
                    <a:lnTo>
                      <a:pt x="1004" y="699"/>
                    </a:lnTo>
                    <a:lnTo>
                      <a:pt x="1005" y="699"/>
                    </a:lnTo>
                    <a:lnTo>
                      <a:pt x="1006" y="699"/>
                    </a:lnTo>
                    <a:lnTo>
                      <a:pt x="1007" y="699"/>
                    </a:lnTo>
                    <a:lnTo>
                      <a:pt x="1008" y="699"/>
                    </a:lnTo>
                    <a:lnTo>
                      <a:pt x="1009" y="699"/>
                    </a:lnTo>
                    <a:lnTo>
                      <a:pt x="1010" y="699"/>
                    </a:lnTo>
                    <a:lnTo>
                      <a:pt x="1011" y="699"/>
                    </a:lnTo>
                    <a:lnTo>
                      <a:pt x="1012" y="699"/>
                    </a:lnTo>
                    <a:lnTo>
                      <a:pt x="1013" y="699"/>
                    </a:lnTo>
                    <a:lnTo>
                      <a:pt x="1014" y="699"/>
                    </a:lnTo>
                    <a:lnTo>
                      <a:pt x="1015" y="699"/>
                    </a:lnTo>
                    <a:lnTo>
                      <a:pt x="1016" y="699"/>
                    </a:lnTo>
                    <a:lnTo>
                      <a:pt x="1017" y="699"/>
                    </a:lnTo>
                    <a:lnTo>
                      <a:pt x="1018" y="699"/>
                    </a:lnTo>
                    <a:lnTo>
                      <a:pt x="1019" y="699"/>
                    </a:lnTo>
                    <a:lnTo>
                      <a:pt x="1020" y="699"/>
                    </a:lnTo>
                    <a:lnTo>
                      <a:pt x="1021" y="699"/>
                    </a:lnTo>
                    <a:lnTo>
                      <a:pt x="1022" y="699"/>
                    </a:lnTo>
                    <a:lnTo>
                      <a:pt x="1023" y="699"/>
                    </a:lnTo>
                    <a:lnTo>
                      <a:pt x="1024" y="699"/>
                    </a:lnTo>
                    <a:lnTo>
                      <a:pt x="1025" y="699"/>
                    </a:lnTo>
                    <a:lnTo>
                      <a:pt x="1026" y="699"/>
                    </a:lnTo>
                    <a:lnTo>
                      <a:pt x="1029" y="699"/>
                    </a:lnTo>
                    <a:lnTo>
                      <a:pt x="1030" y="699"/>
                    </a:lnTo>
                    <a:lnTo>
                      <a:pt x="1031" y="699"/>
                    </a:lnTo>
                    <a:lnTo>
                      <a:pt x="1032" y="699"/>
                    </a:lnTo>
                    <a:lnTo>
                      <a:pt x="1033" y="699"/>
                    </a:lnTo>
                    <a:lnTo>
                      <a:pt x="1034" y="699"/>
                    </a:lnTo>
                    <a:lnTo>
                      <a:pt x="1035" y="699"/>
                    </a:lnTo>
                    <a:lnTo>
                      <a:pt x="1036" y="699"/>
                    </a:lnTo>
                    <a:lnTo>
                      <a:pt x="1037" y="699"/>
                    </a:lnTo>
                    <a:lnTo>
                      <a:pt x="1038" y="699"/>
                    </a:lnTo>
                    <a:lnTo>
                      <a:pt x="1039" y="699"/>
                    </a:lnTo>
                    <a:lnTo>
                      <a:pt x="1040" y="699"/>
                    </a:lnTo>
                    <a:lnTo>
                      <a:pt x="1041" y="699"/>
                    </a:lnTo>
                    <a:lnTo>
                      <a:pt x="1050" y="699"/>
                    </a:lnTo>
                    <a:lnTo>
                      <a:pt x="1051" y="699"/>
                    </a:lnTo>
                    <a:lnTo>
                      <a:pt x="1052" y="699"/>
                    </a:lnTo>
                    <a:lnTo>
                      <a:pt x="1053" y="699"/>
                    </a:lnTo>
                    <a:lnTo>
                      <a:pt x="1054" y="699"/>
                    </a:lnTo>
                    <a:lnTo>
                      <a:pt x="1055" y="699"/>
                    </a:lnTo>
                    <a:lnTo>
                      <a:pt x="1056" y="699"/>
                    </a:lnTo>
                    <a:lnTo>
                      <a:pt x="1057" y="699"/>
                    </a:lnTo>
                    <a:lnTo>
                      <a:pt x="1058" y="699"/>
                    </a:lnTo>
                    <a:lnTo>
                      <a:pt x="1059" y="699"/>
                    </a:lnTo>
                    <a:lnTo>
                      <a:pt x="1060" y="699"/>
                    </a:lnTo>
                    <a:lnTo>
                      <a:pt x="1061" y="699"/>
                    </a:lnTo>
                    <a:lnTo>
                      <a:pt x="1062" y="699"/>
                    </a:lnTo>
                    <a:lnTo>
                      <a:pt x="1063" y="699"/>
                    </a:lnTo>
                    <a:lnTo>
                      <a:pt x="1064" y="699"/>
                    </a:lnTo>
                    <a:lnTo>
                      <a:pt x="1065" y="699"/>
                    </a:lnTo>
                    <a:lnTo>
                      <a:pt x="1066" y="699"/>
                    </a:lnTo>
                    <a:lnTo>
                      <a:pt x="1067" y="699"/>
                    </a:lnTo>
                    <a:lnTo>
                      <a:pt x="1068" y="699"/>
                    </a:lnTo>
                    <a:lnTo>
                      <a:pt x="1069" y="699"/>
                    </a:lnTo>
                    <a:lnTo>
                      <a:pt x="1070" y="699"/>
                    </a:lnTo>
                    <a:lnTo>
                      <a:pt x="1071" y="699"/>
                    </a:lnTo>
                    <a:lnTo>
                      <a:pt x="1072" y="699"/>
                    </a:lnTo>
                    <a:lnTo>
                      <a:pt x="1073" y="699"/>
                    </a:lnTo>
                    <a:lnTo>
                      <a:pt x="1074" y="699"/>
                    </a:lnTo>
                    <a:lnTo>
                      <a:pt x="1075" y="699"/>
                    </a:lnTo>
                    <a:lnTo>
                      <a:pt x="1076" y="699"/>
                    </a:lnTo>
                    <a:lnTo>
                      <a:pt x="1077" y="699"/>
                    </a:lnTo>
                    <a:lnTo>
                      <a:pt x="1078" y="699"/>
                    </a:lnTo>
                    <a:lnTo>
                      <a:pt x="1079" y="699"/>
                    </a:lnTo>
                    <a:lnTo>
                      <a:pt x="1080" y="699"/>
                    </a:lnTo>
                    <a:lnTo>
                      <a:pt x="1081" y="699"/>
                    </a:lnTo>
                    <a:lnTo>
                      <a:pt x="1082" y="699"/>
                    </a:lnTo>
                    <a:lnTo>
                      <a:pt x="1090" y="699"/>
                    </a:lnTo>
                    <a:lnTo>
                      <a:pt x="1091" y="699"/>
                    </a:lnTo>
                    <a:lnTo>
                      <a:pt x="1092" y="699"/>
                    </a:lnTo>
                    <a:lnTo>
                      <a:pt x="1093" y="699"/>
                    </a:lnTo>
                    <a:lnTo>
                      <a:pt x="1094" y="699"/>
                    </a:lnTo>
                    <a:lnTo>
                      <a:pt x="1095" y="699"/>
                    </a:lnTo>
                    <a:lnTo>
                      <a:pt x="1096" y="699"/>
                    </a:lnTo>
                    <a:lnTo>
                      <a:pt x="1097" y="699"/>
                    </a:lnTo>
                    <a:lnTo>
                      <a:pt x="1098" y="699"/>
                    </a:lnTo>
                    <a:lnTo>
                      <a:pt x="1099" y="699"/>
                    </a:lnTo>
                    <a:lnTo>
                      <a:pt x="1100" y="699"/>
                    </a:lnTo>
                    <a:lnTo>
                      <a:pt x="1101" y="699"/>
                    </a:lnTo>
                    <a:lnTo>
                      <a:pt x="1102" y="699"/>
                    </a:lnTo>
                    <a:lnTo>
                      <a:pt x="1103" y="699"/>
                    </a:lnTo>
                    <a:lnTo>
                      <a:pt x="1104" y="699"/>
                    </a:lnTo>
                    <a:lnTo>
                      <a:pt x="1105" y="699"/>
                    </a:lnTo>
                    <a:lnTo>
                      <a:pt x="1106" y="699"/>
                    </a:lnTo>
                    <a:lnTo>
                      <a:pt x="1107" y="699"/>
                    </a:lnTo>
                    <a:lnTo>
                      <a:pt x="1108" y="699"/>
                    </a:lnTo>
                    <a:lnTo>
                      <a:pt x="1109" y="699"/>
                    </a:lnTo>
                    <a:lnTo>
                      <a:pt x="1110" y="699"/>
                    </a:lnTo>
                    <a:lnTo>
                      <a:pt x="1111" y="699"/>
                    </a:lnTo>
                    <a:lnTo>
                      <a:pt x="1112" y="699"/>
                    </a:lnTo>
                    <a:lnTo>
                      <a:pt x="1113" y="699"/>
                    </a:lnTo>
                    <a:lnTo>
                      <a:pt x="1114" y="699"/>
                    </a:lnTo>
                    <a:lnTo>
                      <a:pt x="1115" y="699"/>
                    </a:lnTo>
                    <a:lnTo>
                      <a:pt x="1116" y="699"/>
                    </a:lnTo>
                    <a:lnTo>
                      <a:pt x="1117" y="699"/>
                    </a:lnTo>
                    <a:lnTo>
                      <a:pt x="1118" y="699"/>
                    </a:lnTo>
                    <a:lnTo>
                      <a:pt x="1119" y="699"/>
                    </a:lnTo>
                    <a:lnTo>
                      <a:pt x="1120" y="699"/>
                    </a:lnTo>
                    <a:lnTo>
                      <a:pt x="1121" y="699"/>
                    </a:lnTo>
                    <a:lnTo>
                      <a:pt x="1122" y="699"/>
                    </a:lnTo>
                    <a:lnTo>
                      <a:pt x="1123" y="699"/>
                    </a:lnTo>
                    <a:lnTo>
                      <a:pt x="1124" y="699"/>
                    </a:lnTo>
                    <a:lnTo>
                      <a:pt x="1125" y="699"/>
                    </a:lnTo>
                    <a:lnTo>
                      <a:pt x="1126" y="699"/>
                    </a:lnTo>
                    <a:lnTo>
                      <a:pt x="1127" y="699"/>
                    </a:lnTo>
                    <a:lnTo>
                      <a:pt x="1128" y="699"/>
                    </a:lnTo>
                    <a:lnTo>
                      <a:pt x="1142" y="699"/>
                    </a:lnTo>
                    <a:lnTo>
                      <a:pt x="1143" y="699"/>
                    </a:lnTo>
                    <a:lnTo>
                      <a:pt x="1144" y="699"/>
                    </a:lnTo>
                    <a:lnTo>
                      <a:pt x="1145" y="699"/>
                    </a:lnTo>
                    <a:lnTo>
                      <a:pt x="1146" y="699"/>
                    </a:lnTo>
                    <a:lnTo>
                      <a:pt x="1147" y="699"/>
                    </a:lnTo>
                    <a:lnTo>
                      <a:pt x="1148" y="699"/>
                    </a:lnTo>
                    <a:lnTo>
                      <a:pt x="1149" y="699"/>
                    </a:lnTo>
                    <a:lnTo>
                      <a:pt x="1150" y="699"/>
                    </a:lnTo>
                    <a:lnTo>
                      <a:pt x="1151" y="699"/>
                    </a:lnTo>
                    <a:lnTo>
                      <a:pt x="1152" y="699"/>
                    </a:lnTo>
                    <a:lnTo>
                      <a:pt x="1153" y="699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8" name="Line 249"/>
              <p:cNvSpPr>
                <a:spLocks noChangeShapeType="1"/>
              </p:cNvSpPr>
              <p:nvPr/>
            </p:nvSpPr>
            <p:spPr bwMode="auto">
              <a:xfrm flipV="1">
                <a:off x="3802567" y="5759546"/>
                <a:ext cx="68263" cy="174528"/>
              </a:xfrm>
              <a:prstGeom prst="line">
                <a:avLst/>
              </a:prstGeom>
              <a:noFill/>
              <a:ln w="12700" cap="rnd">
                <a:solidFill>
                  <a:srgbClr val="00B0F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19" name="Line 263"/>
              <p:cNvSpPr>
                <a:spLocks noChangeShapeType="1"/>
              </p:cNvSpPr>
              <p:nvPr/>
            </p:nvSpPr>
            <p:spPr bwMode="auto">
              <a:xfrm flipV="1">
                <a:off x="7064881" y="5989609"/>
                <a:ext cx="67496" cy="153510"/>
              </a:xfrm>
              <a:prstGeom prst="line">
                <a:avLst/>
              </a:prstGeom>
              <a:noFill/>
              <a:ln w="12700" cap="rnd">
                <a:solidFill>
                  <a:srgbClr val="00B0F0"/>
                </a:solidFill>
                <a:round/>
                <a:headEnd/>
                <a:tailEnd/>
              </a:ln>
              <a:extLst>
                <a:ext uri="{909E8E84-426E-40DD-AFC4-6F175D3DCCD1}">
    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</p:grpSp>
      </p:grpSp>
      <p:sp>
        <p:nvSpPr>
          <p:cNvPr id="25608" name="TextBox 428"/>
          <p:cNvSpPr txBox="1">
            <a:spLocks noChangeArrowheads="1"/>
          </p:cNvSpPr>
          <p:nvPr/>
        </p:nvSpPr>
        <p:spPr bwMode="auto">
          <a:xfrm>
            <a:off x="2379663" y="1295400"/>
            <a:ext cx="252412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defTabSz="457200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600"/>
              <a:t>*</a:t>
            </a:r>
          </a:p>
        </p:txBody>
      </p:sp>
      <p:sp>
        <p:nvSpPr>
          <p:cNvPr id="25609" name="TextBox 428"/>
          <p:cNvSpPr txBox="1">
            <a:spLocks noChangeArrowheads="1"/>
          </p:cNvSpPr>
          <p:nvPr/>
        </p:nvSpPr>
        <p:spPr bwMode="auto">
          <a:xfrm>
            <a:off x="5353050" y="1303338"/>
            <a:ext cx="252413" cy="585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defTabSz="457200"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1000" b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600"/>
              <a:t>*</a:t>
            </a:r>
          </a:p>
        </p:txBody>
      </p:sp>
      <p:sp>
        <p:nvSpPr>
          <p:cNvPr id="25610" name="Rectangle 3"/>
          <p:cNvSpPr>
            <a:spLocks noChangeArrowheads="1"/>
          </p:cNvSpPr>
          <p:nvPr/>
        </p:nvSpPr>
        <p:spPr bwMode="auto">
          <a:xfrm>
            <a:off x="1143000" y="1171575"/>
            <a:ext cx="27908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700">
                <a:solidFill>
                  <a:srgbClr val="000000"/>
                </a:solidFill>
                <a:cs typeface="Arial" charset="0"/>
              </a:rPr>
              <a:t>(D6) VDRFYKTLRAEQASQ           MW+H 1811.940 (*L=+7 Da)</a:t>
            </a:r>
          </a:p>
        </p:txBody>
      </p:sp>
      <p:sp>
        <p:nvSpPr>
          <p:cNvPr id="25611" name="Rectangle 5"/>
          <p:cNvSpPr>
            <a:spLocks noChangeArrowheads="1"/>
          </p:cNvSpPr>
          <p:nvPr/>
        </p:nvSpPr>
        <p:spPr bwMode="auto">
          <a:xfrm>
            <a:off x="4043363" y="1171575"/>
            <a:ext cx="280035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="http://schemas.openxmlformats.org/drawingml/2006/main" xmlns:r="http://schemas.openxmlformats.org/officeDocument/2006/relationships" xmlns:p="http://schemas.openxmlformats.org/presentationml/2006/main"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700">
                <a:solidFill>
                  <a:srgbClr val="000000"/>
                </a:solidFill>
              </a:rPr>
              <a:t>(D6.1) DRFYKTLRAEQASQ             MW+H 1712.872 (</a:t>
            </a:r>
            <a:r>
              <a:rPr lang="en-US" sz="700">
                <a:solidFill>
                  <a:srgbClr val="000000"/>
                </a:solidFill>
                <a:cs typeface="Arial" charset="0"/>
              </a:rPr>
              <a:t>*L=</a:t>
            </a:r>
            <a:r>
              <a:rPr lang="en-US" sz="700">
                <a:solidFill>
                  <a:srgbClr val="000000"/>
                </a:solidFill>
              </a:rPr>
              <a:t>+7 Da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19175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4</TotalTime>
  <Words>111</Words>
  <Application>Microsoft Macintosh PowerPoint</Application>
  <PresentationFormat>Custom</PresentationFormat>
  <Paragraphs>7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onsultan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JF</dc:creator>
  <cp:lastModifiedBy>Leonia Bozzacco</cp:lastModifiedBy>
  <cp:revision>343</cp:revision>
  <cp:lastPrinted>2012-03-30T21:20:31Z</cp:lastPrinted>
  <dcterms:created xsi:type="dcterms:W3CDTF">2012-05-27T20:04:17Z</dcterms:created>
  <dcterms:modified xsi:type="dcterms:W3CDTF">2012-05-27T20:05:28Z</dcterms:modified>
</cp:coreProperties>
</file>